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74" r:id="rId4"/>
    <p:sldId id="275" r:id="rId5"/>
    <p:sldId id="277" r:id="rId6"/>
    <p:sldId id="276" r:id="rId7"/>
    <p:sldId id="269" r:id="rId8"/>
    <p:sldId id="260" r:id="rId9"/>
    <p:sldId id="271" r:id="rId10"/>
    <p:sldId id="263" r:id="rId11"/>
    <p:sldId id="264" r:id="rId12"/>
  </p:sldIdLst>
  <p:sldSz cx="9144000" cy="6858000" type="screen4x3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370" autoAdjust="0"/>
    <p:restoredTop sz="94660"/>
  </p:normalViewPr>
  <p:slideViewPr>
    <p:cSldViewPr snapToGrid="0">
      <p:cViewPr varScale="1">
        <p:scale>
          <a:sx n="71" d="100"/>
          <a:sy n="71" d="100"/>
        </p:scale>
        <p:origin x="-750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0" d="100"/>
        <a:sy n="60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642B64-406A-454C-A6D2-9A7E143A3164}" type="datetimeFigureOut">
              <a:rPr kumimoji="1" lang="ja-JP" altLang="en-US" smtClean="0"/>
              <a:pPr/>
              <a:t>2012/11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C4E539-1843-4330-A5E5-590AF803BFEE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="" xmlns:p14="http://schemas.microsoft.com/office/powerpoint/2010/main" val="6118571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642B64-406A-454C-A6D2-9A7E143A3164}" type="datetimeFigureOut">
              <a:rPr kumimoji="1" lang="ja-JP" altLang="en-US" smtClean="0"/>
              <a:pPr/>
              <a:t>2012/11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C4E539-1843-4330-A5E5-590AF803BFEE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="" xmlns:p14="http://schemas.microsoft.com/office/powerpoint/2010/main" val="13933784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642B64-406A-454C-A6D2-9A7E143A3164}" type="datetimeFigureOut">
              <a:rPr kumimoji="1" lang="ja-JP" altLang="en-US" smtClean="0"/>
              <a:pPr/>
              <a:t>2012/11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C4E539-1843-4330-A5E5-590AF803BFEE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="" xmlns:p14="http://schemas.microsoft.com/office/powerpoint/2010/main" val="24394680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642B64-406A-454C-A6D2-9A7E143A3164}" type="datetimeFigureOut">
              <a:rPr kumimoji="1" lang="ja-JP" altLang="en-US" smtClean="0"/>
              <a:pPr/>
              <a:t>2012/11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C4E539-1843-4330-A5E5-590AF803BFEE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="" xmlns:p14="http://schemas.microsoft.com/office/powerpoint/2010/main" val="38453864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642B64-406A-454C-A6D2-9A7E143A3164}" type="datetimeFigureOut">
              <a:rPr kumimoji="1" lang="ja-JP" altLang="en-US" smtClean="0"/>
              <a:pPr/>
              <a:t>2012/11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C4E539-1843-4330-A5E5-590AF803BFEE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="" xmlns:p14="http://schemas.microsoft.com/office/powerpoint/2010/main" val="39596509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642B64-406A-454C-A6D2-9A7E143A3164}" type="datetimeFigureOut">
              <a:rPr kumimoji="1" lang="ja-JP" altLang="en-US" smtClean="0"/>
              <a:pPr/>
              <a:t>2012/11/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C4E539-1843-4330-A5E5-590AF803BFEE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="" xmlns:p14="http://schemas.microsoft.com/office/powerpoint/2010/main" val="25771979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642B64-406A-454C-A6D2-9A7E143A3164}" type="datetimeFigureOut">
              <a:rPr kumimoji="1" lang="ja-JP" altLang="en-US" smtClean="0"/>
              <a:pPr/>
              <a:t>2012/11/7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C4E539-1843-4330-A5E5-590AF803BFEE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="" xmlns:p14="http://schemas.microsoft.com/office/powerpoint/2010/main" val="14927426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642B64-406A-454C-A6D2-9A7E143A3164}" type="datetimeFigureOut">
              <a:rPr kumimoji="1" lang="ja-JP" altLang="en-US" smtClean="0"/>
              <a:pPr/>
              <a:t>2012/11/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C4E539-1843-4330-A5E5-590AF803BFEE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="" xmlns:p14="http://schemas.microsoft.com/office/powerpoint/2010/main" val="9228408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642B64-406A-454C-A6D2-9A7E143A3164}" type="datetimeFigureOut">
              <a:rPr kumimoji="1" lang="ja-JP" altLang="en-US" smtClean="0"/>
              <a:pPr/>
              <a:t>2012/11/7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C4E539-1843-4330-A5E5-590AF803BFEE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="" xmlns:p14="http://schemas.microsoft.com/office/powerpoint/2010/main" val="14201069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642B64-406A-454C-A6D2-9A7E143A3164}" type="datetimeFigureOut">
              <a:rPr kumimoji="1" lang="ja-JP" altLang="en-US" smtClean="0"/>
              <a:pPr/>
              <a:t>2012/11/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C4E539-1843-4330-A5E5-590AF803BFEE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="" xmlns:p14="http://schemas.microsoft.com/office/powerpoint/2010/main" val="9933001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642B64-406A-454C-A6D2-9A7E143A3164}" type="datetimeFigureOut">
              <a:rPr kumimoji="1" lang="ja-JP" altLang="en-US" smtClean="0"/>
              <a:pPr/>
              <a:t>2012/11/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C4E539-1843-4330-A5E5-590AF803BFEE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="" xmlns:p14="http://schemas.microsoft.com/office/powerpoint/2010/main" val="18525156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642B64-406A-454C-A6D2-9A7E143A3164}" type="datetimeFigureOut">
              <a:rPr kumimoji="1" lang="ja-JP" altLang="en-US" smtClean="0"/>
              <a:pPr/>
              <a:t>2012/11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C4E539-1843-4330-A5E5-590AF803BFEE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="" xmlns:p14="http://schemas.microsoft.com/office/powerpoint/2010/main" val="24794249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2276823493"/>
              </p:ext>
            </p:extLst>
          </p:nvPr>
        </p:nvGraphicFramePr>
        <p:xfrm>
          <a:off x="1987550" y="908720"/>
          <a:ext cx="5168900" cy="2305050"/>
        </p:xfrm>
        <a:graphic>
          <a:graphicData uri="http://schemas.openxmlformats.org/drawingml/2006/table">
            <a:tbl>
              <a:tblPr/>
              <a:tblGrid>
                <a:gridCol w="2121469"/>
                <a:gridCol w="789605"/>
                <a:gridCol w="1395286"/>
                <a:gridCol w="862540"/>
              </a:tblGrid>
              <a:tr h="438150">
                <a:tc gridSpan="4">
                  <a:txBody>
                    <a:bodyPr/>
                    <a:lstStyle/>
                    <a:p>
                      <a:pPr algn="l" rtl="0" fontAlgn="ctr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Supplemental Table </a:t>
                      </a:r>
                      <a:r>
                        <a:rPr lang="en-US" altLang="ja-JP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A</a:t>
                      </a:r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. 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Baseline proteinuria predicting renal outcome in multivariable Cox-Hazard model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26670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Predictor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HR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95% CI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p valu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67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Baseline UPE, g/day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2.3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1.31 to 4.0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0.004 </a:t>
                      </a:r>
                      <a:r>
                        <a:rPr lang="en-US" altLang="ja-JP" sz="12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#</a:t>
                      </a:r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 Unicode M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667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Age, year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0.9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0.94 to 1.0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&gt;0.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667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Current smoking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1.2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0.36 to 4.5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&gt;0.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667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U-RBC </a:t>
                      </a:r>
                      <a:r>
                        <a:rPr lang="en-US" sz="1200" b="0" i="0" u="sng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&gt;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 30/hpf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0.1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0.42 to 0.7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0.019 </a:t>
                      </a:r>
                      <a:r>
                        <a:rPr lang="en-US" altLang="ja-JP" sz="12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#</a:t>
                      </a:r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 Unicode M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667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eGFR&lt;60ml/min/1.73m</a:t>
                      </a:r>
                      <a:r>
                        <a:rPr lang="en-US" sz="12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 Unicode M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7.0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1.37 to 36.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0.020 </a:t>
                      </a:r>
                      <a:r>
                        <a:rPr lang="en-US" altLang="ja-JP" sz="12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#</a:t>
                      </a:r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 Unicode M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667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Tonsillectomy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0.9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0.22 to 4.0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&gt;0.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="" xmlns:p14="http://schemas.microsoft.com/office/powerpoint/2010/main" val="238738455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グループ化 1"/>
          <p:cNvGrpSpPr/>
          <p:nvPr/>
        </p:nvGrpSpPr>
        <p:grpSpPr>
          <a:xfrm>
            <a:off x="2609851" y="4751255"/>
            <a:ext cx="3952875" cy="57150"/>
            <a:chOff x="2609851" y="5544235"/>
            <a:chExt cx="3952875" cy="57150"/>
          </a:xfrm>
        </p:grpSpPr>
        <p:sp>
          <p:nvSpPr>
            <p:cNvPr id="3" name="Line 10"/>
            <p:cNvSpPr>
              <a:spLocks noChangeShapeType="1"/>
            </p:cNvSpPr>
            <p:nvPr/>
          </p:nvSpPr>
          <p:spPr bwMode="auto">
            <a:xfrm>
              <a:off x="2609851" y="5544235"/>
              <a:ext cx="0" cy="57150"/>
            </a:xfrm>
            <a:prstGeom prst="line">
              <a:avLst/>
            </a:pr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" name="Line 19"/>
            <p:cNvSpPr>
              <a:spLocks noChangeShapeType="1"/>
            </p:cNvSpPr>
            <p:nvPr/>
          </p:nvSpPr>
          <p:spPr bwMode="auto">
            <a:xfrm>
              <a:off x="3590926" y="5544235"/>
              <a:ext cx="0" cy="57150"/>
            </a:xfrm>
            <a:prstGeom prst="line">
              <a:avLst/>
            </a:pr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" name="Line 28"/>
            <p:cNvSpPr>
              <a:spLocks noChangeShapeType="1"/>
            </p:cNvSpPr>
            <p:nvPr/>
          </p:nvSpPr>
          <p:spPr bwMode="auto">
            <a:xfrm>
              <a:off x="4581526" y="5544235"/>
              <a:ext cx="0" cy="57150"/>
            </a:xfrm>
            <a:prstGeom prst="line">
              <a:avLst/>
            </a:pr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" name="Line 37"/>
            <p:cNvSpPr>
              <a:spLocks noChangeShapeType="1"/>
            </p:cNvSpPr>
            <p:nvPr/>
          </p:nvSpPr>
          <p:spPr bwMode="auto">
            <a:xfrm>
              <a:off x="5572126" y="5544235"/>
              <a:ext cx="0" cy="57150"/>
            </a:xfrm>
            <a:prstGeom prst="line">
              <a:avLst/>
            </a:pr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" name="Line 40"/>
            <p:cNvSpPr>
              <a:spLocks noChangeShapeType="1"/>
            </p:cNvSpPr>
            <p:nvPr/>
          </p:nvSpPr>
          <p:spPr bwMode="auto">
            <a:xfrm>
              <a:off x="6102170" y="5544235"/>
              <a:ext cx="0" cy="57150"/>
            </a:xfrm>
            <a:prstGeom prst="line">
              <a:avLst/>
            </a:pr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" name="Line 46"/>
            <p:cNvSpPr>
              <a:spLocks noChangeShapeType="1"/>
            </p:cNvSpPr>
            <p:nvPr/>
          </p:nvSpPr>
          <p:spPr bwMode="auto">
            <a:xfrm>
              <a:off x="6562726" y="5544235"/>
              <a:ext cx="0" cy="57150"/>
            </a:xfrm>
            <a:prstGeom prst="line">
              <a:avLst/>
            </a:pr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9" name="グループ化 8"/>
          <p:cNvGrpSpPr/>
          <p:nvPr/>
        </p:nvGrpSpPr>
        <p:grpSpPr>
          <a:xfrm>
            <a:off x="2428876" y="910250"/>
            <a:ext cx="4456112" cy="3633788"/>
            <a:chOff x="2428876" y="1658225"/>
            <a:chExt cx="4456112" cy="3633788"/>
          </a:xfrm>
        </p:grpSpPr>
        <p:sp>
          <p:nvSpPr>
            <p:cNvPr id="10" name="Freeform 68"/>
            <p:cNvSpPr>
              <a:spLocks/>
            </p:cNvSpPr>
            <p:nvPr/>
          </p:nvSpPr>
          <p:spPr bwMode="auto">
            <a:xfrm>
              <a:off x="2430463" y="3048875"/>
              <a:ext cx="4451350" cy="2178050"/>
            </a:xfrm>
            <a:custGeom>
              <a:avLst/>
              <a:gdLst>
                <a:gd name="T0" fmla="*/ 0 w 2804"/>
                <a:gd name="T1" fmla="*/ 1270 h 1372"/>
                <a:gd name="T2" fmla="*/ 66 w 2804"/>
                <a:gd name="T3" fmla="*/ 1263 h 1372"/>
                <a:gd name="T4" fmla="*/ 131 w 2804"/>
                <a:gd name="T5" fmla="*/ 1255 h 1372"/>
                <a:gd name="T6" fmla="*/ 196 w 2804"/>
                <a:gd name="T7" fmla="*/ 1248 h 1372"/>
                <a:gd name="T8" fmla="*/ 261 w 2804"/>
                <a:gd name="T9" fmla="*/ 1241 h 1372"/>
                <a:gd name="T10" fmla="*/ 326 w 2804"/>
                <a:gd name="T11" fmla="*/ 1234 h 1372"/>
                <a:gd name="T12" fmla="*/ 392 w 2804"/>
                <a:gd name="T13" fmla="*/ 1228 h 1372"/>
                <a:gd name="T14" fmla="*/ 457 w 2804"/>
                <a:gd name="T15" fmla="*/ 1222 h 1372"/>
                <a:gd name="T16" fmla="*/ 522 w 2804"/>
                <a:gd name="T17" fmla="*/ 1217 h 1372"/>
                <a:gd name="T18" fmla="*/ 587 w 2804"/>
                <a:gd name="T19" fmla="*/ 1212 h 1372"/>
                <a:gd name="T20" fmla="*/ 652 w 2804"/>
                <a:gd name="T21" fmla="*/ 1209 h 1372"/>
                <a:gd name="T22" fmla="*/ 717 w 2804"/>
                <a:gd name="T23" fmla="*/ 1205 h 1372"/>
                <a:gd name="T24" fmla="*/ 783 w 2804"/>
                <a:gd name="T25" fmla="*/ 1204 h 1372"/>
                <a:gd name="T26" fmla="*/ 848 w 2804"/>
                <a:gd name="T27" fmla="*/ 1209 h 1372"/>
                <a:gd name="T28" fmla="*/ 913 w 2804"/>
                <a:gd name="T29" fmla="*/ 1222 h 1372"/>
                <a:gd name="T30" fmla="*/ 978 w 2804"/>
                <a:gd name="T31" fmla="*/ 1243 h 1372"/>
                <a:gd name="T32" fmla="*/ 1043 w 2804"/>
                <a:gd name="T33" fmla="*/ 1268 h 1372"/>
                <a:gd name="T34" fmla="*/ 1109 w 2804"/>
                <a:gd name="T35" fmla="*/ 1294 h 1372"/>
                <a:gd name="T36" fmla="*/ 1173 w 2804"/>
                <a:gd name="T37" fmla="*/ 1320 h 1372"/>
                <a:gd name="T38" fmla="*/ 1239 w 2804"/>
                <a:gd name="T39" fmla="*/ 1341 h 1372"/>
                <a:gd name="T40" fmla="*/ 1304 w 2804"/>
                <a:gd name="T41" fmla="*/ 1358 h 1372"/>
                <a:gd name="T42" fmla="*/ 1369 w 2804"/>
                <a:gd name="T43" fmla="*/ 1369 h 1372"/>
                <a:gd name="T44" fmla="*/ 1434 w 2804"/>
                <a:gd name="T45" fmla="*/ 1372 h 1372"/>
                <a:gd name="T46" fmla="*/ 1499 w 2804"/>
                <a:gd name="T47" fmla="*/ 1367 h 1372"/>
                <a:gd name="T48" fmla="*/ 1565 w 2804"/>
                <a:gd name="T49" fmla="*/ 1353 h 1372"/>
                <a:gd name="T50" fmla="*/ 1630 w 2804"/>
                <a:gd name="T51" fmla="*/ 1329 h 1372"/>
                <a:gd name="T52" fmla="*/ 1695 w 2804"/>
                <a:gd name="T53" fmla="*/ 1294 h 1372"/>
                <a:gd name="T54" fmla="*/ 1760 w 2804"/>
                <a:gd name="T55" fmla="*/ 1249 h 1372"/>
                <a:gd name="T56" fmla="*/ 1825 w 2804"/>
                <a:gd name="T57" fmla="*/ 1193 h 1372"/>
                <a:gd name="T58" fmla="*/ 1890 w 2804"/>
                <a:gd name="T59" fmla="*/ 1127 h 1372"/>
                <a:gd name="T60" fmla="*/ 1956 w 2804"/>
                <a:gd name="T61" fmla="*/ 1052 h 1372"/>
                <a:gd name="T62" fmla="*/ 2021 w 2804"/>
                <a:gd name="T63" fmla="*/ 967 h 1372"/>
                <a:gd name="T64" fmla="*/ 2086 w 2804"/>
                <a:gd name="T65" fmla="*/ 876 h 1372"/>
                <a:gd name="T66" fmla="*/ 2151 w 2804"/>
                <a:gd name="T67" fmla="*/ 777 h 1372"/>
                <a:gd name="T68" fmla="*/ 2216 w 2804"/>
                <a:gd name="T69" fmla="*/ 673 h 1372"/>
                <a:gd name="T70" fmla="*/ 2282 w 2804"/>
                <a:gd name="T71" fmla="*/ 567 h 1372"/>
                <a:gd name="T72" fmla="*/ 2347 w 2804"/>
                <a:gd name="T73" fmla="*/ 463 h 1372"/>
                <a:gd name="T74" fmla="*/ 2412 w 2804"/>
                <a:gd name="T75" fmla="*/ 369 h 1372"/>
                <a:gd name="T76" fmla="*/ 2477 w 2804"/>
                <a:gd name="T77" fmla="*/ 286 h 1372"/>
                <a:gd name="T78" fmla="*/ 2542 w 2804"/>
                <a:gd name="T79" fmla="*/ 215 h 1372"/>
                <a:gd name="T80" fmla="*/ 2607 w 2804"/>
                <a:gd name="T81" fmla="*/ 152 h 1372"/>
                <a:gd name="T82" fmla="*/ 2673 w 2804"/>
                <a:gd name="T83" fmla="*/ 97 h 1372"/>
                <a:gd name="T84" fmla="*/ 2738 w 2804"/>
                <a:gd name="T85" fmla="*/ 47 h 1372"/>
                <a:gd name="T86" fmla="*/ 2803 w 2804"/>
                <a:gd name="T87" fmla="*/ 0 h 1372"/>
                <a:gd name="T88" fmla="*/ 2804 w 2804"/>
                <a:gd name="T89" fmla="*/ 0 h 13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</a:cxnLst>
              <a:rect l="0" t="0" r="r" b="b"/>
              <a:pathLst>
                <a:path w="2804" h="1372">
                  <a:moveTo>
                    <a:pt x="0" y="1270"/>
                  </a:moveTo>
                  <a:lnTo>
                    <a:pt x="66" y="1263"/>
                  </a:lnTo>
                  <a:lnTo>
                    <a:pt x="131" y="1255"/>
                  </a:lnTo>
                  <a:lnTo>
                    <a:pt x="196" y="1248"/>
                  </a:lnTo>
                  <a:lnTo>
                    <a:pt x="261" y="1241"/>
                  </a:lnTo>
                  <a:lnTo>
                    <a:pt x="326" y="1234"/>
                  </a:lnTo>
                  <a:lnTo>
                    <a:pt x="392" y="1228"/>
                  </a:lnTo>
                  <a:lnTo>
                    <a:pt x="457" y="1222"/>
                  </a:lnTo>
                  <a:lnTo>
                    <a:pt x="522" y="1217"/>
                  </a:lnTo>
                  <a:lnTo>
                    <a:pt x="587" y="1212"/>
                  </a:lnTo>
                  <a:lnTo>
                    <a:pt x="652" y="1209"/>
                  </a:lnTo>
                  <a:lnTo>
                    <a:pt x="717" y="1205"/>
                  </a:lnTo>
                  <a:lnTo>
                    <a:pt x="783" y="1204"/>
                  </a:lnTo>
                  <a:lnTo>
                    <a:pt x="848" y="1209"/>
                  </a:lnTo>
                  <a:lnTo>
                    <a:pt x="913" y="1222"/>
                  </a:lnTo>
                  <a:lnTo>
                    <a:pt x="978" y="1243"/>
                  </a:lnTo>
                  <a:lnTo>
                    <a:pt x="1043" y="1268"/>
                  </a:lnTo>
                  <a:lnTo>
                    <a:pt x="1109" y="1294"/>
                  </a:lnTo>
                  <a:lnTo>
                    <a:pt x="1173" y="1320"/>
                  </a:lnTo>
                  <a:lnTo>
                    <a:pt x="1239" y="1341"/>
                  </a:lnTo>
                  <a:lnTo>
                    <a:pt x="1304" y="1358"/>
                  </a:lnTo>
                  <a:lnTo>
                    <a:pt x="1369" y="1369"/>
                  </a:lnTo>
                  <a:lnTo>
                    <a:pt x="1434" y="1372"/>
                  </a:lnTo>
                  <a:lnTo>
                    <a:pt x="1499" y="1367"/>
                  </a:lnTo>
                  <a:lnTo>
                    <a:pt x="1565" y="1353"/>
                  </a:lnTo>
                  <a:lnTo>
                    <a:pt x="1630" y="1329"/>
                  </a:lnTo>
                  <a:lnTo>
                    <a:pt x="1695" y="1294"/>
                  </a:lnTo>
                  <a:lnTo>
                    <a:pt x="1760" y="1249"/>
                  </a:lnTo>
                  <a:lnTo>
                    <a:pt x="1825" y="1193"/>
                  </a:lnTo>
                  <a:lnTo>
                    <a:pt x="1890" y="1127"/>
                  </a:lnTo>
                  <a:lnTo>
                    <a:pt x="1956" y="1052"/>
                  </a:lnTo>
                  <a:lnTo>
                    <a:pt x="2021" y="967"/>
                  </a:lnTo>
                  <a:lnTo>
                    <a:pt x="2086" y="876"/>
                  </a:lnTo>
                  <a:lnTo>
                    <a:pt x="2151" y="777"/>
                  </a:lnTo>
                  <a:lnTo>
                    <a:pt x="2216" y="673"/>
                  </a:lnTo>
                  <a:lnTo>
                    <a:pt x="2282" y="567"/>
                  </a:lnTo>
                  <a:lnTo>
                    <a:pt x="2347" y="463"/>
                  </a:lnTo>
                  <a:lnTo>
                    <a:pt x="2412" y="369"/>
                  </a:lnTo>
                  <a:lnTo>
                    <a:pt x="2477" y="286"/>
                  </a:lnTo>
                  <a:lnTo>
                    <a:pt x="2542" y="215"/>
                  </a:lnTo>
                  <a:lnTo>
                    <a:pt x="2607" y="152"/>
                  </a:lnTo>
                  <a:lnTo>
                    <a:pt x="2673" y="97"/>
                  </a:lnTo>
                  <a:lnTo>
                    <a:pt x="2738" y="47"/>
                  </a:lnTo>
                  <a:lnTo>
                    <a:pt x="2803" y="0"/>
                  </a:lnTo>
                  <a:lnTo>
                    <a:pt x="2804" y="0"/>
                  </a:lnTo>
                </a:path>
              </a:pathLst>
            </a:custGeom>
            <a:noFill/>
            <a:ln w="2857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" name="Freeform 69"/>
            <p:cNvSpPr>
              <a:spLocks noEditPoints="1"/>
            </p:cNvSpPr>
            <p:nvPr/>
          </p:nvSpPr>
          <p:spPr bwMode="auto">
            <a:xfrm>
              <a:off x="2430463" y="4115675"/>
              <a:ext cx="4454525" cy="1176338"/>
            </a:xfrm>
            <a:custGeom>
              <a:avLst/>
              <a:gdLst>
                <a:gd name="T0" fmla="*/ 48 w 2806"/>
                <a:gd name="T1" fmla="*/ 714 h 741"/>
                <a:gd name="T2" fmla="*/ 108 w 2806"/>
                <a:gd name="T3" fmla="*/ 706 h 741"/>
                <a:gd name="T4" fmla="*/ 144 w 2806"/>
                <a:gd name="T5" fmla="*/ 710 h 741"/>
                <a:gd name="T6" fmla="*/ 228 w 2806"/>
                <a:gd name="T7" fmla="*/ 701 h 741"/>
                <a:gd name="T8" fmla="*/ 261 w 2806"/>
                <a:gd name="T9" fmla="*/ 706 h 741"/>
                <a:gd name="T10" fmla="*/ 288 w 2806"/>
                <a:gd name="T11" fmla="*/ 699 h 741"/>
                <a:gd name="T12" fmla="*/ 324 w 2806"/>
                <a:gd name="T13" fmla="*/ 698 h 741"/>
                <a:gd name="T14" fmla="*/ 408 w 2806"/>
                <a:gd name="T15" fmla="*/ 701 h 741"/>
                <a:gd name="T16" fmla="*/ 468 w 2806"/>
                <a:gd name="T17" fmla="*/ 694 h 741"/>
                <a:gd name="T18" fmla="*/ 504 w 2806"/>
                <a:gd name="T19" fmla="*/ 699 h 741"/>
                <a:gd name="T20" fmla="*/ 587 w 2806"/>
                <a:gd name="T21" fmla="*/ 692 h 741"/>
                <a:gd name="T22" fmla="*/ 624 w 2806"/>
                <a:gd name="T23" fmla="*/ 692 h 741"/>
                <a:gd name="T24" fmla="*/ 652 w 2806"/>
                <a:gd name="T25" fmla="*/ 698 h 741"/>
                <a:gd name="T26" fmla="*/ 684 w 2806"/>
                <a:gd name="T27" fmla="*/ 692 h 741"/>
                <a:gd name="T28" fmla="*/ 768 w 2806"/>
                <a:gd name="T29" fmla="*/ 699 h 741"/>
                <a:gd name="T30" fmla="*/ 828 w 2806"/>
                <a:gd name="T31" fmla="*/ 695 h 741"/>
                <a:gd name="T32" fmla="*/ 864 w 2806"/>
                <a:gd name="T33" fmla="*/ 703 h 741"/>
                <a:gd name="T34" fmla="*/ 948 w 2806"/>
                <a:gd name="T35" fmla="*/ 703 h 741"/>
                <a:gd name="T36" fmla="*/ 978 w 2806"/>
                <a:gd name="T37" fmla="*/ 712 h 741"/>
                <a:gd name="T38" fmla="*/ 1008 w 2806"/>
                <a:gd name="T39" fmla="*/ 709 h 741"/>
                <a:gd name="T40" fmla="*/ 1091 w 2806"/>
                <a:gd name="T41" fmla="*/ 723 h 741"/>
                <a:gd name="T42" fmla="*/ 1151 w 2806"/>
                <a:gd name="T43" fmla="*/ 723 h 741"/>
                <a:gd name="T44" fmla="*/ 1187 w 2806"/>
                <a:gd name="T45" fmla="*/ 732 h 741"/>
                <a:gd name="T46" fmla="*/ 1271 w 2806"/>
                <a:gd name="T47" fmla="*/ 732 h 741"/>
                <a:gd name="T48" fmla="*/ 1307 w 2806"/>
                <a:gd name="T49" fmla="*/ 740 h 741"/>
                <a:gd name="T50" fmla="*/ 1331 w 2806"/>
                <a:gd name="T51" fmla="*/ 734 h 741"/>
                <a:gd name="T52" fmla="*/ 1367 w 2806"/>
                <a:gd name="T53" fmla="*/ 735 h 741"/>
                <a:gd name="T54" fmla="*/ 1451 w 2806"/>
                <a:gd name="T55" fmla="*/ 737 h 741"/>
                <a:gd name="T56" fmla="*/ 1509 w 2806"/>
                <a:gd name="T57" fmla="*/ 724 h 741"/>
                <a:gd name="T58" fmla="*/ 1546 w 2806"/>
                <a:gd name="T59" fmla="*/ 723 h 741"/>
                <a:gd name="T60" fmla="*/ 1626 w 2806"/>
                <a:gd name="T61" fmla="*/ 696 h 741"/>
                <a:gd name="T62" fmla="*/ 1648 w 2806"/>
                <a:gd name="T63" fmla="*/ 688 h 741"/>
                <a:gd name="T64" fmla="*/ 1727 w 2806"/>
                <a:gd name="T65" fmla="*/ 660 h 741"/>
                <a:gd name="T66" fmla="*/ 1776 w 2806"/>
                <a:gd name="T67" fmla="*/ 625 h 741"/>
                <a:gd name="T68" fmla="*/ 1810 w 2806"/>
                <a:gd name="T69" fmla="*/ 611 h 741"/>
                <a:gd name="T70" fmla="*/ 1874 w 2806"/>
                <a:gd name="T71" fmla="*/ 556 h 741"/>
                <a:gd name="T72" fmla="*/ 1892 w 2806"/>
                <a:gd name="T73" fmla="*/ 541 h 741"/>
                <a:gd name="T74" fmla="*/ 1953 w 2806"/>
                <a:gd name="T75" fmla="*/ 486 h 741"/>
                <a:gd name="T76" fmla="*/ 1984 w 2806"/>
                <a:gd name="T77" fmla="*/ 463 h 741"/>
                <a:gd name="T78" fmla="*/ 2022 w 2806"/>
                <a:gd name="T79" fmla="*/ 417 h 741"/>
                <a:gd name="T80" fmla="*/ 2051 w 2806"/>
                <a:gd name="T81" fmla="*/ 394 h 741"/>
                <a:gd name="T82" fmla="*/ 2102 w 2806"/>
                <a:gd name="T83" fmla="*/ 327 h 741"/>
                <a:gd name="T84" fmla="*/ 2118 w 2806"/>
                <a:gd name="T85" fmla="*/ 309 h 741"/>
                <a:gd name="T86" fmla="*/ 2142 w 2806"/>
                <a:gd name="T87" fmla="*/ 282 h 741"/>
                <a:gd name="T88" fmla="*/ 2200 w 2806"/>
                <a:gd name="T89" fmla="*/ 222 h 741"/>
                <a:gd name="T90" fmla="*/ 2219 w 2806"/>
                <a:gd name="T91" fmla="*/ 200 h 741"/>
                <a:gd name="T92" fmla="*/ 2258 w 2806"/>
                <a:gd name="T93" fmla="*/ 145 h 741"/>
                <a:gd name="T94" fmla="*/ 2287 w 2806"/>
                <a:gd name="T95" fmla="*/ 123 h 741"/>
                <a:gd name="T96" fmla="*/ 2343 w 2806"/>
                <a:gd name="T97" fmla="*/ 60 h 741"/>
                <a:gd name="T98" fmla="*/ 2364 w 2806"/>
                <a:gd name="T99" fmla="*/ 46 h 741"/>
                <a:gd name="T100" fmla="*/ 2440 w 2806"/>
                <a:gd name="T101" fmla="*/ 15 h 741"/>
                <a:gd name="T102" fmla="*/ 2499 w 2806"/>
                <a:gd name="T103" fmla="*/ 2 h 741"/>
                <a:gd name="T104" fmla="*/ 2544 w 2806"/>
                <a:gd name="T105" fmla="*/ 14 h 741"/>
                <a:gd name="T106" fmla="*/ 2567 w 2806"/>
                <a:gd name="T107" fmla="*/ 23 h 741"/>
                <a:gd name="T108" fmla="*/ 2600 w 2806"/>
                <a:gd name="T109" fmla="*/ 36 h 741"/>
                <a:gd name="T110" fmla="*/ 2674 w 2806"/>
                <a:gd name="T111" fmla="*/ 75 h 741"/>
                <a:gd name="T112" fmla="*/ 2693 w 2806"/>
                <a:gd name="T113" fmla="*/ 91 h 741"/>
                <a:gd name="T114" fmla="*/ 2753 w 2806"/>
                <a:gd name="T115" fmla="*/ 150 h 741"/>
                <a:gd name="T116" fmla="*/ 2801 w 2806"/>
                <a:gd name="T117" fmla="*/ 186 h 7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</a:cxnLst>
              <a:rect l="0" t="0" r="r" b="b"/>
              <a:pathLst>
                <a:path w="2806" h="741">
                  <a:moveTo>
                    <a:pt x="0" y="710"/>
                  </a:moveTo>
                  <a:lnTo>
                    <a:pt x="12" y="709"/>
                  </a:lnTo>
                  <a:lnTo>
                    <a:pt x="12" y="715"/>
                  </a:lnTo>
                  <a:lnTo>
                    <a:pt x="0" y="716"/>
                  </a:lnTo>
                  <a:lnTo>
                    <a:pt x="0" y="710"/>
                  </a:lnTo>
                  <a:close/>
                  <a:moveTo>
                    <a:pt x="36" y="709"/>
                  </a:moveTo>
                  <a:lnTo>
                    <a:pt x="48" y="708"/>
                  </a:lnTo>
                  <a:lnTo>
                    <a:pt x="48" y="714"/>
                  </a:lnTo>
                  <a:lnTo>
                    <a:pt x="36" y="715"/>
                  </a:lnTo>
                  <a:lnTo>
                    <a:pt x="36" y="709"/>
                  </a:lnTo>
                  <a:close/>
                  <a:moveTo>
                    <a:pt x="72" y="707"/>
                  </a:moveTo>
                  <a:lnTo>
                    <a:pt x="84" y="706"/>
                  </a:lnTo>
                  <a:lnTo>
                    <a:pt x="84" y="712"/>
                  </a:lnTo>
                  <a:lnTo>
                    <a:pt x="72" y="713"/>
                  </a:lnTo>
                  <a:lnTo>
                    <a:pt x="72" y="707"/>
                  </a:lnTo>
                  <a:close/>
                  <a:moveTo>
                    <a:pt x="108" y="706"/>
                  </a:moveTo>
                  <a:lnTo>
                    <a:pt x="120" y="705"/>
                  </a:lnTo>
                  <a:lnTo>
                    <a:pt x="120" y="711"/>
                  </a:lnTo>
                  <a:lnTo>
                    <a:pt x="108" y="712"/>
                  </a:lnTo>
                  <a:lnTo>
                    <a:pt x="108" y="706"/>
                  </a:lnTo>
                  <a:close/>
                  <a:moveTo>
                    <a:pt x="144" y="704"/>
                  </a:moveTo>
                  <a:lnTo>
                    <a:pt x="156" y="704"/>
                  </a:lnTo>
                  <a:lnTo>
                    <a:pt x="156" y="710"/>
                  </a:lnTo>
                  <a:lnTo>
                    <a:pt x="144" y="710"/>
                  </a:lnTo>
                  <a:lnTo>
                    <a:pt x="144" y="704"/>
                  </a:lnTo>
                  <a:close/>
                  <a:moveTo>
                    <a:pt x="180" y="703"/>
                  </a:moveTo>
                  <a:lnTo>
                    <a:pt x="192" y="702"/>
                  </a:lnTo>
                  <a:lnTo>
                    <a:pt x="192" y="708"/>
                  </a:lnTo>
                  <a:lnTo>
                    <a:pt x="180" y="709"/>
                  </a:lnTo>
                  <a:lnTo>
                    <a:pt x="180" y="703"/>
                  </a:lnTo>
                  <a:close/>
                  <a:moveTo>
                    <a:pt x="216" y="702"/>
                  </a:moveTo>
                  <a:lnTo>
                    <a:pt x="228" y="701"/>
                  </a:lnTo>
                  <a:lnTo>
                    <a:pt x="228" y="707"/>
                  </a:lnTo>
                  <a:lnTo>
                    <a:pt x="216" y="708"/>
                  </a:lnTo>
                  <a:lnTo>
                    <a:pt x="216" y="702"/>
                  </a:lnTo>
                  <a:close/>
                  <a:moveTo>
                    <a:pt x="252" y="700"/>
                  </a:moveTo>
                  <a:lnTo>
                    <a:pt x="261" y="700"/>
                  </a:lnTo>
                  <a:lnTo>
                    <a:pt x="264" y="700"/>
                  </a:lnTo>
                  <a:lnTo>
                    <a:pt x="264" y="706"/>
                  </a:lnTo>
                  <a:lnTo>
                    <a:pt x="261" y="706"/>
                  </a:lnTo>
                  <a:lnTo>
                    <a:pt x="261" y="706"/>
                  </a:lnTo>
                  <a:lnTo>
                    <a:pt x="252" y="706"/>
                  </a:lnTo>
                  <a:lnTo>
                    <a:pt x="252" y="700"/>
                  </a:lnTo>
                  <a:close/>
                  <a:moveTo>
                    <a:pt x="288" y="699"/>
                  </a:moveTo>
                  <a:lnTo>
                    <a:pt x="300" y="699"/>
                  </a:lnTo>
                  <a:lnTo>
                    <a:pt x="300" y="705"/>
                  </a:lnTo>
                  <a:lnTo>
                    <a:pt x="288" y="705"/>
                  </a:lnTo>
                  <a:lnTo>
                    <a:pt x="288" y="699"/>
                  </a:lnTo>
                  <a:close/>
                  <a:moveTo>
                    <a:pt x="324" y="698"/>
                  </a:moveTo>
                  <a:lnTo>
                    <a:pt x="326" y="697"/>
                  </a:lnTo>
                  <a:lnTo>
                    <a:pt x="336" y="697"/>
                  </a:lnTo>
                  <a:lnTo>
                    <a:pt x="336" y="703"/>
                  </a:lnTo>
                  <a:lnTo>
                    <a:pt x="326" y="703"/>
                  </a:lnTo>
                  <a:lnTo>
                    <a:pt x="326" y="703"/>
                  </a:lnTo>
                  <a:lnTo>
                    <a:pt x="324" y="704"/>
                  </a:lnTo>
                  <a:lnTo>
                    <a:pt x="324" y="698"/>
                  </a:lnTo>
                  <a:close/>
                  <a:moveTo>
                    <a:pt x="360" y="697"/>
                  </a:moveTo>
                  <a:lnTo>
                    <a:pt x="372" y="696"/>
                  </a:lnTo>
                  <a:lnTo>
                    <a:pt x="372" y="702"/>
                  </a:lnTo>
                  <a:lnTo>
                    <a:pt x="360" y="703"/>
                  </a:lnTo>
                  <a:lnTo>
                    <a:pt x="360" y="697"/>
                  </a:lnTo>
                  <a:close/>
                  <a:moveTo>
                    <a:pt x="396" y="696"/>
                  </a:moveTo>
                  <a:lnTo>
                    <a:pt x="408" y="695"/>
                  </a:lnTo>
                  <a:lnTo>
                    <a:pt x="408" y="701"/>
                  </a:lnTo>
                  <a:lnTo>
                    <a:pt x="396" y="702"/>
                  </a:lnTo>
                  <a:lnTo>
                    <a:pt x="396" y="696"/>
                  </a:lnTo>
                  <a:close/>
                  <a:moveTo>
                    <a:pt x="432" y="695"/>
                  </a:moveTo>
                  <a:lnTo>
                    <a:pt x="444" y="694"/>
                  </a:lnTo>
                  <a:lnTo>
                    <a:pt x="444" y="700"/>
                  </a:lnTo>
                  <a:lnTo>
                    <a:pt x="432" y="701"/>
                  </a:lnTo>
                  <a:lnTo>
                    <a:pt x="432" y="695"/>
                  </a:lnTo>
                  <a:close/>
                  <a:moveTo>
                    <a:pt x="468" y="694"/>
                  </a:moveTo>
                  <a:lnTo>
                    <a:pt x="480" y="694"/>
                  </a:lnTo>
                  <a:lnTo>
                    <a:pt x="480" y="700"/>
                  </a:lnTo>
                  <a:lnTo>
                    <a:pt x="468" y="700"/>
                  </a:lnTo>
                  <a:lnTo>
                    <a:pt x="468" y="694"/>
                  </a:lnTo>
                  <a:close/>
                  <a:moveTo>
                    <a:pt x="504" y="693"/>
                  </a:moveTo>
                  <a:lnTo>
                    <a:pt x="516" y="693"/>
                  </a:lnTo>
                  <a:lnTo>
                    <a:pt x="516" y="699"/>
                  </a:lnTo>
                  <a:lnTo>
                    <a:pt x="504" y="699"/>
                  </a:lnTo>
                  <a:lnTo>
                    <a:pt x="504" y="693"/>
                  </a:lnTo>
                  <a:close/>
                  <a:moveTo>
                    <a:pt x="540" y="693"/>
                  </a:moveTo>
                  <a:lnTo>
                    <a:pt x="552" y="693"/>
                  </a:lnTo>
                  <a:lnTo>
                    <a:pt x="552" y="699"/>
                  </a:lnTo>
                  <a:lnTo>
                    <a:pt x="540" y="699"/>
                  </a:lnTo>
                  <a:lnTo>
                    <a:pt x="540" y="693"/>
                  </a:lnTo>
                  <a:close/>
                  <a:moveTo>
                    <a:pt x="576" y="692"/>
                  </a:moveTo>
                  <a:lnTo>
                    <a:pt x="587" y="692"/>
                  </a:lnTo>
                  <a:lnTo>
                    <a:pt x="588" y="692"/>
                  </a:lnTo>
                  <a:lnTo>
                    <a:pt x="588" y="698"/>
                  </a:lnTo>
                  <a:lnTo>
                    <a:pt x="587" y="698"/>
                  </a:lnTo>
                  <a:lnTo>
                    <a:pt x="587" y="698"/>
                  </a:lnTo>
                  <a:lnTo>
                    <a:pt x="576" y="698"/>
                  </a:lnTo>
                  <a:lnTo>
                    <a:pt x="576" y="692"/>
                  </a:lnTo>
                  <a:close/>
                  <a:moveTo>
                    <a:pt x="612" y="692"/>
                  </a:moveTo>
                  <a:lnTo>
                    <a:pt x="624" y="692"/>
                  </a:lnTo>
                  <a:lnTo>
                    <a:pt x="624" y="698"/>
                  </a:lnTo>
                  <a:lnTo>
                    <a:pt x="612" y="698"/>
                  </a:lnTo>
                  <a:lnTo>
                    <a:pt x="612" y="692"/>
                  </a:lnTo>
                  <a:close/>
                  <a:moveTo>
                    <a:pt x="648" y="692"/>
                  </a:moveTo>
                  <a:lnTo>
                    <a:pt x="652" y="692"/>
                  </a:lnTo>
                  <a:lnTo>
                    <a:pt x="660" y="692"/>
                  </a:lnTo>
                  <a:lnTo>
                    <a:pt x="660" y="698"/>
                  </a:lnTo>
                  <a:lnTo>
                    <a:pt x="652" y="698"/>
                  </a:lnTo>
                  <a:lnTo>
                    <a:pt x="652" y="698"/>
                  </a:lnTo>
                  <a:lnTo>
                    <a:pt x="648" y="698"/>
                  </a:lnTo>
                  <a:lnTo>
                    <a:pt x="648" y="692"/>
                  </a:lnTo>
                  <a:close/>
                  <a:moveTo>
                    <a:pt x="684" y="692"/>
                  </a:moveTo>
                  <a:lnTo>
                    <a:pt x="696" y="692"/>
                  </a:lnTo>
                  <a:lnTo>
                    <a:pt x="696" y="698"/>
                  </a:lnTo>
                  <a:lnTo>
                    <a:pt x="684" y="698"/>
                  </a:lnTo>
                  <a:lnTo>
                    <a:pt x="684" y="692"/>
                  </a:lnTo>
                  <a:close/>
                  <a:moveTo>
                    <a:pt x="720" y="692"/>
                  </a:moveTo>
                  <a:lnTo>
                    <a:pt x="732" y="693"/>
                  </a:lnTo>
                  <a:lnTo>
                    <a:pt x="732" y="699"/>
                  </a:lnTo>
                  <a:lnTo>
                    <a:pt x="720" y="698"/>
                  </a:lnTo>
                  <a:lnTo>
                    <a:pt x="720" y="692"/>
                  </a:lnTo>
                  <a:close/>
                  <a:moveTo>
                    <a:pt x="756" y="693"/>
                  </a:moveTo>
                  <a:lnTo>
                    <a:pt x="768" y="693"/>
                  </a:lnTo>
                  <a:lnTo>
                    <a:pt x="768" y="699"/>
                  </a:lnTo>
                  <a:lnTo>
                    <a:pt x="756" y="699"/>
                  </a:lnTo>
                  <a:lnTo>
                    <a:pt x="756" y="693"/>
                  </a:lnTo>
                  <a:close/>
                  <a:moveTo>
                    <a:pt x="792" y="694"/>
                  </a:moveTo>
                  <a:lnTo>
                    <a:pt x="804" y="694"/>
                  </a:lnTo>
                  <a:lnTo>
                    <a:pt x="804" y="700"/>
                  </a:lnTo>
                  <a:lnTo>
                    <a:pt x="792" y="700"/>
                  </a:lnTo>
                  <a:lnTo>
                    <a:pt x="792" y="694"/>
                  </a:lnTo>
                  <a:close/>
                  <a:moveTo>
                    <a:pt x="828" y="695"/>
                  </a:moveTo>
                  <a:lnTo>
                    <a:pt x="840" y="696"/>
                  </a:lnTo>
                  <a:lnTo>
                    <a:pt x="840" y="702"/>
                  </a:lnTo>
                  <a:lnTo>
                    <a:pt x="828" y="701"/>
                  </a:lnTo>
                  <a:lnTo>
                    <a:pt x="828" y="695"/>
                  </a:lnTo>
                  <a:close/>
                  <a:moveTo>
                    <a:pt x="864" y="697"/>
                  </a:moveTo>
                  <a:lnTo>
                    <a:pt x="876" y="698"/>
                  </a:lnTo>
                  <a:lnTo>
                    <a:pt x="876" y="704"/>
                  </a:lnTo>
                  <a:lnTo>
                    <a:pt x="864" y="703"/>
                  </a:lnTo>
                  <a:lnTo>
                    <a:pt x="864" y="697"/>
                  </a:lnTo>
                  <a:close/>
                  <a:moveTo>
                    <a:pt x="900" y="699"/>
                  </a:moveTo>
                  <a:lnTo>
                    <a:pt x="912" y="700"/>
                  </a:lnTo>
                  <a:lnTo>
                    <a:pt x="912" y="706"/>
                  </a:lnTo>
                  <a:lnTo>
                    <a:pt x="900" y="705"/>
                  </a:lnTo>
                  <a:lnTo>
                    <a:pt x="900" y="699"/>
                  </a:lnTo>
                  <a:close/>
                  <a:moveTo>
                    <a:pt x="936" y="702"/>
                  </a:moveTo>
                  <a:lnTo>
                    <a:pt x="948" y="703"/>
                  </a:lnTo>
                  <a:lnTo>
                    <a:pt x="948" y="709"/>
                  </a:lnTo>
                  <a:lnTo>
                    <a:pt x="936" y="708"/>
                  </a:lnTo>
                  <a:lnTo>
                    <a:pt x="936" y="702"/>
                  </a:lnTo>
                  <a:close/>
                  <a:moveTo>
                    <a:pt x="972" y="705"/>
                  </a:moveTo>
                  <a:lnTo>
                    <a:pt x="978" y="706"/>
                  </a:lnTo>
                  <a:lnTo>
                    <a:pt x="984" y="706"/>
                  </a:lnTo>
                  <a:lnTo>
                    <a:pt x="983" y="712"/>
                  </a:lnTo>
                  <a:lnTo>
                    <a:pt x="978" y="712"/>
                  </a:lnTo>
                  <a:lnTo>
                    <a:pt x="978" y="712"/>
                  </a:lnTo>
                  <a:lnTo>
                    <a:pt x="971" y="711"/>
                  </a:lnTo>
                  <a:lnTo>
                    <a:pt x="972" y="705"/>
                  </a:lnTo>
                  <a:close/>
                  <a:moveTo>
                    <a:pt x="1008" y="709"/>
                  </a:moveTo>
                  <a:lnTo>
                    <a:pt x="1020" y="710"/>
                  </a:lnTo>
                  <a:lnTo>
                    <a:pt x="1019" y="716"/>
                  </a:lnTo>
                  <a:lnTo>
                    <a:pt x="1007" y="715"/>
                  </a:lnTo>
                  <a:lnTo>
                    <a:pt x="1008" y="709"/>
                  </a:lnTo>
                  <a:close/>
                  <a:moveTo>
                    <a:pt x="1044" y="712"/>
                  </a:moveTo>
                  <a:lnTo>
                    <a:pt x="1056" y="714"/>
                  </a:lnTo>
                  <a:lnTo>
                    <a:pt x="1055" y="720"/>
                  </a:lnTo>
                  <a:lnTo>
                    <a:pt x="1043" y="718"/>
                  </a:lnTo>
                  <a:lnTo>
                    <a:pt x="1044" y="712"/>
                  </a:lnTo>
                  <a:close/>
                  <a:moveTo>
                    <a:pt x="1080" y="716"/>
                  </a:moveTo>
                  <a:lnTo>
                    <a:pt x="1091" y="717"/>
                  </a:lnTo>
                  <a:lnTo>
                    <a:pt x="1091" y="723"/>
                  </a:lnTo>
                  <a:lnTo>
                    <a:pt x="1079" y="722"/>
                  </a:lnTo>
                  <a:lnTo>
                    <a:pt x="1080" y="716"/>
                  </a:lnTo>
                  <a:close/>
                  <a:moveTo>
                    <a:pt x="1115" y="720"/>
                  </a:moveTo>
                  <a:lnTo>
                    <a:pt x="1127" y="721"/>
                  </a:lnTo>
                  <a:lnTo>
                    <a:pt x="1127" y="727"/>
                  </a:lnTo>
                  <a:lnTo>
                    <a:pt x="1115" y="726"/>
                  </a:lnTo>
                  <a:lnTo>
                    <a:pt x="1115" y="720"/>
                  </a:lnTo>
                  <a:close/>
                  <a:moveTo>
                    <a:pt x="1151" y="723"/>
                  </a:moveTo>
                  <a:lnTo>
                    <a:pt x="1163" y="724"/>
                  </a:lnTo>
                  <a:lnTo>
                    <a:pt x="1163" y="730"/>
                  </a:lnTo>
                  <a:lnTo>
                    <a:pt x="1151" y="729"/>
                  </a:lnTo>
                  <a:lnTo>
                    <a:pt x="1151" y="723"/>
                  </a:lnTo>
                  <a:close/>
                  <a:moveTo>
                    <a:pt x="1187" y="726"/>
                  </a:moveTo>
                  <a:lnTo>
                    <a:pt x="1199" y="727"/>
                  </a:lnTo>
                  <a:lnTo>
                    <a:pt x="1199" y="733"/>
                  </a:lnTo>
                  <a:lnTo>
                    <a:pt x="1187" y="732"/>
                  </a:lnTo>
                  <a:lnTo>
                    <a:pt x="1187" y="726"/>
                  </a:lnTo>
                  <a:close/>
                  <a:moveTo>
                    <a:pt x="1223" y="729"/>
                  </a:moveTo>
                  <a:lnTo>
                    <a:pt x="1235" y="730"/>
                  </a:lnTo>
                  <a:lnTo>
                    <a:pt x="1234" y="736"/>
                  </a:lnTo>
                  <a:lnTo>
                    <a:pt x="1222" y="735"/>
                  </a:lnTo>
                  <a:lnTo>
                    <a:pt x="1223" y="729"/>
                  </a:lnTo>
                  <a:close/>
                  <a:moveTo>
                    <a:pt x="1259" y="732"/>
                  </a:moveTo>
                  <a:lnTo>
                    <a:pt x="1271" y="732"/>
                  </a:lnTo>
                  <a:lnTo>
                    <a:pt x="1270" y="738"/>
                  </a:lnTo>
                  <a:lnTo>
                    <a:pt x="1258" y="738"/>
                  </a:lnTo>
                  <a:lnTo>
                    <a:pt x="1259" y="732"/>
                  </a:lnTo>
                  <a:close/>
                  <a:moveTo>
                    <a:pt x="1295" y="733"/>
                  </a:moveTo>
                  <a:lnTo>
                    <a:pt x="1304" y="734"/>
                  </a:lnTo>
                  <a:lnTo>
                    <a:pt x="1304" y="734"/>
                  </a:lnTo>
                  <a:lnTo>
                    <a:pt x="1307" y="734"/>
                  </a:lnTo>
                  <a:lnTo>
                    <a:pt x="1307" y="740"/>
                  </a:lnTo>
                  <a:lnTo>
                    <a:pt x="1304" y="740"/>
                  </a:lnTo>
                  <a:lnTo>
                    <a:pt x="1294" y="739"/>
                  </a:lnTo>
                  <a:lnTo>
                    <a:pt x="1295" y="733"/>
                  </a:lnTo>
                  <a:close/>
                  <a:moveTo>
                    <a:pt x="1331" y="734"/>
                  </a:moveTo>
                  <a:lnTo>
                    <a:pt x="1343" y="735"/>
                  </a:lnTo>
                  <a:lnTo>
                    <a:pt x="1343" y="741"/>
                  </a:lnTo>
                  <a:lnTo>
                    <a:pt x="1331" y="740"/>
                  </a:lnTo>
                  <a:lnTo>
                    <a:pt x="1331" y="734"/>
                  </a:lnTo>
                  <a:close/>
                  <a:moveTo>
                    <a:pt x="1367" y="735"/>
                  </a:moveTo>
                  <a:lnTo>
                    <a:pt x="1369" y="735"/>
                  </a:lnTo>
                  <a:lnTo>
                    <a:pt x="1369" y="735"/>
                  </a:lnTo>
                  <a:lnTo>
                    <a:pt x="1378" y="735"/>
                  </a:lnTo>
                  <a:lnTo>
                    <a:pt x="1379" y="741"/>
                  </a:lnTo>
                  <a:lnTo>
                    <a:pt x="1369" y="741"/>
                  </a:lnTo>
                  <a:lnTo>
                    <a:pt x="1367" y="741"/>
                  </a:lnTo>
                  <a:lnTo>
                    <a:pt x="1367" y="735"/>
                  </a:lnTo>
                  <a:close/>
                  <a:moveTo>
                    <a:pt x="1402" y="733"/>
                  </a:moveTo>
                  <a:lnTo>
                    <a:pt x="1414" y="733"/>
                  </a:lnTo>
                  <a:lnTo>
                    <a:pt x="1415" y="739"/>
                  </a:lnTo>
                  <a:lnTo>
                    <a:pt x="1403" y="739"/>
                  </a:lnTo>
                  <a:lnTo>
                    <a:pt x="1402" y="733"/>
                  </a:lnTo>
                  <a:close/>
                  <a:moveTo>
                    <a:pt x="1438" y="732"/>
                  </a:moveTo>
                  <a:lnTo>
                    <a:pt x="1450" y="731"/>
                  </a:lnTo>
                  <a:lnTo>
                    <a:pt x="1451" y="737"/>
                  </a:lnTo>
                  <a:lnTo>
                    <a:pt x="1439" y="738"/>
                  </a:lnTo>
                  <a:lnTo>
                    <a:pt x="1438" y="732"/>
                  </a:lnTo>
                  <a:close/>
                  <a:moveTo>
                    <a:pt x="1474" y="728"/>
                  </a:moveTo>
                  <a:lnTo>
                    <a:pt x="1486" y="727"/>
                  </a:lnTo>
                  <a:lnTo>
                    <a:pt x="1487" y="733"/>
                  </a:lnTo>
                  <a:lnTo>
                    <a:pt x="1475" y="734"/>
                  </a:lnTo>
                  <a:lnTo>
                    <a:pt x="1474" y="728"/>
                  </a:lnTo>
                  <a:close/>
                  <a:moveTo>
                    <a:pt x="1509" y="724"/>
                  </a:moveTo>
                  <a:lnTo>
                    <a:pt x="1521" y="721"/>
                  </a:lnTo>
                  <a:lnTo>
                    <a:pt x="1522" y="727"/>
                  </a:lnTo>
                  <a:lnTo>
                    <a:pt x="1511" y="730"/>
                  </a:lnTo>
                  <a:lnTo>
                    <a:pt x="1509" y="724"/>
                  </a:lnTo>
                  <a:close/>
                  <a:moveTo>
                    <a:pt x="1545" y="717"/>
                  </a:moveTo>
                  <a:lnTo>
                    <a:pt x="1557" y="715"/>
                  </a:lnTo>
                  <a:lnTo>
                    <a:pt x="1557" y="721"/>
                  </a:lnTo>
                  <a:lnTo>
                    <a:pt x="1546" y="723"/>
                  </a:lnTo>
                  <a:lnTo>
                    <a:pt x="1545" y="717"/>
                  </a:lnTo>
                  <a:close/>
                  <a:moveTo>
                    <a:pt x="1580" y="709"/>
                  </a:moveTo>
                  <a:lnTo>
                    <a:pt x="1591" y="706"/>
                  </a:lnTo>
                  <a:lnTo>
                    <a:pt x="1593" y="712"/>
                  </a:lnTo>
                  <a:lnTo>
                    <a:pt x="1581" y="715"/>
                  </a:lnTo>
                  <a:lnTo>
                    <a:pt x="1580" y="709"/>
                  </a:lnTo>
                  <a:close/>
                  <a:moveTo>
                    <a:pt x="1614" y="699"/>
                  </a:moveTo>
                  <a:lnTo>
                    <a:pt x="1626" y="696"/>
                  </a:lnTo>
                  <a:lnTo>
                    <a:pt x="1627" y="702"/>
                  </a:lnTo>
                  <a:lnTo>
                    <a:pt x="1616" y="705"/>
                  </a:lnTo>
                  <a:lnTo>
                    <a:pt x="1614" y="699"/>
                  </a:lnTo>
                  <a:close/>
                  <a:moveTo>
                    <a:pt x="1648" y="688"/>
                  </a:moveTo>
                  <a:lnTo>
                    <a:pt x="1659" y="684"/>
                  </a:lnTo>
                  <a:lnTo>
                    <a:pt x="1661" y="689"/>
                  </a:lnTo>
                  <a:lnTo>
                    <a:pt x="1650" y="693"/>
                  </a:lnTo>
                  <a:lnTo>
                    <a:pt x="1648" y="688"/>
                  </a:lnTo>
                  <a:close/>
                  <a:moveTo>
                    <a:pt x="1682" y="675"/>
                  </a:moveTo>
                  <a:lnTo>
                    <a:pt x="1692" y="670"/>
                  </a:lnTo>
                  <a:lnTo>
                    <a:pt x="1695" y="676"/>
                  </a:lnTo>
                  <a:lnTo>
                    <a:pt x="1683" y="680"/>
                  </a:lnTo>
                  <a:lnTo>
                    <a:pt x="1682" y="675"/>
                  </a:lnTo>
                  <a:close/>
                  <a:moveTo>
                    <a:pt x="1714" y="660"/>
                  </a:moveTo>
                  <a:lnTo>
                    <a:pt x="1724" y="654"/>
                  </a:lnTo>
                  <a:lnTo>
                    <a:pt x="1727" y="660"/>
                  </a:lnTo>
                  <a:lnTo>
                    <a:pt x="1716" y="665"/>
                  </a:lnTo>
                  <a:lnTo>
                    <a:pt x="1714" y="660"/>
                  </a:lnTo>
                  <a:close/>
                  <a:moveTo>
                    <a:pt x="1746" y="643"/>
                  </a:moveTo>
                  <a:lnTo>
                    <a:pt x="1757" y="638"/>
                  </a:lnTo>
                  <a:lnTo>
                    <a:pt x="1759" y="643"/>
                  </a:lnTo>
                  <a:lnTo>
                    <a:pt x="1749" y="649"/>
                  </a:lnTo>
                  <a:lnTo>
                    <a:pt x="1746" y="643"/>
                  </a:lnTo>
                  <a:close/>
                  <a:moveTo>
                    <a:pt x="1776" y="625"/>
                  </a:moveTo>
                  <a:lnTo>
                    <a:pt x="1787" y="619"/>
                  </a:lnTo>
                  <a:lnTo>
                    <a:pt x="1790" y="624"/>
                  </a:lnTo>
                  <a:lnTo>
                    <a:pt x="1780" y="630"/>
                  </a:lnTo>
                  <a:lnTo>
                    <a:pt x="1776" y="625"/>
                  </a:lnTo>
                  <a:close/>
                  <a:moveTo>
                    <a:pt x="1807" y="606"/>
                  </a:moveTo>
                  <a:lnTo>
                    <a:pt x="1817" y="600"/>
                  </a:lnTo>
                  <a:lnTo>
                    <a:pt x="1820" y="604"/>
                  </a:lnTo>
                  <a:lnTo>
                    <a:pt x="1810" y="611"/>
                  </a:lnTo>
                  <a:lnTo>
                    <a:pt x="1807" y="606"/>
                  </a:lnTo>
                  <a:close/>
                  <a:moveTo>
                    <a:pt x="1836" y="585"/>
                  </a:moveTo>
                  <a:lnTo>
                    <a:pt x="1845" y="578"/>
                  </a:lnTo>
                  <a:lnTo>
                    <a:pt x="1849" y="583"/>
                  </a:lnTo>
                  <a:lnTo>
                    <a:pt x="1840" y="590"/>
                  </a:lnTo>
                  <a:lnTo>
                    <a:pt x="1836" y="585"/>
                  </a:lnTo>
                  <a:close/>
                  <a:moveTo>
                    <a:pt x="1865" y="563"/>
                  </a:moveTo>
                  <a:lnTo>
                    <a:pt x="1874" y="556"/>
                  </a:lnTo>
                  <a:lnTo>
                    <a:pt x="1878" y="561"/>
                  </a:lnTo>
                  <a:lnTo>
                    <a:pt x="1868" y="568"/>
                  </a:lnTo>
                  <a:lnTo>
                    <a:pt x="1865" y="563"/>
                  </a:lnTo>
                  <a:close/>
                  <a:moveTo>
                    <a:pt x="1892" y="541"/>
                  </a:moveTo>
                  <a:lnTo>
                    <a:pt x="1901" y="533"/>
                  </a:lnTo>
                  <a:lnTo>
                    <a:pt x="1905" y="537"/>
                  </a:lnTo>
                  <a:lnTo>
                    <a:pt x="1896" y="546"/>
                  </a:lnTo>
                  <a:lnTo>
                    <a:pt x="1892" y="541"/>
                  </a:lnTo>
                  <a:close/>
                  <a:moveTo>
                    <a:pt x="1919" y="517"/>
                  </a:moveTo>
                  <a:lnTo>
                    <a:pt x="1928" y="509"/>
                  </a:lnTo>
                  <a:lnTo>
                    <a:pt x="1932" y="513"/>
                  </a:lnTo>
                  <a:lnTo>
                    <a:pt x="1923" y="521"/>
                  </a:lnTo>
                  <a:lnTo>
                    <a:pt x="1919" y="517"/>
                  </a:lnTo>
                  <a:close/>
                  <a:moveTo>
                    <a:pt x="1946" y="493"/>
                  </a:moveTo>
                  <a:lnTo>
                    <a:pt x="1954" y="486"/>
                  </a:lnTo>
                  <a:lnTo>
                    <a:pt x="1953" y="486"/>
                  </a:lnTo>
                  <a:lnTo>
                    <a:pt x="1955" y="485"/>
                  </a:lnTo>
                  <a:lnTo>
                    <a:pt x="1959" y="489"/>
                  </a:lnTo>
                  <a:lnTo>
                    <a:pt x="1958" y="490"/>
                  </a:lnTo>
                  <a:lnTo>
                    <a:pt x="1950" y="497"/>
                  </a:lnTo>
                  <a:lnTo>
                    <a:pt x="1946" y="493"/>
                  </a:lnTo>
                  <a:close/>
                  <a:moveTo>
                    <a:pt x="1971" y="468"/>
                  </a:moveTo>
                  <a:lnTo>
                    <a:pt x="1980" y="459"/>
                  </a:lnTo>
                  <a:lnTo>
                    <a:pt x="1984" y="463"/>
                  </a:lnTo>
                  <a:lnTo>
                    <a:pt x="1976" y="472"/>
                  </a:lnTo>
                  <a:lnTo>
                    <a:pt x="1971" y="468"/>
                  </a:lnTo>
                  <a:close/>
                  <a:moveTo>
                    <a:pt x="1997" y="442"/>
                  </a:moveTo>
                  <a:lnTo>
                    <a:pt x="2005" y="433"/>
                  </a:lnTo>
                  <a:lnTo>
                    <a:pt x="2010" y="438"/>
                  </a:lnTo>
                  <a:lnTo>
                    <a:pt x="2001" y="446"/>
                  </a:lnTo>
                  <a:lnTo>
                    <a:pt x="1997" y="442"/>
                  </a:lnTo>
                  <a:close/>
                  <a:moveTo>
                    <a:pt x="2022" y="417"/>
                  </a:moveTo>
                  <a:lnTo>
                    <a:pt x="2030" y="408"/>
                  </a:lnTo>
                  <a:lnTo>
                    <a:pt x="2034" y="412"/>
                  </a:lnTo>
                  <a:lnTo>
                    <a:pt x="2027" y="421"/>
                  </a:lnTo>
                  <a:lnTo>
                    <a:pt x="2022" y="417"/>
                  </a:lnTo>
                  <a:close/>
                  <a:moveTo>
                    <a:pt x="2046" y="390"/>
                  </a:moveTo>
                  <a:lnTo>
                    <a:pt x="2054" y="381"/>
                  </a:lnTo>
                  <a:lnTo>
                    <a:pt x="2059" y="385"/>
                  </a:lnTo>
                  <a:lnTo>
                    <a:pt x="2051" y="394"/>
                  </a:lnTo>
                  <a:lnTo>
                    <a:pt x="2046" y="390"/>
                  </a:lnTo>
                  <a:close/>
                  <a:moveTo>
                    <a:pt x="2070" y="363"/>
                  </a:moveTo>
                  <a:lnTo>
                    <a:pt x="2079" y="355"/>
                  </a:lnTo>
                  <a:lnTo>
                    <a:pt x="2083" y="358"/>
                  </a:lnTo>
                  <a:lnTo>
                    <a:pt x="2075" y="367"/>
                  </a:lnTo>
                  <a:lnTo>
                    <a:pt x="2070" y="363"/>
                  </a:lnTo>
                  <a:close/>
                  <a:moveTo>
                    <a:pt x="2094" y="337"/>
                  </a:moveTo>
                  <a:lnTo>
                    <a:pt x="2102" y="327"/>
                  </a:lnTo>
                  <a:lnTo>
                    <a:pt x="2107" y="331"/>
                  </a:lnTo>
                  <a:lnTo>
                    <a:pt x="2099" y="340"/>
                  </a:lnTo>
                  <a:lnTo>
                    <a:pt x="2094" y="337"/>
                  </a:lnTo>
                  <a:close/>
                  <a:moveTo>
                    <a:pt x="2118" y="309"/>
                  </a:moveTo>
                  <a:lnTo>
                    <a:pt x="2126" y="300"/>
                  </a:lnTo>
                  <a:lnTo>
                    <a:pt x="2130" y="304"/>
                  </a:lnTo>
                  <a:lnTo>
                    <a:pt x="2123" y="313"/>
                  </a:lnTo>
                  <a:lnTo>
                    <a:pt x="2118" y="309"/>
                  </a:lnTo>
                  <a:close/>
                  <a:moveTo>
                    <a:pt x="2142" y="282"/>
                  </a:moveTo>
                  <a:lnTo>
                    <a:pt x="2149" y="274"/>
                  </a:lnTo>
                  <a:lnTo>
                    <a:pt x="2149" y="274"/>
                  </a:lnTo>
                  <a:lnTo>
                    <a:pt x="2150" y="273"/>
                  </a:lnTo>
                  <a:lnTo>
                    <a:pt x="2154" y="277"/>
                  </a:lnTo>
                  <a:lnTo>
                    <a:pt x="2153" y="277"/>
                  </a:lnTo>
                  <a:lnTo>
                    <a:pt x="2146" y="286"/>
                  </a:lnTo>
                  <a:lnTo>
                    <a:pt x="2142" y="282"/>
                  </a:lnTo>
                  <a:close/>
                  <a:moveTo>
                    <a:pt x="2165" y="255"/>
                  </a:moveTo>
                  <a:lnTo>
                    <a:pt x="2172" y="246"/>
                  </a:lnTo>
                  <a:lnTo>
                    <a:pt x="2177" y="249"/>
                  </a:lnTo>
                  <a:lnTo>
                    <a:pt x="2169" y="258"/>
                  </a:lnTo>
                  <a:lnTo>
                    <a:pt x="2165" y="255"/>
                  </a:lnTo>
                  <a:close/>
                  <a:moveTo>
                    <a:pt x="2188" y="227"/>
                  </a:moveTo>
                  <a:lnTo>
                    <a:pt x="2196" y="218"/>
                  </a:lnTo>
                  <a:lnTo>
                    <a:pt x="2200" y="222"/>
                  </a:lnTo>
                  <a:lnTo>
                    <a:pt x="2193" y="231"/>
                  </a:lnTo>
                  <a:lnTo>
                    <a:pt x="2188" y="227"/>
                  </a:lnTo>
                  <a:close/>
                  <a:moveTo>
                    <a:pt x="2211" y="199"/>
                  </a:moveTo>
                  <a:lnTo>
                    <a:pt x="2214" y="196"/>
                  </a:lnTo>
                  <a:lnTo>
                    <a:pt x="2219" y="190"/>
                  </a:lnTo>
                  <a:lnTo>
                    <a:pt x="2223" y="194"/>
                  </a:lnTo>
                  <a:lnTo>
                    <a:pt x="2219" y="200"/>
                  </a:lnTo>
                  <a:lnTo>
                    <a:pt x="2219" y="200"/>
                  </a:lnTo>
                  <a:lnTo>
                    <a:pt x="2216" y="203"/>
                  </a:lnTo>
                  <a:lnTo>
                    <a:pt x="2211" y="199"/>
                  </a:lnTo>
                  <a:close/>
                  <a:moveTo>
                    <a:pt x="2235" y="172"/>
                  </a:moveTo>
                  <a:lnTo>
                    <a:pt x="2243" y="163"/>
                  </a:lnTo>
                  <a:lnTo>
                    <a:pt x="2247" y="167"/>
                  </a:lnTo>
                  <a:lnTo>
                    <a:pt x="2239" y="176"/>
                  </a:lnTo>
                  <a:lnTo>
                    <a:pt x="2235" y="172"/>
                  </a:lnTo>
                  <a:close/>
                  <a:moveTo>
                    <a:pt x="2258" y="145"/>
                  </a:moveTo>
                  <a:lnTo>
                    <a:pt x="2266" y="136"/>
                  </a:lnTo>
                  <a:lnTo>
                    <a:pt x="2271" y="140"/>
                  </a:lnTo>
                  <a:lnTo>
                    <a:pt x="2263" y="149"/>
                  </a:lnTo>
                  <a:lnTo>
                    <a:pt x="2258" y="145"/>
                  </a:lnTo>
                  <a:close/>
                  <a:moveTo>
                    <a:pt x="2283" y="118"/>
                  </a:moveTo>
                  <a:lnTo>
                    <a:pt x="2291" y="110"/>
                  </a:lnTo>
                  <a:lnTo>
                    <a:pt x="2295" y="114"/>
                  </a:lnTo>
                  <a:lnTo>
                    <a:pt x="2287" y="123"/>
                  </a:lnTo>
                  <a:lnTo>
                    <a:pt x="2283" y="118"/>
                  </a:lnTo>
                  <a:close/>
                  <a:moveTo>
                    <a:pt x="2309" y="93"/>
                  </a:moveTo>
                  <a:lnTo>
                    <a:pt x="2317" y="85"/>
                  </a:lnTo>
                  <a:lnTo>
                    <a:pt x="2321" y="89"/>
                  </a:lnTo>
                  <a:lnTo>
                    <a:pt x="2313" y="97"/>
                  </a:lnTo>
                  <a:lnTo>
                    <a:pt x="2309" y="93"/>
                  </a:lnTo>
                  <a:close/>
                  <a:moveTo>
                    <a:pt x="2334" y="68"/>
                  </a:moveTo>
                  <a:lnTo>
                    <a:pt x="2343" y="60"/>
                  </a:lnTo>
                  <a:lnTo>
                    <a:pt x="2348" y="64"/>
                  </a:lnTo>
                  <a:lnTo>
                    <a:pt x="2339" y="73"/>
                  </a:lnTo>
                  <a:lnTo>
                    <a:pt x="2334" y="68"/>
                  </a:lnTo>
                  <a:close/>
                  <a:moveTo>
                    <a:pt x="2364" y="46"/>
                  </a:moveTo>
                  <a:lnTo>
                    <a:pt x="2374" y="40"/>
                  </a:lnTo>
                  <a:lnTo>
                    <a:pt x="2377" y="45"/>
                  </a:lnTo>
                  <a:lnTo>
                    <a:pt x="2367" y="51"/>
                  </a:lnTo>
                  <a:lnTo>
                    <a:pt x="2364" y="46"/>
                  </a:lnTo>
                  <a:close/>
                  <a:moveTo>
                    <a:pt x="2394" y="27"/>
                  </a:moveTo>
                  <a:lnTo>
                    <a:pt x="2404" y="20"/>
                  </a:lnTo>
                  <a:lnTo>
                    <a:pt x="2407" y="25"/>
                  </a:lnTo>
                  <a:lnTo>
                    <a:pt x="2397" y="32"/>
                  </a:lnTo>
                  <a:lnTo>
                    <a:pt x="2394" y="27"/>
                  </a:lnTo>
                  <a:close/>
                  <a:moveTo>
                    <a:pt x="2427" y="12"/>
                  </a:moveTo>
                  <a:lnTo>
                    <a:pt x="2439" y="9"/>
                  </a:lnTo>
                  <a:lnTo>
                    <a:pt x="2440" y="15"/>
                  </a:lnTo>
                  <a:lnTo>
                    <a:pt x="2429" y="18"/>
                  </a:lnTo>
                  <a:lnTo>
                    <a:pt x="2427" y="12"/>
                  </a:lnTo>
                  <a:close/>
                  <a:moveTo>
                    <a:pt x="2462" y="3"/>
                  </a:moveTo>
                  <a:lnTo>
                    <a:pt x="2474" y="0"/>
                  </a:lnTo>
                  <a:lnTo>
                    <a:pt x="2475" y="6"/>
                  </a:lnTo>
                  <a:lnTo>
                    <a:pt x="2463" y="9"/>
                  </a:lnTo>
                  <a:lnTo>
                    <a:pt x="2462" y="3"/>
                  </a:lnTo>
                  <a:close/>
                  <a:moveTo>
                    <a:pt x="2499" y="2"/>
                  </a:moveTo>
                  <a:lnTo>
                    <a:pt x="2510" y="3"/>
                  </a:lnTo>
                  <a:lnTo>
                    <a:pt x="2510" y="9"/>
                  </a:lnTo>
                  <a:lnTo>
                    <a:pt x="2498" y="8"/>
                  </a:lnTo>
                  <a:lnTo>
                    <a:pt x="2499" y="2"/>
                  </a:lnTo>
                  <a:close/>
                  <a:moveTo>
                    <a:pt x="2534" y="6"/>
                  </a:moveTo>
                  <a:lnTo>
                    <a:pt x="2543" y="7"/>
                  </a:lnTo>
                  <a:lnTo>
                    <a:pt x="2547" y="8"/>
                  </a:lnTo>
                  <a:lnTo>
                    <a:pt x="2544" y="14"/>
                  </a:lnTo>
                  <a:lnTo>
                    <a:pt x="2541" y="12"/>
                  </a:lnTo>
                  <a:lnTo>
                    <a:pt x="2542" y="12"/>
                  </a:lnTo>
                  <a:lnTo>
                    <a:pt x="2534" y="12"/>
                  </a:lnTo>
                  <a:lnTo>
                    <a:pt x="2534" y="6"/>
                  </a:lnTo>
                  <a:close/>
                  <a:moveTo>
                    <a:pt x="2569" y="17"/>
                  </a:moveTo>
                  <a:lnTo>
                    <a:pt x="2580" y="22"/>
                  </a:lnTo>
                  <a:lnTo>
                    <a:pt x="2578" y="27"/>
                  </a:lnTo>
                  <a:lnTo>
                    <a:pt x="2567" y="23"/>
                  </a:lnTo>
                  <a:lnTo>
                    <a:pt x="2569" y="17"/>
                  </a:lnTo>
                  <a:close/>
                  <a:moveTo>
                    <a:pt x="2603" y="31"/>
                  </a:moveTo>
                  <a:lnTo>
                    <a:pt x="2609" y="33"/>
                  </a:lnTo>
                  <a:lnTo>
                    <a:pt x="2613" y="36"/>
                  </a:lnTo>
                  <a:lnTo>
                    <a:pt x="2610" y="41"/>
                  </a:lnTo>
                  <a:lnTo>
                    <a:pt x="2606" y="38"/>
                  </a:lnTo>
                  <a:lnTo>
                    <a:pt x="2606" y="39"/>
                  </a:lnTo>
                  <a:lnTo>
                    <a:pt x="2600" y="36"/>
                  </a:lnTo>
                  <a:lnTo>
                    <a:pt x="2603" y="31"/>
                  </a:lnTo>
                  <a:close/>
                  <a:moveTo>
                    <a:pt x="2634" y="49"/>
                  </a:moveTo>
                  <a:lnTo>
                    <a:pt x="2644" y="56"/>
                  </a:lnTo>
                  <a:lnTo>
                    <a:pt x="2641" y="61"/>
                  </a:lnTo>
                  <a:lnTo>
                    <a:pt x="2631" y="54"/>
                  </a:lnTo>
                  <a:lnTo>
                    <a:pt x="2634" y="49"/>
                  </a:lnTo>
                  <a:close/>
                  <a:moveTo>
                    <a:pt x="2664" y="69"/>
                  </a:moveTo>
                  <a:lnTo>
                    <a:pt x="2674" y="75"/>
                  </a:lnTo>
                  <a:lnTo>
                    <a:pt x="2671" y="80"/>
                  </a:lnTo>
                  <a:lnTo>
                    <a:pt x="2661" y="74"/>
                  </a:lnTo>
                  <a:lnTo>
                    <a:pt x="2664" y="69"/>
                  </a:lnTo>
                  <a:close/>
                  <a:moveTo>
                    <a:pt x="2693" y="91"/>
                  </a:moveTo>
                  <a:lnTo>
                    <a:pt x="2702" y="98"/>
                  </a:lnTo>
                  <a:lnTo>
                    <a:pt x="2699" y="103"/>
                  </a:lnTo>
                  <a:lnTo>
                    <a:pt x="2689" y="95"/>
                  </a:lnTo>
                  <a:lnTo>
                    <a:pt x="2693" y="91"/>
                  </a:lnTo>
                  <a:close/>
                  <a:moveTo>
                    <a:pt x="2721" y="114"/>
                  </a:moveTo>
                  <a:lnTo>
                    <a:pt x="2730" y="121"/>
                  </a:lnTo>
                  <a:lnTo>
                    <a:pt x="2726" y="126"/>
                  </a:lnTo>
                  <a:lnTo>
                    <a:pt x="2717" y="118"/>
                  </a:lnTo>
                  <a:lnTo>
                    <a:pt x="2721" y="114"/>
                  </a:lnTo>
                  <a:close/>
                  <a:moveTo>
                    <a:pt x="2748" y="137"/>
                  </a:moveTo>
                  <a:lnTo>
                    <a:pt x="2757" y="145"/>
                  </a:lnTo>
                  <a:lnTo>
                    <a:pt x="2753" y="150"/>
                  </a:lnTo>
                  <a:lnTo>
                    <a:pt x="2744" y="141"/>
                  </a:lnTo>
                  <a:lnTo>
                    <a:pt x="2748" y="137"/>
                  </a:lnTo>
                  <a:close/>
                  <a:moveTo>
                    <a:pt x="2775" y="162"/>
                  </a:moveTo>
                  <a:lnTo>
                    <a:pt x="2783" y="170"/>
                  </a:lnTo>
                  <a:lnTo>
                    <a:pt x="2779" y="174"/>
                  </a:lnTo>
                  <a:lnTo>
                    <a:pt x="2771" y="166"/>
                  </a:lnTo>
                  <a:lnTo>
                    <a:pt x="2775" y="162"/>
                  </a:lnTo>
                  <a:close/>
                  <a:moveTo>
                    <a:pt x="2801" y="186"/>
                  </a:moveTo>
                  <a:lnTo>
                    <a:pt x="2805" y="190"/>
                  </a:lnTo>
                  <a:lnTo>
                    <a:pt x="2806" y="192"/>
                  </a:lnTo>
                  <a:lnTo>
                    <a:pt x="2802" y="196"/>
                  </a:lnTo>
                  <a:lnTo>
                    <a:pt x="2801" y="195"/>
                  </a:lnTo>
                  <a:lnTo>
                    <a:pt x="2801" y="195"/>
                  </a:lnTo>
                  <a:lnTo>
                    <a:pt x="2797" y="191"/>
                  </a:lnTo>
                  <a:lnTo>
                    <a:pt x="2801" y="186"/>
                  </a:lnTo>
                  <a:close/>
                </a:path>
              </a:pathLst>
            </a:custGeom>
            <a:solidFill>
              <a:srgbClr val="000000"/>
            </a:solidFill>
            <a:ln w="6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" name="Freeform 70"/>
            <p:cNvSpPr>
              <a:spLocks noEditPoints="1"/>
            </p:cNvSpPr>
            <p:nvPr/>
          </p:nvSpPr>
          <p:spPr bwMode="auto">
            <a:xfrm>
              <a:off x="2428876" y="1658225"/>
              <a:ext cx="3640138" cy="3021013"/>
            </a:xfrm>
            <a:custGeom>
              <a:avLst/>
              <a:gdLst>
                <a:gd name="T0" fmla="*/ 32 w 2293"/>
                <a:gd name="T1" fmla="*/ 1205 h 1903"/>
                <a:gd name="T2" fmla="*/ 107 w 2293"/>
                <a:gd name="T3" fmla="*/ 1167 h 1903"/>
                <a:gd name="T4" fmla="*/ 131 w 2293"/>
                <a:gd name="T5" fmla="*/ 1161 h 1903"/>
                <a:gd name="T6" fmla="*/ 206 w 2293"/>
                <a:gd name="T7" fmla="*/ 1123 h 1903"/>
                <a:gd name="T8" fmla="*/ 257 w 2293"/>
                <a:gd name="T9" fmla="*/ 1092 h 1903"/>
                <a:gd name="T10" fmla="*/ 303 w 2293"/>
                <a:gd name="T11" fmla="*/ 1076 h 1903"/>
                <a:gd name="T12" fmla="*/ 322 w 2293"/>
                <a:gd name="T13" fmla="*/ 1060 h 1903"/>
                <a:gd name="T14" fmla="*/ 394 w 2293"/>
                <a:gd name="T15" fmla="*/ 1035 h 1903"/>
                <a:gd name="T16" fmla="*/ 457 w 2293"/>
                <a:gd name="T17" fmla="*/ 1001 h 1903"/>
                <a:gd name="T18" fmla="*/ 490 w 2293"/>
                <a:gd name="T19" fmla="*/ 994 h 1903"/>
                <a:gd name="T20" fmla="*/ 555 w 2293"/>
                <a:gd name="T21" fmla="*/ 963 h 1903"/>
                <a:gd name="T22" fmla="*/ 623 w 2293"/>
                <a:gd name="T23" fmla="*/ 939 h 1903"/>
                <a:gd name="T24" fmla="*/ 692 w 2293"/>
                <a:gd name="T25" fmla="*/ 918 h 1903"/>
                <a:gd name="T26" fmla="*/ 763 w 2293"/>
                <a:gd name="T27" fmla="*/ 906 h 1903"/>
                <a:gd name="T28" fmla="*/ 834 w 2293"/>
                <a:gd name="T29" fmla="*/ 920 h 1903"/>
                <a:gd name="T30" fmla="*/ 889 w 2293"/>
                <a:gd name="T31" fmla="*/ 965 h 1903"/>
                <a:gd name="T32" fmla="*/ 912 w 2293"/>
                <a:gd name="T33" fmla="*/ 996 h 1903"/>
                <a:gd name="T34" fmla="*/ 954 w 2293"/>
                <a:gd name="T35" fmla="*/ 1066 h 1903"/>
                <a:gd name="T36" fmla="*/ 990 w 2293"/>
                <a:gd name="T37" fmla="*/ 1128 h 1903"/>
                <a:gd name="T38" fmla="*/ 1021 w 2293"/>
                <a:gd name="T39" fmla="*/ 1193 h 1903"/>
                <a:gd name="T40" fmla="*/ 1052 w 2293"/>
                <a:gd name="T41" fmla="*/ 1258 h 1903"/>
                <a:gd name="T42" fmla="*/ 1081 w 2293"/>
                <a:gd name="T43" fmla="*/ 1323 h 1903"/>
                <a:gd name="T44" fmla="*/ 1112 w 2293"/>
                <a:gd name="T45" fmla="*/ 1378 h 1903"/>
                <a:gd name="T46" fmla="*/ 1126 w 2293"/>
                <a:gd name="T47" fmla="*/ 1408 h 1903"/>
                <a:gd name="T48" fmla="*/ 1156 w 2293"/>
                <a:gd name="T49" fmla="*/ 1474 h 1903"/>
                <a:gd name="T50" fmla="*/ 1186 w 2293"/>
                <a:gd name="T51" fmla="*/ 1539 h 1903"/>
                <a:gd name="T52" fmla="*/ 1218 w 2293"/>
                <a:gd name="T53" fmla="*/ 1604 h 1903"/>
                <a:gd name="T54" fmla="*/ 1251 w 2293"/>
                <a:gd name="T55" fmla="*/ 1668 h 1903"/>
                <a:gd name="T56" fmla="*/ 1288 w 2293"/>
                <a:gd name="T57" fmla="*/ 1729 h 1903"/>
                <a:gd name="T58" fmla="*/ 1336 w 2293"/>
                <a:gd name="T59" fmla="*/ 1797 h 1903"/>
                <a:gd name="T60" fmla="*/ 1384 w 2293"/>
                <a:gd name="T61" fmla="*/ 1849 h 1903"/>
                <a:gd name="T62" fmla="*/ 1437 w 2293"/>
                <a:gd name="T63" fmla="*/ 1887 h 1903"/>
                <a:gd name="T64" fmla="*/ 1465 w 2293"/>
                <a:gd name="T65" fmla="*/ 1897 h 1903"/>
                <a:gd name="T66" fmla="*/ 1536 w 2293"/>
                <a:gd name="T67" fmla="*/ 1891 h 1903"/>
                <a:gd name="T68" fmla="*/ 1597 w 2293"/>
                <a:gd name="T69" fmla="*/ 1852 h 1903"/>
                <a:gd name="T70" fmla="*/ 1647 w 2293"/>
                <a:gd name="T71" fmla="*/ 1800 h 1903"/>
                <a:gd name="T72" fmla="*/ 1689 w 2293"/>
                <a:gd name="T73" fmla="*/ 1741 h 1903"/>
                <a:gd name="T74" fmla="*/ 1725 w 2293"/>
                <a:gd name="T75" fmla="*/ 1679 h 1903"/>
                <a:gd name="T76" fmla="*/ 1761 w 2293"/>
                <a:gd name="T77" fmla="*/ 1603 h 1903"/>
                <a:gd name="T78" fmla="*/ 1786 w 2293"/>
                <a:gd name="T79" fmla="*/ 1549 h 1903"/>
                <a:gd name="T80" fmla="*/ 1817 w 2293"/>
                <a:gd name="T81" fmla="*/ 1484 h 1903"/>
                <a:gd name="T82" fmla="*/ 1846 w 2293"/>
                <a:gd name="T83" fmla="*/ 1418 h 1903"/>
                <a:gd name="T84" fmla="*/ 1874 w 2293"/>
                <a:gd name="T85" fmla="*/ 1352 h 1903"/>
                <a:gd name="T86" fmla="*/ 1894 w 2293"/>
                <a:gd name="T87" fmla="*/ 1320 h 1903"/>
                <a:gd name="T88" fmla="*/ 1924 w 2293"/>
                <a:gd name="T89" fmla="*/ 1243 h 1903"/>
                <a:gd name="T90" fmla="*/ 1951 w 2293"/>
                <a:gd name="T91" fmla="*/ 1176 h 1903"/>
                <a:gd name="T92" fmla="*/ 1976 w 2293"/>
                <a:gd name="T93" fmla="*/ 1108 h 1903"/>
                <a:gd name="T94" fmla="*/ 2000 w 2293"/>
                <a:gd name="T95" fmla="*/ 1040 h 1903"/>
                <a:gd name="T96" fmla="*/ 2024 w 2293"/>
                <a:gd name="T97" fmla="*/ 972 h 1903"/>
                <a:gd name="T98" fmla="*/ 2046 w 2293"/>
                <a:gd name="T99" fmla="*/ 904 h 1903"/>
                <a:gd name="T100" fmla="*/ 2069 w 2293"/>
                <a:gd name="T101" fmla="*/ 835 h 1903"/>
                <a:gd name="T102" fmla="*/ 2084 w 2293"/>
                <a:gd name="T103" fmla="*/ 769 h 1903"/>
                <a:gd name="T104" fmla="*/ 2092 w 2293"/>
                <a:gd name="T105" fmla="*/ 742 h 1903"/>
                <a:gd name="T106" fmla="*/ 2113 w 2293"/>
                <a:gd name="T107" fmla="*/ 673 h 1903"/>
                <a:gd name="T108" fmla="*/ 2133 w 2293"/>
                <a:gd name="T109" fmla="*/ 604 h 1903"/>
                <a:gd name="T110" fmla="*/ 2153 w 2293"/>
                <a:gd name="T111" fmla="*/ 535 h 1903"/>
                <a:gd name="T112" fmla="*/ 2172 w 2293"/>
                <a:gd name="T113" fmla="*/ 466 h 1903"/>
                <a:gd name="T114" fmla="*/ 2191 w 2293"/>
                <a:gd name="T115" fmla="*/ 396 h 1903"/>
                <a:gd name="T116" fmla="*/ 2210 w 2293"/>
                <a:gd name="T117" fmla="*/ 327 h 1903"/>
                <a:gd name="T118" fmla="*/ 2227 w 2293"/>
                <a:gd name="T119" fmla="*/ 257 h 1903"/>
                <a:gd name="T120" fmla="*/ 2244 w 2293"/>
                <a:gd name="T121" fmla="*/ 187 h 1903"/>
                <a:gd name="T122" fmla="*/ 2261 w 2293"/>
                <a:gd name="T123" fmla="*/ 117 h 1903"/>
                <a:gd name="T124" fmla="*/ 2286 w 2293"/>
                <a:gd name="T125" fmla="*/ 36 h 19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  <a:cxn ang="0">
                  <a:pos x="T124" y="T125"/>
                </a:cxn>
              </a:cxnLst>
              <a:rect l="0" t="0" r="r" b="b"/>
              <a:pathLst>
                <a:path w="2293" h="1903">
                  <a:moveTo>
                    <a:pt x="0" y="1222"/>
                  </a:moveTo>
                  <a:lnTo>
                    <a:pt x="11" y="1216"/>
                  </a:lnTo>
                  <a:lnTo>
                    <a:pt x="13" y="1222"/>
                  </a:lnTo>
                  <a:lnTo>
                    <a:pt x="3" y="1227"/>
                  </a:lnTo>
                  <a:lnTo>
                    <a:pt x="0" y="1222"/>
                  </a:lnTo>
                  <a:close/>
                  <a:moveTo>
                    <a:pt x="32" y="1205"/>
                  </a:moveTo>
                  <a:lnTo>
                    <a:pt x="43" y="1200"/>
                  </a:lnTo>
                  <a:lnTo>
                    <a:pt x="45" y="1205"/>
                  </a:lnTo>
                  <a:lnTo>
                    <a:pt x="35" y="1210"/>
                  </a:lnTo>
                  <a:lnTo>
                    <a:pt x="32" y="1205"/>
                  </a:lnTo>
                  <a:close/>
                  <a:moveTo>
                    <a:pt x="64" y="1189"/>
                  </a:moveTo>
                  <a:lnTo>
                    <a:pt x="65" y="1188"/>
                  </a:lnTo>
                  <a:lnTo>
                    <a:pt x="75" y="1183"/>
                  </a:lnTo>
                  <a:lnTo>
                    <a:pt x="78" y="1188"/>
                  </a:lnTo>
                  <a:lnTo>
                    <a:pt x="68" y="1193"/>
                  </a:lnTo>
                  <a:lnTo>
                    <a:pt x="68" y="1193"/>
                  </a:lnTo>
                  <a:lnTo>
                    <a:pt x="67" y="1194"/>
                  </a:lnTo>
                  <a:lnTo>
                    <a:pt x="64" y="1189"/>
                  </a:lnTo>
                  <a:close/>
                  <a:moveTo>
                    <a:pt x="96" y="1172"/>
                  </a:moveTo>
                  <a:lnTo>
                    <a:pt x="107" y="1167"/>
                  </a:lnTo>
                  <a:lnTo>
                    <a:pt x="109" y="1172"/>
                  </a:lnTo>
                  <a:lnTo>
                    <a:pt x="99" y="1177"/>
                  </a:lnTo>
                  <a:lnTo>
                    <a:pt x="96" y="1172"/>
                  </a:lnTo>
                  <a:close/>
                  <a:moveTo>
                    <a:pt x="128" y="1156"/>
                  </a:moveTo>
                  <a:lnTo>
                    <a:pt x="130" y="1155"/>
                  </a:lnTo>
                  <a:lnTo>
                    <a:pt x="139" y="1150"/>
                  </a:lnTo>
                  <a:lnTo>
                    <a:pt x="142" y="1156"/>
                  </a:lnTo>
                  <a:lnTo>
                    <a:pt x="133" y="1160"/>
                  </a:lnTo>
                  <a:lnTo>
                    <a:pt x="133" y="1160"/>
                  </a:lnTo>
                  <a:lnTo>
                    <a:pt x="131" y="1161"/>
                  </a:lnTo>
                  <a:lnTo>
                    <a:pt x="128" y="1156"/>
                  </a:lnTo>
                  <a:close/>
                  <a:moveTo>
                    <a:pt x="160" y="1140"/>
                  </a:moveTo>
                  <a:lnTo>
                    <a:pt x="171" y="1134"/>
                  </a:lnTo>
                  <a:lnTo>
                    <a:pt x="174" y="1140"/>
                  </a:lnTo>
                  <a:lnTo>
                    <a:pt x="163" y="1145"/>
                  </a:lnTo>
                  <a:lnTo>
                    <a:pt x="160" y="1140"/>
                  </a:lnTo>
                  <a:close/>
                  <a:moveTo>
                    <a:pt x="192" y="1123"/>
                  </a:moveTo>
                  <a:lnTo>
                    <a:pt x="196" y="1122"/>
                  </a:lnTo>
                  <a:lnTo>
                    <a:pt x="203" y="1118"/>
                  </a:lnTo>
                  <a:lnTo>
                    <a:pt x="206" y="1123"/>
                  </a:lnTo>
                  <a:lnTo>
                    <a:pt x="198" y="1127"/>
                  </a:lnTo>
                  <a:lnTo>
                    <a:pt x="198" y="1127"/>
                  </a:lnTo>
                  <a:lnTo>
                    <a:pt x="195" y="1129"/>
                  </a:lnTo>
                  <a:lnTo>
                    <a:pt x="192" y="1123"/>
                  </a:lnTo>
                  <a:close/>
                  <a:moveTo>
                    <a:pt x="225" y="1107"/>
                  </a:moveTo>
                  <a:lnTo>
                    <a:pt x="235" y="1102"/>
                  </a:lnTo>
                  <a:lnTo>
                    <a:pt x="238" y="1107"/>
                  </a:lnTo>
                  <a:lnTo>
                    <a:pt x="228" y="1113"/>
                  </a:lnTo>
                  <a:lnTo>
                    <a:pt x="225" y="1107"/>
                  </a:lnTo>
                  <a:close/>
                  <a:moveTo>
                    <a:pt x="257" y="1092"/>
                  </a:moveTo>
                  <a:lnTo>
                    <a:pt x="261" y="1090"/>
                  </a:lnTo>
                  <a:lnTo>
                    <a:pt x="268" y="1086"/>
                  </a:lnTo>
                  <a:lnTo>
                    <a:pt x="270" y="1092"/>
                  </a:lnTo>
                  <a:lnTo>
                    <a:pt x="264" y="1095"/>
                  </a:lnTo>
                  <a:lnTo>
                    <a:pt x="264" y="1095"/>
                  </a:lnTo>
                  <a:lnTo>
                    <a:pt x="260" y="1097"/>
                  </a:lnTo>
                  <a:lnTo>
                    <a:pt x="257" y="1092"/>
                  </a:lnTo>
                  <a:close/>
                  <a:moveTo>
                    <a:pt x="289" y="1076"/>
                  </a:moveTo>
                  <a:lnTo>
                    <a:pt x="300" y="1071"/>
                  </a:lnTo>
                  <a:lnTo>
                    <a:pt x="303" y="1076"/>
                  </a:lnTo>
                  <a:lnTo>
                    <a:pt x="292" y="1081"/>
                  </a:lnTo>
                  <a:lnTo>
                    <a:pt x="289" y="1076"/>
                  </a:lnTo>
                  <a:close/>
                  <a:moveTo>
                    <a:pt x="322" y="1060"/>
                  </a:moveTo>
                  <a:lnTo>
                    <a:pt x="326" y="1059"/>
                  </a:lnTo>
                  <a:lnTo>
                    <a:pt x="333" y="1056"/>
                  </a:lnTo>
                  <a:lnTo>
                    <a:pt x="336" y="1061"/>
                  </a:lnTo>
                  <a:lnTo>
                    <a:pt x="328" y="1064"/>
                  </a:lnTo>
                  <a:lnTo>
                    <a:pt x="329" y="1064"/>
                  </a:lnTo>
                  <a:lnTo>
                    <a:pt x="325" y="1066"/>
                  </a:lnTo>
                  <a:lnTo>
                    <a:pt x="322" y="1060"/>
                  </a:lnTo>
                  <a:close/>
                  <a:moveTo>
                    <a:pt x="355" y="1045"/>
                  </a:moveTo>
                  <a:lnTo>
                    <a:pt x="366" y="1041"/>
                  </a:lnTo>
                  <a:lnTo>
                    <a:pt x="368" y="1046"/>
                  </a:lnTo>
                  <a:lnTo>
                    <a:pt x="357" y="1051"/>
                  </a:lnTo>
                  <a:lnTo>
                    <a:pt x="355" y="1045"/>
                  </a:lnTo>
                  <a:close/>
                  <a:moveTo>
                    <a:pt x="388" y="1031"/>
                  </a:moveTo>
                  <a:lnTo>
                    <a:pt x="391" y="1029"/>
                  </a:lnTo>
                  <a:lnTo>
                    <a:pt x="399" y="1026"/>
                  </a:lnTo>
                  <a:lnTo>
                    <a:pt x="401" y="1031"/>
                  </a:lnTo>
                  <a:lnTo>
                    <a:pt x="394" y="1035"/>
                  </a:lnTo>
                  <a:lnTo>
                    <a:pt x="394" y="1035"/>
                  </a:lnTo>
                  <a:lnTo>
                    <a:pt x="390" y="1036"/>
                  </a:lnTo>
                  <a:lnTo>
                    <a:pt x="388" y="1031"/>
                  </a:lnTo>
                  <a:close/>
                  <a:moveTo>
                    <a:pt x="421" y="1016"/>
                  </a:moveTo>
                  <a:lnTo>
                    <a:pt x="432" y="1012"/>
                  </a:lnTo>
                  <a:lnTo>
                    <a:pt x="434" y="1017"/>
                  </a:lnTo>
                  <a:lnTo>
                    <a:pt x="423" y="1022"/>
                  </a:lnTo>
                  <a:lnTo>
                    <a:pt x="421" y="1016"/>
                  </a:lnTo>
                  <a:close/>
                  <a:moveTo>
                    <a:pt x="454" y="1002"/>
                  </a:moveTo>
                  <a:lnTo>
                    <a:pt x="457" y="1001"/>
                  </a:lnTo>
                  <a:lnTo>
                    <a:pt x="465" y="997"/>
                  </a:lnTo>
                  <a:lnTo>
                    <a:pt x="467" y="1003"/>
                  </a:lnTo>
                  <a:lnTo>
                    <a:pt x="459" y="1006"/>
                  </a:lnTo>
                  <a:lnTo>
                    <a:pt x="459" y="1006"/>
                  </a:lnTo>
                  <a:lnTo>
                    <a:pt x="456" y="1008"/>
                  </a:lnTo>
                  <a:lnTo>
                    <a:pt x="454" y="1002"/>
                  </a:lnTo>
                  <a:close/>
                  <a:moveTo>
                    <a:pt x="487" y="989"/>
                  </a:moveTo>
                  <a:lnTo>
                    <a:pt x="498" y="984"/>
                  </a:lnTo>
                  <a:lnTo>
                    <a:pt x="501" y="990"/>
                  </a:lnTo>
                  <a:lnTo>
                    <a:pt x="490" y="994"/>
                  </a:lnTo>
                  <a:lnTo>
                    <a:pt x="487" y="989"/>
                  </a:lnTo>
                  <a:close/>
                  <a:moveTo>
                    <a:pt x="521" y="975"/>
                  </a:moveTo>
                  <a:lnTo>
                    <a:pt x="522" y="975"/>
                  </a:lnTo>
                  <a:lnTo>
                    <a:pt x="532" y="971"/>
                  </a:lnTo>
                  <a:lnTo>
                    <a:pt x="534" y="977"/>
                  </a:lnTo>
                  <a:lnTo>
                    <a:pt x="524" y="981"/>
                  </a:lnTo>
                  <a:lnTo>
                    <a:pt x="524" y="981"/>
                  </a:lnTo>
                  <a:lnTo>
                    <a:pt x="523" y="981"/>
                  </a:lnTo>
                  <a:lnTo>
                    <a:pt x="521" y="975"/>
                  </a:lnTo>
                  <a:close/>
                  <a:moveTo>
                    <a:pt x="555" y="963"/>
                  </a:moveTo>
                  <a:lnTo>
                    <a:pt x="566" y="959"/>
                  </a:lnTo>
                  <a:lnTo>
                    <a:pt x="568" y="964"/>
                  </a:lnTo>
                  <a:lnTo>
                    <a:pt x="557" y="969"/>
                  </a:lnTo>
                  <a:lnTo>
                    <a:pt x="555" y="963"/>
                  </a:lnTo>
                  <a:close/>
                  <a:moveTo>
                    <a:pt x="589" y="951"/>
                  </a:moveTo>
                  <a:lnTo>
                    <a:pt x="600" y="947"/>
                  </a:lnTo>
                  <a:lnTo>
                    <a:pt x="602" y="952"/>
                  </a:lnTo>
                  <a:lnTo>
                    <a:pt x="591" y="956"/>
                  </a:lnTo>
                  <a:lnTo>
                    <a:pt x="589" y="951"/>
                  </a:lnTo>
                  <a:close/>
                  <a:moveTo>
                    <a:pt x="623" y="939"/>
                  </a:moveTo>
                  <a:lnTo>
                    <a:pt x="634" y="936"/>
                  </a:lnTo>
                  <a:lnTo>
                    <a:pt x="636" y="941"/>
                  </a:lnTo>
                  <a:lnTo>
                    <a:pt x="625" y="945"/>
                  </a:lnTo>
                  <a:lnTo>
                    <a:pt x="623" y="939"/>
                  </a:lnTo>
                  <a:close/>
                  <a:moveTo>
                    <a:pt x="657" y="928"/>
                  </a:moveTo>
                  <a:lnTo>
                    <a:pt x="669" y="925"/>
                  </a:lnTo>
                  <a:lnTo>
                    <a:pt x="670" y="931"/>
                  </a:lnTo>
                  <a:lnTo>
                    <a:pt x="659" y="934"/>
                  </a:lnTo>
                  <a:lnTo>
                    <a:pt x="657" y="928"/>
                  </a:lnTo>
                  <a:close/>
                  <a:moveTo>
                    <a:pt x="692" y="918"/>
                  </a:moveTo>
                  <a:lnTo>
                    <a:pt x="703" y="915"/>
                  </a:lnTo>
                  <a:lnTo>
                    <a:pt x="705" y="921"/>
                  </a:lnTo>
                  <a:lnTo>
                    <a:pt x="693" y="924"/>
                  </a:lnTo>
                  <a:lnTo>
                    <a:pt x="692" y="918"/>
                  </a:lnTo>
                  <a:close/>
                  <a:moveTo>
                    <a:pt x="727" y="910"/>
                  </a:moveTo>
                  <a:lnTo>
                    <a:pt x="739" y="909"/>
                  </a:lnTo>
                  <a:lnTo>
                    <a:pt x="740" y="915"/>
                  </a:lnTo>
                  <a:lnTo>
                    <a:pt x="728" y="916"/>
                  </a:lnTo>
                  <a:lnTo>
                    <a:pt x="727" y="910"/>
                  </a:lnTo>
                  <a:close/>
                  <a:moveTo>
                    <a:pt x="763" y="906"/>
                  </a:moveTo>
                  <a:lnTo>
                    <a:pt x="775" y="904"/>
                  </a:lnTo>
                  <a:lnTo>
                    <a:pt x="775" y="910"/>
                  </a:lnTo>
                  <a:lnTo>
                    <a:pt x="763" y="912"/>
                  </a:lnTo>
                  <a:lnTo>
                    <a:pt x="763" y="906"/>
                  </a:lnTo>
                  <a:close/>
                  <a:moveTo>
                    <a:pt x="799" y="909"/>
                  </a:moveTo>
                  <a:lnTo>
                    <a:pt x="811" y="912"/>
                  </a:lnTo>
                  <a:lnTo>
                    <a:pt x="809" y="918"/>
                  </a:lnTo>
                  <a:lnTo>
                    <a:pt x="798" y="914"/>
                  </a:lnTo>
                  <a:lnTo>
                    <a:pt x="799" y="909"/>
                  </a:lnTo>
                  <a:close/>
                  <a:moveTo>
                    <a:pt x="834" y="920"/>
                  </a:moveTo>
                  <a:lnTo>
                    <a:pt x="845" y="924"/>
                  </a:lnTo>
                  <a:lnTo>
                    <a:pt x="843" y="929"/>
                  </a:lnTo>
                  <a:lnTo>
                    <a:pt x="832" y="925"/>
                  </a:lnTo>
                  <a:lnTo>
                    <a:pt x="834" y="920"/>
                  </a:lnTo>
                  <a:close/>
                  <a:moveTo>
                    <a:pt x="864" y="939"/>
                  </a:moveTo>
                  <a:lnTo>
                    <a:pt x="873" y="948"/>
                  </a:lnTo>
                  <a:lnTo>
                    <a:pt x="868" y="952"/>
                  </a:lnTo>
                  <a:lnTo>
                    <a:pt x="860" y="943"/>
                  </a:lnTo>
                  <a:lnTo>
                    <a:pt x="864" y="939"/>
                  </a:lnTo>
                  <a:close/>
                  <a:moveTo>
                    <a:pt x="889" y="965"/>
                  </a:moveTo>
                  <a:lnTo>
                    <a:pt x="898" y="973"/>
                  </a:lnTo>
                  <a:lnTo>
                    <a:pt x="894" y="978"/>
                  </a:lnTo>
                  <a:lnTo>
                    <a:pt x="885" y="969"/>
                  </a:lnTo>
                  <a:lnTo>
                    <a:pt x="889" y="965"/>
                  </a:lnTo>
                  <a:close/>
                  <a:moveTo>
                    <a:pt x="915" y="990"/>
                  </a:moveTo>
                  <a:lnTo>
                    <a:pt x="916" y="992"/>
                  </a:lnTo>
                  <a:lnTo>
                    <a:pt x="922" y="1001"/>
                  </a:lnTo>
                  <a:lnTo>
                    <a:pt x="917" y="1004"/>
                  </a:lnTo>
                  <a:lnTo>
                    <a:pt x="911" y="995"/>
                  </a:lnTo>
                  <a:lnTo>
                    <a:pt x="912" y="996"/>
                  </a:lnTo>
                  <a:lnTo>
                    <a:pt x="911" y="995"/>
                  </a:lnTo>
                  <a:lnTo>
                    <a:pt x="915" y="990"/>
                  </a:lnTo>
                  <a:close/>
                  <a:moveTo>
                    <a:pt x="934" y="1021"/>
                  </a:moveTo>
                  <a:lnTo>
                    <a:pt x="941" y="1032"/>
                  </a:lnTo>
                  <a:lnTo>
                    <a:pt x="936" y="1035"/>
                  </a:lnTo>
                  <a:lnTo>
                    <a:pt x="929" y="1025"/>
                  </a:lnTo>
                  <a:lnTo>
                    <a:pt x="934" y="1021"/>
                  </a:lnTo>
                  <a:close/>
                  <a:moveTo>
                    <a:pt x="953" y="1052"/>
                  </a:moveTo>
                  <a:lnTo>
                    <a:pt x="960" y="1062"/>
                  </a:lnTo>
                  <a:lnTo>
                    <a:pt x="954" y="1066"/>
                  </a:lnTo>
                  <a:lnTo>
                    <a:pt x="948" y="1055"/>
                  </a:lnTo>
                  <a:lnTo>
                    <a:pt x="953" y="1052"/>
                  </a:lnTo>
                  <a:close/>
                  <a:moveTo>
                    <a:pt x="972" y="1083"/>
                  </a:moveTo>
                  <a:lnTo>
                    <a:pt x="978" y="1093"/>
                  </a:lnTo>
                  <a:lnTo>
                    <a:pt x="973" y="1096"/>
                  </a:lnTo>
                  <a:lnTo>
                    <a:pt x="967" y="1086"/>
                  </a:lnTo>
                  <a:lnTo>
                    <a:pt x="972" y="1083"/>
                  </a:lnTo>
                  <a:close/>
                  <a:moveTo>
                    <a:pt x="990" y="1115"/>
                  </a:moveTo>
                  <a:lnTo>
                    <a:pt x="995" y="1125"/>
                  </a:lnTo>
                  <a:lnTo>
                    <a:pt x="990" y="1128"/>
                  </a:lnTo>
                  <a:lnTo>
                    <a:pt x="984" y="1117"/>
                  </a:lnTo>
                  <a:lnTo>
                    <a:pt x="990" y="1115"/>
                  </a:lnTo>
                  <a:close/>
                  <a:moveTo>
                    <a:pt x="1005" y="1147"/>
                  </a:moveTo>
                  <a:lnTo>
                    <a:pt x="1011" y="1158"/>
                  </a:lnTo>
                  <a:lnTo>
                    <a:pt x="1005" y="1161"/>
                  </a:lnTo>
                  <a:lnTo>
                    <a:pt x="1000" y="1150"/>
                  </a:lnTo>
                  <a:lnTo>
                    <a:pt x="1005" y="1147"/>
                  </a:lnTo>
                  <a:close/>
                  <a:moveTo>
                    <a:pt x="1021" y="1179"/>
                  </a:moveTo>
                  <a:lnTo>
                    <a:pt x="1026" y="1190"/>
                  </a:lnTo>
                  <a:lnTo>
                    <a:pt x="1021" y="1193"/>
                  </a:lnTo>
                  <a:lnTo>
                    <a:pt x="1016" y="1182"/>
                  </a:lnTo>
                  <a:lnTo>
                    <a:pt x="1021" y="1179"/>
                  </a:lnTo>
                  <a:close/>
                  <a:moveTo>
                    <a:pt x="1037" y="1212"/>
                  </a:moveTo>
                  <a:lnTo>
                    <a:pt x="1042" y="1222"/>
                  </a:lnTo>
                  <a:lnTo>
                    <a:pt x="1037" y="1225"/>
                  </a:lnTo>
                  <a:lnTo>
                    <a:pt x="1032" y="1214"/>
                  </a:lnTo>
                  <a:lnTo>
                    <a:pt x="1037" y="1212"/>
                  </a:lnTo>
                  <a:close/>
                  <a:moveTo>
                    <a:pt x="1053" y="1244"/>
                  </a:moveTo>
                  <a:lnTo>
                    <a:pt x="1057" y="1255"/>
                  </a:lnTo>
                  <a:lnTo>
                    <a:pt x="1052" y="1258"/>
                  </a:lnTo>
                  <a:lnTo>
                    <a:pt x="1047" y="1247"/>
                  </a:lnTo>
                  <a:lnTo>
                    <a:pt x="1053" y="1244"/>
                  </a:lnTo>
                  <a:close/>
                  <a:moveTo>
                    <a:pt x="1067" y="1277"/>
                  </a:moveTo>
                  <a:lnTo>
                    <a:pt x="1072" y="1288"/>
                  </a:lnTo>
                  <a:lnTo>
                    <a:pt x="1066" y="1291"/>
                  </a:lnTo>
                  <a:lnTo>
                    <a:pt x="1062" y="1279"/>
                  </a:lnTo>
                  <a:lnTo>
                    <a:pt x="1067" y="1277"/>
                  </a:lnTo>
                  <a:close/>
                  <a:moveTo>
                    <a:pt x="1082" y="1310"/>
                  </a:moveTo>
                  <a:lnTo>
                    <a:pt x="1087" y="1321"/>
                  </a:lnTo>
                  <a:lnTo>
                    <a:pt x="1081" y="1323"/>
                  </a:lnTo>
                  <a:lnTo>
                    <a:pt x="1077" y="1312"/>
                  </a:lnTo>
                  <a:lnTo>
                    <a:pt x="1082" y="1310"/>
                  </a:lnTo>
                  <a:close/>
                  <a:moveTo>
                    <a:pt x="1096" y="1343"/>
                  </a:moveTo>
                  <a:lnTo>
                    <a:pt x="1102" y="1354"/>
                  </a:lnTo>
                  <a:lnTo>
                    <a:pt x="1096" y="1356"/>
                  </a:lnTo>
                  <a:lnTo>
                    <a:pt x="1091" y="1345"/>
                  </a:lnTo>
                  <a:lnTo>
                    <a:pt x="1096" y="1343"/>
                  </a:lnTo>
                  <a:close/>
                  <a:moveTo>
                    <a:pt x="1111" y="1376"/>
                  </a:moveTo>
                  <a:lnTo>
                    <a:pt x="1112" y="1378"/>
                  </a:lnTo>
                  <a:lnTo>
                    <a:pt x="1112" y="1378"/>
                  </a:lnTo>
                  <a:lnTo>
                    <a:pt x="1116" y="1387"/>
                  </a:lnTo>
                  <a:lnTo>
                    <a:pt x="1111" y="1389"/>
                  </a:lnTo>
                  <a:lnTo>
                    <a:pt x="1107" y="1380"/>
                  </a:lnTo>
                  <a:lnTo>
                    <a:pt x="1106" y="1378"/>
                  </a:lnTo>
                  <a:lnTo>
                    <a:pt x="1111" y="1376"/>
                  </a:lnTo>
                  <a:close/>
                  <a:moveTo>
                    <a:pt x="1126" y="1408"/>
                  </a:moveTo>
                  <a:lnTo>
                    <a:pt x="1131" y="1419"/>
                  </a:lnTo>
                  <a:lnTo>
                    <a:pt x="1126" y="1422"/>
                  </a:lnTo>
                  <a:lnTo>
                    <a:pt x="1121" y="1411"/>
                  </a:lnTo>
                  <a:lnTo>
                    <a:pt x="1126" y="1408"/>
                  </a:lnTo>
                  <a:close/>
                  <a:moveTo>
                    <a:pt x="1141" y="1441"/>
                  </a:moveTo>
                  <a:lnTo>
                    <a:pt x="1146" y="1452"/>
                  </a:lnTo>
                  <a:lnTo>
                    <a:pt x="1141" y="1455"/>
                  </a:lnTo>
                  <a:lnTo>
                    <a:pt x="1135" y="1444"/>
                  </a:lnTo>
                  <a:lnTo>
                    <a:pt x="1141" y="1441"/>
                  </a:lnTo>
                  <a:close/>
                  <a:moveTo>
                    <a:pt x="1156" y="1474"/>
                  </a:moveTo>
                  <a:lnTo>
                    <a:pt x="1161" y="1485"/>
                  </a:lnTo>
                  <a:lnTo>
                    <a:pt x="1155" y="1488"/>
                  </a:lnTo>
                  <a:lnTo>
                    <a:pt x="1150" y="1477"/>
                  </a:lnTo>
                  <a:lnTo>
                    <a:pt x="1156" y="1474"/>
                  </a:lnTo>
                  <a:close/>
                  <a:moveTo>
                    <a:pt x="1171" y="1507"/>
                  </a:moveTo>
                  <a:lnTo>
                    <a:pt x="1176" y="1518"/>
                  </a:lnTo>
                  <a:lnTo>
                    <a:pt x="1170" y="1520"/>
                  </a:lnTo>
                  <a:lnTo>
                    <a:pt x="1165" y="1509"/>
                  </a:lnTo>
                  <a:lnTo>
                    <a:pt x="1171" y="1507"/>
                  </a:lnTo>
                  <a:close/>
                  <a:moveTo>
                    <a:pt x="1186" y="1539"/>
                  </a:moveTo>
                  <a:lnTo>
                    <a:pt x="1192" y="1550"/>
                  </a:lnTo>
                  <a:lnTo>
                    <a:pt x="1186" y="1553"/>
                  </a:lnTo>
                  <a:lnTo>
                    <a:pt x="1181" y="1542"/>
                  </a:lnTo>
                  <a:lnTo>
                    <a:pt x="1186" y="1539"/>
                  </a:lnTo>
                  <a:close/>
                  <a:moveTo>
                    <a:pt x="1202" y="1572"/>
                  </a:moveTo>
                  <a:lnTo>
                    <a:pt x="1207" y="1582"/>
                  </a:lnTo>
                  <a:lnTo>
                    <a:pt x="1202" y="1585"/>
                  </a:lnTo>
                  <a:lnTo>
                    <a:pt x="1197" y="1574"/>
                  </a:lnTo>
                  <a:lnTo>
                    <a:pt x="1202" y="1572"/>
                  </a:lnTo>
                  <a:close/>
                  <a:moveTo>
                    <a:pt x="1218" y="1604"/>
                  </a:moveTo>
                  <a:lnTo>
                    <a:pt x="1224" y="1614"/>
                  </a:lnTo>
                  <a:lnTo>
                    <a:pt x="1218" y="1617"/>
                  </a:lnTo>
                  <a:lnTo>
                    <a:pt x="1213" y="1606"/>
                  </a:lnTo>
                  <a:lnTo>
                    <a:pt x="1218" y="1604"/>
                  </a:lnTo>
                  <a:close/>
                  <a:moveTo>
                    <a:pt x="1234" y="1636"/>
                  </a:moveTo>
                  <a:lnTo>
                    <a:pt x="1240" y="1647"/>
                  </a:lnTo>
                  <a:lnTo>
                    <a:pt x="1234" y="1650"/>
                  </a:lnTo>
                  <a:lnTo>
                    <a:pt x="1229" y="1639"/>
                  </a:lnTo>
                  <a:lnTo>
                    <a:pt x="1234" y="1636"/>
                  </a:lnTo>
                  <a:close/>
                  <a:moveTo>
                    <a:pt x="1251" y="1668"/>
                  </a:moveTo>
                  <a:lnTo>
                    <a:pt x="1257" y="1678"/>
                  </a:lnTo>
                  <a:lnTo>
                    <a:pt x="1252" y="1681"/>
                  </a:lnTo>
                  <a:lnTo>
                    <a:pt x="1246" y="1671"/>
                  </a:lnTo>
                  <a:lnTo>
                    <a:pt x="1251" y="1668"/>
                  </a:lnTo>
                  <a:close/>
                  <a:moveTo>
                    <a:pt x="1270" y="1698"/>
                  </a:moveTo>
                  <a:lnTo>
                    <a:pt x="1276" y="1709"/>
                  </a:lnTo>
                  <a:lnTo>
                    <a:pt x="1271" y="1712"/>
                  </a:lnTo>
                  <a:lnTo>
                    <a:pt x="1264" y="1701"/>
                  </a:lnTo>
                  <a:lnTo>
                    <a:pt x="1270" y="1698"/>
                  </a:lnTo>
                  <a:close/>
                  <a:moveTo>
                    <a:pt x="1288" y="1729"/>
                  </a:moveTo>
                  <a:lnTo>
                    <a:pt x="1294" y="1740"/>
                  </a:lnTo>
                  <a:lnTo>
                    <a:pt x="1289" y="1743"/>
                  </a:lnTo>
                  <a:lnTo>
                    <a:pt x="1283" y="1732"/>
                  </a:lnTo>
                  <a:lnTo>
                    <a:pt x="1288" y="1729"/>
                  </a:lnTo>
                  <a:close/>
                  <a:moveTo>
                    <a:pt x="1306" y="1760"/>
                  </a:moveTo>
                  <a:lnTo>
                    <a:pt x="1308" y="1762"/>
                  </a:lnTo>
                  <a:lnTo>
                    <a:pt x="1307" y="1762"/>
                  </a:lnTo>
                  <a:lnTo>
                    <a:pt x="1314" y="1769"/>
                  </a:lnTo>
                  <a:lnTo>
                    <a:pt x="1309" y="1773"/>
                  </a:lnTo>
                  <a:lnTo>
                    <a:pt x="1302" y="1765"/>
                  </a:lnTo>
                  <a:lnTo>
                    <a:pt x="1301" y="1763"/>
                  </a:lnTo>
                  <a:lnTo>
                    <a:pt x="1306" y="1760"/>
                  </a:lnTo>
                  <a:close/>
                  <a:moveTo>
                    <a:pt x="1329" y="1788"/>
                  </a:moveTo>
                  <a:lnTo>
                    <a:pt x="1336" y="1797"/>
                  </a:lnTo>
                  <a:lnTo>
                    <a:pt x="1332" y="1801"/>
                  </a:lnTo>
                  <a:lnTo>
                    <a:pt x="1324" y="1792"/>
                  </a:lnTo>
                  <a:lnTo>
                    <a:pt x="1329" y="1788"/>
                  </a:lnTo>
                  <a:close/>
                  <a:moveTo>
                    <a:pt x="1351" y="1816"/>
                  </a:moveTo>
                  <a:lnTo>
                    <a:pt x="1359" y="1825"/>
                  </a:lnTo>
                  <a:lnTo>
                    <a:pt x="1354" y="1829"/>
                  </a:lnTo>
                  <a:lnTo>
                    <a:pt x="1347" y="1819"/>
                  </a:lnTo>
                  <a:lnTo>
                    <a:pt x="1351" y="1816"/>
                  </a:lnTo>
                  <a:close/>
                  <a:moveTo>
                    <a:pt x="1374" y="1842"/>
                  </a:moveTo>
                  <a:lnTo>
                    <a:pt x="1384" y="1849"/>
                  </a:lnTo>
                  <a:lnTo>
                    <a:pt x="1381" y="1854"/>
                  </a:lnTo>
                  <a:lnTo>
                    <a:pt x="1371" y="1847"/>
                  </a:lnTo>
                  <a:lnTo>
                    <a:pt x="1374" y="1842"/>
                  </a:lnTo>
                  <a:close/>
                  <a:moveTo>
                    <a:pt x="1404" y="1863"/>
                  </a:moveTo>
                  <a:lnTo>
                    <a:pt x="1414" y="1870"/>
                  </a:lnTo>
                  <a:lnTo>
                    <a:pt x="1410" y="1875"/>
                  </a:lnTo>
                  <a:lnTo>
                    <a:pt x="1400" y="1868"/>
                  </a:lnTo>
                  <a:lnTo>
                    <a:pt x="1404" y="1863"/>
                  </a:lnTo>
                  <a:close/>
                  <a:moveTo>
                    <a:pt x="1433" y="1884"/>
                  </a:moveTo>
                  <a:lnTo>
                    <a:pt x="1437" y="1887"/>
                  </a:lnTo>
                  <a:lnTo>
                    <a:pt x="1436" y="1886"/>
                  </a:lnTo>
                  <a:lnTo>
                    <a:pt x="1443" y="1887"/>
                  </a:lnTo>
                  <a:lnTo>
                    <a:pt x="1442" y="1893"/>
                  </a:lnTo>
                  <a:lnTo>
                    <a:pt x="1434" y="1892"/>
                  </a:lnTo>
                  <a:lnTo>
                    <a:pt x="1430" y="1889"/>
                  </a:lnTo>
                  <a:lnTo>
                    <a:pt x="1433" y="1884"/>
                  </a:lnTo>
                  <a:close/>
                  <a:moveTo>
                    <a:pt x="1467" y="1892"/>
                  </a:moveTo>
                  <a:lnTo>
                    <a:pt x="1479" y="1894"/>
                  </a:lnTo>
                  <a:lnTo>
                    <a:pt x="1477" y="1900"/>
                  </a:lnTo>
                  <a:lnTo>
                    <a:pt x="1465" y="1897"/>
                  </a:lnTo>
                  <a:lnTo>
                    <a:pt x="1467" y="1892"/>
                  </a:lnTo>
                  <a:close/>
                  <a:moveTo>
                    <a:pt x="1500" y="1897"/>
                  </a:moveTo>
                  <a:lnTo>
                    <a:pt x="1512" y="1893"/>
                  </a:lnTo>
                  <a:lnTo>
                    <a:pt x="1514" y="1899"/>
                  </a:lnTo>
                  <a:lnTo>
                    <a:pt x="1503" y="1903"/>
                  </a:lnTo>
                  <a:lnTo>
                    <a:pt x="1500" y="1897"/>
                  </a:lnTo>
                  <a:close/>
                  <a:moveTo>
                    <a:pt x="1534" y="1885"/>
                  </a:moveTo>
                  <a:lnTo>
                    <a:pt x="1546" y="1881"/>
                  </a:lnTo>
                  <a:lnTo>
                    <a:pt x="1548" y="1887"/>
                  </a:lnTo>
                  <a:lnTo>
                    <a:pt x="1536" y="1891"/>
                  </a:lnTo>
                  <a:lnTo>
                    <a:pt x="1534" y="1885"/>
                  </a:lnTo>
                  <a:close/>
                  <a:moveTo>
                    <a:pt x="1566" y="1872"/>
                  </a:moveTo>
                  <a:lnTo>
                    <a:pt x="1575" y="1864"/>
                  </a:lnTo>
                  <a:lnTo>
                    <a:pt x="1579" y="1869"/>
                  </a:lnTo>
                  <a:lnTo>
                    <a:pt x="1570" y="1877"/>
                  </a:lnTo>
                  <a:lnTo>
                    <a:pt x="1566" y="1872"/>
                  </a:lnTo>
                  <a:close/>
                  <a:moveTo>
                    <a:pt x="1593" y="1848"/>
                  </a:moveTo>
                  <a:lnTo>
                    <a:pt x="1602" y="1840"/>
                  </a:lnTo>
                  <a:lnTo>
                    <a:pt x="1606" y="1845"/>
                  </a:lnTo>
                  <a:lnTo>
                    <a:pt x="1597" y="1852"/>
                  </a:lnTo>
                  <a:lnTo>
                    <a:pt x="1593" y="1848"/>
                  </a:lnTo>
                  <a:close/>
                  <a:moveTo>
                    <a:pt x="1620" y="1824"/>
                  </a:moveTo>
                  <a:lnTo>
                    <a:pt x="1629" y="1816"/>
                  </a:lnTo>
                  <a:lnTo>
                    <a:pt x="1633" y="1820"/>
                  </a:lnTo>
                  <a:lnTo>
                    <a:pt x="1624" y="1828"/>
                  </a:lnTo>
                  <a:lnTo>
                    <a:pt x="1620" y="1824"/>
                  </a:lnTo>
                  <a:close/>
                  <a:moveTo>
                    <a:pt x="1642" y="1797"/>
                  </a:moveTo>
                  <a:lnTo>
                    <a:pt x="1649" y="1787"/>
                  </a:lnTo>
                  <a:lnTo>
                    <a:pt x="1654" y="1791"/>
                  </a:lnTo>
                  <a:lnTo>
                    <a:pt x="1647" y="1800"/>
                  </a:lnTo>
                  <a:lnTo>
                    <a:pt x="1642" y="1797"/>
                  </a:lnTo>
                  <a:close/>
                  <a:moveTo>
                    <a:pt x="1663" y="1767"/>
                  </a:moveTo>
                  <a:lnTo>
                    <a:pt x="1670" y="1758"/>
                  </a:lnTo>
                  <a:lnTo>
                    <a:pt x="1675" y="1761"/>
                  </a:lnTo>
                  <a:lnTo>
                    <a:pt x="1668" y="1771"/>
                  </a:lnTo>
                  <a:lnTo>
                    <a:pt x="1663" y="1767"/>
                  </a:lnTo>
                  <a:close/>
                  <a:moveTo>
                    <a:pt x="1684" y="1738"/>
                  </a:moveTo>
                  <a:lnTo>
                    <a:pt x="1691" y="1728"/>
                  </a:lnTo>
                  <a:lnTo>
                    <a:pt x="1696" y="1732"/>
                  </a:lnTo>
                  <a:lnTo>
                    <a:pt x="1689" y="1741"/>
                  </a:lnTo>
                  <a:lnTo>
                    <a:pt x="1684" y="1738"/>
                  </a:lnTo>
                  <a:close/>
                  <a:moveTo>
                    <a:pt x="1703" y="1708"/>
                  </a:moveTo>
                  <a:lnTo>
                    <a:pt x="1708" y="1698"/>
                  </a:lnTo>
                  <a:lnTo>
                    <a:pt x="1714" y="1700"/>
                  </a:lnTo>
                  <a:lnTo>
                    <a:pt x="1708" y="1711"/>
                  </a:lnTo>
                  <a:lnTo>
                    <a:pt x="1703" y="1708"/>
                  </a:lnTo>
                  <a:close/>
                  <a:moveTo>
                    <a:pt x="1720" y="1677"/>
                  </a:moveTo>
                  <a:lnTo>
                    <a:pt x="1726" y="1666"/>
                  </a:lnTo>
                  <a:lnTo>
                    <a:pt x="1731" y="1669"/>
                  </a:lnTo>
                  <a:lnTo>
                    <a:pt x="1725" y="1679"/>
                  </a:lnTo>
                  <a:lnTo>
                    <a:pt x="1720" y="1677"/>
                  </a:lnTo>
                  <a:close/>
                  <a:moveTo>
                    <a:pt x="1738" y="1645"/>
                  </a:moveTo>
                  <a:lnTo>
                    <a:pt x="1743" y="1635"/>
                  </a:lnTo>
                  <a:lnTo>
                    <a:pt x="1749" y="1637"/>
                  </a:lnTo>
                  <a:lnTo>
                    <a:pt x="1743" y="1648"/>
                  </a:lnTo>
                  <a:lnTo>
                    <a:pt x="1738" y="1645"/>
                  </a:lnTo>
                  <a:close/>
                  <a:moveTo>
                    <a:pt x="1755" y="1614"/>
                  </a:moveTo>
                  <a:lnTo>
                    <a:pt x="1759" y="1607"/>
                  </a:lnTo>
                  <a:lnTo>
                    <a:pt x="1758" y="1607"/>
                  </a:lnTo>
                  <a:lnTo>
                    <a:pt x="1761" y="1603"/>
                  </a:lnTo>
                  <a:lnTo>
                    <a:pt x="1766" y="1606"/>
                  </a:lnTo>
                  <a:lnTo>
                    <a:pt x="1764" y="1610"/>
                  </a:lnTo>
                  <a:lnTo>
                    <a:pt x="1760" y="1616"/>
                  </a:lnTo>
                  <a:lnTo>
                    <a:pt x="1755" y="1614"/>
                  </a:lnTo>
                  <a:close/>
                  <a:moveTo>
                    <a:pt x="1771" y="1581"/>
                  </a:moveTo>
                  <a:lnTo>
                    <a:pt x="1776" y="1570"/>
                  </a:lnTo>
                  <a:lnTo>
                    <a:pt x="1781" y="1573"/>
                  </a:lnTo>
                  <a:lnTo>
                    <a:pt x="1776" y="1584"/>
                  </a:lnTo>
                  <a:lnTo>
                    <a:pt x="1771" y="1581"/>
                  </a:lnTo>
                  <a:close/>
                  <a:moveTo>
                    <a:pt x="1786" y="1549"/>
                  </a:moveTo>
                  <a:lnTo>
                    <a:pt x="1791" y="1538"/>
                  </a:lnTo>
                  <a:lnTo>
                    <a:pt x="1797" y="1540"/>
                  </a:lnTo>
                  <a:lnTo>
                    <a:pt x="1792" y="1551"/>
                  </a:lnTo>
                  <a:lnTo>
                    <a:pt x="1786" y="1549"/>
                  </a:lnTo>
                  <a:close/>
                  <a:moveTo>
                    <a:pt x="1801" y="1516"/>
                  </a:moveTo>
                  <a:lnTo>
                    <a:pt x="1807" y="1505"/>
                  </a:lnTo>
                  <a:lnTo>
                    <a:pt x="1812" y="1508"/>
                  </a:lnTo>
                  <a:lnTo>
                    <a:pt x="1807" y="1519"/>
                  </a:lnTo>
                  <a:lnTo>
                    <a:pt x="1801" y="1516"/>
                  </a:lnTo>
                  <a:close/>
                  <a:moveTo>
                    <a:pt x="1817" y="1484"/>
                  </a:moveTo>
                  <a:lnTo>
                    <a:pt x="1822" y="1473"/>
                  </a:lnTo>
                  <a:lnTo>
                    <a:pt x="1828" y="1476"/>
                  </a:lnTo>
                  <a:lnTo>
                    <a:pt x="1822" y="1486"/>
                  </a:lnTo>
                  <a:lnTo>
                    <a:pt x="1817" y="1484"/>
                  </a:lnTo>
                  <a:close/>
                  <a:moveTo>
                    <a:pt x="1831" y="1451"/>
                  </a:moveTo>
                  <a:lnTo>
                    <a:pt x="1836" y="1440"/>
                  </a:lnTo>
                  <a:lnTo>
                    <a:pt x="1842" y="1442"/>
                  </a:lnTo>
                  <a:lnTo>
                    <a:pt x="1837" y="1453"/>
                  </a:lnTo>
                  <a:lnTo>
                    <a:pt x="1831" y="1451"/>
                  </a:lnTo>
                  <a:close/>
                  <a:moveTo>
                    <a:pt x="1846" y="1418"/>
                  </a:moveTo>
                  <a:lnTo>
                    <a:pt x="1851" y="1407"/>
                  </a:lnTo>
                  <a:lnTo>
                    <a:pt x="1856" y="1409"/>
                  </a:lnTo>
                  <a:lnTo>
                    <a:pt x="1851" y="1420"/>
                  </a:lnTo>
                  <a:lnTo>
                    <a:pt x="1846" y="1418"/>
                  </a:lnTo>
                  <a:close/>
                  <a:moveTo>
                    <a:pt x="1860" y="1385"/>
                  </a:moveTo>
                  <a:lnTo>
                    <a:pt x="1865" y="1374"/>
                  </a:lnTo>
                  <a:lnTo>
                    <a:pt x="1870" y="1376"/>
                  </a:lnTo>
                  <a:lnTo>
                    <a:pt x="1866" y="1387"/>
                  </a:lnTo>
                  <a:lnTo>
                    <a:pt x="1860" y="1385"/>
                  </a:lnTo>
                  <a:close/>
                  <a:moveTo>
                    <a:pt x="1874" y="1352"/>
                  </a:moveTo>
                  <a:lnTo>
                    <a:pt x="1879" y="1341"/>
                  </a:lnTo>
                  <a:lnTo>
                    <a:pt x="1884" y="1343"/>
                  </a:lnTo>
                  <a:lnTo>
                    <a:pt x="1880" y="1354"/>
                  </a:lnTo>
                  <a:lnTo>
                    <a:pt x="1874" y="1352"/>
                  </a:lnTo>
                  <a:close/>
                  <a:moveTo>
                    <a:pt x="1888" y="1318"/>
                  </a:moveTo>
                  <a:lnTo>
                    <a:pt x="1889" y="1318"/>
                  </a:lnTo>
                  <a:lnTo>
                    <a:pt x="1889" y="1318"/>
                  </a:lnTo>
                  <a:lnTo>
                    <a:pt x="1893" y="1308"/>
                  </a:lnTo>
                  <a:lnTo>
                    <a:pt x="1898" y="1310"/>
                  </a:lnTo>
                  <a:lnTo>
                    <a:pt x="1894" y="1320"/>
                  </a:lnTo>
                  <a:lnTo>
                    <a:pt x="1894" y="1321"/>
                  </a:lnTo>
                  <a:lnTo>
                    <a:pt x="1888" y="1318"/>
                  </a:lnTo>
                  <a:close/>
                  <a:moveTo>
                    <a:pt x="1902" y="1285"/>
                  </a:moveTo>
                  <a:lnTo>
                    <a:pt x="1906" y="1274"/>
                  </a:lnTo>
                  <a:lnTo>
                    <a:pt x="1911" y="1276"/>
                  </a:lnTo>
                  <a:lnTo>
                    <a:pt x="1907" y="1287"/>
                  </a:lnTo>
                  <a:lnTo>
                    <a:pt x="1902" y="1285"/>
                  </a:lnTo>
                  <a:close/>
                  <a:moveTo>
                    <a:pt x="1915" y="1252"/>
                  </a:moveTo>
                  <a:lnTo>
                    <a:pt x="1919" y="1240"/>
                  </a:lnTo>
                  <a:lnTo>
                    <a:pt x="1924" y="1243"/>
                  </a:lnTo>
                  <a:lnTo>
                    <a:pt x="1920" y="1254"/>
                  </a:lnTo>
                  <a:lnTo>
                    <a:pt x="1915" y="1252"/>
                  </a:lnTo>
                  <a:close/>
                  <a:moveTo>
                    <a:pt x="1928" y="1218"/>
                  </a:moveTo>
                  <a:lnTo>
                    <a:pt x="1932" y="1207"/>
                  </a:lnTo>
                  <a:lnTo>
                    <a:pt x="1938" y="1209"/>
                  </a:lnTo>
                  <a:lnTo>
                    <a:pt x="1933" y="1220"/>
                  </a:lnTo>
                  <a:lnTo>
                    <a:pt x="1928" y="1218"/>
                  </a:lnTo>
                  <a:close/>
                  <a:moveTo>
                    <a:pt x="1941" y="1185"/>
                  </a:moveTo>
                  <a:lnTo>
                    <a:pt x="1945" y="1173"/>
                  </a:lnTo>
                  <a:lnTo>
                    <a:pt x="1951" y="1176"/>
                  </a:lnTo>
                  <a:lnTo>
                    <a:pt x="1946" y="1187"/>
                  </a:lnTo>
                  <a:lnTo>
                    <a:pt x="1941" y="1185"/>
                  </a:lnTo>
                  <a:close/>
                  <a:moveTo>
                    <a:pt x="1954" y="1151"/>
                  </a:moveTo>
                  <a:lnTo>
                    <a:pt x="1958" y="1140"/>
                  </a:lnTo>
                  <a:lnTo>
                    <a:pt x="1963" y="1142"/>
                  </a:lnTo>
                  <a:lnTo>
                    <a:pt x="1960" y="1153"/>
                  </a:lnTo>
                  <a:lnTo>
                    <a:pt x="1954" y="1151"/>
                  </a:lnTo>
                  <a:close/>
                  <a:moveTo>
                    <a:pt x="1966" y="1117"/>
                  </a:moveTo>
                  <a:lnTo>
                    <a:pt x="1970" y="1106"/>
                  </a:lnTo>
                  <a:lnTo>
                    <a:pt x="1976" y="1108"/>
                  </a:lnTo>
                  <a:lnTo>
                    <a:pt x="1972" y="1119"/>
                  </a:lnTo>
                  <a:lnTo>
                    <a:pt x="1966" y="1117"/>
                  </a:lnTo>
                  <a:close/>
                  <a:moveTo>
                    <a:pt x="1978" y="1083"/>
                  </a:moveTo>
                  <a:lnTo>
                    <a:pt x="1982" y="1072"/>
                  </a:lnTo>
                  <a:lnTo>
                    <a:pt x="1988" y="1074"/>
                  </a:lnTo>
                  <a:lnTo>
                    <a:pt x="1984" y="1085"/>
                  </a:lnTo>
                  <a:lnTo>
                    <a:pt x="1978" y="1083"/>
                  </a:lnTo>
                  <a:close/>
                  <a:moveTo>
                    <a:pt x="1990" y="1050"/>
                  </a:moveTo>
                  <a:lnTo>
                    <a:pt x="1994" y="1038"/>
                  </a:lnTo>
                  <a:lnTo>
                    <a:pt x="2000" y="1040"/>
                  </a:lnTo>
                  <a:lnTo>
                    <a:pt x="1996" y="1051"/>
                  </a:lnTo>
                  <a:lnTo>
                    <a:pt x="1990" y="1050"/>
                  </a:lnTo>
                  <a:close/>
                  <a:moveTo>
                    <a:pt x="2002" y="1015"/>
                  </a:moveTo>
                  <a:lnTo>
                    <a:pt x="2006" y="1004"/>
                  </a:lnTo>
                  <a:lnTo>
                    <a:pt x="2012" y="1006"/>
                  </a:lnTo>
                  <a:lnTo>
                    <a:pt x="2008" y="1018"/>
                  </a:lnTo>
                  <a:lnTo>
                    <a:pt x="2002" y="1015"/>
                  </a:lnTo>
                  <a:close/>
                  <a:moveTo>
                    <a:pt x="2014" y="982"/>
                  </a:moveTo>
                  <a:lnTo>
                    <a:pt x="2019" y="970"/>
                  </a:lnTo>
                  <a:lnTo>
                    <a:pt x="2024" y="972"/>
                  </a:lnTo>
                  <a:lnTo>
                    <a:pt x="2020" y="984"/>
                  </a:lnTo>
                  <a:lnTo>
                    <a:pt x="2014" y="982"/>
                  </a:lnTo>
                  <a:close/>
                  <a:moveTo>
                    <a:pt x="2026" y="948"/>
                  </a:moveTo>
                  <a:lnTo>
                    <a:pt x="2029" y="936"/>
                  </a:lnTo>
                  <a:lnTo>
                    <a:pt x="2035" y="938"/>
                  </a:lnTo>
                  <a:lnTo>
                    <a:pt x="2032" y="949"/>
                  </a:lnTo>
                  <a:lnTo>
                    <a:pt x="2026" y="948"/>
                  </a:lnTo>
                  <a:close/>
                  <a:moveTo>
                    <a:pt x="2037" y="913"/>
                  </a:moveTo>
                  <a:lnTo>
                    <a:pt x="2041" y="902"/>
                  </a:lnTo>
                  <a:lnTo>
                    <a:pt x="2046" y="904"/>
                  </a:lnTo>
                  <a:lnTo>
                    <a:pt x="2043" y="915"/>
                  </a:lnTo>
                  <a:lnTo>
                    <a:pt x="2037" y="913"/>
                  </a:lnTo>
                  <a:close/>
                  <a:moveTo>
                    <a:pt x="2048" y="879"/>
                  </a:moveTo>
                  <a:lnTo>
                    <a:pt x="2052" y="868"/>
                  </a:lnTo>
                  <a:lnTo>
                    <a:pt x="2058" y="870"/>
                  </a:lnTo>
                  <a:lnTo>
                    <a:pt x="2054" y="881"/>
                  </a:lnTo>
                  <a:lnTo>
                    <a:pt x="2048" y="879"/>
                  </a:lnTo>
                  <a:close/>
                  <a:moveTo>
                    <a:pt x="2059" y="845"/>
                  </a:moveTo>
                  <a:lnTo>
                    <a:pt x="2063" y="834"/>
                  </a:lnTo>
                  <a:lnTo>
                    <a:pt x="2069" y="835"/>
                  </a:lnTo>
                  <a:lnTo>
                    <a:pt x="2065" y="847"/>
                  </a:lnTo>
                  <a:lnTo>
                    <a:pt x="2059" y="845"/>
                  </a:lnTo>
                  <a:close/>
                  <a:moveTo>
                    <a:pt x="2070" y="811"/>
                  </a:moveTo>
                  <a:lnTo>
                    <a:pt x="2074" y="799"/>
                  </a:lnTo>
                  <a:lnTo>
                    <a:pt x="2080" y="801"/>
                  </a:lnTo>
                  <a:lnTo>
                    <a:pt x="2076" y="813"/>
                  </a:lnTo>
                  <a:lnTo>
                    <a:pt x="2070" y="811"/>
                  </a:lnTo>
                  <a:close/>
                  <a:moveTo>
                    <a:pt x="2082" y="777"/>
                  </a:moveTo>
                  <a:lnTo>
                    <a:pt x="2084" y="769"/>
                  </a:lnTo>
                  <a:lnTo>
                    <a:pt x="2084" y="769"/>
                  </a:lnTo>
                  <a:lnTo>
                    <a:pt x="2085" y="765"/>
                  </a:lnTo>
                  <a:lnTo>
                    <a:pt x="2091" y="767"/>
                  </a:lnTo>
                  <a:lnTo>
                    <a:pt x="2090" y="771"/>
                  </a:lnTo>
                  <a:lnTo>
                    <a:pt x="2087" y="778"/>
                  </a:lnTo>
                  <a:lnTo>
                    <a:pt x="2082" y="777"/>
                  </a:lnTo>
                  <a:close/>
                  <a:moveTo>
                    <a:pt x="2092" y="742"/>
                  </a:moveTo>
                  <a:lnTo>
                    <a:pt x="2095" y="730"/>
                  </a:lnTo>
                  <a:lnTo>
                    <a:pt x="2101" y="732"/>
                  </a:lnTo>
                  <a:lnTo>
                    <a:pt x="2098" y="744"/>
                  </a:lnTo>
                  <a:lnTo>
                    <a:pt x="2092" y="742"/>
                  </a:lnTo>
                  <a:close/>
                  <a:moveTo>
                    <a:pt x="2102" y="708"/>
                  </a:moveTo>
                  <a:lnTo>
                    <a:pt x="2106" y="696"/>
                  </a:lnTo>
                  <a:lnTo>
                    <a:pt x="2112" y="698"/>
                  </a:lnTo>
                  <a:lnTo>
                    <a:pt x="2108" y="709"/>
                  </a:lnTo>
                  <a:lnTo>
                    <a:pt x="2102" y="708"/>
                  </a:lnTo>
                  <a:close/>
                  <a:moveTo>
                    <a:pt x="2113" y="673"/>
                  </a:moveTo>
                  <a:lnTo>
                    <a:pt x="2116" y="661"/>
                  </a:lnTo>
                  <a:lnTo>
                    <a:pt x="2122" y="663"/>
                  </a:lnTo>
                  <a:lnTo>
                    <a:pt x="2118" y="675"/>
                  </a:lnTo>
                  <a:lnTo>
                    <a:pt x="2113" y="673"/>
                  </a:lnTo>
                  <a:close/>
                  <a:moveTo>
                    <a:pt x="2123" y="639"/>
                  </a:moveTo>
                  <a:lnTo>
                    <a:pt x="2126" y="627"/>
                  </a:lnTo>
                  <a:lnTo>
                    <a:pt x="2132" y="629"/>
                  </a:lnTo>
                  <a:lnTo>
                    <a:pt x="2129" y="640"/>
                  </a:lnTo>
                  <a:lnTo>
                    <a:pt x="2123" y="639"/>
                  </a:lnTo>
                  <a:close/>
                  <a:moveTo>
                    <a:pt x="2133" y="604"/>
                  </a:moveTo>
                  <a:lnTo>
                    <a:pt x="2137" y="592"/>
                  </a:lnTo>
                  <a:lnTo>
                    <a:pt x="2142" y="594"/>
                  </a:lnTo>
                  <a:lnTo>
                    <a:pt x="2139" y="606"/>
                  </a:lnTo>
                  <a:lnTo>
                    <a:pt x="2133" y="604"/>
                  </a:lnTo>
                  <a:close/>
                  <a:moveTo>
                    <a:pt x="2143" y="570"/>
                  </a:moveTo>
                  <a:lnTo>
                    <a:pt x="2147" y="558"/>
                  </a:lnTo>
                  <a:lnTo>
                    <a:pt x="2153" y="560"/>
                  </a:lnTo>
                  <a:lnTo>
                    <a:pt x="2149" y="571"/>
                  </a:lnTo>
                  <a:lnTo>
                    <a:pt x="2143" y="570"/>
                  </a:lnTo>
                  <a:close/>
                  <a:moveTo>
                    <a:pt x="2153" y="535"/>
                  </a:moveTo>
                  <a:lnTo>
                    <a:pt x="2157" y="523"/>
                  </a:lnTo>
                  <a:lnTo>
                    <a:pt x="2162" y="525"/>
                  </a:lnTo>
                  <a:lnTo>
                    <a:pt x="2159" y="537"/>
                  </a:lnTo>
                  <a:lnTo>
                    <a:pt x="2153" y="535"/>
                  </a:lnTo>
                  <a:close/>
                  <a:moveTo>
                    <a:pt x="2163" y="500"/>
                  </a:moveTo>
                  <a:lnTo>
                    <a:pt x="2166" y="489"/>
                  </a:lnTo>
                  <a:lnTo>
                    <a:pt x="2172" y="490"/>
                  </a:lnTo>
                  <a:lnTo>
                    <a:pt x="2169" y="502"/>
                  </a:lnTo>
                  <a:lnTo>
                    <a:pt x="2163" y="500"/>
                  </a:lnTo>
                  <a:close/>
                  <a:moveTo>
                    <a:pt x="2172" y="466"/>
                  </a:moveTo>
                  <a:lnTo>
                    <a:pt x="2175" y="454"/>
                  </a:lnTo>
                  <a:lnTo>
                    <a:pt x="2181" y="456"/>
                  </a:lnTo>
                  <a:lnTo>
                    <a:pt x="2178" y="467"/>
                  </a:lnTo>
                  <a:lnTo>
                    <a:pt x="2172" y="466"/>
                  </a:lnTo>
                  <a:close/>
                  <a:moveTo>
                    <a:pt x="2182" y="431"/>
                  </a:moveTo>
                  <a:lnTo>
                    <a:pt x="2185" y="419"/>
                  </a:lnTo>
                  <a:lnTo>
                    <a:pt x="2191" y="421"/>
                  </a:lnTo>
                  <a:lnTo>
                    <a:pt x="2187" y="432"/>
                  </a:lnTo>
                  <a:lnTo>
                    <a:pt x="2182" y="431"/>
                  </a:lnTo>
                  <a:close/>
                  <a:moveTo>
                    <a:pt x="2191" y="396"/>
                  </a:moveTo>
                  <a:lnTo>
                    <a:pt x="2194" y="384"/>
                  </a:lnTo>
                  <a:lnTo>
                    <a:pt x="2200" y="386"/>
                  </a:lnTo>
                  <a:lnTo>
                    <a:pt x="2197" y="397"/>
                  </a:lnTo>
                  <a:lnTo>
                    <a:pt x="2191" y="396"/>
                  </a:lnTo>
                  <a:close/>
                  <a:moveTo>
                    <a:pt x="2200" y="361"/>
                  </a:moveTo>
                  <a:lnTo>
                    <a:pt x="2204" y="350"/>
                  </a:lnTo>
                  <a:lnTo>
                    <a:pt x="2209" y="351"/>
                  </a:lnTo>
                  <a:lnTo>
                    <a:pt x="2206" y="363"/>
                  </a:lnTo>
                  <a:lnTo>
                    <a:pt x="2200" y="361"/>
                  </a:lnTo>
                  <a:close/>
                  <a:moveTo>
                    <a:pt x="2210" y="327"/>
                  </a:moveTo>
                  <a:lnTo>
                    <a:pt x="2213" y="315"/>
                  </a:lnTo>
                  <a:lnTo>
                    <a:pt x="2219" y="316"/>
                  </a:lnTo>
                  <a:lnTo>
                    <a:pt x="2216" y="328"/>
                  </a:lnTo>
                  <a:lnTo>
                    <a:pt x="2210" y="327"/>
                  </a:lnTo>
                  <a:close/>
                  <a:moveTo>
                    <a:pt x="2219" y="292"/>
                  </a:moveTo>
                  <a:lnTo>
                    <a:pt x="2222" y="280"/>
                  </a:lnTo>
                  <a:lnTo>
                    <a:pt x="2227" y="282"/>
                  </a:lnTo>
                  <a:lnTo>
                    <a:pt x="2225" y="293"/>
                  </a:lnTo>
                  <a:lnTo>
                    <a:pt x="2219" y="292"/>
                  </a:lnTo>
                  <a:close/>
                  <a:moveTo>
                    <a:pt x="2227" y="257"/>
                  </a:moveTo>
                  <a:lnTo>
                    <a:pt x="2230" y="245"/>
                  </a:lnTo>
                  <a:lnTo>
                    <a:pt x="2236" y="246"/>
                  </a:lnTo>
                  <a:lnTo>
                    <a:pt x="2233" y="258"/>
                  </a:lnTo>
                  <a:lnTo>
                    <a:pt x="2227" y="257"/>
                  </a:lnTo>
                  <a:close/>
                  <a:moveTo>
                    <a:pt x="2236" y="222"/>
                  </a:moveTo>
                  <a:lnTo>
                    <a:pt x="2238" y="210"/>
                  </a:lnTo>
                  <a:lnTo>
                    <a:pt x="2244" y="211"/>
                  </a:lnTo>
                  <a:lnTo>
                    <a:pt x="2242" y="223"/>
                  </a:lnTo>
                  <a:lnTo>
                    <a:pt x="2236" y="222"/>
                  </a:lnTo>
                  <a:close/>
                  <a:moveTo>
                    <a:pt x="2244" y="187"/>
                  </a:moveTo>
                  <a:lnTo>
                    <a:pt x="2247" y="175"/>
                  </a:lnTo>
                  <a:lnTo>
                    <a:pt x="2253" y="177"/>
                  </a:lnTo>
                  <a:lnTo>
                    <a:pt x="2250" y="188"/>
                  </a:lnTo>
                  <a:lnTo>
                    <a:pt x="2244" y="187"/>
                  </a:lnTo>
                  <a:close/>
                  <a:moveTo>
                    <a:pt x="2253" y="152"/>
                  </a:moveTo>
                  <a:lnTo>
                    <a:pt x="2255" y="140"/>
                  </a:lnTo>
                  <a:lnTo>
                    <a:pt x="2261" y="141"/>
                  </a:lnTo>
                  <a:lnTo>
                    <a:pt x="2258" y="153"/>
                  </a:lnTo>
                  <a:lnTo>
                    <a:pt x="2253" y="152"/>
                  </a:lnTo>
                  <a:close/>
                  <a:moveTo>
                    <a:pt x="2261" y="117"/>
                  </a:moveTo>
                  <a:lnTo>
                    <a:pt x="2264" y="105"/>
                  </a:lnTo>
                  <a:lnTo>
                    <a:pt x="2269" y="106"/>
                  </a:lnTo>
                  <a:lnTo>
                    <a:pt x="2267" y="118"/>
                  </a:lnTo>
                  <a:lnTo>
                    <a:pt x="2261" y="117"/>
                  </a:lnTo>
                  <a:close/>
                  <a:moveTo>
                    <a:pt x="2269" y="82"/>
                  </a:moveTo>
                  <a:lnTo>
                    <a:pt x="2272" y="70"/>
                  </a:lnTo>
                  <a:lnTo>
                    <a:pt x="2278" y="72"/>
                  </a:lnTo>
                  <a:lnTo>
                    <a:pt x="2275" y="83"/>
                  </a:lnTo>
                  <a:lnTo>
                    <a:pt x="2269" y="82"/>
                  </a:lnTo>
                  <a:close/>
                  <a:moveTo>
                    <a:pt x="2278" y="47"/>
                  </a:moveTo>
                  <a:lnTo>
                    <a:pt x="2280" y="39"/>
                  </a:lnTo>
                  <a:lnTo>
                    <a:pt x="2280" y="39"/>
                  </a:lnTo>
                  <a:lnTo>
                    <a:pt x="2280" y="35"/>
                  </a:lnTo>
                  <a:lnTo>
                    <a:pt x="2286" y="36"/>
                  </a:lnTo>
                  <a:lnTo>
                    <a:pt x="2286" y="40"/>
                  </a:lnTo>
                  <a:lnTo>
                    <a:pt x="2284" y="48"/>
                  </a:lnTo>
                  <a:lnTo>
                    <a:pt x="2278" y="47"/>
                  </a:lnTo>
                  <a:close/>
                  <a:moveTo>
                    <a:pt x="2285" y="12"/>
                  </a:moveTo>
                  <a:lnTo>
                    <a:pt x="2288" y="0"/>
                  </a:lnTo>
                  <a:lnTo>
                    <a:pt x="2293" y="1"/>
                  </a:lnTo>
                  <a:lnTo>
                    <a:pt x="2291" y="13"/>
                  </a:lnTo>
                  <a:lnTo>
                    <a:pt x="2285" y="12"/>
                  </a:lnTo>
                  <a:close/>
                </a:path>
              </a:pathLst>
            </a:custGeom>
            <a:solidFill>
              <a:srgbClr val="000000"/>
            </a:solidFill>
            <a:ln w="6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sp>
        <p:nvSpPr>
          <p:cNvPr id="13" name="Freeform 71"/>
          <p:cNvSpPr>
            <a:spLocks noEditPoints="1"/>
          </p:cNvSpPr>
          <p:nvPr/>
        </p:nvSpPr>
        <p:spPr bwMode="auto">
          <a:xfrm>
            <a:off x="2266951" y="895963"/>
            <a:ext cx="4610100" cy="3838575"/>
          </a:xfrm>
          <a:custGeom>
            <a:avLst/>
            <a:gdLst>
              <a:gd name="T0" fmla="*/ 0 w 2904"/>
              <a:gd name="T1" fmla="*/ 2418 h 2418"/>
              <a:gd name="T2" fmla="*/ 0 w 2904"/>
              <a:gd name="T3" fmla="*/ 0 h 2418"/>
              <a:gd name="T4" fmla="*/ 2904 w 2904"/>
              <a:gd name="T5" fmla="*/ 2418 h 2418"/>
              <a:gd name="T6" fmla="*/ 0 w 2904"/>
              <a:gd name="T7" fmla="*/ 2418 h 241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904" h="2418">
                <a:moveTo>
                  <a:pt x="0" y="2418"/>
                </a:moveTo>
                <a:lnTo>
                  <a:pt x="0" y="0"/>
                </a:lnTo>
                <a:moveTo>
                  <a:pt x="2904" y="2418"/>
                </a:moveTo>
                <a:lnTo>
                  <a:pt x="0" y="2418"/>
                </a:lnTo>
              </a:path>
            </a:pathLst>
          </a:custGeom>
          <a:noFill/>
          <a:ln w="6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grpSp>
        <p:nvGrpSpPr>
          <p:cNvPr id="14" name="グループ化 13"/>
          <p:cNvGrpSpPr/>
          <p:nvPr/>
        </p:nvGrpSpPr>
        <p:grpSpPr>
          <a:xfrm>
            <a:off x="2368439" y="4796260"/>
            <a:ext cx="4408806" cy="276999"/>
            <a:chOff x="2368439" y="5650538"/>
            <a:chExt cx="4408806" cy="276999"/>
          </a:xfrm>
        </p:grpSpPr>
        <p:sp>
          <p:nvSpPr>
            <p:cNvPr id="15" name="テキスト ボックス 14"/>
            <p:cNvSpPr txBox="1"/>
            <p:nvPr/>
          </p:nvSpPr>
          <p:spPr>
            <a:xfrm>
              <a:off x="3391993" y="5650538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0.1</a:t>
              </a:r>
              <a:endParaRPr kumimoji="1" lang="ja-JP" altLang="en-US" sz="1200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16" name="テキスト ボックス 15"/>
            <p:cNvSpPr txBox="1"/>
            <p:nvPr/>
          </p:nvSpPr>
          <p:spPr>
            <a:xfrm>
              <a:off x="2368439" y="5650538"/>
              <a:ext cx="4828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0.05</a:t>
              </a:r>
              <a:endParaRPr kumimoji="1" lang="ja-JP" altLang="en-US" sz="1200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17" name="テキスト ボックス 16"/>
            <p:cNvSpPr txBox="1"/>
            <p:nvPr/>
          </p:nvSpPr>
          <p:spPr>
            <a:xfrm>
              <a:off x="4399159" y="5650538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0</a:t>
              </a:r>
              <a:r>
                <a:rPr kumimoji="1" lang="en-US" altLang="ja-JP" sz="1200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.2</a:t>
              </a:r>
              <a:endParaRPr kumimoji="1" lang="ja-JP" altLang="en-US" sz="1200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18" name="テキスト ボックス 17"/>
            <p:cNvSpPr txBox="1"/>
            <p:nvPr/>
          </p:nvSpPr>
          <p:spPr>
            <a:xfrm>
              <a:off x="5389269" y="5650538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0</a:t>
              </a:r>
              <a:r>
                <a:rPr kumimoji="1" lang="en-US" altLang="ja-JP" sz="1200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.4</a:t>
              </a:r>
              <a:endParaRPr kumimoji="1" lang="ja-JP" altLang="en-US" sz="1200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19" name="テキスト ボックス 18"/>
            <p:cNvSpPr txBox="1"/>
            <p:nvPr/>
          </p:nvSpPr>
          <p:spPr>
            <a:xfrm>
              <a:off x="5922150" y="5650538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0</a:t>
              </a:r>
              <a:r>
                <a:rPr kumimoji="1" lang="en-US" altLang="ja-JP" sz="1200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.6</a:t>
              </a:r>
              <a:endParaRPr kumimoji="1" lang="ja-JP" altLang="en-US" sz="1200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20" name="テキスト ボックス 19"/>
            <p:cNvSpPr txBox="1"/>
            <p:nvPr/>
          </p:nvSpPr>
          <p:spPr>
            <a:xfrm>
              <a:off x="6379379" y="5650538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0</a:t>
              </a:r>
              <a:r>
                <a:rPr kumimoji="1" lang="en-US" altLang="ja-JP" sz="1200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.8</a:t>
              </a:r>
              <a:endParaRPr kumimoji="1" lang="ja-JP" altLang="en-US" sz="1200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</p:grpSp>
      <p:sp>
        <p:nvSpPr>
          <p:cNvPr id="21" name="テキスト ボックス 20"/>
          <p:cNvSpPr txBox="1"/>
          <p:nvPr/>
        </p:nvSpPr>
        <p:spPr>
          <a:xfrm rot="16200000">
            <a:off x="680426" y="2569871"/>
            <a:ext cx="19255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Risk</a:t>
            </a:r>
            <a:r>
              <a:rPr kumimoji="1" lang="en-US" altLang="ja-JP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r</a:t>
            </a:r>
            <a:r>
              <a:rPr kumimoji="1" lang="en-US" altLang="ja-JP" sz="1200" dirty="0" smtClean="0">
                <a:latin typeface="Arial" pitchFamily="34" charset="0"/>
                <a:cs typeface="Arial" pitchFamily="34" charset="0"/>
              </a:rPr>
              <a:t>atio for renal events</a:t>
            </a:r>
            <a:endParaRPr kumimoji="1" lang="ja-JP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3404196" y="5111295"/>
            <a:ext cx="2541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UPE</a:t>
            </a:r>
            <a:r>
              <a:rPr lang="ja-JP" altLang="en-US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at one year / UPE at baseline</a:t>
            </a:r>
            <a:endParaRPr kumimoji="1" lang="ja-JP" altLang="en-US" sz="1200" baseline="300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3" name="グループ化 22"/>
          <p:cNvGrpSpPr/>
          <p:nvPr/>
        </p:nvGrpSpPr>
        <p:grpSpPr>
          <a:xfrm>
            <a:off x="2701464" y="378801"/>
            <a:ext cx="2365591" cy="637039"/>
            <a:chOff x="3068038" y="1522510"/>
            <a:chExt cx="2365591" cy="637039"/>
          </a:xfrm>
        </p:grpSpPr>
        <p:cxnSp>
          <p:nvCxnSpPr>
            <p:cNvPr id="24" name="直線コネクタ 23"/>
            <p:cNvCxnSpPr/>
            <p:nvPr/>
          </p:nvCxnSpPr>
          <p:spPr>
            <a:xfrm>
              <a:off x="3068038" y="1645620"/>
              <a:ext cx="432048" cy="0"/>
            </a:xfrm>
            <a:prstGeom prst="line">
              <a:avLst/>
            </a:prstGeom>
            <a:ln w="28575">
              <a:solidFill>
                <a:schemeClr val="tx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直線コネクタ 24"/>
            <p:cNvCxnSpPr/>
            <p:nvPr/>
          </p:nvCxnSpPr>
          <p:spPr>
            <a:xfrm>
              <a:off x="3068038" y="2010597"/>
              <a:ext cx="432048" cy="0"/>
            </a:xfrm>
            <a:prstGeom prst="line">
              <a:avLst/>
            </a:prstGeom>
            <a:ln w="1905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テキスト ボックス 25"/>
            <p:cNvSpPr txBox="1"/>
            <p:nvPr/>
          </p:nvSpPr>
          <p:spPr>
            <a:xfrm>
              <a:off x="3500086" y="1522510"/>
              <a:ext cx="5677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Arial" pitchFamily="34" charset="0"/>
                  <a:cs typeface="Arial" pitchFamily="34" charset="0"/>
                </a:rPr>
                <a:t>Mean</a:t>
              </a:r>
            </a:p>
          </p:txBody>
        </p:sp>
        <p:sp>
          <p:nvSpPr>
            <p:cNvPr id="27" name="テキスト ボックス 26"/>
            <p:cNvSpPr txBox="1"/>
            <p:nvPr/>
          </p:nvSpPr>
          <p:spPr>
            <a:xfrm>
              <a:off x="3500086" y="1882550"/>
              <a:ext cx="19335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Arial" pitchFamily="34" charset="0"/>
                  <a:cs typeface="Arial" pitchFamily="34" charset="0"/>
                </a:rPr>
                <a:t>Lower or upper of 95% CI</a:t>
              </a:r>
            </a:p>
          </p:txBody>
        </p:sp>
      </p:grpSp>
      <p:sp>
        <p:nvSpPr>
          <p:cNvPr id="28" name="テキスト ボックス 27"/>
          <p:cNvSpPr txBox="1"/>
          <p:nvPr/>
        </p:nvSpPr>
        <p:spPr>
          <a:xfrm>
            <a:off x="7002270" y="3221085"/>
            <a:ext cx="8739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 smtClean="0">
                <a:latin typeface="Arial" pitchFamily="34" charset="0"/>
                <a:cs typeface="Arial" pitchFamily="34" charset="0"/>
              </a:rPr>
              <a:t>Reduction</a:t>
            </a:r>
            <a:endParaRPr kumimoji="1" lang="ja-JP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7010285" y="1323906"/>
            <a:ext cx="7729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Increase</a:t>
            </a:r>
            <a:endParaRPr kumimoji="1" lang="ja-JP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7035934" y="2088991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Risk</a:t>
            </a:r>
            <a:endParaRPr kumimoji="1" lang="ja-JP" altLang="en-US" sz="12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1" name="直線矢印コネクタ 30"/>
          <p:cNvCxnSpPr/>
          <p:nvPr/>
        </p:nvCxnSpPr>
        <p:spPr>
          <a:xfrm flipV="1">
            <a:off x="7056629" y="655801"/>
            <a:ext cx="0" cy="1575962"/>
          </a:xfrm>
          <a:prstGeom prst="straightConnector1">
            <a:avLst/>
          </a:prstGeom>
          <a:ln>
            <a:solidFill>
              <a:schemeClr val="tx1"/>
            </a:solidFill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線矢印コネクタ 31"/>
          <p:cNvCxnSpPr/>
          <p:nvPr/>
        </p:nvCxnSpPr>
        <p:spPr>
          <a:xfrm>
            <a:off x="7056629" y="2231763"/>
            <a:ext cx="0" cy="2284401"/>
          </a:xfrm>
          <a:prstGeom prst="straightConnector1">
            <a:avLst/>
          </a:prstGeom>
          <a:ln>
            <a:solidFill>
              <a:schemeClr val="tx1"/>
            </a:solidFill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3" name="グループ化 32"/>
          <p:cNvGrpSpPr/>
          <p:nvPr/>
        </p:nvGrpSpPr>
        <p:grpSpPr>
          <a:xfrm>
            <a:off x="1833874" y="745810"/>
            <a:ext cx="410011" cy="3908466"/>
            <a:chOff x="1833874" y="1493785"/>
            <a:chExt cx="410011" cy="3908466"/>
          </a:xfrm>
        </p:grpSpPr>
        <p:grpSp>
          <p:nvGrpSpPr>
            <p:cNvPr id="34" name="グループ化 33"/>
            <p:cNvGrpSpPr/>
            <p:nvPr/>
          </p:nvGrpSpPr>
          <p:grpSpPr>
            <a:xfrm>
              <a:off x="2186735" y="1628800"/>
              <a:ext cx="57150" cy="3609976"/>
              <a:chOff x="2174590" y="1709762"/>
              <a:chExt cx="57150" cy="3609976"/>
            </a:xfrm>
          </p:grpSpPr>
          <p:sp>
            <p:nvSpPr>
              <p:cNvPr id="45" name="Line 49"/>
              <p:cNvSpPr>
                <a:spLocks noChangeShapeType="1"/>
              </p:cNvSpPr>
              <p:nvPr/>
            </p:nvSpPr>
            <p:spPr bwMode="auto">
              <a:xfrm flipH="1">
                <a:off x="2174590" y="5319738"/>
                <a:ext cx="57150" cy="0"/>
              </a:xfrm>
              <a:prstGeom prst="line">
                <a:avLst/>
              </a:prstGeom>
              <a:noFill/>
              <a:ln w="6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6" name="Line 51"/>
              <p:cNvSpPr>
                <a:spLocks noChangeShapeType="1"/>
              </p:cNvSpPr>
              <p:nvPr/>
            </p:nvSpPr>
            <p:spPr bwMode="auto">
              <a:xfrm flipH="1">
                <a:off x="2174590" y="4872063"/>
                <a:ext cx="57150" cy="0"/>
              </a:xfrm>
              <a:prstGeom prst="line">
                <a:avLst/>
              </a:prstGeom>
              <a:noFill/>
              <a:ln w="6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7" name="Line 53"/>
              <p:cNvSpPr>
                <a:spLocks noChangeShapeType="1"/>
              </p:cNvSpPr>
              <p:nvPr/>
            </p:nvSpPr>
            <p:spPr bwMode="auto">
              <a:xfrm flipH="1">
                <a:off x="2174590" y="4414863"/>
                <a:ext cx="57150" cy="0"/>
              </a:xfrm>
              <a:prstGeom prst="line">
                <a:avLst/>
              </a:prstGeom>
              <a:noFill/>
              <a:ln w="6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8" name="Line 55"/>
              <p:cNvSpPr>
                <a:spLocks noChangeShapeType="1"/>
              </p:cNvSpPr>
              <p:nvPr/>
            </p:nvSpPr>
            <p:spPr bwMode="auto">
              <a:xfrm flipH="1">
                <a:off x="2174590" y="3967188"/>
                <a:ext cx="57150" cy="0"/>
              </a:xfrm>
              <a:prstGeom prst="line">
                <a:avLst/>
              </a:prstGeom>
              <a:noFill/>
              <a:ln w="6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9" name="Line 57"/>
              <p:cNvSpPr>
                <a:spLocks noChangeShapeType="1"/>
              </p:cNvSpPr>
              <p:nvPr/>
            </p:nvSpPr>
            <p:spPr bwMode="auto">
              <a:xfrm flipH="1">
                <a:off x="2174590" y="3519513"/>
                <a:ext cx="57150" cy="0"/>
              </a:xfrm>
              <a:prstGeom prst="line">
                <a:avLst/>
              </a:prstGeom>
              <a:noFill/>
              <a:ln w="6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0" name="Line 59"/>
              <p:cNvSpPr>
                <a:spLocks noChangeShapeType="1"/>
              </p:cNvSpPr>
              <p:nvPr/>
            </p:nvSpPr>
            <p:spPr bwMode="auto">
              <a:xfrm flipH="1">
                <a:off x="2174590" y="3062313"/>
                <a:ext cx="57150" cy="0"/>
              </a:xfrm>
              <a:prstGeom prst="line">
                <a:avLst/>
              </a:prstGeom>
              <a:noFill/>
              <a:ln w="6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1" name="Line 61"/>
              <p:cNvSpPr>
                <a:spLocks noChangeShapeType="1"/>
              </p:cNvSpPr>
              <p:nvPr/>
            </p:nvSpPr>
            <p:spPr bwMode="auto">
              <a:xfrm flipH="1">
                <a:off x="2174590" y="2614638"/>
                <a:ext cx="57150" cy="0"/>
              </a:xfrm>
              <a:prstGeom prst="line">
                <a:avLst/>
              </a:prstGeom>
              <a:noFill/>
              <a:ln w="6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2" name="Line 63"/>
              <p:cNvSpPr>
                <a:spLocks noChangeShapeType="1"/>
              </p:cNvSpPr>
              <p:nvPr/>
            </p:nvSpPr>
            <p:spPr bwMode="auto">
              <a:xfrm flipH="1">
                <a:off x="2174590" y="2157438"/>
                <a:ext cx="57150" cy="0"/>
              </a:xfrm>
              <a:prstGeom prst="line">
                <a:avLst/>
              </a:prstGeom>
              <a:noFill/>
              <a:ln w="6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3" name="Line 65"/>
              <p:cNvSpPr>
                <a:spLocks noChangeShapeType="1"/>
              </p:cNvSpPr>
              <p:nvPr/>
            </p:nvSpPr>
            <p:spPr bwMode="auto">
              <a:xfrm flipH="1">
                <a:off x="2174590" y="1709762"/>
                <a:ext cx="57150" cy="0"/>
              </a:xfrm>
              <a:prstGeom prst="line">
                <a:avLst/>
              </a:prstGeom>
              <a:noFill/>
              <a:ln w="6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grpSp>
          <p:nvGrpSpPr>
            <p:cNvPr id="35" name="グループ化 34"/>
            <p:cNvGrpSpPr/>
            <p:nvPr/>
          </p:nvGrpSpPr>
          <p:grpSpPr>
            <a:xfrm>
              <a:off x="1833874" y="1493785"/>
              <a:ext cx="397866" cy="3908466"/>
              <a:chOff x="1511660" y="1493785"/>
              <a:chExt cx="397866" cy="3908466"/>
            </a:xfrm>
          </p:grpSpPr>
          <p:sp>
            <p:nvSpPr>
              <p:cNvPr id="36" name="テキスト ボックス 35"/>
              <p:cNvSpPr txBox="1"/>
              <p:nvPr/>
            </p:nvSpPr>
            <p:spPr>
              <a:xfrm>
                <a:off x="1575780" y="5125252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 smtClean="0">
                    <a:latin typeface="Arial Unicode MS" pitchFamily="50" charset="-128"/>
                    <a:ea typeface="Arial Unicode MS" pitchFamily="50" charset="-128"/>
                    <a:cs typeface="Arial Unicode MS" pitchFamily="50" charset="-128"/>
                  </a:rPr>
                  <a:t>0</a:t>
                </a:r>
                <a:endParaRPr kumimoji="1" lang="ja-JP" altLang="en-US" sz="1200" dirty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endParaRPr>
              </a:p>
            </p:txBody>
          </p:sp>
          <p:sp>
            <p:nvSpPr>
              <p:cNvPr id="37" name="テキスト ボックス 36"/>
              <p:cNvSpPr txBox="1"/>
              <p:nvPr/>
            </p:nvSpPr>
            <p:spPr>
              <a:xfrm>
                <a:off x="1511660" y="4671316"/>
                <a:ext cx="397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 smtClean="0">
                    <a:latin typeface="Arial Unicode MS" pitchFamily="50" charset="-128"/>
                    <a:ea typeface="Arial Unicode MS" pitchFamily="50" charset="-128"/>
                    <a:cs typeface="Arial Unicode MS" pitchFamily="50" charset="-128"/>
                  </a:rPr>
                  <a:t>0.2</a:t>
                </a:r>
                <a:endParaRPr kumimoji="1" lang="ja-JP" altLang="en-US" sz="1200" dirty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endParaRPr>
              </a:p>
            </p:txBody>
          </p:sp>
          <p:sp>
            <p:nvSpPr>
              <p:cNvPr id="38" name="テキスト ボックス 37"/>
              <p:cNvSpPr txBox="1"/>
              <p:nvPr/>
            </p:nvSpPr>
            <p:spPr>
              <a:xfrm>
                <a:off x="1511660" y="4217383"/>
                <a:ext cx="397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 smtClean="0">
                    <a:latin typeface="Arial Unicode MS" pitchFamily="50" charset="-128"/>
                    <a:ea typeface="Arial Unicode MS" pitchFamily="50" charset="-128"/>
                    <a:cs typeface="Arial Unicode MS" pitchFamily="50" charset="-128"/>
                  </a:rPr>
                  <a:t>0.4</a:t>
                </a:r>
                <a:endParaRPr kumimoji="1" lang="ja-JP" altLang="en-US" sz="1200" dirty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endParaRPr>
              </a:p>
            </p:txBody>
          </p:sp>
          <p:sp>
            <p:nvSpPr>
              <p:cNvPr id="39" name="テキスト ボックス 38"/>
              <p:cNvSpPr txBox="1"/>
              <p:nvPr/>
            </p:nvSpPr>
            <p:spPr>
              <a:xfrm>
                <a:off x="1511660" y="3763450"/>
                <a:ext cx="397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 smtClean="0">
                    <a:latin typeface="Arial Unicode MS" pitchFamily="50" charset="-128"/>
                    <a:ea typeface="Arial Unicode MS" pitchFamily="50" charset="-128"/>
                    <a:cs typeface="Arial Unicode MS" pitchFamily="50" charset="-128"/>
                  </a:rPr>
                  <a:t>0.6</a:t>
                </a:r>
                <a:endParaRPr kumimoji="1" lang="ja-JP" altLang="en-US" sz="1200" dirty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endParaRPr>
              </a:p>
            </p:txBody>
          </p:sp>
          <p:sp>
            <p:nvSpPr>
              <p:cNvPr id="40" name="テキスト ボックス 39"/>
              <p:cNvSpPr txBox="1"/>
              <p:nvPr/>
            </p:nvSpPr>
            <p:spPr>
              <a:xfrm>
                <a:off x="1511660" y="3309517"/>
                <a:ext cx="397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 smtClean="0">
                    <a:latin typeface="Arial Unicode MS" pitchFamily="50" charset="-128"/>
                    <a:ea typeface="Arial Unicode MS" pitchFamily="50" charset="-128"/>
                    <a:cs typeface="Arial Unicode MS" pitchFamily="50" charset="-128"/>
                  </a:rPr>
                  <a:t>0.8</a:t>
                </a:r>
                <a:endParaRPr kumimoji="1" lang="ja-JP" altLang="en-US" sz="1200" dirty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endParaRPr>
              </a:p>
            </p:txBody>
          </p:sp>
          <p:sp>
            <p:nvSpPr>
              <p:cNvPr id="41" name="テキスト ボックス 40"/>
              <p:cNvSpPr txBox="1"/>
              <p:nvPr/>
            </p:nvSpPr>
            <p:spPr>
              <a:xfrm>
                <a:off x="1511660" y="2855584"/>
                <a:ext cx="397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dirty="0" smtClean="0">
                    <a:latin typeface="Arial Unicode MS" pitchFamily="50" charset="-128"/>
                    <a:ea typeface="Arial Unicode MS" pitchFamily="50" charset="-128"/>
                    <a:cs typeface="Arial Unicode MS" pitchFamily="50" charset="-128"/>
                  </a:rPr>
                  <a:t>1</a:t>
                </a:r>
                <a:r>
                  <a:rPr kumimoji="1" lang="en-US" altLang="ja-JP" sz="1200" dirty="0" smtClean="0">
                    <a:latin typeface="Arial Unicode MS" pitchFamily="50" charset="-128"/>
                    <a:ea typeface="Arial Unicode MS" pitchFamily="50" charset="-128"/>
                    <a:cs typeface="Arial Unicode MS" pitchFamily="50" charset="-128"/>
                  </a:rPr>
                  <a:t>.0</a:t>
                </a:r>
                <a:endParaRPr kumimoji="1" lang="ja-JP" altLang="en-US" sz="1200" dirty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endParaRPr>
              </a:p>
            </p:txBody>
          </p:sp>
          <p:sp>
            <p:nvSpPr>
              <p:cNvPr id="42" name="テキスト ボックス 41"/>
              <p:cNvSpPr txBox="1"/>
              <p:nvPr/>
            </p:nvSpPr>
            <p:spPr>
              <a:xfrm>
                <a:off x="1511660" y="2401651"/>
                <a:ext cx="397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dirty="0">
                    <a:latin typeface="Arial Unicode MS" pitchFamily="50" charset="-128"/>
                    <a:ea typeface="Arial Unicode MS" pitchFamily="50" charset="-128"/>
                    <a:cs typeface="Arial Unicode MS" pitchFamily="50" charset="-128"/>
                  </a:rPr>
                  <a:t>1</a:t>
                </a:r>
                <a:r>
                  <a:rPr kumimoji="1" lang="en-US" altLang="ja-JP" sz="1200" dirty="0" smtClean="0">
                    <a:latin typeface="Arial Unicode MS" pitchFamily="50" charset="-128"/>
                    <a:ea typeface="Arial Unicode MS" pitchFamily="50" charset="-128"/>
                    <a:cs typeface="Arial Unicode MS" pitchFamily="50" charset="-128"/>
                  </a:rPr>
                  <a:t>.2</a:t>
                </a:r>
                <a:endParaRPr kumimoji="1" lang="ja-JP" altLang="en-US" sz="1200" dirty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endParaRPr>
              </a:p>
            </p:txBody>
          </p:sp>
          <p:sp>
            <p:nvSpPr>
              <p:cNvPr id="43" name="テキスト ボックス 42"/>
              <p:cNvSpPr txBox="1"/>
              <p:nvPr/>
            </p:nvSpPr>
            <p:spPr>
              <a:xfrm>
                <a:off x="1511660" y="1947718"/>
                <a:ext cx="397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dirty="0" smtClean="0">
                    <a:latin typeface="Arial Unicode MS" pitchFamily="50" charset="-128"/>
                    <a:ea typeface="Arial Unicode MS" pitchFamily="50" charset="-128"/>
                    <a:cs typeface="Arial Unicode MS" pitchFamily="50" charset="-128"/>
                  </a:rPr>
                  <a:t>1</a:t>
                </a:r>
                <a:r>
                  <a:rPr kumimoji="1" lang="en-US" altLang="ja-JP" sz="1200" dirty="0" smtClean="0">
                    <a:latin typeface="Arial Unicode MS" pitchFamily="50" charset="-128"/>
                    <a:ea typeface="Arial Unicode MS" pitchFamily="50" charset="-128"/>
                    <a:cs typeface="Arial Unicode MS" pitchFamily="50" charset="-128"/>
                  </a:rPr>
                  <a:t>.4</a:t>
                </a:r>
                <a:endParaRPr kumimoji="1" lang="ja-JP" altLang="en-US" sz="1200" dirty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endParaRPr>
              </a:p>
            </p:txBody>
          </p:sp>
          <p:sp>
            <p:nvSpPr>
              <p:cNvPr id="44" name="テキスト ボックス 43"/>
              <p:cNvSpPr txBox="1"/>
              <p:nvPr/>
            </p:nvSpPr>
            <p:spPr>
              <a:xfrm>
                <a:off x="1511660" y="1493785"/>
                <a:ext cx="397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dirty="0" smtClean="0">
                    <a:latin typeface="Arial Unicode MS" pitchFamily="50" charset="-128"/>
                    <a:ea typeface="Arial Unicode MS" pitchFamily="50" charset="-128"/>
                    <a:cs typeface="Arial Unicode MS" pitchFamily="50" charset="-128"/>
                  </a:rPr>
                  <a:t>1</a:t>
                </a:r>
                <a:r>
                  <a:rPr kumimoji="1" lang="en-US" altLang="ja-JP" sz="1200" dirty="0" smtClean="0">
                    <a:latin typeface="Arial Unicode MS" pitchFamily="50" charset="-128"/>
                    <a:ea typeface="Arial Unicode MS" pitchFamily="50" charset="-128"/>
                    <a:cs typeface="Arial Unicode MS" pitchFamily="50" charset="-128"/>
                  </a:rPr>
                  <a:t>.6</a:t>
                </a:r>
                <a:endParaRPr kumimoji="1" lang="ja-JP" altLang="en-US" sz="1200" dirty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endParaRPr>
              </a:p>
            </p:txBody>
          </p:sp>
        </p:grpSp>
      </p:grpSp>
      <p:sp>
        <p:nvSpPr>
          <p:cNvPr id="54" name="テキスト ボックス 53"/>
          <p:cNvSpPr txBox="1"/>
          <p:nvPr/>
        </p:nvSpPr>
        <p:spPr>
          <a:xfrm>
            <a:off x="463093" y="5891430"/>
            <a:ext cx="838074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 smtClean="0"/>
              <a:t>Supplemental Figure </a:t>
            </a:r>
            <a:r>
              <a:rPr lang="en-US" altLang="ja-JP" b="1" dirty="0" smtClean="0"/>
              <a:t>F. </a:t>
            </a:r>
            <a:r>
              <a:rPr lang="en-US" altLang="ja-JP" dirty="0"/>
              <a:t>Risk ratio for the end point associated with the </a:t>
            </a:r>
            <a:r>
              <a:rPr lang="en-US" altLang="ja-JP" dirty="0" smtClean="0"/>
              <a:t>improvement of proteinuria (UPE at one year/ UPE at baseline).</a:t>
            </a:r>
            <a:endParaRPr kumimoji="1" lang="ja-JP" altLang="en-US" dirty="0"/>
          </a:p>
        </p:txBody>
      </p:sp>
    </p:spTree>
    <p:extLst>
      <p:ext uri="{BB962C8B-B14F-4D97-AF65-F5344CB8AC3E}">
        <p14:creationId xmlns="" xmlns:p14="http://schemas.microsoft.com/office/powerpoint/2010/main" val="418415564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2094159242"/>
              </p:ext>
            </p:extLst>
          </p:nvPr>
        </p:nvGraphicFramePr>
        <p:xfrm>
          <a:off x="1720850" y="476672"/>
          <a:ext cx="5702299" cy="2133600"/>
        </p:xfrm>
        <a:graphic>
          <a:graphicData uri="http://schemas.openxmlformats.org/drawingml/2006/table">
            <a:tbl>
              <a:tblPr/>
              <a:tblGrid>
                <a:gridCol w="3312855"/>
                <a:gridCol w="1675467"/>
                <a:gridCol w="713977"/>
              </a:tblGrid>
              <a:tr h="419100">
                <a:tc gridSpan="3">
                  <a:txBody>
                    <a:bodyPr/>
                    <a:lstStyle/>
                    <a:p>
                      <a:pPr algn="l" rtl="0" fontAlgn="ctr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Supplemental Table E. 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Rate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of UPE at one year to 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UPE at baseline predicting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renal outcome in multivariable Cox-Hazard model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209550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Predictor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Model B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20955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HR (95%CI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p valu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Rate of UPE at one year / baseline UPE &lt; 0.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0.25 (0.07 to 0.90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0.034 </a:t>
                      </a:r>
                      <a:r>
                        <a:rPr lang="en-US" altLang="ja-JP" sz="11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#</a:t>
                      </a:r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 Unicode M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Age, year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0.99 (0.94 to 1.04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&gt;0.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Current smoking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2.39 (0.73 to 7.82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0.1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U-RBC </a:t>
                      </a:r>
                      <a:r>
                        <a:rPr lang="en-US" sz="1100" b="0" i="0" u="sng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&gt;</a:t>
                      </a: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 30/hpf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0.42 (0.10 to 1.78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&gt;0.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eGFR &lt; 60 ml/min/1.73m</a:t>
                      </a:r>
                      <a:r>
                        <a:rPr lang="en-US" sz="11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 Unicode M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9.53 (1.66 to 54.6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0.011 </a:t>
                      </a:r>
                      <a:r>
                        <a:rPr lang="en-US" altLang="ja-JP" sz="11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#</a:t>
                      </a:r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 Unicode M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Tonsillectomy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0.25 (0.08 to 1.31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0.11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="" xmlns:p14="http://schemas.microsoft.com/office/powerpoint/2010/main" val="41400342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グループ化 1"/>
          <p:cNvGrpSpPr/>
          <p:nvPr/>
        </p:nvGrpSpPr>
        <p:grpSpPr>
          <a:xfrm>
            <a:off x="2271713" y="1069196"/>
            <a:ext cx="4610100" cy="3386138"/>
            <a:chOff x="2271713" y="1256185"/>
            <a:chExt cx="4610100" cy="3386138"/>
          </a:xfrm>
        </p:grpSpPr>
        <p:sp>
          <p:nvSpPr>
            <p:cNvPr id="3" name="Freeform 50"/>
            <p:cNvSpPr>
              <a:spLocks/>
            </p:cNvSpPr>
            <p:nvPr/>
          </p:nvSpPr>
          <p:spPr bwMode="auto">
            <a:xfrm>
              <a:off x="2271713" y="1837210"/>
              <a:ext cx="4610100" cy="2328863"/>
            </a:xfrm>
            <a:custGeom>
              <a:avLst/>
              <a:gdLst>
                <a:gd name="T0" fmla="*/ 0 w 2904"/>
                <a:gd name="T1" fmla="*/ 1425 h 1467"/>
                <a:gd name="T2" fmla="*/ 162 w 2904"/>
                <a:gd name="T3" fmla="*/ 1441 h 1467"/>
                <a:gd name="T4" fmla="*/ 328 w 2904"/>
                <a:gd name="T5" fmla="*/ 1455 h 1467"/>
                <a:gd name="T6" fmla="*/ 495 w 2904"/>
                <a:gd name="T7" fmla="*/ 1465 h 1467"/>
                <a:gd name="T8" fmla="*/ 661 w 2904"/>
                <a:gd name="T9" fmla="*/ 1467 h 1467"/>
                <a:gd name="T10" fmla="*/ 827 w 2904"/>
                <a:gd name="T11" fmla="*/ 1461 h 1467"/>
                <a:gd name="T12" fmla="*/ 994 w 2904"/>
                <a:gd name="T13" fmla="*/ 1443 h 1467"/>
                <a:gd name="T14" fmla="*/ 1160 w 2904"/>
                <a:gd name="T15" fmla="*/ 1411 h 1467"/>
                <a:gd name="T16" fmla="*/ 1326 w 2904"/>
                <a:gd name="T17" fmla="*/ 1364 h 1467"/>
                <a:gd name="T18" fmla="*/ 1493 w 2904"/>
                <a:gd name="T19" fmla="*/ 1299 h 1467"/>
                <a:gd name="T20" fmla="*/ 1659 w 2904"/>
                <a:gd name="T21" fmla="*/ 1215 h 1467"/>
                <a:gd name="T22" fmla="*/ 1825 w 2904"/>
                <a:gd name="T23" fmla="*/ 1109 h 1467"/>
                <a:gd name="T24" fmla="*/ 1992 w 2904"/>
                <a:gd name="T25" fmla="*/ 981 h 1467"/>
                <a:gd name="T26" fmla="*/ 2158 w 2904"/>
                <a:gd name="T27" fmla="*/ 832 h 1467"/>
                <a:gd name="T28" fmla="*/ 2325 w 2904"/>
                <a:gd name="T29" fmla="*/ 665 h 1467"/>
                <a:gd name="T30" fmla="*/ 2491 w 2904"/>
                <a:gd name="T31" fmla="*/ 485 h 1467"/>
                <a:gd name="T32" fmla="*/ 2658 w 2904"/>
                <a:gd name="T33" fmla="*/ 294 h 1467"/>
                <a:gd name="T34" fmla="*/ 2824 w 2904"/>
                <a:gd name="T35" fmla="*/ 97 h 1467"/>
                <a:gd name="T36" fmla="*/ 2904 w 2904"/>
                <a:gd name="T37" fmla="*/ 0 h 14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</a:cxnLst>
              <a:rect l="0" t="0" r="r" b="b"/>
              <a:pathLst>
                <a:path w="2904" h="1467">
                  <a:moveTo>
                    <a:pt x="0" y="1425"/>
                  </a:moveTo>
                  <a:lnTo>
                    <a:pt x="162" y="1441"/>
                  </a:lnTo>
                  <a:lnTo>
                    <a:pt x="328" y="1455"/>
                  </a:lnTo>
                  <a:lnTo>
                    <a:pt x="495" y="1465"/>
                  </a:lnTo>
                  <a:lnTo>
                    <a:pt x="661" y="1467"/>
                  </a:lnTo>
                  <a:lnTo>
                    <a:pt x="827" y="1461"/>
                  </a:lnTo>
                  <a:lnTo>
                    <a:pt x="994" y="1443"/>
                  </a:lnTo>
                  <a:lnTo>
                    <a:pt x="1160" y="1411"/>
                  </a:lnTo>
                  <a:lnTo>
                    <a:pt x="1326" y="1364"/>
                  </a:lnTo>
                  <a:lnTo>
                    <a:pt x="1493" y="1299"/>
                  </a:lnTo>
                  <a:lnTo>
                    <a:pt x="1659" y="1215"/>
                  </a:lnTo>
                  <a:lnTo>
                    <a:pt x="1825" y="1109"/>
                  </a:lnTo>
                  <a:lnTo>
                    <a:pt x="1992" y="981"/>
                  </a:lnTo>
                  <a:lnTo>
                    <a:pt x="2158" y="832"/>
                  </a:lnTo>
                  <a:lnTo>
                    <a:pt x="2325" y="665"/>
                  </a:lnTo>
                  <a:lnTo>
                    <a:pt x="2491" y="485"/>
                  </a:lnTo>
                  <a:lnTo>
                    <a:pt x="2658" y="294"/>
                  </a:lnTo>
                  <a:lnTo>
                    <a:pt x="2824" y="97"/>
                  </a:lnTo>
                  <a:lnTo>
                    <a:pt x="2904" y="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" name="Freeform 51"/>
            <p:cNvSpPr>
              <a:spLocks noEditPoints="1"/>
            </p:cNvSpPr>
            <p:nvPr/>
          </p:nvSpPr>
          <p:spPr bwMode="auto">
            <a:xfrm>
              <a:off x="2271713" y="1948335"/>
              <a:ext cx="4610100" cy="2693988"/>
            </a:xfrm>
            <a:custGeom>
              <a:avLst/>
              <a:gdLst>
                <a:gd name="T0" fmla="*/ 36 w 2904"/>
                <a:gd name="T1" fmla="*/ 1647 h 1697"/>
                <a:gd name="T2" fmla="*/ 120 w 2904"/>
                <a:gd name="T3" fmla="*/ 1654 h 1697"/>
                <a:gd name="T4" fmla="*/ 192 w 2904"/>
                <a:gd name="T5" fmla="*/ 1654 h 1697"/>
                <a:gd name="T6" fmla="*/ 252 w 2904"/>
                <a:gd name="T7" fmla="*/ 1659 h 1697"/>
                <a:gd name="T8" fmla="*/ 287 w 2904"/>
                <a:gd name="T9" fmla="*/ 1662 h 1697"/>
                <a:gd name="T10" fmla="*/ 359 w 2904"/>
                <a:gd name="T11" fmla="*/ 1668 h 1697"/>
                <a:gd name="T12" fmla="*/ 395 w 2904"/>
                <a:gd name="T13" fmla="*/ 1670 h 1697"/>
                <a:gd name="T14" fmla="*/ 466 w 2904"/>
                <a:gd name="T15" fmla="*/ 1681 h 1697"/>
                <a:gd name="T16" fmla="*/ 550 w 2904"/>
                <a:gd name="T17" fmla="*/ 1686 h 1697"/>
                <a:gd name="T18" fmla="*/ 622 w 2904"/>
                <a:gd name="T19" fmla="*/ 1684 h 1697"/>
                <a:gd name="T20" fmla="*/ 682 w 2904"/>
                <a:gd name="T21" fmla="*/ 1687 h 1697"/>
                <a:gd name="T22" fmla="*/ 718 w 2904"/>
                <a:gd name="T23" fmla="*/ 1688 h 1697"/>
                <a:gd name="T24" fmla="*/ 790 w 2904"/>
                <a:gd name="T25" fmla="*/ 1696 h 1697"/>
                <a:gd name="T26" fmla="*/ 826 w 2904"/>
                <a:gd name="T27" fmla="*/ 1691 h 1697"/>
                <a:gd name="T28" fmla="*/ 898 w 2904"/>
                <a:gd name="T29" fmla="*/ 1697 h 1697"/>
                <a:gd name="T30" fmla="*/ 982 w 2904"/>
                <a:gd name="T31" fmla="*/ 1697 h 1697"/>
                <a:gd name="T32" fmla="*/ 1054 w 2904"/>
                <a:gd name="T33" fmla="*/ 1688 h 1697"/>
                <a:gd name="T34" fmla="*/ 1114 w 2904"/>
                <a:gd name="T35" fmla="*/ 1685 h 1697"/>
                <a:gd name="T36" fmla="*/ 1162 w 2904"/>
                <a:gd name="T37" fmla="*/ 1688 h 1697"/>
                <a:gd name="T38" fmla="*/ 1221 w 2904"/>
                <a:gd name="T39" fmla="*/ 1674 h 1697"/>
                <a:gd name="T40" fmla="*/ 1257 w 2904"/>
                <a:gd name="T41" fmla="*/ 1669 h 1697"/>
                <a:gd name="T42" fmla="*/ 1329 w 2904"/>
                <a:gd name="T43" fmla="*/ 1664 h 1697"/>
                <a:gd name="T44" fmla="*/ 1410 w 2904"/>
                <a:gd name="T45" fmla="*/ 1642 h 1697"/>
                <a:gd name="T46" fmla="*/ 1478 w 2904"/>
                <a:gd name="T47" fmla="*/ 1617 h 1697"/>
                <a:gd name="T48" fmla="*/ 1533 w 2904"/>
                <a:gd name="T49" fmla="*/ 1596 h 1697"/>
                <a:gd name="T50" fmla="*/ 1566 w 2904"/>
                <a:gd name="T51" fmla="*/ 1581 h 1697"/>
                <a:gd name="T52" fmla="*/ 1635 w 2904"/>
                <a:gd name="T53" fmla="*/ 1558 h 1697"/>
                <a:gd name="T54" fmla="*/ 1708 w 2904"/>
                <a:gd name="T55" fmla="*/ 1516 h 1697"/>
                <a:gd name="T56" fmla="*/ 1765 w 2904"/>
                <a:gd name="T57" fmla="*/ 1472 h 1697"/>
                <a:gd name="T58" fmla="*/ 1815 w 2904"/>
                <a:gd name="T59" fmla="*/ 1439 h 1697"/>
                <a:gd name="T60" fmla="*/ 1852 w 2904"/>
                <a:gd name="T61" fmla="*/ 1409 h 1697"/>
                <a:gd name="T62" fmla="*/ 1897 w 2904"/>
                <a:gd name="T63" fmla="*/ 1369 h 1697"/>
                <a:gd name="T64" fmla="*/ 1924 w 2904"/>
                <a:gd name="T65" fmla="*/ 1346 h 1697"/>
                <a:gd name="T66" fmla="*/ 1982 w 2904"/>
                <a:gd name="T67" fmla="*/ 1302 h 1697"/>
                <a:gd name="T68" fmla="*/ 2040 w 2904"/>
                <a:gd name="T69" fmla="*/ 1241 h 1697"/>
                <a:gd name="T70" fmla="*/ 2084 w 2904"/>
                <a:gd name="T71" fmla="*/ 1184 h 1697"/>
                <a:gd name="T72" fmla="*/ 2124 w 2904"/>
                <a:gd name="T73" fmla="*/ 1139 h 1697"/>
                <a:gd name="T74" fmla="*/ 2161 w 2904"/>
                <a:gd name="T75" fmla="*/ 1108 h 1697"/>
                <a:gd name="T76" fmla="*/ 2193 w 2904"/>
                <a:gd name="T77" fmla="*/ 1057 h 1697"/>
                <a:gd name="T78" fmla="*/ 2215 w 2904"/>
                <a:gd name="T79" fmla="*/ 1028 h 1697"/>
                <a:gd name="T80" fmla="*/ 2264 w 2904"/>
                <a:gd name="T81" fmla="*/ 975 h 1697"/>
                <a:gd name="T82" fmla="*/ 2316 w 2904"/>
                <a:gd name="T83" fmla="*/ 909 h 1697"/>
                <a:gd name="T84" fmla="*/ 2353 w 2904"/>
                <a:gd name="T85" fmla="*/ 847 h 1697"/>
                <a:gd name="T86" fmla="*/ 2387 w 2904"/>
                <a:gd name="T87" fmla="*/ 798 h 1697"/>
                <a:gd name="T88" fmla="*/ 2408 w 2904"/>
                <a:gd name="T89" fmla="*/ 768 h 1697"/>
                <a:gd name="T90" fmla="*/ 2454 w 2904"/>
                <a:gd name="T91" fmla="*/ 713 h 1697"/>
                <a:gd name="T92" fmla="*/ 2502 w 2904"/>
                <a:gd name="T93" fmla="*/ 644 h 1697"/>
                <a:gd name="T94" fmla="*/ 2536 w 2904"/>
                <a:gd name="T95" fmla="*/ 580 h 1697"/>
                <a:gd name="T96" fmla="*/ 2569 w 2904"/>
                <a:gd name="T97" fmla="*/ 530 h 1697"/>
                <a:gd name="T98" fmla="*/ 2588 w 2904"/>
                <a:gd name="T99" fmla="*/ 499 h 1697"/>
                <a:gd name="T100" fmla="*/ 2632 w 2904"/>
                <a:gd name="T101" fmla="*/ 442 h 1697"/>
                <a:gd name="T102" fmla="*/ 2678 w 2904"/>
                <a:gd name="T103" fmla="*/ 371 h 1697"/>
                <a:gd name="T104" fmla="*/ 2711 w 2904"/>
                <a:gd name="T105" fmla="*/ 307 h 1697"/>
                <a:gd name="T106" fmla="*/ 2742 w 2904"/>
                <a:gd name="T107" fmla="*/ 256 h 1697"/>
                <a:gd name="T108" fmla="*/ 2761 w 2904"/>
                <a:gd name="T109" fmla="*/ 225 h 1697"/>
                <a:gd name="T110" fmla="*/ 2804 w 2904"/>
                <a:gd name="T111" fmla="*/ 167 h 1697"/>
                <a:gd name="T112" fmla="*/ 2818 w 2904"/>
                <a:gd name="T113" fmla="*/ 134 h 1697"/>
                <a:gd name="T114" fmla="*/ 2861 w 2904"/>
                <a:gd name="T115" fmla="*/ 75 h 1697"/>
                <a:gd name="T116" fmla="*/ 2904 w 2904"/>
                <a:gd name="T117" fmla="*/ 3 h 169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</a:cxnLst>
              <a:rect l="0" t="0" r="r" b="b"/>
              <a:pathLst>
                <a:path w="2904" h="1697">
                  <a:moveTo>
                    <a:pt x="0" y="1637"/>
                  </a:moveTo>
                  <a:lnTo>
                    <a:pt x="12" y="1638"/>
                  </a:lnTo>
                  <a:lnTo>
                    <a:pt x="12" y="1644"/>
                  </a:lnTo>
                  <a:lnTo>
                    <a:pt x="0" y="1643"/>
                  </a:lnTo>
                  <a:lnTo>
                    <a:pt x="0" y="1637"/>
                  </a:lnTo>
                  <a:close/>
                  <a:moveTo>
                    <a:pt x="36" y="1641"/>
                  </a:moveTo>
                  <a:lnTo>
                    <a:pt x="48" y="1641"/>
                  </a:lnTo>
                  <a:lnTo>
                    <a:pt x="48" y="1647"/>
                  </a:lnTo>
                  <a:lnTo>
                    <a:pt x="36" y="1647"/>
                  </a:lnTo>
                  <a:lnTo>
                    <a:pt x="36" y="1641"/>
                  </a:lnTo>
                  <a:close/>
                  <a:moveTo>
                    <a:pt x="72" y="1644"/>
                  </a:moveTo>
                  <a:lnTo>
                    <a:pt x="84" y="1645"/>
                  </a:lnTo>
                  <a:lnTo>
                    <a:pt x="84" y="1651"/>
                  </a:lnTo>
                  <a:lnTo>
                    <a:pt x="72" y="1650"/>
                  </a:lnTo>
                  <a:lnTo>
                    <a:pt x="72" y="1644"/>
                  </a:lnTo>
                  <a:close/>
                  <a:moveTo>
                    <a:pt x="108" y="1647"/>
                  </a:moveTo>
                  <a:lnTo>
                    <a:pt x="120" y="1648"/>
                  </a:lnTo>
                  <a:lnTo>
                    <a:pt x="120" y="1654"/>
                  </a:lnTo>
                  <a:lnTo>
                    <a:pt x="108" y="1653"/>
                  </a:lnTo>
                  <a:lnTo>
                    <a:pt x="108" y="1647"/>
                  </a:lnTo>
                  <a:close/>
                  <a:moveTo>
                    <a:pt x="144" y="1650"/>
                  </a:moveTo>
                  <a:lnTo>
                    <a:pt x="156" y="1651"/>
                  </a:lnTo>
                  <a:lnTo>
                    <a:pt x="155" y="1657"/>
                  </a:lnTo>
                  <a:lnTo>
                    <a:pt x="143" y="1656"/>
                  </a:lnTo>
                  <a:lnTo>
                    <a:pt x="144" y="1650"/>
                  </a:lnTo>
                  <a:close/>
                  <a:moveTo>
                    <a:pt x="180" y="1653"/>
                  </a:moveTo>
                  <a:lnTo>
                    <a:pt x="192" y="1654"/>
                  </a:lnTo>
                  <a:lnTo>
                    <a:pt x="191" y="1660"/>
                  </a:lnTo>
                  <a:lnTo>
                    <a:pt x="179" y="1659"/>
                  </a:lnTo>
                  <a:lnTo>
                    <a:pt x="180" y="1653"/>
                  </a:lnTo>
                  <a:close/>
                  <a:moveTo>
                    <a:pt x="216" y="1656"/>
                  </a:moveTo>
                  <a:lnTo>
                    <a:pt x="228" y="1657"/>
                  </a:lnTo>
                  <a:lnTo>
                    <a:pt x="227" y="1663"/>
                  </a:lnTo>
                  <a:lnTo>
                    <a:pt x="215" y="1662"/>
                  </a:lnTo>
                  <a:lnTo>
                    <a:pt x="216" y="1656"/>
                  </a:lnTo>
                  <a:close/>
                  <a:moveTo>
                    <a:pt x="252" y="1659"/>
                  </a:moveTo>
                  <a:lnTo>
                    <a:pt x="264" y="1660"/>
                  </a:lnTo>
                  <a:lnTo>
                    <a:pt x="263" y="1666"/>
                  </a:lnTo>
                  <a:lnTo>
                    <a:pt x="251" y="1665"/>
                  </a:lnTo>
                  <a:lnTo>
                    <a:pt x="252" y="1659"/>
                  </a:lnTo>
                  <a:close/>
                  <a:moveTo>
                    <a:pt x="287" y="1662"/>
                  </a:moveTo>
                  <a:lnTo>
                    <a:pt x="299" y="1663"/>
                  </a:lnTo>
                  <a:lnTo>
                    <a:pt x="299" y="1669"/>
                  </a:lnTo>
                  <a:lnTo>
                    <a:pt x="287" y="1668"/>
                  </a:lnTo>
                  <a:lnTo>
                    <a:pt x="287" y="1662"/>
                  </a:lnTo>
                  <a:close/>
                  <a:moveTo>
                    <a:pt x="323" y="1665"/>
                  </a:moveTo>
                  <a:lnTo>
                    <a:pt x="328" y="1665"/>
                  </a:lnTo>
                  <a:lnTo>
                    <a:pt x="328" y="1665"/>
                  </a:lnTo>
                  <a:lnTo>
                    <a:pt x="335" y="1666"/>
                  </a:lnTo>
                  <a:lnTo>
                    <a:pt x="335" y="1672"/>
                  </a:lnTo>
                  <a:lnTo>
                    <a:pt x="328" y="1671"/>
                  </a:lnTo>
                  <a:lnTo>
                    <a:pt x="323" y="1671"/>
                  </a:lnTo>
                  <a:lnTo>
                    <a:pt x="323" y="1665"/>
                  </a:lnTo>
                  <a:close/>
                  <a:moveTo>
                    <a:pt x="359" y="1668"/>
                  </a:moveTo>
                  <a:lnTo>
                    <a:pt x="371" y="1668"/>
                  </a:lnTo>
                  <a:lnTo>
                    <a:pt x="370" y="1674"/>
                  </a:lnTo>
                  <a:lnTo>
                    <a:pt x="359" y="1674"/>
                  </a:lnTo>
                  <a:lnTo>
                    <a:pt x="359" y="1668"/>
                  </a:lnTo>
                  <a:close/>
                  <a:moveTo>
                    <a:pt x="395" y="1670"/>
                  </a:moveTo>
                  <a:lnTo>
                    <a:pt x="407" y="1671"/>
                  </a:lnTo>
                  <a:lnTo>
                    <a:pt x="406" y="1677"/>
                  </a:lnTo>
                  <a:lnTo>
                    <a:pt x="394" y="1676"/>
                  </a:lnTo>
                  <a:lnTo>
                    <a:pt x="395" y="1670"/>
                  </a:lnTo>
                  <a:close/>
                  <a:moveTo>
                    <a:pt x="431" y="1673"/>
                  </a:moveTo>
                  <a:lnTo>
                    <a:pt x="443" y="1673"/>
                  </a:lnTo>
                  <a:lnTo>
                    <a:pt x="442" y="1679"/>
                  </a:lnTo>
                  <a:lnTo>
                    <a:pt x="430" y="1679"/>
                  </a:lnTo>
                  <a:lnTo>
                    <a:pt x="431" y="1673"/>
                  </a:lnTo>
                  <a:close/>
                  <a:moveTo>
                    <a:pt x="467" y="1675"/>
                  </a:moveTo>
                  <a:lnTo>
                    <a:pt x="479" y="1676"/>
                  </a:lnTo>
                  <a:lnTo>
                    <a:pt x="478" y="1682"/>
                  </a:lnTo>
                  <a:lnTo>
                    <a:pt x="466" y="1681"/>
                  </a:lnTo>
                  <a:lnTo>
                    <a:pt x="467" y="1675"/>
                  </a:lnTo>
                  <a:close/>
                  <a:moveTo>
                    <a:pt x="503" y="1677"/>
                  </a:moveTo>
                  <a:lnTo>
                    <a:pt x="515" y="1678"/>
                  </a:lnTo>
                  <a:lnTo>
                    <a:pt x="514" y="1684"/>
                  </a:lnTo>
                  <a:lnTo>
                    <a:pt x="502" y="1683"/>
                  </a:lnTo>
                  <a:lnTo>
                    <a:pt x="503" y="1677"/>
                  </a:lnTo>
                  <a:close/>
                  <a:moveTo>
                    <a:pt x="538" y="1679"/>
                  </a:moveTo>
                  <a:lnTo>
                    <a:pt x="550" y="1680"/>
                  </a:lnTo>
                  <a:lnTo>
                    <a:pt x="550" y="1686"/>
                  </a:lnTo>
                  <a:lnTo>
                    <a:pt x="538" y="1685"/>
                  </a:lnTo>
                  <a:lnTo>
                    <a:pt x="538" y="1679"/>
                  </a:lnTo>
                  <a:close/>
                  <a:moveTo>
                    <a:pt x="574" y="1682"/>
                  </a:moveTo>
                  <a:lnTo>
                    <a:pt x="586" y="1682"/>
                  </a:lnTo>
                  <a:lnTo>
                    <a:pt x="586" y="1688"/>
                  </a:lnTo>
                  <a:lnTo>
                    <a:pt x="574" y="1688"/>
                  </a:lnTo>
                  <a:lnTo>
                    <a:pt x="574" y="1682"/>
                  </a:lnTo>
                  <a:close/>
                  <a:moveTo>
                    <a:pt x="610" y="1683"/>
                  </a:moveTo>
                  <a:lnTo>
                    <a:pt x="622" y="1684"/>
                  </a:lnTo>
                  <a:lnTo>
                    <a:pt x="622" y="1690"/>
                  </a:lnTo>
                  <a:lnTo>
                    <a:pt x="610" y="1689"/>
                  </a:lnTo>
                  <a:lnTo>
                    <a:pt x="610" y="1683"/>
                  </a:lnTo>
                  <a:close/>
                  <a:moveTo>
                    <a:pt x="646" y="1685"/>
                  </a:moveTo>
                  <a:lnTo>
                    <a:pt x="658" y="1686"/>
                  </a:lnTo>
                  <a:lnTo>
                    <a:pt x="658" y="1692"/>
                  </a:lnTo>
                  <a:lnTo>
                    <a:pt x="646" y="1691"/>
                  </a:lnTo>
                  <a:lnTo>
                    <a:pt x="646" y="1685"/>
                  </a:lnTo>
                  <a:close/>
                  <a:moveTo>
                    <a:pt x="682" y="1687"/>
                  </a:moveTo>
                  <a:lnTo>
                    <a:pt x="694" y="1687"/>
                  </a:lnTo>
                  <a:lnTo>
                    <a:pt x="694" y="1693"/>
                  </a:lnTo>
                  <a:lnTo>
                    <a:pt x="682" y="1693"/>
                  </a:lnTo>
                  <a:lnTo>
                    <a:pt x="682" y="1687"/>
                  </a:lnTo>
                  <a:close/>
                  <a:moveTo>
                    <a:pt x="718" y="1688"/>
                  </a:moveTo>
                  <a:lnTo>
                    <a:pt x="730" y="1688"/>
                  </a:lnTo>
                  <a:lnTo>
                    <a:pt x="730" y="1694"/>
                  </a:lnTo>
                  <a:lnTo>
                    <a:pt x="718" y="1694"/>
                  </a:lnTo>
                  <a:lnTo>
                    <a:pt x="718" y="1688"/>
                  </a:lnTo>
                  <a:close/>
                  <a:moveTo>
                    <a:pt x="754" y="1689"/>
                  </a:moveTo>
                  <a:lnTo>
                    <a:pt x="766" y="1689"/>
                  </a:lnTo>
                  <a:lnTo>
                    <a:pt x="766" y="1695"/>
                  </a:lnTo>
                  <a:lnTo>
                    <a:pt x="754" y="1695"/>
                  </a:lnTo>
                  <a:lnTo>
                    <a:pt x="754" y="1689"/>
                  </a:lnTo>
                  <a:close/>
                  <a:moveTo>
                    <a:pt x="790" y="1690"/>
                  </a:moveTo>
                  <a:lnTo>
                    <a:pt x="802" y="1690"/>
                  </a:lnTo>
                  <a:lnTo>
                    <a:pt x="802" y="1696"/>
                  </a:lnTo>
                  <a:lnTo>
                    <a:pt x="790" y="1696"/>
                  </a:lnTo>
                  <a:lnTo>
                    <a:pt x="790" y="1690"/>
                  </a:lnTo>
                  <a:close/>
                  <a:moveTo>
                    <a:pt x="826" y="1691"/>
                  </a:moveTo>
                  <a:lnTo>
                    <a:pt x="828" y="1691"/>
                  </a:lnTo>
                  <a:lnTo>
                    <a:pt x="827" y="1691"/>
                  </a:lnTo>
                  <a:lnTo>
                    <a:pt x="838" y="1691"/>
                  </a:lnTo>
                  <a:lnTo>
                    <a:pt x="838" y="1697"/>
                  </a:lnTo>
                  <a:lnTo>
                    <a:pt x="827" y="1697"/>
                  </a:lnTo>
                  <a:lnTo>
                    <a:pt x="826" y="1697"/>
                  </a:lnTo>
                  <a:lnTo>
                    <a:pt x="826" y="1691"/>
                  </a:lnTo>
                  <a:close/>
                  <a:moveTo>
                    <a:pt x="862" y="1691"/>
                  </a:moveTo>
                  <a:lnTo>
                    <a:pt x="874" y="1691"/>
                  </a:lnTo>
                  <a:lnTo>
                    <a:pt x="874" y="1697"/>
                  </a:lnTo>
                  <a:lnTo>
                    <a:pt x="862" y="1697"/>
                  </a:lnTo>
                  <a:lnTo>
                    <a:pt x="862" y="1691"/>
                  </a:lnTo>
                  <a:close/>
                  <a:moveTo>
                    <a:pt x="898" y="1691"/>
                  </a:moveTo>
                  <a:lnTo>
                    <a:pt x="910" y="1691"/>
                  </a:lnTo>
                  <a:lnTo>
                    <a:pt x="910" y="1697"/>
                  </a:lnTo>
                  <a:lnTo>
                    <a:pt x="898" y="1697"/>
                  </a:lnTo>
                  <a:lnTo>
                    <a:pt x="898" y="1691"/>
                  </a:lnTo>
                  <a:close/>
                  <a:moveTo>
                    <a:pt x="934" y="1691"/>
                  </a:moveTo>
                  <a:lnTo>
                    <a:pt x="946" y="1691"/>
                  </a:lnTo>
                  <a:lnTo>
                    <a:pt x="946" y="1697"/>
                  </a:lnTo>
                  <a:lnTo>
                    <a:pt x="934" y="1697"/>
                  </a:lnTo>
                  <a:lnTo>
                    <a:pt x="934" y="1691"/>
                  </a:lnTo>
                  <a:close/>
                  <a:moveTo>
                    <a:pt x="970" y="1691"/>
                  </a:moveTo>
                  <a:lnTo>
                    <a:pt x="982" y="1691"/>
                  </a:lnTo>
                  <a:lnTo>
                    <a:pt x="982" y="1697"/>
                  </a:lnTo>
                  <a:lnTo>
                    <a:pt x="970" y="1697"/>
                  </a:lnTo>
                  <a:lnTo>
                    <a:pt x="970" y="1691"/>
                  </a:lnTo>
                  <a:close/>
                  <a:moveTo>
                    <a:pt x="1006" y="1691"/>
                  </a:moveTo>
                  <a:lnTo>
                    <a:pt x="1018" y="1690"/>
                  </a:lnTo>
                  <a:lnTo>
                    <a:pt x="1018" y="1696"/>
                  </a:lnTo>
                  <a:lnTo>
                    <a:pt x="1006" y="1697"/>
                  </a:lnTo>
                  <a:lnTo>
                    <a:pt x="1006" y="1691"/>
                  </a:lnTo>
                  <a:close/>
                  <a:moveTo>
                    <a:pt x="1042" y="1689"/>
                  </a:moveTo>
                  <a:lnTo>
                    <a:pt x="1054" y="1688"/>
                  </a:lnTo>
                  <a:lnTo>
                    <a:pt x="1054" y="1694"/>
                  </a:lnTo>
                  <a:lnTo>
                    <a:pt x="1042" y="1695"/>
                  </a:lnTo>
                  <a:lnTo>
                    <a:pt x="1042" y="1689"/>
                  </a:lnTo>
                  <a:close/>
                  <a:moveTo>
                    <a:pt x="1078" y="1687"/>
                  </a:moveTo>
                  <a:lnTo>
                    <a:pt x="1090" y="1686"/>
                  </a:lnTo>
                  <a:lnTo>
                    <a:pt x="1090" y="1692"/>
                  </a:lnTo>
                  <a:lnTo>
                    <a:pt x="1078" y="1693"/>
                  </a:lnTo>
                  <a:lnTo>
                    <a:pt x="1078" y="1687"/>
                  </a:lnTo>
                  <a:close/>
                  <a:moveTo>
                    <a:pt x="1114" y="1685"/>
                  </a:moveTo>
                  <a:lnTo>
                    <a:pt x="1126" y="1684"/>
                  </a:lnTo>
                  <a:lnTo>
                    <a:pt x="1126" y="1690"/>
                  </a:lnTo>
                  <a:lnTo>
                    <a:pt x="1114" y="1691"/>
                  </a:lnTo>
                  <a:lnTo>
                    <a:pt x="1114" y="1685"/>
                  </a:lnTo>
                  <a:close/>
                  <a:moveTo>
                    <a:pt x="1150" y="1683"/>
                  </a:moveTo>
                  <a:lnTo>
                    <a:pt x="1160" y="1682"/>
                  </a:lnTo>
                  <a:lnTo>
                    <a:pt x="1160" y="1683"/>
                  </a:lnTo>
                  <a:lnTo>
                    <a:pt x="1162" y="1682"/>
                  </a:lnTo>
                  <a:lnTo>
                    <a:pt x="1162" y="1688"/>
                  </a:lnTo>
                  <a:lnTo>
                    <a:pt x="1161" y="1688"/>
                  </a:lnTo>
                  <a:lnTo>
                    <a:pt x="1150" y="1689"/>
                  </a:lnTo>
                  <a:lnTo>
                    <a:pt x="1150" y="1683"/>
                  </a:lnTo>
                  <a:close/>
                  <a:moveTo>
                    <a:pt x="1185" y="1679"/>
                  </a:moveTo>
                  <a:lnTo>
                    <a:pt x="1197" y="1677"/>
                  </a:lnTo>
                  <a:lnTo>
                    <a:pt x="1198" y="1683"/>
                  </a:lnTo>
                  <a:lnTo>
                    <a:pt x="1186" y="1685"/>
                  </a:lnTo>
                  <a:lnTo>
                    <a:pt x="1185" y="1679"/>
                  </a:lnTo>
                  <a:close/>
                  <a:moveTo>
                    <a:pt x="1221" y="1674"/>
                  </a:moveTo>
                  <a:lnTo>
                    <a:pt x="1233" y="1672"/>
                  </a:lnTo>
                  <a:lnTo>
                    <a:pt x="1234" y="1678"/>
                  </a:lnTo>
                  <a:lnTo>
                    <a:pt x="1222" y="1680"/>
                  </a:lnTo>
                  <a:lnTo>
                    <a:pt x="1221" y="1674"/>
                  </a:lnTo>
                  <a:close/>
                  <a:moveTo>
                    <a:pt x="1257" y="1669"/>
                  </a:moveTo>
                  <a:lnTo>
                    <a:pt x="1269" y="1667"/>
                  </a:lnTo>
                  <a:lnTo>
                    <a:pt x="1269" y="1673"/>
                  </a:lnTo>
                  <a:lnTo>
                    <a:pt x="1257" y="1675"/>
                  </a:lnTo>
                  <a:lnTo>
                    <a:pt x="1257" y="1669"/>
                  </a:lnTo>
                  <a:close/>
                  <a:moveTo>
                    <a:pt x="1292" y="1664"/>
                  </a:moveTo>
                  <a:lnTo>
                    <a:pt x="1304" y="1662"/>
                  </a:lnTo>
                  <a:lnTo>
                    <a:pt x="1305" y="1668"/>
                  </a:lnTo>
                  <a:lnTo>
                    <a:pt x="1293" y="1670"/>
                  </a:lnTo>
                  <a:lnTo>
                    <a:pt x="1292" y="1664"/>
                  </a:lnTo>
                  <a:close/>
                  <a:moveTo>
                    <a:pt x="1327" y="1658"/>
                  </a:moveTo>
                  <a:lnTo>
                    <a:pt x="1339" y="1655"/>
                  </a:lnTo>
                  <a:lnTo>
                    <a:pt x="1341" y="1661"/>
                  </a:lnTo>
                  <a:lnTo>
                    <a:pt x="1329" y="1664"/>
                  </a:lnTo>
                  <a:lnTo>
                    <a:pt x="1327" y="1658"/>
                  </a:lnTo>
                  <a:close/>
                  <a:moveTo>
                    <a:pt x="1362" y="1649"/>
                  </a:moveTo>
                  <a:lnTo>
                    <a:pt x="1374" y="1646"/>
                  </a:lnTo>
                  <a:lnTo>
                    <a:pt x="1375" y="1652"/>
                  </a:lnTo>
                  <a:lnTo>
                    <a:pt x="1364" y="1655"/>
                  </a:lnTo>
                  <a:lnTo>
                    <a:pt x="1362" y="1649"/>
                  </a:lnTo>
                  <a:close/>
                  <a:moveTo>
                    <a:pt x="1397" y="1640"/>
                  </a:moveTo>
                  <a:lnTo>
                    <a:pt x="1408" y="1637"/>
                  </a:lnTo>
                  <a:lnTo>
                    <a:pt x="1410" y="1642"/>
                  </a:lnTo>
                  <a:lnTo>
                    <a:pt x="1399" y="1645"/>
                  </a:lnTo>
                  <a:lnTo>
                    <a:pt x="1397" y="1640"/>
                  </a:lnTo>
                  <a:close/>
                  <a:moveTo>
                    <a:pt x="1432" y="1630"/>
                  </a:moveTo>
                  <a:lnTo>
                    <a:pt x="1443" y="1627"/>
                  </a:lnTo>
                  <a:lnTo>
                    <a:pt x="1445" y="1633"/>
                  </a:lnTo>
                  <a:lnTo>
                    <a:pt x="1433" y="1636"/>
                  </a:lnTo>
                  <a:lnTo>
                    <a:pt x="1432" y="1630"/>
                  </a:lnTo>
                  <a:close/>
                  <a:moveTo>
                    <a:pt x="1467" y="1621"/>
                  </a:moveTo>
                  <a:lnTo>
                    <a:pt x="1478" y="1617"/>
                  </a:lnTo>
                  <a:lnTo>
                    <a:pt x="1480" y="1623"/>
                  </a:lnTo>
                  <a:lnTo>
                    <a:pt x="1468" y="1626"/>
                  </a:lnTo>
                  <a:lnTo>
                    <a:pt x="1467" y="1621"/>
                  </a:lnTo>
                  <a:close/>
                  <a:moveTo>
                    <a:pt x="1500" y="1610"/>
                  </a:moveTo>
                  <a:lnTo>
                    <a:pt x="1511" y="1605"/>
                  </a:lnTo>
                  <a:lnTo>
                    <a:pt x="1514" y="1611"/>
                  </a:lnTo>
                  <a:lnTo>
                    <a:pt x="1503" y="1616"/>
                  </a:lnTo>
                  <a:lnTo>
                    <a:pt x="1500" y="1610"/>
                  </a:lnTo>
                  <a:close/>
                  <a:moveTo>
                    <a:pt x="1533" y="1596"/>
                  </a:moveTo>
                  <a:lnTo>
                    <a:pt x="1544" y="1591"/>
                  </a:lnTo>
                  <a:lnTo>
                    <a:pt x="1547" y="1596"/>
                  </a:lnTo>
                  <a:lnTo>
                    <a:pt x="1536" y="1601"/>
                  </a:lnTo>
                  <a:lnTo>
                    <a:pt x="1533" y="1596"/>
                  </a:lnTo>
                  <a:close/>
                  <a:moveTo>
                    <a:pt x="1566" y="1581"/>
                  </a:moveTo>
                  <a:lnTo>
                    <a:pt x="1577" y="1576"/>
                  </a:lnTo>
                  <a:lnTo>
                    <a:pt x="1579" y="1582"/>
                  </a:lnTo>
                  <a:lnTo>
                    <a:pt x="1569" y="1587"/>
                  </a:lnTo>
                  <a:lnTo>
                    <a:pt x="1566" y="1581"/>
                  </a:lnTo>
                  <a:close/>
                  <a:moveTo>
                    <a:pt x="1599" y="1567"/>
                  </a:moveTo>
                  <a:lnTo>
                    <a:pt x="1610" y="1562"/>
                  </a:lnTo>
                  <a:lnTo>
                    <a:pt x="1612" y="1567"/>
                  </a:lnTo>
                  <a:lnTo>
                    <a:pt x="1602" y="1572"/>
                  </a:lnTo>
                  <a:lnTo>
                    <a:pt x="1599" y="1567"/>
                  </a:lnTo>
                  <a:close/>
                  <a:moveTo>
                    <a:pt x="1632" y="1552"/>
                  </a:moveTo>
                  <a:lnTo>
                    <a:pt x="1643" y="1547"/>
                  </a:lnTo>
                  <a:lnTo>
                    <a:pt x="1645" y="1553"/>
                  </a:lnTo>
                  <a:lnTo>
                    <a:pt x="1635" y="1558"/>
                  </a:lnTo>
                  <a:lnTo>
                    <a:pt x="1632" y="1552"/>
                  </a:lnTo>
                  <a:close/>
                  <a:moveTo>
                    <a:pt x="1664" y="1537"/>
                  </a:moveTo>
                  <a:lnTo>
                    <a:pt x="1674" y="1530"/>
                  </a:lnTo>
                  <a:lnTo>
                    <a:pt x="1677" y="1535"/>
                  </a:lnTo>
                  <a:lnTo>
                    <a:pt x="1667" y="1542"/>
                  </a:lnTo>
                  <a:lnTo>
                    <a:pt x="1664" y="1537"/>
                  </a:lnTo>
                  <a:close/>
                  <a:moveTo>
                    <a:pt x="1694" y="1517"/>
                  </a:moveTo>
                  <a:lnTo>
                    <a:pt x="1704" y="1511"/>
                  </a:lnTo>
                  <a:lnTo>
                    <a:pt x="1708" y="1516"/>
                  </a:lnTo>
                  <a:lnTo>
                    <a:pt x="1698" y="1523"/>
                  </a:lnTo>
                  <a:lnTo>
                    <a:pt x="1694" y="1517"/>
                  </a:lnTo>
                  <a:close/>
                  <a:moveTo>
                    <a:pt x="1725" y="1498"/>
                  </a:moveTo>
                  <a:lnTo>
                    <a:pt x="1735" y="1491"/>
                  </a:lnTo>
                  <a:lnTo>
                    <a:pt x="1738" y="1496"/>
                  </a:lnTo>
                  <a:lnTo>
                    <a:pt x="1728" y="1503"/>
                  </a:lnTo>
                  <a:lnTo>
                    <a:pt x="1725" y="1498"/>
                  </a:lnTo>
                  <a:close/>
                  <a:moveTo>
                    <a:pt x="1755" y="1478"/>
                  </a:moveTo>
                  <a:lnTo>
                    <a:pt x="1765" y="1472"/>
                  </a:lnTo>
                  <a:lnTo>
                    <a:pt x="1768" y="1477"/>
                  </a:lnTo>
                  <a:lnTo>
                    <a:pt x="1758" y="1483"/>
                  </a:lnTo>
                  <a:lnTo>
                    <a:pt x="1755" y="1478"/>
                  </a:lnTo>
                  <a:close/>
                  <a:moveTo>
                    <a:pt x="1785" y="1459"/>
                  </a:moveTo>
                  <a:lnTo>
                    <a:pt x="1795" y="1452"/>
                  </a:lnTo>
                  <a:lnTo>
                    <a:pt x="1798" y="1457"/>
                  </a:lnTo>
                  <a:lnTo>
                    <a:pt x="1788" y="1464"/>
                  </a:lnTo>
                  <a:lnTo>
                    <a:pt x="1785" y="1459"/>
                  </a:lnTo>
                  <a:close/>
                  <a:moveTo>
                    <a:pt x="1815" y="1439"/>
                  </a:moveTo>
                  <a:lnTo>
                    <a:pt x="1824" y="1434"/>
                  </a:lnTo>
                  <a:lnTo>
                    <a:pt x="1824" y="1434"/>
                  </a:lnTo>
                  <a:lnTo>
                    <a:pt x="1825" y="1433"/>
                  </a:lnTo>
                  <a:lnTo>
                    <a:pt x="1829" y="1437"/>
                  </a:lnTo>
                  <a:lnTo>
                    <a:pt x="1827" y="1439"/>
                  </a:lnTo>
                  <a:lnTo>
                    <a:pt x="1819" y="1444"/>
                  </a:lnTo>
                  <a:lnTo>
                    <a:pt x="1815" y="1439"/>
                  </a:lnTo>
                  <a:close/>
                  <a:moveTo>
                    <a:pt x="1843" y="1417"/>
                  </a:moveTo>
                  <a:lnTo>
                    <a:pt x="1852" y="1409"/>
                  </a:lnTo>
                  <a:lnTo>
                    <a:pt x="1856" y="1413"/>
                  </a:lnTo>
                  <a:lnTo>
                    <a:pt x="1847" y="1421"/>
                  </a:lnTo>
                  <a:lnTo>
                    <a:pt x="1843" y="1417"/>
                  </a:lnTo>
                  <a:close/>
                  <a:moveTo>
                    <a:pt x="1870" y="1393"/>
                  </a:moveTo>
                  <a:lnTo>
                    <a:pt x="1879" y="1385"/>
                  </a:lnTo>
                  <a:lnTo>
                    <a:pt x="1883" y="1390"/>
                  </a:lnTo>
                  <a:lnTo>
                    <a:pt x="1874" y="1398"/>
                  </a:lnTo>
                  <a:lnTo>
                    <a:pt x="1870" y="1393"/>
                  </a:lnTo>
                  <a:close/>
                  <a:moveTo>
                    <a:pt x="1897" y="1369"/>
                  </a:moveTo>
                  <a:lnTo>
                    <a:pt x="1906" y="1361"/>
                  </a:lnTo>
                  <a:lnTo>
                    <a:pt x="1910" y="1366"/>
                  </a:lnTo>
                  <a:lnTo>
                    <a:pt x="1901" y="1374"/>
                  </a:lnTo>
                  <a:lnTo>
                    <a:pt x="1897" y="1369"/>
                  </a:lnTo>
                  <a:close/>
                  <a:moveTo>
                    <a:pt x="1924" y="1346"/>
                  </a:moveTo>
                  <a:lnTo>
                    <a:pt x="1933" y="1338"/>
                  </a:lnTo>
                  <a:lnTo>
                    <a:pt x="1937" y="1342"/>
                  </a:lnTo>
                  <a:lnTo>
                    <a:pt x="1928" y="1350"/>
                  </a:lnTo>
                  <a:lnTo>
                    <a:pt x="1924" y="1346"/>
                  </a:lnTo>
                  <a:close/>
                  <a:moveTo>
                    <a:pt x="1951" y="1322"/>
                  </a:moveTo>
                  <a:lnTo>
                    <a:pt x="1960" y="1314"/>
                  </a:lnTo>
                  <a:lnTo>
                    <a:pt x="1964" y="1318"/>
                  </a:lnTo>
                  <a:lnTo>
                    <a:pt x="1955" y="1326"/>
                  </a:lnTo>
                  <a:lnTo>
                    <a:pt x="1951" y="1322"/>
                  </a:lnTo>
                  <a:close/>
                  <a:moveTo>
                    <a:pt x="1978" y="1298"/>
                  </a:moveTo>
                  <a:lnTo>
                    <a:pt x="1987" y="1290"/>
                  </a:lnTo>
                  <a:lnTo>
                    <a:pt x="1991" y="1295"/>
                  </a:lnTo>
                  <a:lnTo>
                    <a:pt x="1982" y="1302"/>
                  </a:lnTo>
                  <a:lnTo>
                    <a:pt x="1978" y="1298"/>
                  </a:lnTo>
                  <a:close/>
                  <a:moveTo>
                    <a:pt x="2003" y="1273"/>
                  </a:moveTo>
                  <a:lnTo>
                    <a:pt x="2011" y="1264"/>
                  </a:lnTo>
                  <a:lnTo>
                    <a:pt x="2016" y="1268"/>
                  </a:lnTo>
                  <a:lnTo>
                    <a:pt x="2008" y="1277"/>
                  </a:lnTo>
                  <a:lnTo>
                    <a:pt x="2003" y="1273"/>
                  </a:lnTo>
                  <a:close/>
                  <a:moveTo>
                    <a:pt x="2027" y="1246"/>
                  </a:moveTo>
                  <a:lnTo>
                    <a:pt x="2035" y="1237"/>
                  </a:lnTo>
                  <a:lnTo>
                    <a:pt x="2040" y="1241"/>
                  </a:lnTo>
                  <a:lnTo>
                    <a:pt x="2032" y="1250"/>
                  </a:lnTo>
                  <a:lnTo>
                    <a:pt x="2027" y="1246"/>
                  </a:lnTo>
                  <a:close/>
                  <a:moveTo>
                    <a:pt x="2052" y="1220"/>
                  </a:moveTo>
                  <a:lnTo>
                    <a:pt x="2059" y="1211"/>
                  </a:lnTo>
                  <a:lnTo>
                    <a:pt x="2064" y="1215"/>
                  </a:lnTo>
                  <a:lnTo>
                    <a:pt x="2056" y="1223"/>
                  </a:lnTo>
                  <a:lnTo>
                    <a:pt x="2052" y="1220"/>
                  </a:lnTo>
                  <a:close/>
                  <a:moveTo>
                    <a:pt x="2076" y="1193"/>
                  </a:moveTo>
                  <a:lnTo>
                    <a:pt x="2084" y="1184"/>
                  </a:lnTo>
                  <a:lnTo>
                    <a:pt x="2088" y="1188"/>
                  </a:lnTo>
                  <a:lnTo>
                    <a:pt x="2080" y="1197"/>
                  </a:lnTo>
                  <a:lnTo>
                    <a:pt x="2076" y="1193"/>
                  </a:lnTo>
                  <a:close/>
                  <a:moveTo>
                    <a:pt x="2100" y="1166"/>
                  </a:moveTo>
                  <a:lnTo>
                    <a:pt x="2108" y="1157"/>
                  </a:lnTo>
                  <a:lnTo>
                    <a:pt x="2112" y="1161"/>
                  </a:lnTo>
                  <a:lnTo>
                    <a:pt x="2104" y="1170"/>
                  </a:lnTo>
                  <a:lnTo>
                    <a:pt x="2100" y="1166"/>
                  </a:lnTo>
                  <a:close/>
                  <a:moveTo>
                    <a:pt x="2124" y="1139"/>
                  </a:moveTo>
                  <a:lnTo>
                    <a:pt x="2132" y="1131"/>
                  </a:lnTo>
                  <a:lnTo>
                    <a:pt x="2137" y="1134"/>
                  </a:lnTo>
                  <a:lnTo>
                    <a:pt x="2128" y="1143"/>
                  </a:lnTo>
                  <a:lnTo>
                    <a:pt x="2124" y="1139"/>
                  </a:lnTo>
                  <a:close/>
                  <a:moveTo>
                    <a:pt x="2148" y="1113"/>
                  </a:moveTo>
                  <a:lnTo>
                    <a:pt x="2156" y="1104"/>
                  </a:lnTo>
                  <a:lnTo>
                    <a:pt x="2156" y="1104"/>
                  </a:lnTo>
                  <a:lnTo>
                    <a:pt x="2156" y="1104"/>
                  </a:lnTo>
                  <a:lnTo>
                    <a:pt x="2161" y="1108"/>
                  </a:lnTo>
                  <a:lnTo>
                    <a:pt x="2161" y="1108"/>
                  </a:lnTo>
                  <a:lnTo>
                    <a:pt x="2153" y="1117"/>
                  </a:lnTo>
                  <a:lnTo>
                    <a:pt x="2148" y="1113"/>
                  </a:lnTo>
                  <a:close/>
                  <a:moveTo>
                    <a:pt x="2171" y="1085"/>
                  </a:moveTo>
                  <a:lnTo>
                    <a:pt x="2178" y="1076"/>
                  </a:lnTo>
                  <a:lnTo>
                    <a:pt x="2183" y="1079"/>
                  </a:lnTo>
                  <a:lnTo>
                    <a:pt x="2176" y="1089"/>
                  </a:lnTo>
                  <a:lnTo>
                    <a:pt x="2171" y="1085"/>
                  </a:lnTo>
                  <a:close/>
                  <a:moveTo>
                    <a:pt x="2193" y="1057"/>
                  </a:moveTo>
                  <a:lnTo>
                    <a:pt x="2200" y="1047"/>
                  </a:lnTo>
                  <a:lnTo>
                    <a:pt x="2205" y="1051"/>
                  </a:lnTo>
                  <a:lnTo>
                    <a:pt x="2198" y="1061"/>
                  </a:lnTo>
                  <a:lnTo>
                    <a:pt x="2193" y="1057"/>
                  </a:lnTo>
                  <a:close/>
                  <a:moveTo>
                    <a:pt x="2215" y="1028"/>
                  </a:moveTo>
                  <a:lnTo>
                    <a:pt x="2223" y="1019"/>
                  </a:lnTo>
                  <a:lnTo>
                    <a:pt x="2227" y="1023"/>
                  </a:lnTo>
                  <a:lnTo>
                    <a:pt x="2220" y="1032"/>
                  </a:lnTo>
                  <a:lnTo>
                    <a:pt x="2215" y="1028"/>
                  </a:lnTo>
                  <a:close/>
                  <a:moveTo>
                    <a:pt x="2237" y="1000"/>
                  </a:moveTo>
                  <a:lnTo>
                    <a:pt x="2245" y="990"/>
                  </a:lnTo>
                  <a:lnTo>
                    <a:pt x="2250" y="994"/>
                  </a:lnTo>
                  <a:lnTo>
                    <a:pt x="2242" y="1004"/>
                  </a:lnTo>
                  <a:lnTo>
                    <a:pt x="2237" y="1000"/>
                  </a:lnTo>
                  <a:close/>
                  <a:moveTo>
                    <a:pt x="2259" y="972"/>
                  </a:moveTo>
                  <a:lnTo>
                    <a:pt x="2267" y="962"/>
                  </a:lnTo>
                  <a:lnTo>
                    <a:pt x="2272" y="966"/>
                  </a:lnTo>
                  <a:lnTo>
                    <a:pt x="2264" y="975"/>
                  </a:lnTo>
                  <a:lnTo>
                    <a:pt x="2259" y="972"/>
                  </a:lnTo>
                  <a:close/>
                  <a:moveTo>
                    <a:pt x="2281" y="943"/>
                  </a:moveTo>
                  <a:lnTo>
                    <a:pt x="2289" y="934"/>
                  </a:lnTo>
                  <a:lnTo>
                    <a:pt x="2294" y="937"/>
                  </a:lnTo>
                  <a:lnTo>
                    <a:pt x="2286" y="947"/>
                  </a:lnTo>
                  <a:lnTo>
                    <a:pt x="2281" y="943"/>
                  </a:lnTo>
                  <a:close/>
                  <a:moveTo>
                    <a:pt x="2304" y="915"/>
                  </a:moveTo>
                  <a:lnTo>
                    <a:pt x="2311" y="905"/>
                  </a:lnTo>
                  <a:lnTo>
                    <a:pt x="2316" y="909"/>
                  </a:lnTo>
                  <a:lnTo>
                    <a:pt x="2308" y="918"/>
                  </a:lnTo>
                  <a:lnTo>
                    <a:pt x="2304" y="915"/>
                  </a:lnTo>
                  <a:close/>
                  <a:moveTo>
                    <a:pt x="2325" y="886"/>
                  </a:moveTo>
                  <a:lnTo>
                    <a:pt x="2332" y="876"/>
                  </a:lnTo>
                  <a:lnTo>
                    <a:pt x="2337" y="880"/>
                  </a:lnTo>
                  <a:lnTo>
                    <a:pt x="2330" y="890"/>
                  </a:lnTo>
                  <a:lnTo>
                    <a:pt x="2325" y="886"/>
                  </a:lnTo>
                  <a:close/>
                  <a:moveTo>
                    <a:pt x="2346" y="857"/>
                  </a:moveTo>
                  <a:lnTo>
                    <a:pt x="2353" y="847"/>
                  </a:lnTo>
                  <a:lnTo>
                    <a:pt x="2358" y="851"/>
                  </a:lnTo>
                  <a:lnTo>
                    <a:pt x="2351" y="860"/>
                  </a:lnTo>
                  <a:lnTo>
                    <a:pt x="2346" y="857"/>
                  </a:lnTo>
                  <a:close/>
                  <a:moveTo>
                    <a:pt x="2367" y="827"/>
                  </a:moveTo>
                  <a:lnTo>
                    <a:pt x="2374" y="818"/>
                  </a:lnTo>
                  <a:lnTo>
                    <a:pt x="2379" y="821"/>
                  </a:lnTo>
                  <a:lnTo>
                    <a:pt x="2371" y="831"/>
                  </a:lnTo>
                  <a:lnTo>
                    <a:pt x="2367" y="827"/>
                  </a:lnTo>
                  <a:close/>
                  <a:moveTo>
                    <a:pt x="2387" y="798"/>
                  </a:moveTo>
                  <a:lnTo>
                    <a:pt x="2394" y="788"/>
                  </a:lnTo>
                  <a:lnTo>
                    <a:pt x="2399" y="791"/>
                  </a:lnTo>
                  <a:lnTo>
                    <a:pt x="2392" y="801"/>
                  </a:lnTo>
                  <a:lnTo>
                    <a:pt x="2387" y="798"/>
                  </a:lnTo>
                  <a:close/>
                  <a:moveTo>
                    <a:pt x="2408" y="768"/>
                  </a:moveTo>
                  <a:lnTo>
                    <a:pt x="2415" y="758"/>
                  </a:lnTo>
                  <a:lnTo>
                    <a:pt x="2420" y="762"/>
                  </a:lnTo>
                  <a:lnTo>
                    <a:pt x="2413" y="772"/>
                  </a:lnTo>
                  <a:lnTo>
                    <a:pt x="2408" y="768"/>
                  </a:lnTo>
                  <a:close/>
                  <a:moveTo>
                    <a:pt x="2428" y="739"/>
                  </a:moveTo>
                  <a:lnTo>
                    <a:pt x="2436" y="729"/>
                  </a:lnTo>
                  <a:lnTo>
                    <a:pt x="2440" y="732"/>
                  </a:lnTo>
                  <a:lnTo>
                    <a:pt x="2434" y="742"/>
                  </a:lnTo>
                  <a:lnTo>
                    <a:pt x="2428" y="739"/>
                  </a:lnTo>
                  <a:close/>
                  <a:moveTo>
                    <a:pt x="2449" y="709"/>
                  </a:moveTo>
                  <a:lnTo>
                    <a:pt x="2456" y="699"/>
                  </a:lnTo>
                  <a:lnTo>
                    <a:pt x="2461" y="703"/>
                  </a:lnTo>
                  <a:lnTo>
                    <a:pt x="2454" y="713"/>
                  </a:lnTo>
                  <a:lnTo>
                    <a:pt x="2449" y="709"/>
                  </a:lnTo>
                  <a:close/>
                  <a:moveTo>
                    <a:pt x="2470" y="680"/>
                  </a:moveTo>
                  <a:lnTo>
                    <a:pt x="2477" y="670"/>
                  </a:lnTo>
                  <a:lnTo>
                    <a:pt x="2482" y="673"/>
                  </a:lnTo>
                  <a:lnTo>
                    <a:pt x="2475" y="683"/>
                  </a:lnTo>
                  <a:lnTo>
                    <a:pt x="2470" y="680"/>
                  </a:lnTo>
                  <a:close/>
                  <a:moveTo>
                    <a:pt x="2490" y="650"/>
                  </a:moveTo>
                  <a:lnTo>
                    <a:pt x="2497" y="640"/>
                  </a:lnTo>
                  <a:lnTo>
                    <a:pt x="2502" y="644"/>
                  </a:lnTo>
                  <a:lnTo>
                    <a:pt x="2495" y="654"/>
                  </a:lnTo>
                  <a:lnTo>
                    <a:pt x="2490" y="650"/>
                  </a:lnTo>
                  <a:close/>
                  <a:moveTo>
                    <a:pt x="2510" y="620"/>
                  </a:moveTo>
                  <a:lnTo>
                    <a:pt x="2517" y="610"/>
                  </a:lnTo>
                  <a:lnTo>
                    <a:pt x="2521" y="613"/>
                  </a:lnTo>
                  <a:lnTo>
                    <a:pt x="2515" y="623"/>
                  </a:lnTo>
                  <a:lnTo>
                    <a:pt x="2510" y="620"/>
                  </a:lnTo>
                  <a:close/>
                  <a:moveTo>
                    <a:pt x="2530" y="590"/>
                  </a:moveTo>
                  <a:lnTo>
                    <a:pt x="2536" y="580"/>
                  </a:lnTo>
                  <a:lnTo>
                    <a:pt x="2541" y="583"/>
                  </a:lnTo>
                  <a:lnTo>
                    <a:pt x="2535" y="593"/>
                  </a:lnTo>
                  <a:lnTo>
                    <a:pt x="2530" y="590"/>
                  </a:lnTo>
                  <a:close/>
                  <a:moveTo>
                    <a:pt x="2549" y="560"/>
                  </a:moveTo>
                  <a:lnTo>
                    <a:pt x="2556" y="550"/>
                  </a:lnTo>
                  <a:lnTo>
                    <a:pt x="2561" y="553"/>
                  </a:lnTo>
                  <a:lnTo>
                    <a:pt x="2554" y="563"/>
                  </a:lnTo>
                  <a:lnTo>
                    <a:pt x="2549" y="560"/>
                  </a:lnTo>
                  <a:close/>
                  <a:moveTo>
                    <a:pt x="2569" y="530"/>
                  </a:moveTo>
                  <a:lnTo>
                    <a:pt x="2575" y="519"/>
                  </a:lnTo>
                  <a:lnTo>
                    <a:pt x="2580" y="523"/>
                  </a:lnTo>
                  <a:lnTo>
                    <a:pt x="2574" y="533"/>
                  </a:lnTo>
                  <a:lnTo>
                    <a:pt x="2569" y="530"/>
                  </a:lnTo>
                  <a:close/>
                  <a:moveTo>
                    <a:pt x="2588" y="499"/>
                  </a:moveTo>
                  <a:lnTo>
                    <a:pt x="2595" y="489"/>
                  </a:lnTo>
                  <a:lnTo>
                    <a:pt x="2600" y="492"/>
                  </a:lnTo>
                  <a:lnTo>
                    <a:pt x="2593" y="503"/>
                  </a:lnTo>
                  <a:lnTo>
                    <a:pt x="2588" y="499"/>
                  </a:lnTo>
                  <a:close/>
                  <a:moveTo>
                    <a:pt x="2608" y="469"/>
                  </a:moveTo>
                  <a:lnTo>
                    <a:pt x="2614" y="459"/>
                  </a:lnTo>
                  <a:lnTo>
                    <a:pt x="2620" y="462"/>
                  </a:lnTo>
                  <a:lnTo>
                    <a:pt x="2613" y="473"/>
                  </a:lnTo>
                  <a:lnTo>
                    <a:pt x="2608" y="469"/>
                  </a:lnTo>
                  <a:close/>
                  <a:moveTo>
                    <a:pt x="2628" y="439"/>
                  </a:moveTo>
                  <a:lnTo>
                    <a:pt x="2634" y="429"/>
                  </a:lnTo>
                  <a:lnTo>
                    <a:pt x="2639" y="432"/>
                  </a:lnTo>
                  <a:lnTo>
                    <a:pt x="2632" y="442"/>
                  </a:lnTo>
                  <a:lnTo>
                    <a:pt x="2628" y="439"/>
                  </a:lnTo>
                  <a:close/>
                  <a:moveTo>
                    <a:pt x="2647" y="409"/>
                  </a:moveTo>
                  <a:lnTo>
                    <a:pt x="2654" y="399"/>
                  </a:lnTo>
                  <a:lnTo>
                    <a:pt x="2659" y="402"/>
                  </a:lnTo>
                  <a:lnTo>
                    <a:pt x="2652" y="412"/>
                  </a:lnTo>
                  <a:lnTo>
                    <a:pt x="2647" y="409"/>
                  </a:lnTo>
                  <a:close/>
                  <a:moveTo>
                    <a:pt x="2667" y="378"/>
                  </a:moveTo>
                  <a:lnTo>
                    <a:pt x="2673" y="368"/>
                  </a:lnTo>
                  <a:lnTo>
                    <a:pt x="2678" y="371"/>
                  </a:lnTo>
                  <a:lnTo>
                    <a:pt x="2671" y="381"/>
                  </a:lnTo>
                  <a:lnTo>
                    <a:pt x="2667" y="378"/>
                  </a:lnTo>
                  <a:close/>
                  <a:moveTo>
                    <a:pt x="2685" y="348"/>
                  </a:moveTo>
                  <a:lnTo>
                    <a:pt x="2692" y="338"/>
                  </a:lnTo>
                  <a:lnTo>
                    <a:pt x="2697" y="341"/>
                  </a:lnTo>
                  <a:lnTo>
                    <a:pt x="2691" y="351"/>
                  </a:lnTo>
                  <a:lnTo>
                    <a:pt x="2685" y="348"/>
                  </a:lnTo>
                  <a:close/>
                  <a:moveTo>
                    <a:pt x="2704" y="317"/>
                  </a:moveTo>
                  <a:lnTo>
                    <a:pt x="2711" y="307"/>
                  </a:lnTo>
                  <a:lnTo>
                    <a:pt x="2716" y="310"/>
                  </a:lnTo>
                  <a:lnTo>
                    <a:pt x="2709" y="320"/>
                  </a:lnTo>
                  <a:lnTo>
                    <a:pt x="2704" y="317"/>
                  </a:lnTo>
                  <a:close/>
                  <a:moveTo>
                    <a:pt x="2723" y="287"/>
                  </a:moveTo>
                  <a:lnTo>
                    <a:pt x="2730" y="276"/>
                  </a:lnTo>
                  <a:lnTo>
                    <a:pt x="2735" y="279"/>
                  </a:lnTo>
                  <a:lnTo>
                    <a:pt x="2728" y="290"/>
                  </a:lnTo>
                  <a:lnTo>
                    <a:pt x="2723" y="287"/>
                  </a:lnTo>
                  <a:close/>
                  <a:moveTo>
                    <a:pt x="2742" y="256"/>
                  </a:moveTo>
                  <a:lnTo>
                    <a:pt x="2749" y="246"/>
                  </a:lnTo>
                  <a:lnTo>
                    <a:pt x="2754" y="249"/>
                  </a:lnTo>
                  <a:lnTo>
                    <a:pt x="2747" y="259"/>
                  </a:lnTo>
                  <a:lnTo>
                    <a:pt x="2742" y="256"/>
                  </a:lnTo>
                  <a:close/>
                  <a:moveTo>
                    <a:pt x="2761" y="225"/>
                  </a:moveTo>
                  <a:lnTo>
                    <a:pt x="2767" y="215"/>
                  </a:lnTo>
                  <a:lnTo>
                    <a:pt x="2773" y="218"/>
                  </a:lnTo>
                  <a:lnTo>
                    <a:pt x="2766" y="228"/>
                  </a:lnTo>
                  <a:lnTo>
                    <a:pt x="2761" y="225"/>
                  </a:lnTo>
                  <a:close/>
                  <a:moveTo>
                    <a:pt x="2780" y="195"/>
                  </a:moveTo>
                  <a:lnTo>
                    <a:pt x="2787" y="185"/>
                  </a:lnTo>
                  <a:lnTo>
                    <a:pt x="2792" y="188"/>
                  </a:lnTo>
                  <a:lnTo>
                    <a:pt x="2785" y="198"/>
                  </a:lnTo>
                  <a:lnTo>
                    <a:pt x="2780" y="195"/>
                  </a:lnTo>
                  <a:close/>
                  <a:moveTo>
                    <a:pt x="2799" y="164"/>
                  </a:moveTo>
                  <a:lnTo>
                    <a:pt x="2806" y="154"/>
                  </a:lnTo>
                  <a:lnTo>
                    <a:pt x="2811" y="157"/>
                  </a:lnTo>
                  <a:lnTo>
                    <a:pt x="2804" y="167"/>
                  </a:lnTo>
                  <a:lnTo>
                    <a:pt x="2799" y="164"/>
                  </a:lnTo>
                  <a:close/>
                  <a:moveTo>
                    <a:pt x="2818" y="134"/>
                  </a:moveTo>
                  <a:lnTo>
                    <a:pt x="2821" y="129"/>
                  </a:lnTo>
                  <a:lnTo>
                    <a:pt x="2821" y="129"/>
                  </a:lnTo>
                  <a:lnTo>
                    <a:pt x="2824" y="123"/>
                  </a:lnTo>
                  <a:lnTo>
                    <a:pt x="2830" y="126"/>
                  </a:lnTo>
                  <a:lnTo>
                    <a:pt x="2826" y="132"/>
                  </a:lnTo>
                  <a:lnTo>
                    <a:pt x="2823" y="137"/>
                  </a:lnTo>
                  <a:lnTo>
                    <a:pt x="2818" y="134"/>
                  </a:lnTo>
                  <a:close/>
                  <a:moveTo>
                    <a:pt x="2837" y="103"/>
                  </a:moveTo>
                  <a:lnTo>
                    <a:pt x="2843" y="93"/>
                  </a:lnTo>
                  <a:lnTo>
                    <a:pt x="2848" y="96"/>
                  </a:lnTo>
                  <a:lnTo>
                    <a:pt x="2842" y="106"/>
                  </a:lnTo>
                  <a:lnTo>
                    <a:pt x="2837" y="103"/>
                  </a:lnTo>
                  <a:close/>
                  <a:moveTo>
                    <a:pt x="2856" y="72"/>
                  </a:moveTo>
                  <a:lnTo>
                    <a:pt x="2862" y="62"/>
                  </a:lnTo>
                  <a:lnTo>
                    <a:pt x="2867" y="65"/>
                  </a:lnTo>
                  <a:lnTo>
                    <a:pt x="2861" y="75"/>
                  </a:lnTo>
                  <a:lnTo>
                    <a:pt x="2856" y="72"/>
                  </a:lnTo>
                  <a:close/>
                  <a:moveTo>
                    <a:pt x="2874" y="41"/>
                  </a:moveTo>
                  <a:lnTo>
                    <a:pt x="2880" y="31"/>
                  </a:lnTo>
                  <a:lnTo>
                    <a:pt x="2886" y="34"/>
                  </a:lnTo>
                  <a:lnTo>
                    <a:pt x="2879" y="44"/>
                  </a:lnTo>
                  <a:lnTo>
                    <a:pt x="2874" y="41"/>
                  </a:lnTo>
                  <a:close/>
                  <a:moveTo>
                    <a:pt x="2893" y="11"/>
                  </a:moveTo>
                  <a:lnTo>
                    <a:pt x="2899" y="0"/>
                  </a:lnTo>
                  <a:lnTo>
                    <a:pt x="2904" y="3"/>
                  </a:lnTo>
                  <a:lnTo>
                    <a:pt x="2898" y="14"/>
                  </a:lnTo>
                  <a:lnTo>
                    <a:pt x="2893" y="11"/>
                  </a:lnTo>
                  <a:close/>
                </a:path>
              </a:pathLst>
            </a:custGeom>
            <a:solidFill>
              <a:srgbClr val="000000"/>
            </a:solidFill>
            <a:ln w="6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" name="Freeform 52"/>
            <p:cNvSpPr>
              <a:spLocks noEditPoints="1"/>
            </p:cNvSpPr>
            <p:nvPr/>
          </p:nvSpPr>
          <p:spPr bwMode="auto">
            <a:xfrm>
              <a:off x="2271713" y="1256185"/>
              <a:ext cx="4602163" cy="863600"/>
            </a:xfrm>
            <a:custGeom>
              <a:avLst/>
              <a:gdLst>
                <a:gd name="T0" fmla="*/ 48 w 2899"/>
                <a:gd name="T1" fmla="*/ 451 h 544"/>
                <a:gd name="T2" fmla="*/ 69 w 2899"/>
                <a:gd name="T3" fmla="*/ 463 h 544"/>
                <a:gd name="T4" fmla="*/ 141 w 2899"/>
                <a:gd name="T5" fmla="*/ 474 h 544"/>
                <a:gd name="T6" fmla="*/ 187 w 2899"/>
                <a:gd name="T7" fmla="*/ 489 h 544"/>
                <a:gd name="T8" fmla="*/ 211 w 2899"/>
                <a:gd name="T9" fmla="*/ 488 h 544"/>
                <a:gd name="T10" fmla="*/ 294 w 2899"/>
                <a:gd name="T11" fmla="*/ 505 h 544"/>
                <a:gd name="T12" fmla="*/ 329 w 2899"/>
                <a:gd name="T13" fmla="*/ 512 h 544"/>
                <a:gd name="T14" fmla="*/ 364 w 2899"/>
                <a:gd name="T15" fmla="*/ 523 h 544"/>
                <a:gd name="T16" fmla="*/ 388 w 2899"/>
                <a:gd name="T17" fmla="*/ 520 h 544"/>
                <a:gd name="T18" fmla="*/ 471 w 2899"/>
                <a:gd name="T19" fmla="*/ 531 h 544"/>
                <a:gd name="T20" fmla="*/ 495 w 2899"/>
                <a:gd name="T21" fmla="*/ 540 h 544"/>
                <a:gd name="T22" fmla="*/ 567 w 2899"/>
                <a:gd name="T23" fmla="*/ 535 h 544"/>
                <a:gd name="T24" fmla="*/ 615 w 2899"/>
                <a:gd name="T25" fmla="*/ 543 h 544"/>
                <a:gd name="T26" fmla="*/ 639 w 2899"/>
                <a:gd name="T27" fmla="*/ 537 h 544"/>
                <a:gd name="T28" fmla="*/ 722 w 2899"/>
                <a:gd name="T29" fmla="*/ 531 h 544"/>
                <a:gd name="T30" fmla="*/ 747 w 2899"/>
                <a:gd name="T31" fmla="*/ 534 h 544"/>
                <a:gd name="T32" fmla="*/ 817 w 2899"/>
                <a:gd name="T33" fmla="*/ 520 h 544"/>
                <a:gd name="T34" fmla="*/ 817 w 2899"/>
                <a:gd name="T35" fmla="*/ 520 h 544"/>
                <a:gd name="T36" fmla="*/ 898 w 2899"/>
                <a:gd name="T37" fmla="*/ 498 h 544"/>
                <a:gd name="T38" fmla="*/ 923 w 2899"/>
                <a:gd name="T39" fmla="*/ 497 h 544"/>
                <a:gd name="T40" fmla="*/ 990 w 2899"/>
                <a:gd name="T41" fmla="*/ 471 h 544"/>
                <a:gd name="T42" fmla="*/ 990 w 2899"/>
                <a:gd name="T43" fmla="*/ 471 h 544"/>
                <a:gd name="T44" fmla="*/ 1067 w 2899"/>
                <a:gd name="T45" fmla="*/ 438 h 544"/>
                <a:gd name="T46" fmla="*/ 1091 w 2899"/>
                <a:gd name="T47" fmla="*/ 433 h 544"/>
                <a:gd name="T48" fmla="*/ 1154 w 2899"/>
                <a:gd name="T49" fmla="*/ 399 h 544"/>
                <a:gd name="T50" fmla="*/ 1154 w 2899"/>
                <a:gd name="T51" fmla="*/ 399 h 544"/>
                <a:gd name="T52" fmla="*/ 1228 w 2899"/>
                <a:gd name="T53" fmla="*/ 359 h 544"/>
                <a:gd name="T54" fmla="*/ 1252 w 2899"/>
                <a:gd name="T55" fmla="*/ 353 h 544"/>
                <a:gd name="T56" fmla="*/ 1313 w 2899"/>
                <a:gd name="T57" fmla="*/ 313 h 544"/>
                <a:gd name="T58" fmla="*/ 1358 w 2899"/>
                <a:gd name="T59" fmla="*/ 295 h 544"/>
                <a:gd name="T60" fmla="*/ 1375 w 2899"/>
                <a:gd name="T61" fmla="*/ 279 h 544"/>
                <a:gd name="T62" fmla="*/ 1449 w 2899"/>
                <a:gd name="T63" fmla="*/ 237 h 544"/>
                <a:gd name="T64" fmla="*/ 1473 w 2899"/>
                <a:gd name="T65" fmla="*/ 231 h 544"/>
                <a:gd name="T66" fmla="*/ 1533 w 2899"/>
                <a:gd name="T67" fmla="*/ 191 h 544"/>
                <a:gd name="T68" fmla="*/ 1578 w 2899"/>
                <a:gd name="T69" fmla="*/ 174 h 544"/>
                <a:gd name="T70" fmla="*/ 1597 w 2899"/>
                <a:gd name="T71" fmla="*/ 158 h 544"/>
                <a:gd name="T72" fmla="*/ 1672 w 2899"/>
                <a:gd name="T73" fmla="*/ 120 h 544"/>
                <a:gd name="T74" fmla="*/ 1697 w 2899"/>
                <a:gd name="T75" fmla="*/ 117 h 544"/>
                <a:gd name="T76" fmla="*/ 1761 w 2899"/>
                <a:gd name="T77" fmla="*/ 83 h 544"/>
                <a:gd name="T78" fmla="*/ 1807 w 2899"/>
                <a:gd name="T79" fmla="*/ 70 h 544"/>
                <a:gd name="T80" fmla="*/ 1828 w 2899"/>
                <a:gd name="T81" fmla="*/ 56 h 544"/>
                <a:gd name="T82" fmla="*/ 1909 w 2899"/>
                <a:gd name="T83" fmla="*/ 36 h 544"/>
                <a:gd name="T84" fmla="*/ 1934 w 2899"/>
                <a:gd name="T85" fmla="*/ 36 h 544"/>
                <a:gd name="T86" fmla="*/ 2003 w 2899"/>
                <a:gd name="T87" fmla="*/ 14 h 544"/>
                <a:gd name="T88" fmla="*/ 2052 w 2899"/>
                <a:gd name="T89" fmla="*/ 15 h 544"/>
                <a:gd name="T90" fmla="*/ 2075 w 2899"/>
                <a:gd name="T91" fmla="*/ 7 h 544"/>
                <a:gd name="T92" fmla="*/ 2158 w 2899"/>
                <a:gd name="T93" fmla="*/ 0 h 544"/>
                <a:gd name="T94" fmla="*/ 2183 w 2899"/>
                <a:gd name="T95" fmla="*/ 1 h 544"/>
                <a:gd name="T96" fmla="*/ 2231 w 2899"/>
                <a:gd name="T97" fmla="*/ 9 h 544"/>
                <a:gd name="T98" fmla="*/ 2255 w 2899"/>
                <a:gd name="T99" fmla="*/ 4 h 544"/>
                <a:gd name="T100" fmla="*/ 2339 w 2899"/>
                <a:gd name="T101" fmla="*/ 9 h 544"/>
                <a:gd name="T102" fmla="*/ 2362 w 2899"/>
                <a:gd name="T103" fmla="*/ 18 h 544"/>
                <a:gd name="T104" fmla="*/ 2434 w 2899"/>
                <a:gd name="T105" fmla="*/ 23 h 544"/>
                <a:gd name="T106" fmla="*/ 2481 w 2899"/>
                <a:gd name="T107" fmla="*/ 36 h 544"/>
                <a:gd name="T108" fmla="*/ 2505 w 2899"/>
                <a:gd name="T109" fmla="*/ 34 h 544"/>
                <a:gd name="T110" fmla="*/ 2587 w 2899"/>
                <a:gd name="T111" fmla="*/ 53 h 544"/>
                <a:gd name="T112" fmla="*/ 2609 w 2899"/>
                <a:gd name="T113" fmla="*/ 64 h 544"/>
                <a:gd name="T114" fmla="*/ 2680 w 2899"/>
                <a:gd name="T115" fmla="*/ 76 h 544"/>
                <a:gd name="T116" fmla="*/ 2725 w 2899"/>
                <a:gd name="T117" fmla="*/ 95 h 544"/>
                <a:gd name="T118" fmla="*/ 2750 w 2899"/>
                <a:gd name="T119" fmla="*/ 96 h 544"/>
                <a:gd name="T120" fmla="*/ 2825 w 2899"/>
                <a:gd name="T121" fmla="*/ 117 h 544"/>
                <a:gd name="T122" fmla="*/ 2854 w 2899"/>
                <a:gd name="T123" fmla="*/ 126 h 544"/>
                <a:gd name="T124" fmla="*/ 2898 w 2899"/>
                <a:gd name="T125" fmla="*/ 145 h 5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  <a:cxn ang="0">
                  <a:pos x="T124" y="T125"/>
                </a:cxn>
              </a:cxnLst>
              <a:rect l="0" t="0" r="r" b="b"/>
              <a:pathLst>
                <a:path w="2899" h="544">
                  <a:moveTo>
                    <a:pt x="1" y="440"/>
                  </a:moveTo>
                  <a:lnTo>
                    <a:pt x="12" y="443"/>
                  </a:lnTo>
                  <a:lnTo>
                    <a:pt x="11" y="449"/>
                  </a:lnTo>
                  <a:lnTo>
                    <a:pt x="0" y="446"/>
                  </a:lnTo>
                  <a:lnTo>
                    <a:pt x="1" y="440"/>
                  </a:lnTo>
                  <a:close/>
                  <a:moveTo>
                    <a:pt x="36" y="448"/>
                  </a:moveTo>
                  <a:lnTo>
                    <a:pt x="48" y="451"/>
                  </a:lnTo>
                  <a:lnTo>
                    <a:pt x="46" y="457"/>
                  </a:lnTo>
                  <a:lnTo>
                    <a:pt x="34" y="454"/>
                  </a:lnTo>
                  <a:lnTo>
                    <a:pt x="36" y="448"/>
                  </a:lnTo>
                  <a:close/>
                  <a:moveTo>
                    <a:pt x="71" y="457"/>
                  </a:moveTo>
                  <a:lnTo>
                    <a:pt x="82" y="460"/>
                  </a:lnTo>
                  <a:lnTo>
                    <a:pt x="81" y="465"/>
                  </a:lnTo>
                  <a:lnTo>
                    <a:pt x="69" y="463"/>
                  </a:lnTo>
                  <a:lnTo>
                    <a:pt x="71" y="457"/>
                  </a:lnTo>
                  <a:close/>
                  <a:moveTo>
                    <a:pt x="106" y="465"/>
                  </a:moveTo>
                  <a:lnTo>
                    <a:pt x="118" y="468"/>
                  </a:lnTo>
                  <a:lnTo>
                    <a:pt x="116" y="474"/>
                  </a:lnTo>
                  <a:lnTo>
                    <a:pt x="105" y="471"/>
                  </a:lnTo>
                  <a:lnTo>
                    <a:pt x="106" y="465"/>
                  </a:lnTo>
                  <a:close/>
                  <a:moveTo>
                    <a:pt x="141" y="474"/>
                  </a:moveTo>
                  <a:lnTo>
                    <a:pt x="153" y="476"/>
                  </a:lnTo>
                  <a:lnTo>
                    <a:pt x="151" y="482"/>
                  </a:lnTo>
                  <a:lnTo>
                    <a:pt x="139" y="479"/>
                  </a:lnTo>
                  <a:lnTo>
                    <a:pt x="141" y="474"/>
                  </a:lnTo>
                  <a:close/>
                  <a:moveTo>
                    <a:pt x="176" y="481"/>
                  </a:moveTo>
                  <a:lnTo>
                    <a:pt x="188" y="484"/>
                  </a:lnTo>
                  <a:lnTo>
                    <a:pt x="187" y="489"/>
                  </a:lnTo>
                  <a:lnTo>
                    <a:pt x="175" y="487"/>
                  </a:lnTo>
                  <a:lnTo>
                    <a:pt x="176" y="481"/>
                  </a:lnTo>
                  <a:close/>
                  <a:moveTo>
                    <a:pt x="211" y="488"/>
                  </a:moveTo>
                  <a:lnTo>
                    <a:pt x="223" y="491"/>
                  </a:lnTo>
                  <a:lnTo>
                    <a:pt x="222" y="496"/>
                  </a:lnTo>
                  <a:lnTo>
                    <a:pt x="210" y="494"/>
                  </a:lnTo>
                  <a:lnTo>
                    <a:pt x="211" y="488"/>
                  </a:lnTo>
                  <a:close/>
                  <a:moveTo>
                    <a:pt x="247" y="495"/>
                  </a:moveTo>
                  <a:lnTo>
                    <a:pt x="258" y="498"/>
                  </a:lnTo>
                  <a:lnTo>
                    <a:pt x="257" y="504"/>
                  </a:lnTo>
                  <a:lnTo>
                    <a:pt x="246" y="501"/>
                  </a:lnTo>
                  <a:lnTo>
                    <a:pt x="247" y="495"/>
                  </a:lnTo>
                  <a:close/>
                  <a:moveTo>
                    <a:pt x="282" y="502"/>
                  </a:moveTo>
                  <a:lnTo>
                    <a:pt x="294" y="505"/>
                  </a:lnTo>
                  <a:lnTo>
                    <a:pt x="292" y="511"/>
                  </a:lnTo>
                  <a:lnTo>
                    <a:pt x="281" y="508"/>
                  </a:lnTo>
                  <a:lnTo>
                    <a:pt x="282" y="502"/>
                  </a:lnTo>
                  <a:close/>
                  <a:moveTo>
                    <a:pt x="317" y="510"/>
                  </a:moveTo>
                  <a:lnTo>
                    <a:pt x="329" y="512"/>
                  </a:lnTo>
                  <a:lnTo>
                    <a:pt x="329" y="512"/>
                  </a:lnTo>
                  <a:lnTo>
                    <a:pt x="329" y="512"/>
                  </a:lnTo>
                  <a:lnTo>
                    <a:pt x="328" y="518"/>
                  </a:lnTo>
                  <a:lnTo>
                    <a:pt x="328" y="518"/>
                  </a:lnTo>
                  <a:lnTo>
                    <a:pt x="316" y="516"/>
                  </a:lnTo>
                  <a:lnTo>
                    <a:pt x="317" y="510"/>
                  </a:lnTo>
                  <a:close/>
                  <a:moveTo>
                    <a:pt x="352" y="515"/>
                  </a:moveTo>
                  <a:lnTo>
                    <a:pt x="364" y="517"/>
                  </a:lnTo>
                  <a:lnTo>
                    <a:pt x="364" y="523"/>
                  </a:lnTo>
                  <a:lnTo>
                    <a:pt x="352" y="521"/>
                  </a:lnTo>
                  <a:lnTo>
                    <a:pt x="352" y="515"/>
                  </a:lnTo>
                  <a:close/>
                  <a:moveTo>
                    <a:pt x="388" y="520"/>
                  </a:moveTo>
                  <a:lnTo>
                    <a:pt x="400" y="521"/>
                  </a:lnTo>
                  <a:lnTo>
                    <a:pt x="399" y="527"/>
                  </a:lnTo>
                  <a:lnTo>
                    <a:pt x="387" y="526"/>
                  </a:lnTo>
                  <a:lnTo>
                    <a:pt x="388" y="520"/>
                  </a:lnTo>
                  <a:close/>
                  <a:moveTo>
                    <a:pt x="424" y="524"/>
                  </a:moveTo>
                  <a:lnTo>
                    <a:pt x="436" y="526"/>
                  </a:lnTo>
                  <a:lnTo>
                    <a:pt x="435" y="532"/>
                  </a:lnTo>
                  <a:lnTo>
                    <a:pt x="423" y="530"/>
                  </a:lnTo>
                  <a:lnTo>
                    <a:pt x="424" y="524"/>
                  </a:lnTo>
                  <a:close/>
                  <a:moveTo>
                    <a:pt x="460" y="529"/>
                  </a:moveTo>
                  <a:lnTo>
                    <a:pt x="471" y="531"/>
                  </a:lnTo>
                  <a:lnTo>
                    <a:pt x="471" y="537"/>
                  </a:lnTo>
                  <a:lnTo>
                    <a:pt x="459" y="535"/>
                  </a:lnTo>
                  <a:lnTo>
                    <a:pt x="460" y="529"/>
                  </a:lnTo>
                  <a:close/>
                  <a:moveTo>
                    <a:pt x="495" y="534"/>
                  </a:moveTo>
                  <a:lnTo>
                    <a:pt x="507" y="534"/>
                  </a:lnTo>
                  <a:lnTo>
                    <a:pt x="507" y="540"/>
                  </a:lnTo>
                  <a:lnTo>
                    <a:pt x="495" y="540"/>
                  </a:lnTo>
                  <a:lnTo>
                    <a:pt x="495" y="534"/>
                  </a:lnTo>
                  <a:close/>
                  <a:moveTo>
                    <a:pt x="531" y="535"/>
                  </a:moveTo>
                  <a:lnTo>
                    <a:pt x="543" y="535"/>
                  </a:lnTo>
                  <a:lnTo>
                    <a:pt x="543" y="541"/>
                  </a:lnTo>
                  <a:lnTo>
                    <a:pt x="531" y="541"/>
                  </a:lnTo>
                  <a:lnTo>
                    <a:pt x="531" y="535"/>
                  </a:lnTo>
                  <a:close/>
                  <a:moveTo>
                    <a:pt x="567" y="535"/>
                  </a:moveTo>
                  <a:lnTo>
                    <a:pt x="579" y="536"/>
                  </a:lnTo>
                  <a:lnTo>
                    <a:pt x="579" y="542"/>
                  </a:lnTo>
                  <a:lnTo>
                    <a:pt x="567" y="541"/>
                  </a:lnTo>
                  <a:lnTo>
                    <a:pt x="567" y="535"/>
                  </a:lnTo>
                  <a:close/>
                  <a:moveTo>
                    <a:pt x="603" y="536"/>
                  </a:moveTo>
                  <a:lnTo>
                    <a:pt x="615" y="537"/>
                  </a:lnTo>
                  <a:lnTo>
                    <a:pt x="615" y="543"/>
                  </a:lnTo>
                  <a:lnTo>
                    <a:pt x="603" y="542"/>
                  </a:lnTo>
                  <a:lnTo>
                    <a:pt x="603" y="536"/>
                  </a:lnTo>
                  <a:close/>
                  <a:moveTo>
                    <a:pt x="639" y="537"/>
                  </a:moveTo>
                  <a:lnTo>
                    <a:pt x="651" y="538"/>
                  </a:lnTo>
                  <a:lnTo>
                    <a:pt x="651" y="544"/>
                  </a:lnTo>
                  <a:lnTo>
                    <a:pt x="639" y="543"/>
                  </a:lnTo>
                  <a:lnTo>
                    <a:pt x="639" y="537"/>
                  </a:lnTo>
                  <a:close/>
                  <a:moveTo>
                    <a:pt x="675" y="536"/>
                  </a:moveTo>
                  <a:lnTo>
                    <a:pt x="686" y="535"/>
                  </a:lnTo>
                  <a:lnTo>
                    <a:pt x="687" y="541"/>
                  </a:lnTo>
                  <a:lnTo>
                    <a:pt x="675" y="542"/>
                  </a:lnTo>
                  <a:lnTo>
                    <a:pt x="675" y="536"/>
                  </a:lnTo>
                  <a:close/>
                  <a:moveTo>
                    <a:pt x="710" y="532"/>
                  </a:moveTo>
                  <a:lnTo>
                    <a:pt x="722" y="531"/>
                  </a:lnTo>
                  <a:lnTo>
                    <a:pt x="723" y="537"/>
                  </a:lnTo>
                  <a:lnTo>
                    <a:pt x="711" y="538"/>
                  </a:lnTo>
                  <a:lnTo>
                    <a:pt x="710" y="532"/>
                  </a:lnTo>
                  <a:close/>
                  <a:moveTo>
                    <a:pt x="746" y="528"/>
                  </a:moveTo>
                  <a:lnTo>
                    <a:pt x="758" y="526"/>
                  </a:lnTo>
                  <a:lnTo>
                    <a:pt x="759" y="532"/>
                  </a:lnTo>
                  <a:lnTo>
                    <a:pt x="747" y="534"/>
                  </a:lnTo>
                  <a:lnTo>
                    <a:pt x="746" y="528"/>
                  </a:lnTo>
                  <a:close/>
                  <a:moveTo>
                    <a:pt x="782" y="524"/>
                  </a:moveTo>
                  <a:lnTo>
                    <a:pt x="793" y="522"/>
                  </a:lnTo>
                  <a:lnTo>
                    <a:pt x="794" y="528"/>
                  </a:lnTo>
                  <a:lnTo>
                    <a:pt x="783" y="530"/>
                  </a:lnTo>
                  <a:lnTo>
                    <a:pt x="782" y="524"/>
                  </a:lnTo>
                  <a:close/>
                  <a:moveTo>
                    <a:pt x="817" y="520"/>
                  </a:moveTo>
                  <a:lnTo>
                    <a:pt x="827" y="519"/>
                  </a:lnTo>
                  <a:lnTo>
                    <a:pt x="826" y="519"/>
                  </a:lnTo>
                  <a:lnTo>
                    <a:pt x="829" y="518"/>
                  </a:lnTo>
                  <a:lnTo>
                    <a:pt x="831" y="524"/>
                  </a:lnTo>
                  <a:lnTo>
                    <a:pt x="828" y="525"/>
                  </a:lnTo>
                  <a:lnTo>
                    <a:pt x="818" y="526"/>
                  </a:lnTo>
                  <a:lnTo>
                    <a:pt x="817" y="520"/>
                  </a:lnTo>
                  <a:close/>
                  <a:moveTo>
                    <a:pt x="852" y="511"/>
                  </a:moveTo>
                  <a:lnTo>
                    <a:pt x="864" y="508"/>
                  </a:lnTo>
                  <a:lnTo>
                    <a:pt x="865" y="514"/>
                  </a:lnTo>
                  <a:lnTo>
                    <a:pt x="853" y="517"/>
                  </a:lnTo>
                  <a:lnTo>
                    <a:pt x="852" y="511"/>
                  </a:lnTo>
                  <a:close/>
                  <a:moveTo>
                    <a:pt x="886" y="501"/>
                  </a:moveTo>
                  <a:lnTo>
                    <a:pt x="898" y="498"/>
                  </a:lnTo>
                  <a:lnTo>
                    <a:pt x="900" y="504"/>
                  </a:lnTo>
                  <a:lnTo>
                    <a:pt x="888" y="507"/>
                  </a:lnTo>
                  <a:lnTo>
                    <a:pt x="886" y="501"/>
                  </a:lnTo>
                  <a:close/>
                  <a:moveTo>
                    <a:pt x="921" y="491"/>
                  </a:moveTo>
                  <a:lnTo>
                    <a:pt x="933" y="488"/>
                  </a:lnTo>
                  <a:lnTo>
                    <a:pt x="934" y="494"/>
                  </a:lnTo>
                  <a:lnTo>
                    <a:pt x="923" y="497"/>
                  </a:lnTo>
                  <a:lnTo>
                    <a:pt x="921" y="491"/>
                  </a:lnTo>
                  <a:close/>
                  <a:moveTo>
                    <a:pt x="955" y="481"/>
                  </a:moveTo>
                  <a:lnTo>
                    <a:pt x="967" y="478"/>
                  </a:lnTo>
                  <a:lnTo>
                    <a:pt x="969" y="484"/>
                  </a:lnTo>
                  <a:lnTo>
                    <a:pt x="957" y="487"/>
                  </a:lnTo>
                  <a:lnTo>
                    <a:pt x="955" y="481"/>
                  </a:lnTo>
                  <a:close/>
                  <a:moveTo>
                    <a:pt x="990" y="471"/>
                  </a:moveTo>
                  <a:lnTo>
                    <a:pt x="993" y="471"/>
                  </a:lnTo>
                  <a:lnTo>
                    <a:pt x="993" y="471"/>
                  </a:lnTo>
                  <a:lnTo>
                    <a:pt x="1001" y="467"/>
                  </a:lnTo>
                  <a:lnTo>
                    <a:pt x="1003" y="472"/>
                  </a:lnTo>
                  <a:lnTo>
                    <a:pt x="995" y="476"/>
                  </a:lnTo>
                  <a:lnTo>
                    <a:pt x="992" y="477"/>
                  </a:lnTo>
                  <a:lnTo>
                    <a:pt x="990" y="471"/>
                  </a:lnTo>
                  <a:close/>
                  <a:moveTo>
                    <a:pt x="1023" y="457"/>
                  </a:moveTo>
                  <a:lnTo>
                    <a:pt x="1034" y="452"/>
                  </a:lnTo>
                  <a:lnTo>
                    <a:pt x="1036" y="458"/>
                  </a:lnTo>
                  <a:lnTo>
                    <a:pt x="1025" y="463"/>
                  </a:lnTo>
                  <a:lnTo>
                    <a:pt x="1023" y="457"/>
                  </a:lnTo>
                  <a:close/>
                  <a:moveTo>
                    <a:pt x="1056" y="442"/>
                  </a:moveTo>
                  <a:lnTo>
                    <a:pt x="1067" y="438"/>
                  </a:lnTo>
                  <a:lnTo>
                    <a:pt x="1069" y="443"/>
                  </a:lnTo>
                  <a:lnTo>
                    <a:pt x="1058" y="448"/>
                  </a:lnTo>
                  <a:lnTo>
                    <a:pt x="1056" y="442"/>
                  </a:lnTo>
                  <a:close/>
                  <a:moveTo>
                    <a:pt x="1089" y="428"/>
                  </a:moveTo>
                  <a:lnTo>
                    <a:pt x="1099" y="423"/>
                  </a:lnTo>
                  <a:lnTo>
                    <a:pt x="1102" y="428"/>
                  </a:lnTo>
                  <a:lnTo>
                    <a:pt x="1091" y="433"/>
                  </a:lnTo>
                  <a:lnTo>
                    <a:pt x="1089" y="428"/>
                  </a:lnTo>
                  <a:close/>
                  <a:moveTo>
                    <a:pt x="1122" y="413"/>
                  </a:moveTo>
                  <a:lnTo>
                    <a:pt x="1132" y="408"/>
                  </a:lnTo>
                  <a:lnTo>
                    <a:pt x="1135" y="414"/>
                  </a:lnTo>
                  <a:lnTo>
                    <a:pt x="1124" y="418"/>
                  </a:lnTo>
                  <a:lnTo>
                    <a:pt x="1122" y="413"/>
                  </a:lnTo>
                  <a:close/>
                  <a:moveTo>
                    <a:pt x="1154" y="399"/>
                  </a:moveTo>
                  <a:lnTo>
                    <a:pt x="1159" y="396"/>
                  </a:lnTo>
                  <a:lnTo>
                    <a:pt x="1159" y="397"/>
                  </a:lnTo>
                  <a:lnTo>
                    <a:pt x="1165" y="393"/>
                  </a:lnTo>
                  <a:lnTo>
                    <a:pt x="1168" y="399"/>
                  </a:lnTo>
                  <a:lnTo>
                    <a:pt x="1161" y="402"/>
                  </a:lnTo>
                  <a:lnTo>
                    <a:pt x="1157" y="404"/>
                  </a:lnTo>
                  <a:lnTo>
                    <a:pt x="1154" y="399"/>
                  </a:lnTo>
                  <a:close/>
                  <a:moveTo>
                    <a:pt x="1186" y="382"/>
                  </a:moveTo>
                  <a:lnTo>
                    <a:pt x="1197" y="376"/>
                  </a:lnTo>
                  <a:lnTo>
                    <a:pt x="1200" y="381"/>
                  </a:lnTo>
                  <a:lnTo>
                    <a:pt x="1189" y="387"/>
                  </a:lnTo>
                  <a:lnTo>
                    <a:pt x="1186" y="382"/>
                  </a:lnTo>
                  <a:close/>
                  <a:moveTo>
                    <a:pt x="1218" y="365"/>
                  </a:moveTo>
                  <a:lnTo>
                    <a:pt x="1228" y="359"/>
                  </a:lnTo>
                  <a:lnTo>
                    <a:pt x="1231" y="364"/>
                  </a:lnTo>
                  <a:lnTo>
                    <a:pt x="1221" y="370"/>
                  </a:lnTo>
                  <a:lnTo>
                    <a:pt x="1218" y="365"/>
                  </a:lnTo>
                  <a:close/>
                  <a:moveTo>
                    <a:pt x="1249" y="348"/>
                  </a:moveTo>
                  <a:lnTo>
                    <a:pt x="1260" y="342"/>
                  </a:lnTo>
                  <a:lnTo>
                    <a:pt x="1263" y="347"/>
                  </a:lnTo>
                  <a:lnTo>
                    <a:pt x="1252" y="353"/>
                  </a:lnTo>
                  <a:lnTo>
                    <a:pt x="1249" y="348"/>
                  </a:lnTo>
                  <a:close/>
                  <a:moveTo>
                    <a:pt x="1281" y="331"/>
                  </a:moveTo>
                  <a:lnTo>
                    <a:pt x="1292" y="325"/>
                  </a:lnTo>
                  <a:lnTo>
                    <a:pt x="1294" y="330"/>
                  </a:lnTo>
                  <a:lnTo>
                    <a:pt x="1284" y="336"/>
                  </a:lnTo>
                  <a:lnTo>
                    <a:pt x="1281" y="331"/>
                  </a:lnTo>
                  <a:close/>
                  <a:moveTo>
                    <a:pt x="1313" y="313"/>
                  </a:moveTo>
                  <a:lnTo>
                    <a:pt x="1323" y="308"/>
                  </a:lnTo>
                  <a:lnTo>
                    <a:pt x="1326" y="313"/>
                  </a:lnTo>
                  <a:lnTo>
                    <a:pt x="1316" y="319"/>
                  </a:lnTo>
                  <a:lnTo>
                    <a:pt x="1313" y="313"/>
                  </a:lnTo>
                  <a:close/>
                  <a:moveTo>
                    <a:pt x="1344" y="296"/>
                  </a:moveTo>
                  <a:lnTo>
                    <a:pt x="1355" y="290"/>
                  </a:lnTo>
                  <a:lnTo>
                    <a:pt x="1358" y="295"/>
                  </a:lnTo>
                  <a:lnTo>
                    <a:pt x="1347" y="301"/>
                  </a:lnTo>
                  <a:lnTo>
                    <a:pt x="1344" y="296"/>
                  </a:lnTo>
                  <a:close/>
                  <a:moveTo>
                    <a:pt x="1375" y="279"/>
                  </a:moveTo>
                  <a:lnTo>
                    <a:pt x="1386" y="273"/>
                  </a:lnTo>
                  <a:lnTo>
                    <a:pt x="1389" y="278"/>
                  </a:lnTo>
                  <a:lnTo>
                    <a:pt x="1378" y="284"/>
                  </a:lnTo>
                  <a:lnTo>
                    <a:pt x="1375" y="279"/>
                  </a:lnTo>
                  <a:close/>
                  <a:moveTo>
                    <a:pt x="1407" y="261"/>
                  </a:moveTo>
                  <a:lnTo>
                    <a:pt x="1417" y="255"/>
                  </a:lnTo>
                  <a:lnTo>
                    <a:pt x="1420" y="260"/>
                  </a:lnTo>
                  <a:lnTo>
                    <a:pt x="1410" y="266"/>
                  </a:lnTo>
                  <a:lnTo>
                    <a:pt x="1407" y="261"/>
                  </a:lnTo>
                  <a:close/>
                  <a:moveTo>
                    <a:pt x="1438" y="243"/>
                  </a:moveTo>
                  <a:lnTo>
                    <a:pt x="1449" y="237"/>
                  </a:lnTo>
                  <a:lnTo>
                    <a:pt x="1452" y="243"/>
                  </a:lnTo>
                  <a:lnTo>
                    <a:pt x="1441" y="248"/>
                  </a:lnTo>
                  <a:lnTo>
                    <a:pt x="1438" y="243"/>
                  </a:lnTo>
                  <a:close/>
                  <a:moveTo>
                    <a:pt x="1470" y="225"/>
                  </a:moveTo>
                  <a:lnTo>
                    <a:pt x="1480" y="220"/>
                  </a:lnTo>
                  <a:lnTo>
                    <a:pt x="1483" y="225"/>
                  </a:lnTo>
                  <a:lnTo>
                    <a:pt x="1473" y="231"/>
                  </a:lnTo>
                  <a:lnTo>
                    <a:pt x="1470" y="225"/>
                  </a:lnTo>
                  <a:close/>
                  <a:moveTo>
                    <a:pt x="1501" y="208"/>
                  </a:moveTo>
                  <a:lnTo>
                    <a:pt x="1512" y="202"/>
                  </a:lnTo>
                  <a:lnTo>
                    <a:pt x="1515" y="208"/>
                  </a:lnTo>
                  <a:lnTo>
                    <a:pt x="1504" y="213"/>
                  </a:lnTo>
                  <a:lnTo>
                    <a:pt x="1501" y="208"/>
                  </a:lnTo>
                  <a:close/>
                  <a:moveTo>
                    <a:pt x="1533" y="191"/>
                  </a:moveTo>
                  <a:lnTo>
                    <a:pt x="1544" y="186"/>
                  </a:lnTo>
                  <a:lnTo>
                    <a:pt x="1546" y="191"/>
                  </a:lnTo>
                  <a:lnTo>
                    <a:pt x="1536" y="197"/>
                  </a:lnTo>
                  <a:lnTo>
                    <a:pt x="1533" y="191"/>
                  </a:lnTo>
                  <a:close/>
                  <a:moveTo>
                    <a:pt x="1565" y="175"/>
                  </a:moveTo>
                  <a:lnTo>
                    <a:pt x="1576" y="169"/>
                  </a:lnTo>
                  <a:lnTo>
                    <a:pt x="1578" y="174"/>
                  </a:lnTo>
                  <a:lnTo>
                    <a:pt x="1568" y="180"/>
                  </a:lnTo>
                  <a:lnTo>
                    <a:pt x="1565" y="175"/>
                  </a:lnTo>
                  <a:close/>
                  <a:moveTo>
                    <a:pt x="1597" y="158"/>
                  </a:moveTo>
                  <a:lnTo>
                    <a:pt x="1608" y="153"/>
                  </a:lnTo>
                  <a:lnTo>
                    <a:pt x="1611" y="158"/>
                  </a:lnTo>
                  <a:lnTo>
                    <a:pt x="1600" y="163"/>
                  </a:lnTo>
                  <a:lnTo>
                    <a:pt x="1597" y="158"/>
                  </a:lnTo>
                  <a:close/>
                  <a:moveTo>
                    <a:pt x="1629" y="141"/>
                  </a:moveTo>
                  <a:lnTo>
                    <a:pt x="1639" y="136"/>
                  </a:lnTo>
                  <a:lnTo>
                    <a:pt x="1642" y="141"/>
                  </a:lnTo>
                  <a:lnTo>
                    <a:pt x="1632" y="147"/>
                  </a:lnTo>
                  <a:lnTo>
                    <a:pt x="1629" y="141"/>
                  </a:lnTo>
                  <a:close/>
                  <a:moveTo>
                    <a:pt x="1661" y="125"/>
                  </a:moveTo>
                  <a:lnTo>
                    <a:pt x="1672" y="120"/>
                  </a:lnTo>
                  <a:lnTo>
                    <a:pt x="1675" y="126"/>
                  </a:lnTo>
                  <a:lnTo>
                    <a:pt x="1663" y="130"/>
                  </a:lnTo>
                  <a:lnTo>
                    <a:pt x="1661" y="125"/>
                  </a:lnTo>
                  <a:close/>
                  <a:moveTo>
                    <a:pt x="1695" y="111"/>
                  </a:moveTo>
                  <a:lnTo>
                    <a:pt x="1705" y="106"/>
                  </a:lnTo>
                  <a:lnTo>
                    <a:pt x="1708" y="112"/>
                  </a:lnTo>
                  <a:lnTo>
                    <a:pt x="1697" y="117"/>
                  </a:lnTo>
                  <a:lnTo>
                    <a:pt x="1695" y="111"/>
                  </a:lnTo>
                  <a:close/>
                  <a:moveTo>
                    <a:pt x="1728" y="97"/>
                  </a:moveTo>
                  <a:lnTo>
                    <a:pt x="1739" y="93"/>
                  </a:lnTo>
                  <a:lnTo>
                    <a:pt x="1741" y="98"/>
                  </a:lnTo>
                  <a:lnTo>
                    <a:pt x="1730" y="103"/>
                  </a:lnTo>
                  <a:lnTo>
                    <a:pt x="1728" y="97"/>
                  </a:lnTo>
                  <a:close/>
                  <a:moveTo>
                    <a:pt x="1761" y="83"/>
                  </a:moveTo>
                  <a:lnTo>
                    <a:pt x="1772" y="79"/>
                  </a:lnTo>
                  <a:lnTo>
                    <a:pt x="1774" y="84"/>
                  </a:lnTo>
                  <a:lnTo>
                    <a:pt x="1763" y="89"/>
                  </a:lnTo>
                  <a:lnTo>
                    <a:pt x="1761" y="83"/>
                  </a:lnTo>
                  <a:close/>
                  <a:moveTo>
                    <a:pt x="1794" y="69"/>
                  </a:moveTo>
                  <a:lnTo>
                    <a:pt x="1805" y="65"/>
                  </a:lnTo>
                  <a:lnTo>
                    <a:pt x="1807" y="70"/>
                  </a:lnTo>
                  <a:lnTo>
                    <a:pt x="1797" y="75"/>
                  </a:lnTo>
                  <a:lnTo>
                    <a:pt x="1794" y="69"/>
                  </a:lnTo>
                  <a:close/>
                  <a:moveTo>
                    <a:pt x="1828" y="56"/>
                  </a:moveTo>
                  <a:lnTo>
                    <a:pt x="1840" y="53"/>
                  </a:lnTo>
                  <a:lnTo>
                    <a:pt x="1841" y="59"/>
                  </a:lnTo>
                  <a:lnTo>
                    <a:pt x="1830" y="62"/>
                  </a:lnTo>
                  <a:lnTo>
                    <a:pt x="1828" y="56"/>
                  </a:lnTo>
                  <a:close/>
                  <a:moveTo>
                    <a:pt x="1863" y="47"/>
                  </a:moveTo>
                  <a:lnTo>
                    <a:pt x="1875" y="44"/>
                  </a:lnTo>
                  <a:lnTo>
                    <a:pt x="1876" y="50"/>
                  </a:lnTo>
                  <a:lnTo>
                    <a:pt x="1864" y="53"/>
                  </a:lnTo>
                  <a:lnTo>
                    <a:pt x="1863" y="47"/>
                  </a:lnTo>
                  <a:close/>
                  <a:moveTo>
                    <a:pt x="1898" y="38"/>
                  </a:moveTo>
                  <a:lnTo>
                    <a:pt x="1909" y="36"/>
                  </a:lnTo>
                  <a:lnTo>
                    <a:pt x="1911" y="41"/>
                  </a:lnTo>
                  <a:lnTo>
                    <a:pt x="1899" y="44"/>
                  </a:lnTo>
                  <a:lnTo>
                    <a:pt x="1898" y="38"/>
                  </a:lnTo>
                  <a:close/>
                  <a:moveTo>
                    <a:pt x="1933" y="30"/>
                  </a:moveTo>
                  <a:lnTo>
                    <a:pt x="1944" y="27"/>
                  </a:lnTo>
                  <a:lnTo>
                    <a:pt x="1946" y="33"/>
                  </a:lnTo>
                  <a:lnTo>
                    <a:pt x="1934" y="36"/>
                  </a:lnTo>
                  <a:lnTo>
                    <a:pt x="1933" y="30"/>
                  </a:lnTo>
                  <a:close/>
                  <a:moveTo>
                    <a:pt x="1968" y="21"/>
                  </a:moveTo>
                  <a:lnTo>
                    <a:pt x="1979" y="18"/>
                  </a:lnTo>
                  <a:lnTo>
                    <a:pt x="1981" y="24"/>
                  </a:lnTo>
                  <a:lnTo>
                    <a:pt x="1969" y="27"/>
                  </a:lnTo>
                  <a:lnTo>
                    <a:pt x="1968" y="21"/>
                  </a:lnTo>
                  <a:close/>
                  <a:moveTo>
                    <a:pt x="2003" y="14"/>
                  </a:moveTo>
                  <a:lnTo>
                    <a:pt x="2015" y="13"/>
                  </a:lnTo>
                  <a:lnTo>
                    <a:pt x="2016" y="19"/>
                  </a:lnTo>
                  <a:lnTo>
                    <a:pt x="2004" y="20"/>
                  </a:lnTo>
                  <a:lnTo>
                    <a:pt x="2003" y="14"/>
                  </a:lnTo>
                  <a:close/>
                  <a:moveTo>
                    <a:pt x="2039" y="10"/>
                  </a:moveTo>
                  <a:lnTo>
                    <a:pt x="2051" y="9"/>
                  </a:lnTo>
                  <a:lnTo>
                    <a:pt x="2052" y="15"/>
                  </a:lnTo>
                  <a:lnTo>
                    <a:pt x="2040" y="16"/>
                  </a:lnTo>
                  <a:lnTo>
                    <a:pt x="2039" y="10"/>
                  </a:lnTo>
                  <a:close/>
                  <a:moveTo>
                    <a:pt x="2075" y="7"/>
                  </a:moveTo>
                  <a:lnTo>
                    <a:pt x="2087" y="6"/>
                  </a:lnTo>
                  <a:lnTo>
                    <a:pt x="2088" y="12"/>
                  </a:lnTo>
                  <a:lnTo>
                    <a:pt x="2076" y="13"/>
                  </a:lnTo>
                  <a:lnTo>
                    <a:pt x="2075" y="7"/>
                  </a:lnTo>
                  <a:close/>
                  <a:moveTo>
                    <a:pt x="2111" y="4"/>
                  </a:moveTo>
                  <a:lnTo>
                    <a:pt x="2123" y="3"/>
                  </a:lnTo>
                  <a:lnTo>
                    <a:pt x="2123" y="9"/>
                  </a:lnTo>
                  <a:lnTo>
                    <a:pt x="2111" y="10"/>
                  </a:lnTo>
                  <a:lnTo>
                    <a:pt x="2111" y="4"/>
                  </a:lnTo>
                  <a:close/>
                  <a:moveTo>
                    <a:pt x="2147" y="1"/>
                  </a:moveTo>
                  <a:lnTo>
                    <a:pt x="2158" y="0"/>
                  </a:lnTo>
                  <a:lnTo>
                    <a:pt x="2159" y="0"/>
                  </a:lnTo>
                  <a:lnTo>
                    <a:pt x="2159" y="6"/>
                  </a:lnTo>
                  <a:lnTo>
                    <a:pt x="2158" y="6"/>
                  </a:lnTo>
                  <a:lnTo>
                    <a:pt x="2158" y="6"/>
                  </a:lnTo>
                  <a:lnTo>
                    <a:pt x="2147" y="7"/>
                  </a:lnTo>
                  <a:lnTo>
                    <a:pt x="2147" y="1"/>
                  </a:lnTo>
                  <a:close/>
                  <a:moveTo>
                    <a:pt x="2183" y="1"/>
                  </a:moveTo>
                  <a:lnTo>
                    <a:pt x="2195" y="1"/>
                  </a:lnTo>
                  <a:lnTo>
                    <a:pt x="2195" y="7"/>
                  </a:lnTo>
                  <a:lnTo>
                    <a:pt x="2183" y="7"/>
                  </a:lnTo>
                  <a:lnTo>
                    <a:pt x="2183" y="1"/>
                  </a:lnTo>
                  <a:close/>
                  <a:moveTo>
                    <a:pt x="2219" y="2"/>
                  </a:moveTo>
                  <a:lnTo>
                    <a:pt x="2231" y="3"/>
                  </a:lnTo>
                  <a:lnTo>
                    <a:pt x="2231" y="9"/>
                  </a:lnTo>
                  <a:lnTo>
                    <a:pt x="2219" y="8"/>
                  </a:lnTo>
                  <a:lnTo>
                    <a:pt x="2219" y="2"/>
                  </a:lnTo>
                  <a:close/>
                  <a:moveTo>
                    <a:pt x="2255" y="4"/>
                  </a:moveTo>
                  <a:lnTo>
                    <a:pt x="2267" y="4"/>
                  </a:lnTo>
                  <a:lnTo>
                    <a:pt x="2267" y="10"/>
                  </a:lnTo>
                  <a:lnTo>
                    <a:pt x="2255" y="10"/>
                  </a:lnTo>
                  <a:lnTo>
                    <a:pt x="2255" y="4"/>
                  </a:lnTo>
                  <a:close/>
                  <a:moveTo>
                    <a:pt x="2291" y="5"/>
                  </a:moveTo>
                  <a:lnTo>
                    <a:pt x="2303" y="6"/>
                  </a:lnTo>
                  <a:lnTo>
                    <a:pt x="2302" y="12"/>
                  </a:lnTo>
                  <a:lnTo>
                    <a:pt x="2290" y="11"/>
                  </a:lnTo>
                  <a:lnTo>
                    <a:pt x="2291" y="5"/>
                  </a:lnTo>
                  <a:close/>
                  <a:moveTo>
                    <a:pt x="2327" y="7"/>
                  </a:moveTo>
                  <a:lnTo>
                    <a:pt x="2339" y="9"/>
                  </a:lnTo>
                  <a:lnTo>
                    <a:pt x="2338" y="15"/>
                  </a:lnTo>
                  <a:lnTo>
                    <a:pt x="2326" y="13"/>
                  </a:lnTo>
                  <a:lnTo>
                    <a:pt x="2327" y="7"/>
                  </a:lnTo>
                  <a:close/>
                  <a:moveTo>
                    <a:pt x="2363" y="12"/>
                  </a:moveTo>
                  <a:lnTo>
                    <a:pt x="2374" y="14"/>
                  </a:lnTo>
                  <a:lnTo>
                    <a:pt x="2374" y="20"/>
                  </a:lnTo>
                  <a:lnTo>
                    <a:pt x="2362" y="18"/>
                  </a:lnTo>
                  <a:lnTo>
                    <a:pt x="2363" y="12"/>
                  </a:lnTo>
                  <a:close/>
                  <a:moveTo>
                    <a:pt x="2398" y="18"/>
                  </a:moveTo>
                  <a:lnTo>
                    <a:pt x="2410" y="19"/>
                  </a:lnTo>
                  <a:lnTo>
                    <a:pt x="2409" y="25"/>
                  </a:lnTo>
                  <a:lnTo>
                    <a:pt x="2397" y="24"/>
                  </a:lnTo>
                  <a:lnTo>
                    <a:pt x="2398" y="18"/>
                  </a:lnTo>
                  <a:close/>
                  <a:moveTo>
                    <a:pt x="2434" y="23"/>
                  </a:moveTo>
                  <a:lnTo>
                    <a:pt x="2446" y="25"/>
                  </a:lnTo>
                  <a:lnTo>
                    <a:pt x="2445" y="31"/>
                  </a:lnTo>
                  <a:lnTo>
                    <a:pt x="2433" y="29"/>
                  </a:lnTo>
                  <a:lnTo>
                    <a:pt x="2434" y="23"/>
                  </a:lnTo>
                  <a:close/>
                  <a:moveTo>
                    <a:pt x="2470" y="28"/>
                  </a:moveTo>
                  <a:lnTo>
                    <a:pt x="2481" y="30"/>
                  </a:lnTo>
                  <a:lnTo>
                    <a:pt x="2481" y="36"/>
                  </a:lnTo>
                  <a:lnTo>
                    <a:pt x="2469" y="34"/>
                  </a:lnTo>
                  <a:lnTo>
                    <a:pt x="2470" y="28"/>
                  </a:lnTo>
                  <a:close/>
                  <a:moveTo>
                    <a:pt x="2505" y="34"/>
                  </a:moveTo>
                  <a:lnTo>
                    <a:pt x="2517" y="37"/>
                  </a:lnTo>
                  <a:lnTo>
                    <a:pt x="2515" y="43"/>
                  </a:lnTo>
                  <a:lnTo>
                    <a:pt x="2504" y="40"/>
                  </a:lnTo>
                  <a:lnTo>
                    <a:pt x="2505" y="34"/>
                  </a:lnTo>
                  <a:close/>
                  <a:moveTo>
                    <a:pt x="2540" y="43"/>
                  </a:moveTo>
                  <a:lnTo>
                    <a:pt x="2552" y="45"/>
                  </a:lnTo>
                  <a:lnTo>
                    <a:pt x="2551" y="51"/>
                  </a:lnTo>
                  <a:lnTo>
                    <a:pt x="2539" y="48"/>
                  </a:lnTo>
                  <a:lnTo>
                    <a:pt x="2540" y="43"/>
                  </a:lnTo>
                  <a:close/>
                  <a:moveTo>
                    <a:pt x="2575" y="51"/>
                  </a:moveTo>
                  <a:lnTo>
                    <a:pt x="2587" y="53"/>
                  </a:lnTo>
                  <a:lnTo>
                    <a:pt x="2586" y="59"/>
                  </a:lnTo>
                  <a:lnTo>
                    <a:pt x="2574" y="57"/>
                  </a:lnTo>
                  <a:lnTo>
                    <a:pt x="2575" y="51"/>
                  </a:lnTo>
                  <a:close/>
                  <a:moveTo>
                    <a:pt x="2610" y="59"/>
                  </a:moveTo>
                  <a:lnTo>
                    <a:pt x="2622" y="61"/>
                  </a:lnTo>
                  <a:lnTo>
                    <a:pt x="2621" y="67"/>
                  </a:lnTo>
                  <a:lnTo>
                    <a:pt x="2609" y="64"/>
                  </a:lnTo>
                  <a:lnTo>
                    <a:pt x="2610" y="59"/>
                  </a:lnTo>
                  <a:close/>
                  <a:moveTo>
                    <a:pt x="2646" y="67"/>
                  </a:moveTo>
                  <a:lnTo>
                    <a:pt x="2657" y="69"/>
                  </a:lnTo>
                  <a:lnTo>
                    <a:pt x="2656" y="75"/>
                  </a:lnTo>
                  <a:lnTo>
                    <a:pt x="2644" y="73"/>
                  </a:lnTo>
                  <a:lnTo>
                    <a:pt x="2646" y="67"/>
                  </a:lnTo>
                  <a:close/>
                  <a:moveTo>
                    <a:pt x="2680" y="76"/>
                  </a:moveTo>
                  <a:lnTo>
                    <a:pt x="2692" y="79"/>
                  </a:lnTo>
                  <a:lnTo>
                    <a:pt x="2691" y="85"/>
                  </a:lnTo>
                  <a:lnTo>
                    <a:pt x="2679" y="82"/>
                  </a:lnTo>
                  <a:lnTo>
                    <a:pt x="2680" y="76"/>
                  </a:lnTo>
                  <a:close/>
                  <a:moveTo>
                    <a:pt x="2715" y="86"/>
                  </a:moveTo>
                  <a:lnTo>
                    <a:pt x="2727" y="89"/>
                  </a:lnTo>
                  <a:lnTo>
                    <a:pt x="2725" y="95"/>
                  </a:lnTo>
                  <a:lnTo>
                    <a:pt x="2713" y="91"/>
                  </a:lnTo>
                  <a:lnTo>
                    <a:pt x="2715" y="86"/>
                  </a:lnTo>
                  <a:close/>
                  <a:moveTo>
                    <a:pt x="2750" y="96"/>
                  </a:moveTo>
                  <a:lnTo>
                    <a:pt x="2761" y="99"/>
                  </a:lnTo>
                  <a:lnTo>
                    <a:pt x="2760" y="105"/>
                  </a:lnTo>
                  <a:lnTo>
                    <a:pt x="2748" y="101"/>
                  </a:lnTo>
                  <a:lnTo>
                    <a:pt x="2750" y="96"/>
                  </a:lnTo>
                  <a:close/>
                  <a:moveTo>
                    <a:pt x="2784" y="105"/>
                  </a:moveTo>
                  <a:lnTo>
                    <a:pt x="2796" y="109"/>
                  </a:lnTo>
                  <a:lnTo>
                    <a:pt x="2794" y="114"/>
                  </a:lnTo>
                  <a:lnTo>
                    <a:pt x="2783" y="111"/>
                  </a:lnTo>
                  <a:lnTo>
                    <a:pt x="2784" y="105"/>
                  </a:lnTo>
                  <a:close/>
                  <a:moveTo>
                    <a:pt x="2819" y="115"/>
                  </a:moveTo>
                  <a:lnTo>
                    <a:pt x="2825" y="117"/>
                  </a:lnTo>
                  <a:lnTo>
                    <a:pt x="2831" y="118"/>
                  </a:lnTo>
                  <a:lnTo>
                    <a:pt x="2829" y="124"/>
                  </a:lnTo>
                  <a:lnTo>
                    <a:pt x="2823" y="123"/>
                  </a:lnTo>
                  <a:lnTo>
                    <a:pt x="2823" y="123"/>
                  </a:lnTo>
                  <a:lnTo>
                    <a:pt x="2817" y="121"/>
                  </a:lnTo>
                  <a:lnTo>
                    <a:pt x="2819" y="115"/>
                  </a:lnTo>
                  <a:close/>
                  <a:moveTo>
                    <a:pt x="2854" y="126"/>
                  </a:moveTo>
                  <a:lnTo>
                    <a:pt x="2865" y="129"/>
                  </a:lnTo>
                  <a:lnTo>
                    <a:pt x="2863" y="135"/>
                  </a:lnTo>
                  <a:lnTo>
                    <a:pt x="2852" y="132"/>
                  </a:lnTo>
                  <a:lnTo>
                    <a:pt x="2854" y="126"/>
                  </a:lnTo>
                  <a:close/>
                  <a:moveTo>
                    <a:pt x="2888" y="136"/>
                  </a:moveTo>
                  <a:lnTo>
                    <a:pt x="2899" y="140"/>
                  </a:lnTo>
                  <a:lnTo>
                    <a:pt x="2898" y="145"/>
                  </a:lnTo>
                  <a:lnTo>
                    <a:pt x="2886" y="142"/>
                  </a:lnTo>
                  <a:lnTo>
                    <a:pt x="2888" y="136"/>
                  </a:lnTo>
                  <a:close/>
                </a:path>
              </a:pathLst>
            </a:custGeom>
            <a:solidFill>
              <a:srgbClr val="000000"/>
            </a:solidFill>
            <a:ln w="6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sp>
        <p:nvSpPr>
          <p:cNvPr id="6" name="Freeform 53"/>
          <p:cNvSpPr>
            <a:spLocks noEditPoints="1"/>
          </p:cNvSpPr>
          <p:nvPr/>
        </p:nvSpPr>
        <p:spPr bwMode="auto">
          <a:xfrm>
            <a:off x="2266951" y="678671"/>
            <a:ext cx="4610100" cy="3838575"/>
          </a:xfrm>
          <a:custGeom>
            <a:avLst/>
            <a:gdLst>
              <a:gd name="T0" fmla="*/ 0 w 2904"/>
              <a:gd name="T1" fmla="*/ 2418 h 2418"/>
              <a:gd name="T2" fmla="*/ 0 w 2904"/>
              <a:gd name="T3" fmla="*/ 0 h 2418"/>
              <a:gd name="T4" fmla="*/ 2904 w 2904"/>
              <a:gd name="T5" fmla="*/ 2418 h 2418"/>
              <a:gd name="T6" fmla="*/ 0 w 2904"/>
              <a:gd name="T7" fmla="*/ 2418 h 241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904" h="2418">
                <a:moveTo>
                  <a:pt x="0" y="2418"/>
                </a:moveTo>
                <a:lnTo>
                  <a:pt x="0" y="0"/>
                </a:lnTo>
                <a:moveTo>
                  <a:pt x="2904" y="2418"/>
                </a:moveTo>
                <a:lnTo>
                  <a:pt x="0" y="2418"/>
                </a:lnTo>
              </a:path>
            </a:pathLst>
          </a:custGeom>
          <a:noFill/>
          <a:ln w="6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grpSp>
        <p:nvGrpSpPr>
          <p:cNvPr id="7" name="グループ化 6"/>
          <p:cNvGrpSpPr/>
          <p:nvPr/>
        </p:nvGrpSpPr>
        <p:grpSpPr>
          <a:xfrm>
            <a:off x="2643964" y="4535011"/>
            <a:ext cx="4088276" cy="327180"/>
            <a:chOff x="2643964" y="4722000"/>
            <a:chExt cx="4088276" cy="327180"/>
          </a:xfrm>
        </p:grpSpPr>
        <p:grpSp>
          <p:nvGrpSpPr>
            <p:cNvPr id="8" name="グループ化 7"/>
            <p:cNvGrpSpPr/>
            <p:nvPr/>
          </p:nvGrpSpPr>
          <p:grpSpPr>
            <a:xfrm>
              <a:off x="2816805" y="4722000"/>
              <a:ext cx="3707821" cy="57150"/>
              <a:chOff x="2816805" y="5208717"/>
              <a:chExt cx="3707821" cy="57150"/>
            </a:xfrm>
          </p:grpSpPr>
          <p:sp>
            <p:nvSpPr>
              <p:cNvPr id="17" name="Line 9"/>
              <p:cNvSpPr>
                <a:spLocks noChangeShapeType="1"/>
              </p:cNvSpPr>
              <p:nvPr/>
            </p:nvSpPr>
            <p:spPr bwMode="auto">
              <a:xfrm>
                <a:off x="2816805" y="5208717"/>
                <a:ext cx="0" cy="57150"/>
              </a:xfrm>
              <a:prstGeom prst="line">
                <a:avLst/>
              </a:prstGeom>
              <a:noFill/>
              <a:ln w="6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endParaRPr>
              </a:p>
            </p:txBody>
          </p:sp>
          <p:sp>
            <p:nvSpPr>
              <p:cNvPr id="18" name="Line 15"/>
              <p:cNvSpPr>
                <a:spLocks noChangeShapeType="1"/>
              </p:cNvSpPr>
              <p:nvPr/>
            </p:nvSpPr>
            <p:spPr bwMode="auto">
              <a:xfrm>
                <a:off x="3686176" y="5208717"/>
                <a:ext cx="0" cy="57150"/>
              </a:xfrm>
              <a:prstGeom prst="line">
                <a:avLst/>
              </a:prstGeom>
              <a:noFill/>
              <a:ln w="6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endParaRPr>
              </a:p>
            </p:txBody>
          </p:sp>
          <p:sp>
            <p:nvSpPr>
              <p:cNvPr id="19" name="Line 19"/>
              <p:cNvSpPr>
                <a:spLocks noChangeShapeType="1"/>
              </p:cNvSpPr>
              <p:nvPr/>
            </p:nvSpPr>
            <p:spPr bwMode="auto">
              <a:xfrm>
                <a:off x="4391026" y="5208717"/>
                <a:ext cx="0" cy="57150"/>
              </a:xfrm>
              <a:prstGeom prst="line">
                <a:avLst/>
              </a:prstGeom>
              <a:noFill/>
              <a:ln w="6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endParaRPr>
              </a:p>
            </p:txBody>
          </p:sp>
          <p:sp>
            <p:nvSpPr>
              <p:cNvPr id="20" name="Line 21"/>
              <p:cNvSpPr>
                <a:spLocks noChangeShapeType="1"/>
              </p:cNvSpPr>
              <p:nvPr/>
            </p:nvSpPr>
            <p:spPr bwMode="auto">
              <a:xfrm>
                <a:off x="4887035" y="5208717"/>
                <a:ext cx="0" cy="57150"/>
              </a:xfrm>
              <a:prstGeom prst="line">
                <a:avLst/>
              </a:prstGeom>
              <a:noFill/>
              <a:ln w="6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endParaRPr>
              </a:p>
            </p:txBody>
          </p:sp>
          <p:sp>
            <p:nvSpPr>
              <p:cNvPr id="21" name="Line 25"/>
              <p:cNvSpPr>
                <a:spLocks noChangeShapeType="1"/>
              </p:cNvSpPr>
              <p:nvPr/>
            </p:nvSpPr>
            <p:spPr bwMode="auto">
              <a:xfrm>
                <a:off x="5382090" y="5208717"/>
                <a:ext cx="0" cy="57150"/>
              </a:xfrm>
              <a:prstGeom prst="line">
                <a:avLst/>
              </a:prstGeom>
              <a:noFill/>
              <a:ln w="6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endParaRPr>
              </a:p>
            </p:txBody>
          </p:sp>
          <p:sp>
            <p:nvSpPr>
              <p:cNvPr id="22" name="Line 27"/>
              <p:cNvSpPr>
                <a:spLocks noChangeShapeType="1"/>
              </p:cNvSpPr>
              <p:nvPr/>
            </p:nvSpPr>
            <p:spPr bwMode="auto">
              <a:xfrm>
                <a:off x="5810251" y="5208717"/>
                <a:ext cx="0" cy="57150"/>
              </a:xfrm>
              <a:prstGeom prst="line">
                <a:avLst/>
              </a:prstGeom>
              <a:noFill/>
              <a:ln w="6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endParaRPr>
              </a:p>
            </p:txBody>
          </p:sp>
          <p:sp>
            <p:nvSpPr>
              <p:cNvPr id="23" name="Line 29"/>
              <p:cNvSpPr>
                <a:spLocks noChangeShapeType="1"/>
              </p:cNvSpPr>
              <p:nvPr/>
            </p:nvSpPr>
            <p:spPr bwMode="auto">
              <a:xfrm>
                <a:off x="6192180" y="5208717"/>
                <a:ext cx="0" cy="57150"/>
              </a:xfrm>
              <a:prstGeom prst="line">
                <a:avLst/>
              </a:prstGeom>
              <a:noFill/>
              <a:ln w="6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endParaRPr>
              </a:p>
            </p:txBody>
          </p:sp>
          <p:sp>
            <p:nvSpPr>
              <p:cNvPr id="24" name="Line 31"/>
              <p:cNvSpPr>
                <a:spLocks noChangeShapeType="1"/>
              </p:cNvSpPr>
              <p:nvPr/>
            </p:nvSpPr>
            <p:spPr bwMode="auto">
              <a:xfrm>
                <a:off x="6524626" y="5208717"/>
                <a:ext cx="0" cy="57150"/>
              </a:xfrm>
              <a:prstGeom prst="line">
                <a:avLst/>
              </a:prstGeom>
              <a:noFill/>
              <a:ln w="6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endParaRPr>
              </a:p>
            </p:txBody>
          </p:sp>
        </p:grpSp>
        <p:sp>
          <p:nvSpPr>
            <p:cNvPr id="9" name="テキスト ボックス 8"/>
            <p:cNvSpPr txBox="1"/>
            <p:nvPr/>
          </p:nvSpPr>
          <p:spPr>
            <a:xfrm>
              <a:off x="2643964" y="4772181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0.6</a:t>
              </a:r>
              <a:endParaRPr kumimoji="1" lang="ja-JP" altLang="en-US" sz="1200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10" name="テキスト ボックス 9"/>
            <p:cNvSpPr txBox="1"/>
            <p:nvPr/>
          </p:nvSpPr>
          <p:spPr>
            <a:xfrm>
              <a:off x="3499059" y="4772181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0.8</a:t>
              </a:r>
              <a:endParaRPr kumimoji="1" lang="ja-JP" altLang="en-US" sz="1200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11" name="テキスト ボックス 10"/>
            <p:cNvSpPr txBox="1"/>
            <p:nvPr/>
          </p:nvSpPr>
          <p:spPr>
            <a:xfrm>
              <a:off x="4219139" y="4772181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1</a:t>
              </a:r>
              <a:r>
                <a:rPr kumimoji="1" lang="en-US" altLang="ja-JP" sz="1200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.0</a:t>
              </a:r>
              <a:endParaRPr kumimoji="1" lang="ja-JP" altLang="en-US" sz="1200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12" name="テキスト ボックス 11"/>
            <p:cNvSpPr txBox="1"/>
            <p:nvPr/>
          </p:nvSpPr>
          <p:spPr>
            <a:xfrm>
              <a:off x="4714194" y="4772181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1</a:t>
              </a:r>
              <a:r>
                <a:rPr kumimoji="1" lang="en-US" altLang="ja-JP" sz="1200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.2</a:t>
              </a:r>
              <a:endParaRPr kumimoji="1" lang="ja-JP" altLang="en-US" sz="1200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13" name="テキスト ボックス 12"/>
            <p:cNvSpPr txBox="1"/>
            <p:nvPr/>
          </p:nvSpPr>
          <p:spPr>
            <a:xfrm>
              <a:off x="5209249" y="4772181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1</a:t>
              </a:r>
              <a:r>
                <a:rPr kumimoji="1" lang="en-US" altLang="ja-JP" sz="1200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.4</a:t>
              </a:r>
              <a:endParaRPr kumimoji="1" lang="ja-JP" altLang="en-US" sz="1200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14" name="テキスト ボックス 13"/>
            <p:cNvSpPr txBox="1"/>
            <p:nvPr/>
          </p:nvSpPr>
          <p:spPr>
            <a:xfrm>
              <a:off x="5614294" y="4772181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1</a:t>
              </a:r>
              <a:r>
                <a:rPr kumimoji="1" lang="en-US" altLang="ja-JP" sz="1200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.6</a:t>
              </a:r>
              <a:endParaRPr kumimoji="1" lang="ja-JP" altLang="en-US" sz="1200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15" name="テキスト ボックス 14"/>
            <p:cNvSpPr txBox="1"/>
            <p:nvPr/>
          </p:nvSpPr>
          <p:spPr>
            <a:xfrm>
              <a:off x="6019339" y="4772181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1</a:t>
              </a:r>
              <a:r>
                <a:rPr kumimoji="1" lang="en-US" altLang="ja-JP" sz="1200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.8</a:t>
              </a:r>
              <a:endParaRPr kumimoji="1" lang="ja-JP" altLang="en-US" sz="1200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16" name="テキスト ボックス 15"/>
            <p:cNvSpPr txBox="1"/>
            <p:nvPr/>
          </p:nvSpPr>
          <p:spPr>
            <a:xfrm>
              <a:off x="6334374" y="4772181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2</a:t>
              </a:r>
              <a:r>
                <a:rPr kumimoji="1" lang="en-US" altLang="ja-JP" sz="1200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.0</a:t>
              </a:r>
              <a:endParaRPr kumimoji="1" lang="ja-JP" altLang="en-US" sz="1200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</p:grpSp>
      <p:grpSp>
        <p:nvGrpSpPr>
          <p:cNvPr id="25" name="グループ化 24"/>
          <p:cNvGrpSpPr/>
          <p:nvPr/>
        </p:nvGrpSpPr>
        <p:grpSpPr>
          <a:xfrm>
            <a:off x="1866734" y="676726"/>
            <a:ext cx="410011" cy="3825425"/>
            <a:chOff x="1608849" y="863715"/>
            <a:chExt cx="410011" cy="3825425"/>
          </a:xfrm>
        </p:grpSpPr>
        <p:grpSp>
          <p:nvGrpSpPr>
            <p:cNvPr id="26" name="グループ化 25"/>
            <p:cNvGrpSpPr/>
            <p:nvPr/>
          </p:nvGrpSpPr>
          <p:grpSpPr>
            <a:xfrm>
              <a:off x="1961710" y="1017252"/>
              <a:ext cx="57150" cy="3533776"/>
              <a:chOff x="2176733" y="1017252"/>
              <a:chExt cx="57150" cy="3533776"/>
            </a:xfrm>
          </p:grpSpPr>
          <p:sp>
            <p:nvSpPr>
              <p:cNvPr id="35" name="Line 35"/>
              <p:cNvSpPr>
                <a:spLocks noChangeShapeType="1"/>
              </p:cNvSpPr>
              <p:nvPr/>
            </p:nvSpPr>
            <p:spPr bwMode="auto">
              <a:xfrm flipH="1">
                <a:off x="2176733" y="4551028"/>
                <a:ext cx="57150" cy="0"/>
              </a:xfrm>
              <a:prstGeom prst="line">
                <a:avLst/>
              </a:prstGeom>
              <a:noFill/>
              <a:ln w="6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endParaRPr>
              </a:p>
            </p:txBody>
          </p:sp>
          <p:sp>
            <p:nvSpPr>
              <p:cNvPr id="36" name="Line 37"/>
              <p:cNvSpPr>
                <a:spLocks noChangeShapeType="1"/>
              </p:cNvSpPr>
              <p:nvPr/>
            </p:nvSpPr>
            <p:spPr bwMode="auto">
              <a:xfrm flipH="1">
                <a:off x="2176733" y="3960478"/>
                <a:ext cx="57150" cy="0"/>
              </a:xfrm>
              <a:prstGeom prst="line">
                <a:avLst/>
              </a:prstGeom>
              <a:noFill/>
              <a:ln w="6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endParaRPr>
              </a:p>
            </p:txBody>
          </p:sp>
          <p:sp>
            <p:nvSpPr>
              <p:cNvPr id="37" name="Line 39"/>
              <p:cNvSpPr>
                <a:spLocks noChangeShapeType="1"/>
              </p:cNvSpPr>
              <p:nvPr/>
            </p:nvSpPr>
            <p:spPr bwMode="auto">
              <a:xfrm flipH="1">
                <a:off x="2176733" y="3369928"/>
                <a:ext cx="57150" cy="0"/>
              </a:xfrm>
              <a:prstGeom prst="line">
                <a:avLst/>
              </a:prstGeom>
              <a:noFill/>
              <a:ln w="6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endParaRPr>
              </a:p>
            </p:txBody>
          </p:sp>
          <p:sp>
            <p:nvSpPr>
              <p:cNvPr id="38" name="Line 41"/>
              <p:cNvSpPr>
                <a:spLocks noChangeShapeType="1"/>
              </p:cNvSpPr>
              <p:nvPr/>
            </p:nvSpPr>
            <p:spPr bwMode="auto">
              <a:xfrm flipH="1">
                <a:off x="2176733" y="2779378"/>
                <a:ext cx="57150" cy="0"/>
              </a:xfrm>
              <a:prstGeom prst="line">
                <a:avLst/>
              </a:prstGeom>
              <a:noFill/>
              <a:ln w="6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endParaRPr>
              </a:p>
            </p:txBody>
          </p:sp>
          <p:sp>
            <p:nvSpPr>
              <p:cNvPr id="39" name="Line 43"/>
              <p:cNvSpPr>
                <a:spLocks noChangeShapeType="1"/>
              </p:cNvSpPr>
              <p:nvPr/>
            </p:nvSpPr>
            <p:spPr bwMode="auto">
              <a:xfrm flipH="1">
                <a:off x="2176733" y="2188828"/>
                <a:ext cx="57150" cy="0"/>
              </a:xfrm>
              <a:prstGeom prst="line">
                <a:avLst/>
              </a:prstGeom>
              <a:noFill/>
              <a:ln w="6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endParaRPr>
              </a:p>
            </p:txBody>
          </p:sp>
          <p:sp>
            <p:nvSpPr>
              <p:cNvPr id="40" name="Line 45"/>
              <p:cNvSpPr>
                <a:spLocks noChangeShapeType="1"/>
              </p:cNvSpPr>
              <p:nvPr/>
            </p:nvSpPr>
            <p:spPr bwMode="auto">
              <a:xfrm flipH="1">
                <a:off x="2176733" y="1598278"/>
                <a:ext cx="57150" cy="0"/>
              </a:xfrm>
              <a:prstGeom prst="line">
                <a:avLst/>
              </a:prstGeom>
              <a:noFill/>
              <a:ln w="6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endParaRPr>
              </a:p>
            </p:txBody>
          </p:sp>
          <p:sp>
            <p:nvSpPr>
              <p:cNvPr id="41" name="Line 47"/>
              <p:cNvSpPr>
                <a:spLocks noChangeShapeType="1"/>
              </p:cNvSpPr>
              <p:nvPr/>
            </p:nvSpPr>
            <p:spPr bwMode="auto">
              <a:xfrm flipH="1">
                <a:off x="2176733" y="1017252"/>
                <a:ext cx="57150" cy="0"/>
              </a:xfrm>
              <a:prstGeom prst="line">
                <a:avLst/>
              </a:prstGeom>
              <a:noFill/>
              <a:ln w="6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endParaRPr>
              </a:p>
            </p:txBody>
          </p:sp>
        </p:grpSp>
        <p:grpSp>
          <p:nvGrpSpPr>
            <p:cNvPr id="27" name="グループ化 26"/>
            <p:cNvGrpSpPr/>
            <p:nvPr/>
          </p:nvGrpSpPr>
          <p:grpSpPr>
            <a:xfrm>
              <a:off x="1608849" y="863715"/>
              <a:ext cx="397866" cy="3825425"/>
              <a:chOff x="1608849" y="863715"/>
              <a:chExt cx="397866" cy="3825425"/>
            </a:xfrm>
          </p:grpSpPr>
          <p:sp>
            <p:nvSpPr>
              <p:cNvPr id="28" name="テキスト ボックス 27"/>
              <p:cNvSpPr txBox="1"/>
              <p:nvPr/>
            </p:nvSpPr>
            <p:spPr>
              <a:xfrm>
                <a:off x="1672969" y="4412141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 smtClean="0">
                    <a:latin typeface="Arial Unicode MS" pitchFamily="50" charset="-128"/>
                    <a:ea typeface="Arial Unicode MS" pitchFamily="50" charset="-128"/>
                    <a:cs typeface="Arial Unicode MS" pitchFamily="50" charset="-128"/>
                  </a:rPr>
                  <a:t>0</a:t>
                </a:r>
                <a:endParaRPr kumimoji="1" lang="ja-JP" altLang="en-US" sz="1200" dirty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endParaRPr>
              </a:p>
            </p:txBody>
          </p:sp>
          <p:sp>
            <p:nvSpPr>
              <p:cNvPr id="29" name="テキスト ボックス 28"/>
              <p:cNvSpPr txBox="1"/>
              <p:nvPr/>
            </p:nvSpPr>
            <p:spPr>
              <a:xfrm>
                <a:off x="1608849" y="3820735"/>
                <a:ext cx="397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 smtClean="0">
                    <a:latin typeface="Arial Unicode MS" pitchFamily="50" charset="-128"/>
                    <a:ea typeface="Arial Unicode MS" pitchFamily="50" charset="-128"/>
                    <a:cs typeface="Arial Unicode MS" pitchFamily="50" charset="-128"/>
                  </a:rPr>
                  <a:t>0.2</a:t>
                </a:r>
                <a:endParaRPr kumimoji="1" lang="ja-JP" altLang="en-US" sz="1200" dirty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endParaRPr>
              </a:p>
            </p:txBody>
          </p:sp>
          <p:sp>
            <p:nvSpPr>
              <p:cNvPr id="30" name="テキスト ボックス 29"/>
              <p:cNvSpPr txBox="1"/>
              <p:nvPr/>
            </p:nvSpPr>
            <p:spPr>
              <a:xfrm>
                <a:off x="1608849" y="3229331"/>
                <a:ext cx="397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 smtClean="0">
                    <a:latin typeface="Arial Unicode MS" pitchFamily="50" charset="-128"/>
                    <a:ea typeface="Arial Unicode MS" pitchFamily="50" charset="-128"/>
                    <a:cs typeface="Arial Unicode MS" pitchFamily="50" charset="-128"/>
                  </a:rPr>
                  <a:t>0.4</a:t>
                </a:r>
                <a:endParaRPr kumimoji="1" lang="ja-JP" altLang="en-US" sz="1200" dirty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endParaRPr>
              </a:p>
            </p:txBody>
          </p:sp>
          <p:sp>
            <p:nvSpPr>
              <p:cNvPr id="31" name="テキスト ボックス 30"/>
              <p:cNvSpPr txBox="1"/>
              <p:nvPr/>
            </p:nvSpPr>
            <p:spPr>
              <a:xfrm>
                <a:off x="1608849" y="2637927"/>
                <a:ext cx="397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 smtClean="0">
                    <a:latin typeface="Arial Unicode MS" pitchFamily="50" charset="-128"/>
                    <a:ea typeface="Arial Unicode MS" pitchFamily="50" charset="-128"/>
                    <a:cs typeface="Arial Unicode MS" pitchFamily="50" charset="-128"/>
                  </a:rPr>
                  <a:t>0.6</a:t>
                </a:r>
                <a:endParaRPr kumimoji="1" lang="ja-JP" altLang="en-US" sz="1200" dirty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endParaRPr>
              </a:p>
            </p:txBody>
          </p:sp>
          <p:sp>
            <p:nvSpPr>
              <p:cNvPr id="32" name="テキスト ボックス 31"/>
              <p:cNvSpPr txBox="1"/>
              <p:nvPr/>
            </p:nvSpPr>
            <p:spPr>
              <a:xfrm>
                <a:off x="1608849" y="2046523"/>
                <a:ext cx="397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 smtClean="0">
                    <a:latin typeface="Arial Unicode MS" pitchFamily="50" charset="-128"/>
                    <a:ea typeface="Arial Unicode MS" pitchFamily="50" charset="-128"/>
                    <a:cs typeface="Arial Unicode MS" pitchFamily="50" charset="-128"/>
                  </a:rPr>
                  <a:t>0.8</a:t>
                </a:r>
                <a:endParaRPr kumimoji="1" lang="ja-JP" altLang="en-US" sz="1200" dirty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endParaRPr>
              </a:p>
            </p:txBody>
          </p:sp>
          <p:sp>
            <p:nvSpPr>
              <p:cNvPr id="33" name="テキスト ボックス 32"/>
              <p:cNvSpPr txBox="1"/>
              <p:nvPr/>
            </p:nvSpPr>
            <p:spPr>
              <a:xfrm>
                <a:off x="1608849" y="1455119"/>
                <a:ext cx="397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dirty="0" smtClean="0">
                    <a:latin typeface="Arial Unicode MS" pitchFamily="50" charset="-128"/>
                    <a:ea typeface="Arial Unicode MS" pitchFamily="50" charset="-128"/>
                    <a:cs typeface="Arial Unicode MS" pitchFamily="50" charset="-128"/>
                  </a:rPr>
                  <a:t>1</a:t>
                </a:r>
                <a:r>
                  <a:rPr kumimoji="1" lang="en-US" altLang="ja-JP" sz="1200" dirty="0" smtClean="0">
                    <a:latin typeface="Arial Unicode MS" pitchFamily="50" charset="-128"/>
                    <a:ea typeface="Arial Unicode MS" pitchFamily="50" charset="-128"/>
                    <a:cs typeface="Arial Unicode MS" pitchFamily="50" charset="-128"/>
                  </a:rPr>
                  <a:t>.0</a:t>
                </a:r>
                <a:endParaRPr kumimoji="1" lang="ja-JP" altLang="en-US" sz="1200" dirty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endParaRPr>
              </a:p>
            </p:txBody>
          </p:sp>
          <p:sp>
            <p:nvSpPr>
              <p:cNvPr id="34" name="テキスト ボックス 33"/>
              <p:cNvSpPr txBox="1"/>
              <p:nvPr/>
            </p:nvSpPr>
            <p:spPr>
              <a:xfrm>
                <a:off x="1608849" y="863715"/>
                <a:ext cx="397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dirty="0">
                    <a:latin typeface="Arial Unicode MS" pitchFamily="50" charset="-128"/>
                    <a:ea typeface="Arial Unicode MS" pitchFamily="50" charset="-128"/>
                    <a:cs typeface="Arial Unicode MS" pitchFamily="50" charset="-128"/>
                  </a:rPr>
                  <a:t>1</a:t>
                </a:r>
                <a:r>
                  <a:rPr kumimoji="1" lang="en-US" altLang="ja-JP" sz="1200" dirty="0" smtClean="0">
                    <a:latin typeface="Arial Unicode MS" pitchFamily="50" charset="-128"/>
                    <a:ea typeface="Arial Unicode MS" pitchFamily="50" charset="-128"/>
                    <a:cs typeface="Arial Unicode MS" pitchFamily="50" charset="-128"/>
                  </a:rPr>
                  <a:t>.2</a:t>
                </a:r>
                <a:endParaRPr kumimoji="1" lang="ja-JP" altLang="en-US" sz="1200" dirty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endParaRPr>
              </a:p>
            </p:txBody>
          </p:sp>
        </p:grpSp>
      </p:grpSp>
      <p:sp>
        <p:nvSpPr>
          <p:cNvPr id="42" name="テキスト ボックス 41"/>
          <p:cNvSpPr txBox="1"/>
          <p:nvPr/>
        </p:nvSpPr>
        <p:spPr>
          <a:xfrm rot="16200000">
            <a:off x="734432" y="2327810"/>
            <a:ext cx="19255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Risk</a:t>
            </a:r>
            <a:r>
              <a:rPr kumimoji="1" lang="en-US" altLang="ja-JP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r</a:t>
            </a:r>
            <a:r>
              <a:rPr kumimoji="1" lang="en-US" altLang="ja-JP" sz="1200" dirty="0" smtClean="0">
                <a:latin typeface="Arial" pitchFamily="34" charset="0"/>
                <a:cs typeface="Arial" pitchFamily="34" charset="0"/>
              </a:rPr>
              <a:t>atio for renal events</a:t>
            </a:r>
            <a:endParaRPr kumimoji="1" lang="ja-JP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3752997" y="4808185"/>
            <a:ext cx="15840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UPE</a:t>
            </a:r>
            <a:r>
              <a:rPr lang="ja-JP" altLang="en-US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at baseline, g/d</a:t>
            </a:r>
            <a:endParaRPr kumimoji="1" lang="ja-JP" altLang="en-US" sz="1200" baseline="300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4" name="グループ化 43"/>
          <p:cNvGrpSpPr/>
          <p:nvPr/>
        </p:nvGrpSpPr>
        <p:grpSpPr>
          <a:xfrm>
            <a:off x="2573721" y="343689"/>
            <a:ext cx="2365591" cy="637039"/>
            <a:chOff x="3068038" y="1522510"/>
            <a:chExt cx="2365591" cy="637039"/>
          </a:xfrm>
        </p:grpSpPr>
        <p:cxnSp>
          <p:nvCxnSpPr>
            <p:cNvPr id="45" name="直線コネクタ 44"/>
            <p:cNvCxnSpPr/>
            <p:nvPr/>
          </p:nvCxnSpPr>
          <p:spPr>
            <a:xfrm>
              <a:off x="3068038" y="1645620"/>
              <a:ext cx="432048" cy="0"/>
            </a:xfrm>
            <a:prstGeom prst="line">
              <a:avLst/>
            </a:prstGeom>
            <a:ln w="28575">
              <a:solidFill>
                <a:schemeClr val="tx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線コネクタ 45"/>
            <p:cNvCxnSpPr/>
            <p:nvPr/>
          </p:nvCxnSpPr>
          <p:spPr>
            <a:xfrm>
              <a:off x="3068038" y="2010597"/>
              <a:ext cx="432048" cy="0"/>
            </a:xfrm>
            <a:prstGeom prst="line">
              <a:avLst/>
            </a:prstGeom>
            <a:ln w="1905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テキスト ボックス 46"/>
            <p:cNvSpPr txBox="1"/>
            <p:nvPr/>
          </p:nvSpPr>
          <p:spPr>
            <a:xfrm>
              <a:off x="3500086" y="1522510"/>
              <a:ext cx="5677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Arial" pitchFamily="34" charset="0"/>
                  <a:cs typeface="Arial" pitchFamily="34" charset="0"/>
                </a:rPr>
                <a:t>Mean</a:t>
              </a:r>
            </a:p>
          </p:txBody>
        </p:sp>
        <p:sp>
          <p:nvSpPr>
            <p:cNvPr id="48" name="テキスト ボックス 47"/>
            <p:cNvSpPr txBox="1"/>
            <p:nvPr/>
          </p:nvSpPr>
          <p:spPr>
            <a:xfrm>
              <a:off x="3500086" y="1882550"/>
              <a:ext cx="19335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Arial" pitchFamily="34" charset="0"/>
                  <a:cs typeface="Arial" pitchFamily="34" charset="0"/>
                </a:rPr>
                <a:t>Lower or upper of 95% CI</a:t>
              </a:r>
            </a:p>
          </p:txBody>
        </p:sp>
      </p:grpSp>
      <p:sp>
        <p:nvSpPr>
          <p:cNvPr id="49" name="テキスト ボックス 48"/>
          <p:cNvSpPr txBox="1"/>
          <p:nvPr/>
        </p:nvSpPr>
        <p:spPr>
          <a:xfrm>
            <a:off x="7002270" y="2588696"/>
            <a:ext cx="8739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 smtClean="0">
                <a:latin typeface="Arial" pitchFamily="34" charset="0"/>
                <a:cs typeface="Arial" pitchFamily="34" charset="0"/>
              </a:rPr>
              <a:t>Reduction</a:t>
            </a:r>
            <a:endParaRPr kumimoji="1" lang="ja-JP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7010285" y="811741"/>
            <a:ext cx="7729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Increase</a:t>
            </a:r>
            <a:endParaRPr kumimoji="1" lang="ja-JP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1" name="テキスト ボックス 50"/>
          <p:cNvSpPr txBox="1"/>
          <p:nvPr/>
        </p:nvSpPr>
        <p:spPr>
          <a:xfrm>
            <a:off x="7035934" y="1292552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Risk</a:t>
            </a:r>
            <a:endParaRPr kumimoji="1" lang="ja-JP" altLang="en-US" sz="12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2" name="直線矢印コネクタ 51"/>
          <p:cNvCxnSpPr/>
          <p:nvPr/>
        </p:nvCxnSpPr>
        <p:spPr>
          <a:xfrm flipV="1">
            <a:off x="7056629" y="503675"/>
            <a:ext cx="0" cy="882481"/>
          </a:xfrm>
          <a:prstGeom prst="straightConnector1">
            <a:avLst/>
          </a:prstGeom>
          <a:ln>
            <a:solidFill>
              <a:schemeClr val="tx1"/>
            </a:solidFill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線矢印コネクタ 52"/>
          <p:cNvCxnSpPr/>
          <p:nvPr/>
        </p:nvCxnSpPr>
        <p:spPr>
          <a:xfrm>
            <a:off x="7056629" y="1376631"/>
            <a:ext cx="0" cy="2987408"/>
          </a:xfrm>
          <a:prstGeom prst="straightConnector1">
            <a:avLst/>
          </a:prstGeom>
          <a:ln>
            <a:solidFill>
              <a:schemeClr val="tx1"/>
            </a:solidFill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テキスト ボックス 53"/>
          <p:cNvSpPr txBox="1"/>
          <p:nvPr/>
        </p:nvSpPr>
        <p:spPr>
          <a:xfrm>
            <a:off x="328336" y="5373216"/>
            <a:ext cx="82761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/>
              <a:t>Supplemental Figure A.</a:t>
            </a:r>
            <a:r>
              <a:rPr lang="ja-JP" altLang="en-US" b="1" dirty="0"/>
              <a:t> </a:t>
            </a:r>
            <a:r>
              <a:rPr lang="en-US" altLang="ja-JP" dirty="0"/>
              <a:t>Risk ratio for the end point associated with the baseline </a:t>
            </a:r>
            <a:r>
              <a:rPr lang="en-US" altLang="ja-JP" dirty="0" smtClean="0"/>
              <a:t>UPE</a:t>
            </a:r>
            <a:endParaRPr kumimoji="1" lang="ja-JP" altLang="en-US" dirty="0"/>
          </a:p>
        </p:txBody>
      </p:sp>
      <p:sp>
        <p:nvSpPr>
          <p:cNvPr id="55" name="テキスト ボックス 54"/>
          <p:cNvSpPr txBox="1"/>
          <p:nvPr/>
        </p:nvSpPr>
        <p:spPr>
          <a:xfrm>
            <a:off x="539552" y="5805264"/>
            <a:ext cx="784887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Plots of the risk ratios and 95% confidence intervals </a:t>
            </a:r>
            <a:r>
              <a:rPr lang="en-US" altLang="ja-JP" sz="12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(CI) adjusted </a:t>
            </a:r>
            <a:r>
              <a:rPr lang="en-US" altLang="ja-JP" sz="1200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for the baseline </a:t>
            </a:r>
            <a:r>
              <a:rPr lang="en-US" altLang="ja-JP" sz="1200" dirty="0" err="1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eGFR</a:t>
            </a:r>
            <a:r>
              <a:rPr lang="en-US" altLang="ja-JP" sz="1200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for the endpoint using the level of baseline proteinuria examination as the continuous variable were shown (reference; the highest quartile, the median of which was 2.34 g/day). The degree of proteinuria was log transformed.</a:t>
            </a:r>
            <a:endParaRPr kumimoji="1" lang="ja-JP" altLang="en-US" sz="1200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20753231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3787287536"/>
              </p:ext>
            </p:extLst>
          </p:nvPr>
        </p:nvGraphicFramePr>
        <p:xfrm>
          <a:off x="2160364" y="404664"/>
          <a:ext cx="4787900" cy="2564765"/>
        </p:xfrm>
        <a:graphic>
          <a:graphicData uri="http://schemas.openxmlformats.org/drawingml/2006/table">
            <a:tbl>
              <a:tblPr/>
              <a:tblGrid>
                <a:gridCol w="2284485"/>
                <a:gridCol w="1665770"/>
                <a:gridCol w="837645"/>
              </a:tblGrid>
              <a:tr h="507365">
                <a:tc gridSpan="3">
                  <a:txBody>
                    <a:bodyPr/>
                    <a:lstStyle/>
                    <a:p>
                      <a:pPr algn="l" rtl="0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Supplemental Table B. 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Categorized proteinuria at baseline predicting renal outcome in multivariable Cox-Hazard model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22860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Predictor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HR (95% CI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p valu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Category of UPE at baselin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     &lt; 1.0 g/day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0.24 (0.05 to 1.18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0.07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     </a:t>
                      </a:r>
                      <a:r>
                        <a:rPr lang="en-US" sz="1200" b="0" i="0" u="sng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&gt;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 1.0 g/day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referenc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 Unicode M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Age, year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0.9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&gt;0.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Current smoking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2.4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0.13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U-RBC </a:t>
                      </a:r>
                      <a:r>
                        <a:rPr lang="en-US" sz="1200" b="0" i="0" u="sng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&gt;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 30/hpf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0.30 (0.08 to 1.13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0.07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eGFR&lt;60ml/min/1.73m</a:t>
                      </a:r>
                      <a:r>
                        <a:rPr lang="en-US" sz="12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 Unicode M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8.59 (1.65 to 44.7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0.011 </a:t>
                      </a:r>
                      <a:r>
                        <a:rPr lang="en-US" altLang="ja-JP" sz="12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#</a:t>
                      </a:r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 Unicode M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Tonsillectomy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0.73 (0.19 to 2.82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&gt;0.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="" xmlns:p14="http://schemas.microsoft.com/office/powerpoint/2010/main" val="26795835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323528" y="5254912"/>
            <a:ext cx="8420128" cy="9848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 smtClean="0"/>
              <a:t>Supplemental Figure B.</a:t>
            </a:r>
            <a:r>
              <a:rPr lang="ja-JP" altLang="en-US" b="1" dirty="0" smtClean="0"/>
              <a:t> </a:t>
            </a:r>
            <a:r>
              <a:rPr lang="en-US" altLang="ja-JP" dirty="0" smtClean="0"/>
              <a:t>An equation of propensity score for UPE at one year &lt;0.4 g/day with baseline clinical predictors</a:t>
            </a:r>
          </a:p>
          <a:p>
            <a:r>
              <a:rPr kumimoji="1"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The propensity score was estimated by logistic regression model for UPE at one year &lt; 0.4 g/day (</a:t>
            </a:r>
            <a:r>
              <a:rPr kumimoji="1" lang="en-US" altLang="ja-JP" sz="1100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Nagelkelke</a:t>
            </a:r>
            <a:r>
              <a:rPr kumimoji="1"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R square was 0.268, p&lt;0.001). </a:t>
            </a:r>
            <a:endParaRPr kumimoji="1" lang="ja-JP" altLang="en-US" sz="1100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1150699" y="892366"/>
            <a:ext cx="6955750" cy="923330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kumimoji="1" lang="en-US" altLang="ja-JP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Propensity score for UPE at one year &lt; 0.4 g/day</a:t>
            </a:r>
          </a:p>
          <a:p>
            <a:endParaRPr kumimoji="1" lang="en-US" altLang="ja-JP" dirty="0" smtClean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  <a:p>
            <a:r>
              <a:rPr lang="en-US" altLang="ja-JP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= </a:t>
            </a:r>
            <a:r>
              <a:rPr kumimoji="1" lang="en-US" altLang="ja-JP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1.605  </a:t>
            </a:r>
            <a:r>
              <a:rPr kumimoji="1" lang="en-US" altLang="ja-JP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+</a:t>
            </a:r>
            <a:r>
              <a:rPr kumimoji="1" lang="en-US" altLang="ja-JP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 0.023 x Age (years)  </a:t>
            </a:r>
            <a:r>
              <a:rPr lang="en-US" altLang="ja-JP" b="1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-</a:t>
            </a:r>
            <a:r>
              <a:rPr kumimoji="1" lang="en-US" altLang="ja-JP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 1.097 x UPE at baseline (g/day) </a:t>
            </a:r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grpSp>
        <p:nvGrpSpPr>
          <p:cNvPr id="14" name="グループ化 13"/>
          <p:cNvGrpSpPr/>
          <p:nvPr/>
        </p:nvGrpSpPr>
        <p:grpSpPr>
          <a:xfrm>
            <a:off x="4078948" y="2923575"/>
            <a:ext cx="2896947" cy="923330"/>
            <a:chOff x="3331237" y="1916832"/>
            <a:chExt cx="2896947" cy="923330"/>
          </a:xfrm>
        </p:grpSpPr>
        <p:sp>
          <p:nvSpPr>
            <p:cNvPr id="7" name="テキスト ボックス 6"/>
            <p:cNvSpPr txBox="1"/>
            <p:nvPr/>
          </p:nvSpPr>
          <p:spPr>
            <a:xfrm>
              <a:off x="3331237" y="1916832"/>
              <a:ext cx="2896947" cy="923330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kumimoji="1" lang="en-US" altLang="ja-JP" dirty="0" err="1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eGFR</a:t>
              </a:r>
              <a:r>
                <a:rPr kumimoji="1"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 </a:t>
              </a:r>
              <a:r>
                <a:rPr lang="en-US" altLang="ja-JP" dirty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&lt;</a:t>
              </a:r>
              <a:r>
                <a:rPr kumimoji="1"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 </a:t>
              </a:r>
              <a:r>
                <a:rPr lang="en-US" altLang="ja-JP" dirty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6</a:t>
              </a:r>
              <a:r>
                <a:rPr kumimoji="1"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0 ml/min/1.73m</a:t>
              </a:r>
              <a:r>
                <a:rPr kumimoji="1" lang="en-US" altLang="ja-JP" baseline="30000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2</a:t>
              </a:r>
            </a:p>
            <a:p>
              <a:r>
                <a:rPr kumimoji="1"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   - 0.161 for “Yes”</a:t>
              </a:r>
            </a:p>
            <a:p>
              <a:r>
                <a:rPr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   +0.161 for “No”</a:t>
              </a:r>
              <a:r>
                <a:rPr kumimoji="1"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 </a:t>
              </a:r>
              <a:endParaRPr kumimoji="1" lang="ja-JP" altLang="en-US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13" name="左中かっこ 12"/>
            <p:cNvSpPr/>
            <p:nvPr/>
          </p:nvSpPr>
          <p:spPr>
            <a:xfrm>
              <a:off x="3356386" y="2305848"/>
              <a:ext cx="181213" cy="432048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15" name="グループ化 14"/>
          <p:cNvGrpSpPr/>
          <p:nvPr/>
        </p:nvGrpSpPr>
        <p:grpSpPr>
          <a:xfrm>
            <a:off x="1581364" y="2944720"/>
            <a:ext cx="2037737" cy="923330"/>
            <a:chOff x="3331237" y="1916832"/>
            <a:chExt cx="2037737" cy="923330"/>
          </a:xfrm>
        </p:grpSpPr>
        <p:sp>
          <p:nvSpPr>
            <p:cNvPr id="16" name="テキスト ボックス 15"/>
            <p:cNvSpPr txBox="1"/>
            <p:nvPr/>
          </p:nvSpPr>
          <p:spPr>
            <a:xfrm>
              <a:off x="3331237" y="1916832"/>
              <a:ext cx="2037737" cy="923330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kumimoji="1"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U-RBC </a:t>
              </a:r>
              <a:r>
                <a:rPr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&gt;</a:t>
              </a:r>
              <a:r>
                <a:rPr kumimoji="1"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 </a:t>
              </a:r>
              <a:r>
                <a:rPr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3</a:t>
              </a:r>
              <a:r>
                <a:rPr kumimoji="1"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0 /</a:t>
              </a:r>
              <a:r>
                <a:rPr kumimoji="1" lang="en-US" altLang="ja-JP" dirty="0" err="1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hpf</a:t>
              </a:r>
              <a:endParaRPr kumimoji="1" lang="en-US" altLang="ja-JP" baseline="300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  <a:p>
              <a:r>
                <a:rPr kumimoji="1"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   +0.645 for “Yes”</a:t>
              </a:r>
            </a:p>
            <a:p>
              <a:r>
                <a:rPr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   - 0.000 for “No”</a:t>
              </a:r>
              <a:r>
                <a:rPr kumimoji="1"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 </a:t>
              </a:r>
              <a:endParaRPr kumimoji="1" lang="ja-JP" altLang="en-US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17" name="左中かっこ 16"/>
            <p:cNvSpPr/>
            <p:nvPr/>
          </p:nvSpPr>
          <p:spPr>
            <a:xfrm>
              <a:off x="3356386" y="2305848"/>
              <a:ext cx="181213" cy="432048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18" name="グループ化 17"/>
          <p:cNvGrpSpPr/>
          <p:nvPr/>
        </p:nvGrpSpPr>
        <p:grpSpPr>
          <a:xfrm>
            <a:off x="1590329" y="3953648"/>
            <a:ext cx="2044149" cy="923330"/>
            <a:chOff x="3331237" y="1916832"/>
            <a:chExt cx="2044149" cy="923330"/>
          </a:xfrm>
        </p:grpSpPr>
        <p:sp>
          <p:nvSpPr>
            <p:cNvPr id="19" name="テキスト ボックス 18"/>
            <p:cNvSpPr txBox="1"/>
            <p:nvPr/>
          </p:nvSpPr>
          <p:spPr>
            <a:xfrm>
              <a:off x="3331237" y="1916832"/>
              <a:ext cx="2044149" cy="923330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kumimoji="1"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Tonsillectomy</a:t>
              </a:r>
              <a:endParaRPr kumimoji="1" lang="en-US" altLang="ja-JP" baseline="300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  <a:p>
              <a:r>
                <a:rPr kumimoji="1"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   - 0.107 for “Yes”</a:t>
              </a:r>
            </a:p>
            <a:p>
              <a:r>
                <a:rPr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   +0.107 for “No”</a:t>
              </a:r>
              <a:r>
                <a:rPr kumimoji="1"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 </a:t>
              </a:r>
              <a:endParaRPr kumimoji="1" lang="ja-JP" altLang="en-US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20" name="左中かっこ 19"/>
            <p:cNvSpPr/>
            <p:nvPr/>
          </p:nvSpPr>
          <p:spPr>
            <a:xfrm>
              <a:off x="3356386" y="2305848"/>
              <a:ext cx="181213" cy="432048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21" name="グループ化 20"/>
          <p:cNvGrpSpPr/>
          <p:nvPr/>
        </p:nvGrpSpPr>
        <p:grpSpPr>
          <a:xfrm>
            <a:off x="6590829" y="1892214"/>
            <a:ext cx="2037737" cy="923330"/>
            <a:chOff x="3331237" y="1916832"/>
            <a:chExt cx="2037737" cy="923330"/>
          </a:xfrm>
        </p:grpSpPr>
        <p:sp>
          <p:nvSpPr>
            <p:cNvPr id="22" name="テキスト ボックス 21"/>
            <p:cNvSpPr txBox="1"/>
            <p:nvPr/>
          </p:nvSpPr>
          <p:spPr>
            <a:xfrm>
              <a:off x="3331237" y="1916832"/>
              <a:ext cx="2037737" cy="923330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kumimoji="1"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Current smoker</a:t>
              </a:r>
              <a:endParaRPr kumimoji="1" lang="en-US" altLang="ja-JP" baseline="300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  <a:p>
              <a:r>
                <a:rPr kumimoji="1"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   +0.071 for “Yes”</a:t>
              </a:r>
            </a:p>
            <a:p>
              <a:r>
                <a:rPr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   - 0.071 for “No”</a:t>
              </a:r>
              <a:r>
                <a:rPr kumimoji="1"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 </a:t>
              </a:r>
              <a:endParaRPr kumimoji="1" lang="ja-JP" altLang="en-US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23" name="左中かっこ 22"/>
            <p:cNvSpPr/>
            <p:nvPr/>
          </p:nvSpPr>
          <p:spPr>
            <a:xfrm>
              <a:off x="3356386" y="2305848"/>
              <a:ext cx="181213" cy="432048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24" name="テキスト ボックス 23"/>
          <p:cNvSpPr txBox="1"/>
          <p:nvPr/>
        </p:nvSpPr>
        <p:spPr>
          <a:xfrm>
            <a:off x="1324606" y="2311465"/>
            <a:ext cx="319318" cy="3693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kumimoji="1" lang="en-US" altLang="ja-JP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+</a:t>
            </a:r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3822250" y="2311465"/>
            <a:ext cx="319318" cy="3693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kumimoji="1" lang="en-US" altLang="ja-JP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+</a:t>
            </a:r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1324606" y="3356779"/>
            <a:ext cx="319318" cy="3693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kumimoji="1" lang="en-US" altLang="ja-JP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+</a:t>
            </a:r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3822250" y="3356779"/>
            <a:ext cx="319318" cy="3693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kumimoji="1" lang="en-US" altLang="ja-JP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+</a:t>
            </a:r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grpSp>
        <p:nvGrpSpPr>
          <p:cNvPr id="28" name="グループ化 27"/>
          <p:cNvGrpSpPr/>
          <p:nvPr/>
        </p:nvGrpSpPr>
        <p:grpSpPr>
          <a:xfrm>
            <a:off x="1581364" y="1892214"/>
            <a:ext cx="2339102" cy="923330"/>
            <a:chOff x="3331237" y="1916832"/>
            <a:chExt cx="2339102" cy="923330"/>
          </a:xfrm>
        </p:grpSpPr>
        <p:sp>
          <p:nvSpPr>
            <p:cNvPr id="29" name="テキスト ボックス 28"/>
            <p:cNvSpPr txBox="1"/>
            <p:nvPr/>
          </p:nvSpPr>
          <p:spPr>
            <a:xfrm>
              <a:off x="3331237" y="1916832"/>
              <a:ext cx="2339102" cy="923330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kumimoji="1"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Sex</a:t>
              </a:r>
              <a:endParaRPr kumimoji="1" lang="en-US" altLang="ja-JP" baseline="300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  <a:p>
              <a:r>
                <a:rPr kumimoji="1"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   - 0.011 for “</a:t>
              </a:r>
              <a:r>
                <a:rPr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female</a:t>
              </a:r>
              <a:r>
                <a:rPr kumimoji="1"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”</a:t>
              </a:r>
            </a:p>
            <a:p>
              <a:r>
                <a:rPr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   +0.011 for “male”</a:t>
              </a:r>
              <a:r>
                <a:rPr kumimoji="1"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 </a:t>
              </a:r>
              <a:endParaRPr kumimoji="1" lang="ja-JP" altLang="en-US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30" name="左中かっこ 29"/>
            <p:cNvSpPr/>
            <p:nvPr/>
          </p:nvSpPr>
          <p:spPr>
            <a:xfrm>
              <a:off x="3356386" y="2305848"/>
              <a:ext cx="181213" cy="432048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31" name="グループ化 30"/>
          <p:cNvGrpSpPr/>
          <p:nvPr/>
        </p:nvGrpSpPr>
        <p:grpSpPr>
          <a:xfrm>
            <a:off x="4078948" y="1892214"/>
            <a:ext cx="2204450" cy="923330"/>
            <a:chOff x="3331237" y="1916832"/>
            <a:chExt cx="2204450" cy="923330"/>
          </a:xfrm>
        </p:grpSpPr>
        <p:sp>
          <p:nvSpPr>
            <p:cNvPr id="32" name="テキスト ボックス 31"/>
            <p:cNvSpPr txBox="1"/>
            <p:nvPr/>
          </p:nvSpPr>
          <p:spPr>
            <a:xfrm>
              <a:off x="3331237" y="1916832"/>
              <a:ext cx="2204450" cy="923330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kumimoji="1"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BP &gt; 130/80 mmHg</a:t>
              </a:r>
              <a:endParaRPr kumimoji="1" lang="en-US" altLang="ja-JP" baseline="300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  <a:p>
              <a:r>
                <a:rPr kumimoji="1"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   +0.345 for “</a:t>
              </a:r>
              <a:r>
                <a:rPr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Yes</a:t>
              </a:r>
              <a:r>
                <a:rPr kumimoji="1"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”</a:t>
              </a:r>
            </a:p>
            <a:p>
              <a:r>
                <a:rPr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   +0.345 for “No”</a:t>
              </a:r>
              <a:r>
                <a:rPr kumimoji="1"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 </a:t>
              </a:r>
              <a:endParaRPr kumimoji="1" lang="ja-JP" altLang="en-US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33" name="左中かっこ 32"/>
            <p:cNvSpPr/>
            <p:nvPr/>
          </p:nvSpPr>
          <p:spPr>
            <a:xfrm>
              <a:off x="3356386" y="2305848"/>
              <a:ext cx="181213" cy="432048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37" name="グループ化 36"/>
          <p:cNvGrpSpPr/>
          <p:nvPr/>
        </p:nvGrpSpPr>
        <p:grpSpPr>
          <a:xfrm>
            <a:off x="4145286" y="3953648"/>
            <a:ext cx="2037737" cy="923330"/>
            <a:chOff x="3331237" y="1916832"/>
            <a:chExt cx="2037737" cy="923330"/>
          </a:xfrm>
        </p:grpSpPr>
        <p:sp>
          <p:nvSpPr>
            <p:cNvPr id="38" name="テキスト ボックス 37"/>
            <p:cNvSpPr txBox="1"/>
            <p:nvPr/>
          </p:nvSpPr>
          <p:spPr>
            <a:xfrm>
              <a:off x="3331237" y="1916832"/>
              <a:ext cx="2037737" cy="923330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kumimoji="1"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RAAS inhibitors</a:t>
              </a:r>
              <a:endParaRPr kumimoji="1" lang="en-US" altLang="ja-JP" baseline="300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  <a:p>
              <a:r>
                <a:rPr kumimoji="1"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   +0.037 for “</a:t>
              </a:r>
              <a:r>
                <a:rPr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Yes</a:t>
              </a:r>
              <a:r>
                <a:rPr kumimoji="1"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”</a:t>
              </a:r>
            </a:p>
            <a:p>
              <a:r>
                <a:rPr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   +0.037 for “No”</a:t>
              </a:r>
              <a:r>
                <a:rPr kumimoji="1"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 </a:t>
              </a:r>
              <a:endParaRPr kumimoji="1" lang="ja-JP" altLang="en-US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39" name="左中かっこ 38"/>
            <p:cNvSpPr/>
            <p:nvPr/>
          </p:nvSpPr>
          <p:spPr>
            <a:xfrm>
              <a:off x="3356386" y="2305848"/>
              <a:ext cx="181213" cy="432048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40" name="テキスト ボックス 39"/>
          <p:cNvSpPr txBox="1"/>
          <p:nvPr/>
        </p:nvSpPr>
        <p:spPr>
          <a:xfrm>
            <a:off x="6319894" y="2311465"/>
            <a:ext cx="319318" cy="3693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kumimoji="1" lang="en-US" altLang="ja-JP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+</a:t>
            </a:r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1324606" y="4378789"/>
            <a:ext cx="319318" cy="3693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kumimoji="1" lang="en-US" altLang="ja-JP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+</a:t>
            </a:r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3822250" y="4378789"/>
            <a:ext cx="319318" cy="3693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kumimoji="1" lang="en-US" altLang="ja-JP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+</a:t>
            </a:r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172899469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323528" y="4456152"/>
            <a:ext cx="8420128" cy="9848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 smtClean="0"/>
              <a:t>Supplemental Figure C.</a:t>
            </a:r>
            <a:r>
              <a:rPr lang="ja-JP" altLang="en-US" b="1" dirty="0" smtClean="0"/>
              <a:t> </a:t>
            </a:r>
            <a:r>
              <a:rPr lang="en-US" altLang="ja-JP" dirty="0" smtClean="0"/>
              <a:t>An equation of propensity score for UPE at one year &lt;0.4 g/day with Oxford classification and baseline UPE</a:t>
            </a:r>
          </a:p>
          <a:p>
            <a:r>
              <a:rPr kumimoji="1"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The propensity score was estimated by logistic regression model for UPE at one year &lt; 0.4 g/day (</a:t>
            </a:r>
            <a:r>
              <a:rPr kumimoji="1" lang="en-US" altLang="ja-JP" sz="1100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Nagelkelke</a:t>
            </a:r>
            <a:r>
              <a:rPr kumimoji="1"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R square was 0.269 p&lt;0.001). </a:t>
            </a:r>
            <a:endParaRPr kumimoji="1" lang="ja-JP" altLang="en-US" sz="1100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1150699" y="1007976"/>
            <a:ext cx="5327099" cy="923330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kumimoji="1" lang="en-US" altLang="ja-JP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Propensity score for UPE at one year &lt; 0.4 g/day</a:t>
            </a:r>
          </a:p>
          <a:p>
            <a:endParaRPr kumimoji="1" lang="en-US" altLang="ja-JP" dirty="0" smtClean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  <a:p>
            <a:r>
              <a:rPr lang="en-US" altLang="ja-JP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= </a:t>
            </a:r>
            <a:r>
              <a:rPr kumimoji="1" lang="en-US" altLang="ja-JP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2.257  </a:t>
            </a:r>
            <a:r>
              <a:rPr lang="en-US" altLang="ja-JP" b="1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-</a:t>
            </a:r>
            <a:r>
              <a:rPr kumimoji="1" lang="en-US" altLang="ja-JP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 </a:t>
            </a:r>
            <a:r>
              <a:rPr lang="en-US" altLang="ja-JP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0.992</a:t>
            </a:r>
            <a:r>
              <a:rPr kumimoji="1" lang="en-US" altLang="ja-JP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x UPE at baseline (g/day) </a:t>
            </a:r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grpSp>
        <p:nvGrpSpPr>
          <p:cNvPr id="15" name="グループ化 14"/>
          <p:cNvGrpSpPr/>
          <p:nvPr/>
        </p:nvGrpSpPr>
        <p:grpSpPr>
          <a:xfrm>
            <a:off x="1581364" y="2967997"/>
            <a:ext cx="1980029" cy="1107996"/>
            <a:chOff x="3331237" y="1824499"/>
            <a:chExt cx="1980029" cy="1107996"/>
          </a:xfrm>
        </p:grpSpPr>
        <p:sp>
          <p:nvSpPr>
            <p:cNvPr id="16" name="テキスト ボックス 15"/>
            <p:cNvSpPr txBox="1"/>
            <p:nvPr/>
          </p:nvSpPr>
          <p:spPr>
            <a:xfrm>
              <a:off x="3331237" y="1824499"/>
              <a:ext cx="1980029" cy="1107996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endParaRPr kumimoji="1" lang="en-US" altLang="ja-JP" baseline="300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  <a:p>
              <a:r>
                <a:rPr kumimoji="1"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   - 0.078 for “T0”</a:t>
              </a:r>
            </a:p>
            <a:p>
              <a:r>
                <a:rPr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   - 0.459 for “T1”</a:t>
              </a:r>
              <a:r>
                <a:rPr kumimoji="1"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 </a:t>
              </a:r>
            </a:p>
            <a:p>
              <a:r>
                <a:rPr lang="en-US" altLang="ja-JP" dirty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 </a:t>
              </a:r>
              <a:r>
                <a:rPr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  +0.537 for “T2”</a:t>
              </a:r>
              <a:endParaRPr kumimoji="1" lang="ja-JP" altLang="en-US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17" name="左中かっこ 16"/>
            <p:cNvSpPr/>
            <p:nvPr/>
          </p:nvSpPr>
          <p:spPr>
            <a:xfrm>
              <a:off x="3356386" y="2116069"/>
              <a:ext cx="146983" cy="763793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21" name="グループ化 20"/>
          <p:cNvGrpSpPr/>
          <p:nvPr/>
        </p:nvGrpSpPr>
        <p:grpSpPr>
          <a:xfrm>
            <a:off x="6590829" y="2053990"/>
            <a:ext cx="1992853" cy="830997"/>
            <a:chOff x="3331237" y="1962998"/>
            <a:chExt cx="1992853" cy="830997"/>
          </a:xfrm>
        </p:grpSpPr>
        <p:sp>
          <p:nvSpPr>
            <p:cNvPr id="22" name="テキスト ボックス 21"/>
            <p:cNvSpPr txBox="1"/>
            <p:nvPr/>
          </p:nvSpPr>
          <p:spPr>
            <a:xfrm>
              <a:off x="3331237" y="1962998"/>
              <a:ext cx="1992853" cy="830997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endParaRPr kumimoji="1" lang="en-US" altLang="ja-JP" baseline="300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  <a:p>
              <a:r>
                <a:rPr kumimoji="1"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   +0.004 for “S0”</a:t>
              </a:r>
            </a:p>
            <a:p>
              <a:r>
                <a:rPr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   - 0.004 for “S1”</a:t>
              </a:r>
              <a:r>
                <a:rPr kumimoji="1"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 </a:t>
              </a:r>
              <a:endParaRPr kumimoji="1" lang="ja-JP" altLang="en-US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23" name="左中かっこ 22"/>
            <p:cNvSpPr/>
            <p:nvPr/>
          </p:nvSpPr>
          <p:spPr>
            <a:xfrm>
              <a:off x="3356386" y="2305848"/>
              <a:ext cx="181213" cy="432048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24" name="テキスト ボックス 23"/>
          <p:cNvSpPr txBox="1"/>
          <p:nvPr/>
        </p:nvSpPr>
        <p:spPr>
          <a:xfrm>
            <a:off x="1324606" y="2427075"/>
            <a:ext cx="319318" cy="3693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kumimoji="1" lang="en-US" altLang="ja-JP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+</a:t>
            </a:r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3822250" y="2427075"/>
            <a:ext cx="319318" cy="3693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kumimoji="1" lang="en-US" altLang="ja-JP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+</a:t>
            </a:r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1324606" y="3472389"/>
            <a:ext cx="319318" cy="3693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kumimoji="1" lang="en-US" altLang="ja-JP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+</a:t>
            </a:r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grpSp>
        <p:nvGrpSpPr>
          <p:cNvPr id="28" name="グループ化 27"/>
          <p:cNvGrpSpPr/>
          <p:nvPr/>
        </p:nvGrpSpPr>
        <p:grpSpPr>
          <a:xfrm>
            <a:off x="1581364" y="2053990"/>
            <a:ext cx="2024913" cy="830997"/>
            <a:chOff x="3331237" y="1962998"/>
            <a:chExt cx="2024913" cy="830997"/>
          </a:xfrm>
        </p:grpSpPr>
        <p:sp>
          <p:nvSpPr>
            <p:cNvPr id="29" name="テキスト ボックス 28"/>
            <p:cNvSpPr txBox="1"/>
            <p:nvPr/>
          </p:nvSpPr>
          <p:spPr>
            <a:xfrm>
              <a:off x="3331237" y="1962998"/>
              <a:ext cx="2024913" cy="830997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endParaRPr kumimoji="1" lang="en-US" altLang="ja-JP" baseline="300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  <a:p>
              <a:r>
                <a:rPr kumimoji="1"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   </a:t>
              </a:r>
              <a:r>
                <a:rPr lang="en-US" altLang="ja-JP" dirty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+</a:t>
              </a:r>
              <a:r>
                <a:rPr kumimoji="1"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0.192 for “</a:t>
              </a:r>
              <a:r>
                <a:rPr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M0</a:t>
              </a:r>
              <a:r>
                <a:rPr kumimoji="1"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”</a:t>
              </a:r>
            </a:p>
            <a:p>
              <a:r>
                <a:rPr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   - 0.192 for “M1”</a:t>
              </a:r>
              <a:r>
                <a:rPr kumimoji="1"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 </a:t>
              </a:r>
              <a:endParaRPr kumimoji="1" lang="ja-JP" altLang="en-US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30" name="左中かっこ 29"/>
            <p:cNvSpPr/>
            <p:nvPr/>
          </p:nvSpPr>
          <p:spPr>
            <a:xfrm>
              <a:off x="3356386" y="2305848"/>
              <a:ext cx="181213" cy="432048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31" name="グループ化 30"/>
          <p:cNvGrpSpPr/>
          <p:nvPr/>
        </p:nvGrpSpPr>
        <p:grpSpPr>
          <a:xfrm>
            <a:off x="4078948" y="2007824"/>
            <a:ext cx="1986441" cy="923330"/>
            <a:chOff x="3331237" y="1916832"/>
            <a:chExt cx="1986441" cy="923330"/>
          </a:xfrm>
        </p:grpSpPr>
        <p:sp>
          <p:nvSpPr>
            <p:cNvPr id="32" name="テキスト ボックス 31"/>
            <p:cNvSpPr txBox="1"/>
            <p:nvPr/>
          </p:nvSpPr>
          <p:spPr>
            <a:xfrm>
              <a:off x="3331237" y="1916832"/>
              <a:ext cx="1986441" cy="923330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endParaRPr kumimoji="1" lang="en-US" altLang="ja-JP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  <a:p>
              <a:r>
                <a:rPr lang="en-US" altLang="ja-JP" dirty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 </a:t>
              </a:r>
              <a:r>
                <a:rPr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  </a:t>
              </a:r>
              <a:r>
                <a:rPr kumimoji="1"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+0.000 for “</a:t>
              </a:r>
              <a:r>
                <a:rPr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E0</a:t>
              </a:r>
              <a:r>
                <a:rPr kumimoji="1"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”</a:t>
              </a:r>
            </a:p>
            <a:p>
              <a:r>
                <a:rPr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   +0.942 for “E1”</a:t>
              </a:r>
              <a:r>
                <a:rPr kumimoji="1"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 </a:t>
              </a:r>
              <a:endParaRPr kumimoji="1" lang="ja-JP" altLang="en-US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33" name="左中かっこ 32"/>
            <p:cNvSpPr/>
            <p:nvPr/>
          </p:nvSpPr>
          <p:spPr>
            <a:xfrm>
              <a:off x="3356386" y="2305848"/>
              <a:ext cx="181213" cy="432048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40" name="テキスト ボックス 39"/>
          <p:cNvSpPr txBox="1"/>
          <p:nvPr/>
        </p:nvSpPr>
        <p:spPr>
          <a:xfrm>
            <a:off x="6319894" y="2427075"/>
            <a:ext cx="319318" cy="3693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kumimoji="1" lang="en-US" altLang="ja-JP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+</a:t>
            </a:r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360987397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323528" y="3079342"/>
            <a:ext cx="8420128" cy="9848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 smtClean="0"/>
              <a:t>Supplemental Figure D.</a:t>
            </a:r>
            <a:r>
              <a:rPr lang="ja-JP" altLang="en-US" b="1" dirty="0" smtClean="0"/>
              <a:t> </a:t>
            </a:r>
            <a:r>
              <a:rPr lang="en-US" altLang="ja-JP" dirty="0" smtClean="0"/>
              <a:t>An equation of propensity score for UPE at one year &lt;0.4 g/day with HG and baseline UPE</a:t>
            </a:r>
          </a:p>
          <a:p>
            <a:r>
              <a:rPr kumimoji="1"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The propensity score was estimated by logistic regression model for UPE at one year &lt; 0.4 g/day (</a:t>
            </a:r>
            <a:r>
              <a:rPr kumimoji="1" lang="en-US" altLang="ja-JP" sz="1100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Nagelkelke</a:t>
            </a:r>
            <a:r>
              <a:rPr kumimoji="1"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R square was 0.271 p&lt;0.001). </a:t>
            </a:r>
            <a:endParaRPr kumimoji="1" lang="ja-JP" altLang="en-US" sz="1100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1150699" y="730978"/>
            <a:ext cx="5205271" cy="1477328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kumimoji="1" lang="en-US" altLang="ja-JP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Propensity score for UPE at one year &lt; 0.4 g/day</a:t>
            </a:r>
          </a:p>
          <a:p>
            <a:endParaRPr kumimoji="1" lang="en-US" altLang="ja-JP" dirty="0" smtClean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  <a:p>
            <a:endParaRPr lang="en-US" altLang="ja-JP" dirty="0" smtClean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  <a:p>
            <a:endParaRPr lang="en-US" altLang="ja-JP" dirty="0" smtClean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  <a:p>
            <a:r>
              <a:rPr lang="en-US" altLang="ja-JP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= </a:t>
            </a:r>
            <a:r>
              <a:rPr kumimoji="1" lang="en-US" altLang="ja-JP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2.314  </a:t>
            </a:r>
            <a:r>
              <a:rPr lang="en-US" altLang="ja-JP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-</a:t>
            </a:r>
            <a:r>
              <a:rPr kumimoji="1" lang="en-US" altLang="ja-JP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 0.821 x UPE at baseline (g/day) </a:t>
            </a:r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5633859" y="1870024"/>
            <a:ext cx="319318" cy="3693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kumimoji="1" lang="en-US" altLang="ja-JP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+</a:t>
            </a:r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grpSp>
        <p:nvGrpSpPr>
          <p:cNvPr id="28" name="グループ化 27"/>
          <p:cNvGrpSpPr/>
          <p:nvPr/>
        </p:nvGrpSpPr>
        <p:grpSpPr>
          <a:xfrm>
            <a:off x="5995717" y="1312274"/>
            <a:ext cx="2242922" cy="1200329"/>
            <a:chOff x="3331237" y="1778333"/>
            <a:chExt cx="2242922" cy="1200329"/>
          </a:xfrm>
        </p:grpSpPr>
        <p:sp>
          <p:nvSpPr>
            <p:cNvPr id="29" name="テキスト ボックス 28"/>
            <p:cNvSpPr txBox="1"/>
            <p:nvPr/>
          </p:nvSpPr>
          <p:spPr>
            <a:xfrm>
              <a:off x="3331237" y="1778333"/>
              <a:ext cx="2242922" cy="1200329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kumimoji="1"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HG</a:t>
              </a:r>
              <a:endParaRPr kumimoji="1" lang="en-US" altLang="ja-JP" baseline="300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  <a:p>
              <a:r>
                <a:rPr kumimoji="1"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   +0.000 for “</a:t>
              </a:r>
              <a:r>
                <a:rPr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HG 1</a:t>
              </a:r>
              <a:r>
                <a:rPr kumimoji="1"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”</a:t>
              </a:r>
            </a:p>
            <a:p>
              <a:r>
                <a:rPr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   +0.890 for “HG 2”</a:t>
              </a:r>
              <a:r>
                <a:rPr kumimoji="1"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 </a:t>
              </a:r>
            </a:p>
            <a:p>
              <a:r>
                <a:rPr lang="en-US" altLang="ja-JP" dirty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 </a:t>
              </a:r>
              <a:r>
                <a:rPr lang="en-US" altLang="ja-JP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  - 0.535 for “HG 3”</a:t>
              </a:r>
              <a:endParaRPr kumimoji="1" lang="ja-JP" altLang="en-US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30" name="左中かっこ 29"/>
            <p:cNvSpPr/>
            <p:nvPr/>
          </p:nvSpPr>
          <p:spPr>
            <a:xfrm>
              <a:off x="3356386" y="2168113"/>
              <a:ext cx="201258" cy="715325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</p:spTree>
    <p:extLst>
      <p:ext uri="{BB962C8B-B14F-4D97-AF65-F5344CB8AC3E}">
        <p14:creationId xmlns="" xmlns:p14="http://schemas.microsoft.com/office/powerpoint/2010/main" val="409681990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3381508603"/>
              </p:ext>
            </p:extLst>
          </p:nvPr>
        </p:nvGraphicFramePr>
        <p:xfrm>
          <a:off x="457198" y="953541"/>
          <a:ext cx="7941547" cy="2329960"/>
        </p:xfrm>
        <a:graphic>
          <a:graphicData uri="http://schemas.openxmlformats.org/drawingml/2006/table">
            <a:tbl>
              <a:tblPr/>
              <a:tblGrid>
                <a:gridCol w="1785547"/>
                <a:gridCol w="1440000"/>
                <a:gridCol w="612000"/>
                <a:gridCol w="1440000"/>
                <a:gridCol w="612000"/>
                <a:gridCol w="1440000"/>
                <a:gridCol w="612000"/>
              </a:tblGrid>
              <a:tr h="422044">
                <a:tc gridSpan="7"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Supplemental Table C.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 Predictive power of UPE at one year &lt; 0.4 g/day in various multivariable Cox-Hazard models for the outcome adjusted with each propensity score</a:t>
                      </a:r>
                    </a:p>
                  </a:txBody>
                  <a:tcPr marL="7923" marR="7923" marT="7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212343"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Predictor</a:t>
                      </a:r>
                    </a:p>
                  </a:txBody>
                  <a:tcPr marL="7923" marR="7923" marT="79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6"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Cox-Hazard models for outcome adjusted with each propensity score</a:t>
                      </a:r>
                    </a:p>
                  </a:txBody>
                  <a:tcPr marL="7923" marR="7923" marT="79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21234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Model with clinical characteristics </a:t>
                      </a:r>
                      <a:r>
                        <a:rPr lang="en-US" sz="10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b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 Unicode MS"/>
                      </a:endParaRPr>
                    </a:p>
                  </a:txBody>
                  <a:tcPr marL="7923" marR="7923" marT="79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Model with Oxford classification </a:t>
                      </a:r>
                      <a:r>
                        <a:rPr lang="en-US" sz="10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c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 Unicode MS"/>
                      </a:endParaRPr>
                    </a:p>
                  </a:txBody>
                  <a:tcPr marL="7923" marR="7923" marT="79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Model with HG </a:t>
                      </a:r>
                      <a:r>
                        <a:rPr lang="en-US" sz="10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d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 Unicode MS"/>
                      </a:endParaRPr>
                    </a:p>
                  </a:txBody>
                  <a:tcPr marL="7923" marR="7923" marT="79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21234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HR (95% CI)</a:t>
                      </a:r>
                    </a:p>
                  </a:txBody>
                  <a:tcPr marL="7923" marR="7923" marT="79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p value</a:t>
                      </a:r>
                    </a:p>
                  </a:txBody>
                  <a:tcPr marL="7923" marR="7923" marT="79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HR (95% CI)</a:t>
                      </a:r>
                    </a:p>
                  </a:txBody>
                  <a:tcPr marL="7923" marR="7923" marT="79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p value</a:t>
                      </a:r>
                    </a:p>
                  </a:txBody>
                  <a:tcPr marL="7923" marR="7923" marT="79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HR (95% CI)</a:t>
                      </a:r>
                    </a:p>
                  </a:txBody>
                  <a:tcPr marL="7923" marR="7923" marT="79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p value</a:t>
                      </a:r>
                    </a:p>
                  </a:txBody>
                  <a:tcPr marL="7923" marR="7923" marT="79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234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UPE at one year &lt;0.4 g/day </a:t>
                      </a:r>
                      <a:r>
                        <a:rPr lang="en-US" sz="10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 Unicode MS"/>
                      </a:endParaRPr>
                    </a:p>
                  </a:txBody>
                  <a:tcPr marL="7923" marR="7923" marT="79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0.19 (0.05 to 0.78)</a:t>
                      </a:r>
                    </a:p>
                  </a:txBody>
                  <a:tcPr marL="7923" marR="7923" marT="79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0.022 </a:t>
                      </a:r>
                      <a:r>
                        <a:rPr lang="en-US" altLang="ja-JP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#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 Unicode MS"/>
                      </a:endParaRPr>
                    </a:p>
                  </a:txBody>
                  <a:tcPr marL="7923" marR="7923" marT="79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0.13 (0.02 to 0.77)</a:t>
                      </a:r>
                    </a:p>
                  </a:txBody>
                  <a:tcPr marL="7923" marR="7923" marT="79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0.025 </a:t>
                      </a:r>
                      <a:r>
                        <a:rPr lang="en-US" altLang="ja-JP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#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 Unicode MS"/>
                      </a:endParaRPr>
                    </a:p>
                  </a:txBody>
                  <a:tcPr marL="7923" marR="7923" marT="79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0.12 (0.02 to 0.59)</a:t>
                      </a:r>
                    </a:p>
                  </a:txBody>
                  <a:tcPr marL="7923" marR="7923" marT="79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0.009 </a:t>
                      </a:r>
                      <a:r>
                        <a:rPr lang="en-US" altLang="ja-JP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#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 Unicode MS"/>
                      </a:endParaRPr>
                    </a:p>
                  </a:txBody>
                  <a:tcPr marL="7923" marR="7923" marT="79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2343">
                <a:tc gridSpan="7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Abbeviations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: UPE; </a:t>
                      </a:r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unrine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 protein excretion volume, HR; hazard ratio, CI; confidence interval, HG; histological grade.</a:t>
                      </a:r>
                    </a:p>
                  </a:txBody>
                  <a:tcPr marL="7923" marR="7923" marT="79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846201">
                <a:tc gridSpan="7">
                  <a:txBody>
                    <a:bodyPr/>
                    <a:lstStyle/>
                    <a:p>
                      <a:pPr algn="l" rtl="0" fontAlgn="t"/>
                      <a:r>
                        <a:rPr lang="en-US" sz="9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a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 Yes </a:t>
                      </a:r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vs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 No. </a:t>
                      </a:r>
                      <a:r>
                        <a:rPr lang="en-US" sz="9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b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 The propensity score for UPE at one year &lt;0.4 g/day was constructed by baseline characteristics including age, sex, blood pressure, smoking, proteinuria, hematuria, </a:t>
                      </a:r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eGFR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, tonsillectomy, RAAS inhibitors. </a:t>
                      </a:r>
                      <a:r>
                        <a:rPr lang="en-US" sz="9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c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 The propensity </a:t>
                      </a:r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socre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 for UPE at one year &lt;0.4 g/day was constructed by </a:t>
                      </a:r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mesangial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 </a:t>
                      </a:r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hypercellularity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, </a:t>
                      </a:r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endocapillary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 </a:t>
                      </a:r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hypercellularity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, segmental sclerosis, </a:t>
                      </a:r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tubulointerstitial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 atrophy/fibrosis in the Oxford classification and baseline proteinuria. </a:t>
                      </a:r>
                      <a:r>
                        <a:rPr lang="en-US" sz="9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d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 The propensity score for UPE at one year &lt;0.4 g/day was constructed by HG and baseline proteinuria. </a:t>
                      </a:r>
                      <a:r>
                        <a:rPr lang="en-US" sz="9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#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 p&lt;0.05.</a:t>
                      </a:r>
                    </a:p>
                  </a:txBody>
                  <a:tcPr marL="7923" marR="7923" marT="792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</a:tbl>
          </a:graphicData>
        </a:graphic>
      </p:graphicFrame>
    </p:spTree>
    <p:extLst>
      <p:ext uri="{BB962C8B-B14F-4D97-AF65-F5344CB8AC3E}">
        <p14:creationId xmlns="" xmlns:p14="http://schemas.microsoft.com/office/powerpoint/2010/main" val="364601709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グループ化 13"/>
          <p:cNvGrpSpPr/>
          <p:nvPr/>
        </p:nvGrpSpPr>
        <p:grpSpPr>
          <a:xfrm>
            <a:off x="3313599" y="1086880"/>
            <a:ext cx="2581275" cy="2419350"/>
            <a:chOff x="3313599" y="1086880"/>
            <a:chExt cx="2581275" cy="2419350"/>
          </a:xfrm>
        </p:grpSpPr>
        <p:grpSp>
          <p:nvGrpSpPr>
            <p:cNvPr id="372" name="グループ化 371"/>
            <p:cNvGrpSpPr/>
            <p:nvPr/>
          </p:nvGrpSpPr>
          <p:grpSpPr>
            <a:xfrm>
              <a:off x="3532674" y="3287155"/>
              <a:ext cx="2362200" cy="219075"/>
              <a:chOff x="1914525" y="4259263"/>
              <a:chExt cx="2362200" cy="219075"/>
            </a:xfrm>
          </p:grpSpPr>
          <p:sp>
            <p:nvSpPr>
              <p:cNvPr id="373" name="Rectangle 747"/>
              <p:cNvSpPr>
                <a:spLocks noChangeArrowheads="1"/>
              </p:cNvSpPr>
              <p:nvPr/>
            </p:nvSpPr>
            <p:spPr bwMode="auto">
              <a:xfrm>
                <a:off x="1914525" y="4259263"/>
                <a:ext cx="361950" cy="2190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メイリオ" pitchFamily="50" charset="-128"/>
                    <a:ea typeface="メイリオ" pitchFamily="50" charset="-128"/>
                    <a:cs typeface="ＭＳ Ｐゴシック" pitchFamily="50" charset="-128"/>
                  </a:rPr>
                  <a:t>0.00</a:t>
                </a:r>
                <a:endParaRPr kumimoji="1" lang="ja-JP" altLang="ja-JP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  <p:sp>
            <p:nvSpPr>
              <p:cNvPr id="374" name="Rectangle 752"/>
              <p:cNvSpPr>
                <a:spLocks noChangeArrowheads="1"/>
              </p:cNvSpPr>
              <p:nvPr/>
            </p:nvSpPr>
            <p:spPr bwMode="auto">
              <a:xfrm>
                <a:off x="2295525" y="4259263"/>
                <a:ext cx="361950" cy="2190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メイリオ" pitchFamily="50" charset="-128"/>
                    <a:ea typeface="メイリオ" pitchFamily="50" charset="-128"/>
                    <a:cs typeface="ＭＳ Ｐゴシック" pitchFamily="50" charset="-128"/>
                  </a:rPr>
                  <a:t>0.20</a:t>
                </a:r>
                <a:endParaRPr kumimoji="1" lang="ja-JP" altLang="ja-JP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  <p:sp>
            <p:nvSpPr>
              <p:cNvPr id="375" name="Rectangle 757"/>
              <p:cNvSpPr>
                <a:spLocks noChangeArrowheads="1"/>
              </p:cNvSpPr>
              <p:nvPr/>
            </p:nvSpPr>
            <p:spPr bwMode="auto">
              <a:xfrm>
                <a:off x="2705100" y="4259263"/>
                <a:ext cx="361950" cy="2190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メイリオ" pitchFamily="50" charset="-128"/>
                    <a:ea typeface="メイリオ" pitchFamily="50" charset="-128"/>
                    <a:cs typeface="ＭＳ Ｐゴシック" pitchFamily="50" charset="-128"/>
                  </a:rPr>
                  <a:t>0.40</a:t>
                </a:r>
                <a:endParaRPr kumimoji="1" lang="ja-JP" altLang="ja-JP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  <p:sp>
            <p:nvSpPr>
              <p:cNvPr id="376" name="Rectangle 762"/>
              <p:cNvSpPr>
                <a:spLocks noChangeArrowheads="1"/>
              </p:cNvSpPr>
              <p:nvPr/>
            </p:nvSpPr>
            <p:spPr bwMode="auto">
              <a:xfrm>
                <a:off x="3114675" y="4259263"/>
                <a:ext cx="361950" cy="2190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メイリオ" pitchFamily="50" charset="-128"/>
                    <a:ea typeface="メイリオ" pitchFamily="50" charset="-128"/>
                    <a:cs typeface="ＭＳ Ｐゴシック" pitchFamily="50" charset="-128"/>
                  </a:rPr>
                  <a:t>0.60</a:t>
                </a:r>
                <a:endParaRPr kumimoji="1" lang="ja-JP" altLang="ja-JP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  <p:sp>
            <p:nvSpPr>
              <p:cNvPr id="377" name="Rectangle 767"/>
              <p:cNvSpPr>
                <a:spLocks noChangeArrowheads="1"/>
              </p:cNvSpPr>
              <p:nvPr/>
            </p:nvSpPr>
            <p:spPr bwMode="auto">
              <a:xfrm>
                <a:off x="3524250" y="4259263"/>
                <a:ext cx="361950" cy="2190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メイリオ" pitchFamily="50" charset="-128"/>
                    <a:ea typeface="メイリオ" pitchFamily="50" charset="-128"/>
                    <a:cs typeface="ＭＳ Ｐゴシック" pitchFamily="50" charset="-128"/>
                  </a:rPr>
                  <a:t>0.80</a:t>
                </a:r>
                <a:endParaRPr kumimoji="1" lang="ja-JP" altLang="ja-JP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  <p:sp>
            <p:nvSpPr>
              <p:cNvPr id="378" name="Rectangle 772"/>
              <p:cNvSpPr>
                <a:spLocks noChangeArrowheads="1"/>
              </p:cNvSpPr>
              <p:nvPr/>
            </p:nvSpPr>
            <p:spPr bwMode="auto">
              <a:xfrm>
                <a:off x="3914775" y="4259263"/>
                <a:ext cx="361950" cy="2190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メイリオ" pitchFamily="50" charset="-128"/>
                    <a:ea typeface="メイリオ" pitchFamily="50" charset="-128"/>
                    <a:cs typeface="ＭＳ Ｐゴシック" pitchFamily="50" charset="-128"/>
                  </a:rPr>
                  <a:t>1.00</a:t>
                </a:r>
                <a:endParaRPr kumimoji="1" lang="ja-JP" altLang="ja-JP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</p:grpSp>
        <p:grpSp>
          <p:nvGrpSpPr>
            <p:cNvPr id="2" name="グループ化 1"/>
            <p:cNvGrpSpPr/>
            <p:nvPr/>
          </p:nvGrpSpPr>
          <p:grpSpPr>
            <a:xfrm>
              <a:off x="3313599" y="1086880"/>
              <a:ext cx="361950" cy="2266950"/>
              <a:chOff x="1695450" y="2058988"/>
              <a:chExt cx="361950" cy="2266950"/>
            </a:xfrm>
          </p:grpSpPr>
          <p:sp>
            <p:nvSpPr>
              <p:cNvPr id="3" name="Rectangle 399"/>
              <p:cNvSpPr>
                <a:spLocks noChangeArrowheads="1"/>
              </p:cNvSpPr>
              <p:nvPr/>
            </p:nvSpPr>
            <p:spPr bwMode="auto">
              <a:xfrm>
                <a:off x="1695450" y="4106863"/>
                <a:ext cx="361950" cy="2190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メイリオ" pitchFamily="50" charset="-128"/>
                    <a:ea typeface="メイリオ" pitchFamily="50" charset="-128"/>
                    <a:cs typeface="ＭＳ Ｐゴシック" pitchFamily="50" charset="-128"/>
                  </a:rPr>
                  <a:t>0.00</a:t>
                </a:r>
                <a:endParaRPr kumimoji="1" lang="ja-JP" altLang="ja-JP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  <p:sp>
            <p:nvSpPr>
              <p:cNvPr id="4" name="Rectangle 402"/>
              <p:cNvSpPr>
                <a:spLocks noChangeArrowheads="1"/>
              </p:cNvSpPr>
              <p:nvPr/>
            </p:nvSpPr>
            <p:spPr bwMode="auto">
              <a:xfrm>
                <a:off x="1695450" y="3897313"/>
                <a:ext cx="361950" cy="2190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メイリオ" pitchFamily="50" charset="-128"/>
                    <a:ea typeface="メイリオ" pitchFamily="50" charset="-128"/>
                    <a:cs typeface="ＭＳ Ｐゴシック" pitchFamily="50" charset="-128"/>
                  </a:rPr>
                  <a:t>0.10</a:t>
                </a:r>
                <a:endParaRPr kumimoji="1" lang="ja-JP" altLang="ja-JP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  <p:sp>
            <p:nvSpPr>
              <p:cNvPr id="5" name="Rectangle 405"/>
              <p:cNvSpPr>
                <a:spLocks noChangeArrowheads="1"/>
              </p:cNvSpPr>
              <p:nvPr/>
            </p:nvSpPr>
            <p:spPr bwMode="auto">
              <a:xfrm>
                <a:off x="1695450" y="3697288"/>
                <a:ext cx="361950" cy="2190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メイリオ" pitchFamily="50" charset="-128"/>
                    <a:ea typeface="メイリオ" pitchFamily="50" charset="-128"/>
                    <a:cs typeface="ＭＳ Ｐゴシック" pitchFamily="50" charset="-128"/>
                  </a:rPr>
                  <a:t>0.20</a:t>
                </a:r>
                <a:endParaRPr kumimoji="1" lang="ja-JP" altLang="ja-JP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  <p:sp>
            <p:nvSpPr>
              <p:cNvPr id="6" name="Rectangle 408"/>
              <p:cNvSpPr>
                <a:spLocks noChangeArrowheads="1"/>
              </p:cNvSpPr>
              <p:nvPr/>
            </p:nvSpPr>
            <p:spPr bwMode="auto">
              <a:xfrm>
                <a:off x="1695450" y="3487738"/>
                <a:ext cx="361950" cy="2190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メイリオ" pitchFamily="50" charset="-128"/>
                    <a:ea typeface="メイリオ" pitchFamily="50" charset="-128"/>
                    <a:cs typeface="ＭＳ Ｐゴシック" pitchFamily="50" charset="-128"/>
                  </a:rPr>
                  <a:t>0.30</a:t>
                </a:r>
                <a:endParaRPr kumimoji="1" lang="ja-JP" altLang="ja-JP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  <p:sp>
            <p:nvSpPr>
              <p:cNvPr id="7" name="Rectangle 411"/>
              <p:cNvSpPr>
                <a:spLocks noChangeArrowheads="1"/>
              </p:cNvSpPr>
              <p:nvPr/>
            </p:nvSpPr>
            <p:spPr bwMode="auto">
              <a:xfrm>
                <a:off x="1695450" y="3287713"/>
                <a:ext cx="361950" cy="2190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メイリオ" pitchFamily="50" charset="-128"/>
                    <a:ea typeface="メイリオ" pitchFamily="50" charset="-128"/>
                    <a:cs typeface="ＭＳ Ｐゴシック" pitchFamily="50" charset="-128"/>
                  </a:rPr>
                  <a:t>0.40</a:t>
                </a:r>
                <a:endParaRPr kumimoji="1" lang="ja-JP" altLang="ja-JP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  <p:sp>
            <p:nvSpPr>
              <p:cNvPr id="8" name="Rectangle 414"/>
              <p:cNvSpPr>
                <a:spLocks noChangeArrowheads="1"/>
              </p:cNvSpPr>
              <p:nvPr/>
            </p:nvSpPr>
            <p:spPr bwMode="auto">
              <a:xfrm>
                <a:off x="1695450" y="3078163"/>
                <a:ext cx="361950" cy="2190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メイリオ" pitchFamily="50" charset="-128"/>
                    <a:ea typeface="メイリオ" pitchFamily="50" charset="-128"/>
                    <a:cs typeface="ＭＳ Ｐゴシック" pitchFamily="50" charset="-128"/>
                  </a:rPr>
                  <a:t>0.50</a:t>
                </a:r>
                <a:endParaRPr kumimoji="1" lang="ja-JP" altLang="ja-JP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  <p:sp>
            <p:nvSpPr>
              <p:cNvPr id="9" name="Rectangle 417"/>
              <p:cNvSpPr>
                <a:spLocks noChangeArrowheads="1"/>
              </p:cNvSpPr>
              <p:nvPr/>
            </p:nvSpPr>
            <p:spPr bwMode="auto">
              <a:xfrm>
                <a:off x="1695450" y="2878138"/>
                <a:ext cx="361950" cy="2190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メイリオ" pitchFamily="50" charset="-128"/>
                    <a:ea typeface="メイリオ" pitchFamily="50" charset="-128"/>
                    <a:cs typeface="ＭＳ Ｐゴシック" pitchFamily="50" charset="-128"/>
                  </a:rPr>
                  <a:t>0.60</a:t>
                </a:r>
                <a:endParaRPr kumimoji="1" lang="ja-JP" altLang="ja-JP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  <p:sp>
            <p:nvSpPr>
              <p:cNvPr id="10" name="Rectangle 420"/>
              <p:cNvSpPr>
                <a:spLocks noChangeArrowheads="1"/>
              </p:cNvSpPr>
              <p:nvPr/>
            </p:nvSpPr>
            <p:spPr bwMode="auto">
              <a:xfrm>
                <a:off x="1695450" y="2668588"/>
                <a:ext cx="361950" cy="2190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メイリオ" pitchFamily="50" charset="-128"/>
                    <a:ea typeface="メイリオ" pitchFamily="50" charset="-128"/>
                    <a:cs typeface="ＭＳ Ｐゴシック" pitchFamily="50" charset="-128"/>
                  </a:rPr>
                  <a:t>0.70</a:t>
                </a:r>
                <a:endParaRPr kumimoji="1" lang="ja-JP" altLang="ja-JP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  <p:sp>
            <p:nvSpPr>
              <p:cNvPr id="11" name="Rectangle 423"/>
              <p:cNvSpPr>
                <a:spLocks noChangeArrowheads="1"/>
              </p:cNvSpPr>
              <p:nvPr/>
            </p:nvSpPr>
            <p:spPr bwMode="auto">
              <a:xfrm>
                <a:off x="1695450" y="2468563"/>
                <a:ext cx="361950" cy="2190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メイリオ" pitchFamily="50" charset="-128"/>
                    <a:ea typeface="メイリオ" pitchFamily="50" charset="-128"/>
                    <a:cs typeface="ＭＳ Ｐゴシック" pitchFamily="50" charset="-128"/>
                  </a:rPr>
                  <a:t>0.80</a:t>
                </a:r>
                <a:endParaRPr kumimoji="1" lang="ja-JP" altLang="ja-JP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  <p:sp>
            <p:nvSpPr>
              <p:cNvPr id="12" name="Rectangle 426"/>
              <p:cNvSpPr>
                <a:spLocks noChangeArrowheads="1"/>
              </p:cNvSpPr>
              <p:nvPr/>
            </p:nvSpPr>
            <p:spPr bwMode="auto">
              <a:xfrm>
                <a:off x="1695450" y="2268538"/>
                <a:ext cx="361950" cy="2190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メイリオ" pitchFamily="50" charset="-128"/>
                    <a:ea typeface="メイリオ" pitchFamily="50" charset="-128"/>
                    <a:cs typeface="ＭＳ Ｐゴシック" pitchFamily="50" charset="-128"/>
                  </a:rPr>
                  <a:t>0.90</a:t>
                </a:r>
                <a:endParaRPr kumimoji="1" lang="ja-JP" altLang="ja-JP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  <p:sp>
            <p:nvSpPr>
              <p:cNvPr id="13" name="Rectangle 429"/>
              <p:cNvSpPr>
                <a:spLocks noChangeArrowheads="1"/>
              </p:cNvSpPr>
              <p:nvPr/>
            </p:nvSpPr>
            <p:spPr bwMode="auto">
              <a:xfrm>
                <a:off x="1695450" y="2058988"/>
                <a:ext cx="361950" cy="2190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メイリオ" pitchFamily="50" charset="-128"/>
                    <a:ea typeface="メイリオ" pitchFamily="50" charset="-128"/>
                    <a:cs typeface="ＭＳ Ｐゴシック" pitchFamily="50" charset="-128"/>
                  </a:rPr>
                  <a:t>1.00</a:t>
                </a:r>
                <a:endParaRPr kumimoji="1" lang="ja-JP" altLang="ja-JP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</p:grpSp>
        <p:sp>
          <p:nvSpPr>
            <p:cNvPr id="15" name="Line 398"/>
            <p:cNvSpPr>
              <a:spLocks noChangeShapeType="1"/>
            </p:cNvSpPr>
            <p:nvPr/>
          </p:nvSpPr>
          <p:spPr bwMode="auto">
            <a:xfrm flipH="1">
              <a:off x="3566012" y="3215717"/>
              <a:ext cx="57150" cy="0"/>
            </a:xfrm>
            <a:prstGeom prst="line">
              <a:avLst/>
            </a:pr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" name="Line 400"/>
            <p:cNvSpPr>
              <a:spLocks noChangeShapeType="1"/>
            </p:cNvSpPr>
            <p:nvPr/>
          </p:nvSpPr>
          <p:spPr bwMode="auto">
            <a:xfrm flipH="1">
              <a:off x="3594587" y="3110942"/>
              <a:ext cx="28575" cy="0"/>
            </a:xfrm>
            <a:prstGeom prst="line">
              <a:avLst/>
            </a:pr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" name="Line 401"/>
            <p:cNvSpPr>
              <a:spLocks noChangeShapeType="1"/>
            </p:cNvSpPr>
            <p:nvPr/>
          </p:nvSpPr>
          <p:spPr bwMode="auto">
            <a:xfrm flipH="1">
              <a:off x="3566012" y="3006167"/>
              <a:ext cx="57150" cy="0"/>
            </a:xfrm>
            <a:prstGeom prst="line">
              <a:avLst/>
            </a:pr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" name="Line 403"/>
            <p:cNvSpPr>
              <a:spLocks noChangeShapeType="1"/>
            </p:cNvSpPr>
            <p:nvPr/>
          </p:nvSpPr>
          <p:spPr bwMode="auto">
            <a:xfrm flipH="1">
              <a:off x="3594587" y="2910917"/>
              <a:ext cx="28575" cy="0"/>
            </a:xfrm>
            <a:prstGeom prst="line">
              <a:avLst/>
            </a:pr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" name="Line 404"/>
            <p:cNvSpPr>
              <a:spLocks noChangeShapeType="1"/>
            </p:cNvSpPr>
            <p:nvPr/>
          </p:nvSpPr>
          <p:spPr bwMode="auto">
            <a:xfrm flipH="1">
              <a:off x="3566012" y="2806142"/>
              <a:ext cx="57150" cy="0"/>
            </a:xfrm>
            <a:prstGeom prst="line">
              <a:avLst/>
            </a:pr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" name="Line 406"/>
            <p:cNvSpPr>
              <a:spLocks noChangeShapeType="1"/>
            </p:cNvSpPr>
            <p:nvPr/>
          </p:nvSpPr>
          <p:spPr bwMode="auto">
            <a:xfrm flipH="1">
              <a:off x="3594587" y="2701367"/>
              <a:ext cx="28575" cy="0"/>
            </a:xfrm>
            <a:prstGeom prst="line">
              <a:avLst/>
            </a:pr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" name="Line 407"/>
            <p:cNvSpPr>
              <a:spLocks noChangeShapeType="1"/>
            </p:cNvSpPr>
            <p:nvPr/>
          </p:nvSpPr>
          <p:spPr bwMode="auto">
            <a:xfrm flipH="1">
              <a:off x="3566012" y="2596592"/>
              <a:ext cx="57150" cy="0"/>
            </a:xfrm>
            <a:prstGeom prst="line">
              <a:avLst/>
            </a:pr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" name="Line 409"/>
            <p:cNvSpPr>
              <a:spLocks noChangeShapeType="1"/>
            </p:cNvSpPr>
            <p:nvPr/>
          </p:nvSpPr>
          <p:spPr bwMode="auto">
            <a:xfrm flipH="1">
              <a:off x="3594587" y="2501342"/>
              <a:ext cx="28575" cy="0"/>
            </a:xfrm>
            <a:prstGeom prst="line">
              <a:avLst/>
            </a:pr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" name="Line 410"/>
            <p:cNvSpPr>
              <a:spLocks noChangeShapeType="1"/>
            </p:cNvSpPr>
            <p:nvPr/>
          </p:nvSpPr>
          <p:spPr bwMode="auto">
            <a:xfrm flipH="1">
              <a:off x="3566012" y="2396567"/>
              <a:ext cx="57150" cy="0"/>
            </a:xfrm>
            <a:prstGeom prst="line">
              <a:avLst/>
            </a:pr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" name="Line 412"/>
            <p:cNvSpPr>
              <a:spLocks noChangeShapeType="1"/>
            </p:cNvSpPr>
            <p:nvPr/>
          </p:nvSpPr>
          <p:spPr bwMode="auto">
            <a:xfrm flipH="1">
              <a:off x="3594587" y="2291792"/>
              <a:ext cx="28575" cy="0"/>
            </a:xfrm>
            <a:prstGeom prst="line">
              <a:avLst/>
            </a:pr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" name="Line 413"/>
            <p:cNvSpPr>
              <a:spLocks noChangeShapeType="1"/>
            </p:cNvSpPr>
            <p:nvPr/>
          </p:nvSpPr>
          <p:spPr bwMode="auto">
            <a:xfrm flipH="1">
              <a:off x="3566012" y="2187017"/>
              <a:ext cx="57150" cy="0"/>
            </a:xfrm>
            <a:prstGeom prst="line">
              <a:avLst/>
            </a:pr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" name="Line 415"/>
            <p:cNvSpPr>
              <a:spLocks noChangeShapeType="1"/>
            </p:cNvSpPr>
            <p:nvPr/>
          </p:nvSpPr>
          <p:spPr bwMode="auto">
            <a:xfrm flipH="1">
              <a:off x="3594587" y="2091767"/>
              <a:ext cx="28575" cy="0"/>
            </a:xfrm>
            <a:prstGeom prst="line">
              <a:avLst/>
            </a:pr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" name="Line 416"/>
            <p:cNvSpPr>
              <a:spLocks noChangeShapeType="1"/>
            </p:cNvSpPr>
            <p:nvPr/>
          </p:nvSpPr>
          <p:spPr bwMode="auto">
            <a:xfrm flipH="1">
              <a:off x="3566012" y="1986992"/>
              <a:ext cx="57150" cy="0"/>
            </a:xfrm>
            <a:prstGeom prst="line">
              <a:avLst/>
            </a:pr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" name="Line 418"/>
            <p:cNvSpPr>
              <a:spLocks noChangeShapeType="1"/>
            </p:cNvSpPr>
            <p:nvPr/>
          </p:nvSpPr>
          <p:spPr bwMode="auto">
            <a:xfrm flipH="1">
              <a:off x="3594587" y="1882217"/>
              <a:ext cx="28575" cy="0"/>
            </a:xfrm>
            <a:prstGeom prst="line">
              <a:avLst/>
            </a:pr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" name="Line 419"/>
            <p:cNvSpPr>
              <a:spLocks noChangeShapeType="1"/>
            </p:cNvSpPr>
            <p:nvPr/>
          </p:nvSpPr>
          <p:spPr bwMode="auto">
            <a:xfrm flipH="1">
              <a:off x="3566012" y="1777442"/>
              <a:ext cx="57150" cy="0"/>
            </a:xfrm>
            <a:prstGeom prst="line">
              <a:avLst/>
            </a:pr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" name="Line 421"/>
            <p:cNvSpPr>
              <a:spLocks noChangeShapeType="1"/>
            </p:cNvSpPr>
            <p:nvPr/>
          </p:nvSpPr>
          <p:spPr bwMode="auto">
            <a:xfrm flipH="1">
              <a:off x="3594587" y="1682192"/>
              <a:ext cx="28575" cy="0"/>
            </a:xfrm>
            <a:prstGeom prst="line">
              <a:avLst/>
            </a:pr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" name="Line 422"/>
            <p:cNvSpPr>
              <a:spLocks noChangeShapeType="1"/>
            </p:cNvSpPr>
            <p:nvPr/>
          </p:nvSpPr>
          <p:spPr bwMode="auto">
            <a:xfrm flipH="1">
              <a:off x="3566012" y="1577417"/>
              <a:ext cx="57150" cy="0"/>
            </a:xfrm>
            <a:prstGeom prst="line">
              <a:avLst/>
            </a:pr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" name="Line 424"/>
            <p:cNvSpPr>
              <a:spLocks noChangeShapeType="1"/>
            </p:cNvSpPr>
            <p:nvPr/>
          </p:nvSpPr>
          <p:spPr bwMode="auto">
            <a:xfrm flipH="1">
              <a:off x="3594587" y="1472642"/>
              <a:ext cx="28575" cy="0"/>
            </a:xfrm>
            <a:prstGeom prst="line">
              <a:avLst/>
            </a:pr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" name="Line 425"/>
            <p:cNvSpPr>
              <a:spLocks noChangeShapeType="1"/>
            </p:cNvSpPr>
            <p:nvPr/>
          </p:nvSpPr>
          <p:spPr bwMode="auto">
            <a:xfrm flipH="1">
              <a:off x="3566012" y="1377392"/>
              <a:ext cx="57150" cy="0"/>
            </a:xfrm>
            <a:prstGeom prst="line">
              <a:avLst/>
            </a:pr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" name="Line 427"/>
            <p:cNvSpPr>
              <a:spLocks noChangeShapeType="1"/>
            </p:cNvSpPr>
            <p:nvPr/>
          </p:nvSpPr>
          <p:spPr bwMode="auto">
            <a:xfrm flipH="1">
              <a:off x="3594587" y="1272617"/>
              <a:ext cx="28575" cy="0"/>
            </a:xfrm>
            <a:prstGeom prst="line">
              <a:avLst/>
            </a:pr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" name="Line 428"/>
            <p:cNvSpPr>
              <a:spLocks noChangeShapeType="1"/>
            </p:cNvSpPr>
            <p:nvPr/>
          </p:nvSpPr>
          <p:spPr bwMode="auto">
            <a:xfrm flipH="1">
              <a:off x="3566012" y="1167842"/>
              <a:ext cx="57150" cy="0"/>
            </a:xfrm>
            <a:prstGeom prst="line">
              <a:avLst/>
            </a:pr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" name="Rectangle 430"/>
            <p:cNvSpPr>
              <a:spLocks noChangeArrowheads="1"/>
            </p:cNvSpPr>
            <p:nvPr/>
          </p:nvSpPr>
          <p:spPr bwMode="auto">
            <a:xfrm>
              <a:off x="3623162" y="1167842"/>
              <a:ext cx="2047875" cy="2047875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" name="Line 431"/>
            <p:cNvSpPr>
              <a:spLocks noChangeShapeType="1"/>
            </p:cNvSpPr>
            <p:nvPr/>
          </p:nvSpPr>
          <p:spPr bwMode="auto">
            <a:xfrm flipV="1">
              <a:off x="3623162" y="1177367"/>
              <a:ext cx="0" cy="2028825"/>
            </a:xfrm>
            <a:prstGeom prst="line">
              <a:avLst/>
            </a:prstGeom>
            <a:noFill/>
            <a:ln w="6" cap="flat">
              <a:solidFill>
                <a:srgbClr val="D7D7D7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" name="Line 432"/>
            <p:cNvSpPr>
              <a:spLocks noChangeShapeType="1"/>
            </p:cNvSpPr>
            <p:nvPr/>
          </p:nvSpPr>
          <p:spPr bwMode="auto">
            <a:xfrm flipV="1">
              <a:off x="3832712" y="1177367"/>
              <a:ext cx="0" cy="2028825"/>
            </a:xfrm>
            <a:prstGeom prst="line">
              <a:avLst/>
            </a:prstGeom>
            <a:noFill/>
            <a:ln w="6" cap="flat">
              <a:solidFill>
                <a:srgbClr val="D7D7D7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" name="Line 433"/>
            <p:cNvSpPr>
              <a:spLocks noChangeShapeType="1"/>
            </p:cNvSpPr>
            <p:nvPr/>
          </p:nvSpPr>
          <p:spPr bwMode="auto">
            <a:xfrm flipV="1">
              <a:off x="4032737" y="1177367"/>
              <a:ext cx="0" cy="2028825"/>
            </a:xfrm>
            <a:prstGeom prst="line">
              <a:avLst/>
            </a:prstGeom>
            <a:noFill/>
            <a:ln w="6" cap="flat">
              <a:solidFill>
                <a:srgbClr val="D7D7D7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" name="Line 434"/>
            <p:cNvSpPr>
              <a:spLocks noChangeShapeType="1"/>
            </p:cNvSpPr>
            <p:nvPr/>
          </p:nvSpPr>
          <p:spPr bwMode="auto">
            <a:xfrm flipV="1">
              <a:off x="4242287" y="1177367"/>
              <a:ext cx="0" cy="2028825"/>
            </a:xfrm>
            <a:prstGeom prst="line">
              <a:avLst/>
            </a:prstGeom>
            <a:noFill/>
            <a:ln w="6" cap="flat">
              <a:solidFill>
                <a:srgbClr val="D7D7D7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" name="Line 435"/>
            <p:cNvSpPr>
              <a:spLocks noChangeShapeType="1"/>
            </p:cNvSpPr>
            <p:nvPr/>
          </p:nvSpPr>
          <p:spPr bwMode="auto">
            <a:xfrm flipV="1">
              <a:off x="4442312" y="1177367"/>
              <a:ext cx="0" cy="2028825"/>
            </a:xfrm>
            <a:prstGeom prst="line">
              <a:avLst/>
            </a:prstGeom>
            <a:noFill/>
            <a:ln w="6" cap="flat">
              <a:solidFill>
                <a:srgbClr val="D7D7D7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2" name="Line 436"/>
            <p:cNvSpPr>
              <a:spLocks noChangeShapeType="1"/>
            </p:cNvSpPr>
            <p:nvPr/>
          </p:nvSpPr>
          <p:spPr bwMode="auto">
            <a:xfrm flipV="1">
              <a:off x="4651862" y="1177367"/>
              <a:ext cx="0" cy="2028825"/>
            </a:xfrm>
            <a:prstGeom prst="line">
              <a:avLst/>
            </a:prstGeom>
            <a:noFill/>
            <a:ln w="6" cap="flat">
              <a:solidFill>
                <a:srgbClr val="D7D7D7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3" name="Line 437"/>
            <p:cNvSpPr>
              <a:spLocks noChangeShapeType="1"/>
            </p:cNvSpPr>
            <p:nvPr/>
          </p:nvSpPr>
          <p:spPr bwMode="auto">
            <a:xfrm flipV="1">
              <a:off x="4851887" y="1177367"/>
              <a:ext cx="0" cy="2028825"/>
            </a:xfrm>
            <a:prstGeom prst="line">
              <a:avLst/>
            </a:prstGeom>
            <a:noFill/>
            <a:ln w="6" cap="flat">
              <a:solidFill>
                <a:srgbClr val="D7D7D7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4" name="Line 438"/>
            <p:cNvSpPr>
              <a:spLocks noChangeShapeType="1"/>
            </p:cNvSpPr>
            <p:nvPr/>
          </p:nvSpPr>
          <p:spPr bwMode="auto">
            <a:xfrm flipV="1">
              <a:off x="5061437" y="1177367"/>
              <a:ext cx="0" cy="2028825"/>
            </a:xfrm>
            <a:prstGeom prst="line">
              <a:avLst/>
            </a:prstGeom>
            <a:noFill/>
            <a:ln w="6" cap="flat">
              <a:solidFill>
                <a:srgbClr val="D7D7D7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5" name="Line 439"/>
            <p:cNvSpPr>
              <a:spLocks noChangeShapeType="1"/>
            </p:cNvSpPr>
            <p:nvPr/>
          </p:nvSpPr>
          <p:spPr bwMode="auto">
            <a:xfrm flipV="1">
              <a:off x="5261462" y="1177367"/>
              <a:ext cx="0" cy="2028825"/>
            </a:xfrm>
            <a:prstGeom prst="line">
              <a:avLst/>
            </a:prstGeom>
            <a:noFill/>
            <a:ln w="6" cap="flat">
              <a:solidFill>
                <a:srgbClr val="D7D7D7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6" name="Line 440"/>
            <p:cNvSpPr>
              <a:spLocks noChangeShapeType="1"/>
            </p:cNvSpPr>
            <p:nvPr/>
          </p:nvSpPr>
          <p:spPr bwMode="auto">
            <a:xfrm flipV="1">
              <a:off x="5461487" y="1177367"/>
              <a:ext cx="0" cy="2028825"/>
            </a:xfrm>
            <a:prstGeom prst="line">
              <a:avLst/>
            </a:prstGeom>
            <a:noFill/>
            <a:ln w="6" cap="flat">
              <a:solidFill>
                <a:srgbClr val="D7D7D7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7" name="Line 441"/>
            <p:cNvSpPr>
              <a:spLocks noChangeShapeType="1"/>
            </p:cNvSpPr>
            <p:nvPr/>
          </p:nvSpPr>
          <p:spPr bwMode="auto">
            <a:xfrm flipV="1">
              <a:off x="5671037" y="1177367"/>
              <a:ext cx="0" cy="2028825"/>
            </a:xfrm>
            <a:prstGeom prst="line">
              <a:avLst/>
            </a:prstGeom>
            <a:noFill/>
            <a:ln w="6" cap="flat">
              <a:solidFill>
                <a:srgbClr val="D7D7D7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8" name="Line 442"/>
            <p:cNvSpPr>
              <a:spLocks noChangeShapeType="1"/>
            </p:cNvSpPr>
            <p:nvPr/>
          </p:nvSpPr>
          <p:spPr bwMode="auto">
            <a:xfrm>
              <a:off x="3632687" y="3215717"/>
              <a:ext cx="2028825" cy="0"/>
            </a:xfrm>
            <a:prstGeom prst="line">
              <a:avLst/>
            </a:prstGeom>
            <a:noFill/>
            <a:ln w="6" cap="flat">
              <a:solidFill>
                <a:srgbClr val="D7D7D7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9" name="Line 443"/>
            <p:cNvSpPr>
              <a:spLocks noChangeShapeType="1"/>
            </p:cNvSpPr>
            <p:nvPr/>
          </p:nvSpPr>
          <p:spPr bwMode="auto">
            <a:xfrm>
              <a:off x="3632687" y="3006167"/>
              <a:ext cx="2028825" cy="0"/>
            </a:xfrm>
            <a:prstGeom prst="line">
              <a:avLst/>
            </a:prstGeom>
            <a:noFill/>
            <a:ln w="6" cap="flat">
              <a:solidFill>
                <a:srgbClr val="D7D7D7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0" name="Line 444"/>
            <p:cNvSpPr>
              <a:spLocks noChangeShapeType="1"/>
            </p:cNvSpPr>
            <p:nvPr/>
          </p:nvSpPr>
          <p:spPr bwMode="auto">
            <a:xfrm>
              <a:off x="3632687" y="2806142"/>
              <a:ext cx="2028825" cy="0"/>
            </a:xfrm>
            <a:prstGeom prst="line">
              <a:avLst/>
            </a:prstGeom>
            <a:noFill/>
            <a:ln w="6" cap="flat">
              <a:solidFill>
                <a:srgbClr val="D7D7D7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1" name="Line 445"/>
            <p:cNvSpPr>
              <a:spLocks noChangeShapeType="1"/>
            </p:cNvSpPr>
            <p:nvPr/>
          </p:nvSpPr>
          <p:spPr bwMode="auto">
            <a:xfrm>
              <a:off x="3632687" y="2596592"/>
              <a:ext cx="2028825" cy="0"/>
            </a:xfrm>
            <a:prstGeom prst="line">
              <a:avLst/>
            </a:prstGeom>
            <a:noFill/>
            <a:ln w="6" cap="flat">
              <a:solidFill>
                <a:srgbClr val="D7D7D7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2" name="Line 446"/>
            <p:cNvSpPr>
              <a:spLocks noChangeShapeType="1"/>
            </p:cNvSpPr>
            <p:nvPr/>
          </p:nvSpPr>
          <p:spPr bwMode="auto">
            <a:xfrm>
              <a:off x="3632687" y="2396567"/>
              <a:ext cx="2028825" cy="0"/>
            </a:xfrm>
            <a:prstGeom prst="line">
              <a:avLst/>
            </a:prstGeom>
            <a:noFill/>
            <a:ln w="6" cap="flat">
              <a:solidFill>
                <a:srgbClr val="D7D7D7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3" name="Line 447"/>
            <p:cNvSpPr>
              <a:spLocks noChangeShapeType="1"/>
            </p:cNvSpPr>
            <p:nvPr/>
          </p:nvSpPr>
          <p:spPr bwMode="auto">
            <a:xfrm>
              <a:off x="3632687" y="2187017"/>
              <a:ext cx="2028825" cy="0"/>
            </a:xfrm>
            <a:prstGeom prst="line">
              <a:avLst/>
            </a:prstGeom>
            <a:noFill/>
            <a:ln w="6" cap="flat">
              <a:solidFill>
                <a:srgbClr val="D7D7D7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4" name="Line 448"/>
            <p:cNvSpPr>
              <a:spLocks noChangeShapeType="1"/>
            </p:cNvSpPr>
            <p:nvPr/>
          </p:nvSpPr>
          <p:spPr bwMode="auto">
            <a:xfrm>
              <a:off x="3632687" y="1986992"/>
              <a:ext cx="2028825" cy="0"/>
            </a:xfrm>
            <a:prstGeom prst="line">
              <a:avLst/>
            </a:prstGeom>
            <a:noFill/>
            <a:ln w="6" cap="flat">
              <a:solidFill>
                <a:srgbClr val="D7D7D7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5" name="Line 449"/>
            <p:cNvSpPr>
              <a:spLocks noChangeShapeType="1"/>
            </p:cNvSpPr>
            <p:nvPr/>
          </p:nvSpPr>
          <p:spPr bwMode="auto">
            <a:xfrm>
              <a:off x="3632687" y="1777442"/>
              <a:ext cx="2028825" cy="0"/>
            </a:xfrm>
            <a:prstGeom prst="line">
              <a:avLst/>
            </a:prstGeom>
            <a:noFill/>
            <a:ln w="6" cap="flat">
              <a:solidFill>
                <a:srgbClr val="D7D7D7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6" name="Line 450"/>
            <p:cNvSpPr>
              <a:spLocks noChangeShapeType="1"/>
            </p:cNvSpPr>
            <p:nvPr/>
          </p:nvSpPr>
          <p:spPr bwMode="auto">
            <a:xfrm>
              <a:off x="3632687" y="1577417"/>
              <a:ext cx="2028825" cy="0"/>
            </a:xfrm>
            <a:prstGeom prst="line">
              <a:avLst/>
            </a:prstGeom>
            <a:noFill/>
            <a:ln w="6" cap="flat">
              <a:solidFill>
                <a:srgbClr val="D7D7D7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7" name="Line 451"/>
            <p:cNvSpPr>
              <a:spLocks noChangeShapeType="1"/>
            </p:cNvSpPr>
            <p:nvPr/>
          </p:nvSpPr>
          <p:spPr bwMode="auto">
            <a:xfrm>
              <a:off x="3632687" y="1377392"/>
              <a:ext cx="2028825" cy="0"/>
            </a:xfrm>
            <a:prstGeom prst="line">
              <a:avLst/>
            </a:prstGeom>
            <a:noFill/>
            <a:ln w="6" cap="flat">
              <a:solidFill>
                <a:srgbClr val="D7D7D7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8" name="Line 452"/>
            <p:cNvSpPr>
              <a:spLocks noChangeShapeType="1"/>
            </p:cNvSpPr>
            <p:nvPr/>
          </p:nvSpPr>
          <p:spPr bwMode="auto">
            <a:xfrm>
              <a:off x="3632687" y="1167842"/>
              <a:ext cx="2028825" cy="0"/>
            </a:xfrm>
            <a:prstGeom prst="line">
              <a:avLst/>
            </a:prstGeom>
            <a:noFill/>
            <a:ln w="6" cap="flat">
              <a:solidFill>
                <a:srgbClr val="D7D7D7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0" name="Line 454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1" name="Line 455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2" name="Line 456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3" name="Line 457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4" name="Line 458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5" name="Line 459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6" name="Line 460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7" name="Line 461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8" name="Line 462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9" name="Line 463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0" name="Line 464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1" name="Line 465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2" name="Line 466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3" name="Line 467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4" name="Line 468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5" name="Line 469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6" name="Line 470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7" name="Line 471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8" name="Line 472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9" name="Line 473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0" name="Line 474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1" name="Line 475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2" name="Line 476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3" name="Line 477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4" name="Line 478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5" name="Line 479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6" name="Line 480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7" name="Line 481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8" name="Line 482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9" name="Line 483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0" name="Line 484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1" name="Line 485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2" name="Line 486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3" name="Line 487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4" name="Line 488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5" name="Line 489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6" name="Line 490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7" name="Line 491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" name="Line 492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" name="Line 493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0" name="Line 494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1" name="Line 495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2" name="Line 496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3" name="Line 497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4" name="Line 498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5" name="Line 499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6" name="Line 500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7" name="Line 501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8" name="Line 502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9" name="Line 503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0" name="Line 504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1" name="Line 505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2" name="Line 506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3" name="Line 507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4" name="Line 508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5" name="Line 509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6" name="Line 510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7" name="Line 511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8" name="Line 512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9" name="Line 513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0" name="Line 514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1" name="Line 515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2" name="Line 516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3" name="Line 517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4" name="Line 518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5" name="Line 519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6" name="Line 520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7" name="Line 521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8" name="Line 522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" name="Line 523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" name="Line 524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" name="Line 525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2" name="Line 526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" name="Line 527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" name="Line 528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" name="Line 529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6" name="Line 530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7" name="Line 531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8" name="Line 532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9" name="Line 533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0" name="Line 534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1" name="Line 535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2" name="Line 536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3" name="Line 537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4" name="Line 538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5" name="Line 539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6" name="Line 540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7" name="Line 541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8" name="Line 542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9" name="Line 543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0" name="Line 544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1" name="Line 545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2" name="Line 546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3" name="Line 547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4" name="Line 548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5" name="Line 549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6" name="Line 550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7" name="Line 551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8" name="Line 552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9" name="Line 553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0" name="Line 554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1" name="Line 555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2" name="Line 556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3" name="Line 557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4" name="Line 558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5" name="Line 559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6" name="Line 560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7" name="Line 561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8" name="Line 562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9" name="Line 563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0" name="Line 564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1" name="Line 565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2" name="Line 566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3" name="Line 567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4" name="Line 568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5" name="Line 569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6" name="Line 570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7" name="Line 571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8" name="Line 572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9" name="Line 573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0" name="Line 574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" name="Line 575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2" name="Line 576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3" name="Line 577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4" name="Line 578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5" name="Line 579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6" name="Line 580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7" name="Line 581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8" name="Line 582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9" name="Line 583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0" name="Line 584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1" name="Line 585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2" name="Line 586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3" name="Line 587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4" name="Line 588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5" name="Line 589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6" name="Line 590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7" name="Line 591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8" name="Line 593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9" name="Line 594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0" name="Line 595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1" name="Line 596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2" name="Line 597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3" name="Line 598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4" name="Line 599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5" name="Line 600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6" name="Line 601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7" name="Line 602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8" name="Line 603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9" name="Line 604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0" name="Line 605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1" name="Line 606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2" name="Line 607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3" name="Line 608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4" name="Line 609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5" name="Line 610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6" name="Line 611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7" name="Line 612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8" name="Line 613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9" name="Line 614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0" name="Line 615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1" name="Line 616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2" name="Line 617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3" name="Line 618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4" name="Line 619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5" name="Line 620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6" name="Line 621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7" name="Line 622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8" name="Line 623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9" name="Line 624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0" name="Line 625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1" name="Line 626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2" name="Line 627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3" name="Line 628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4" name="Line 629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5" name="Line 630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6" name="Line 631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7" name="Line 632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8" name="Line 633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9" name="Line 634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0" name="Line 635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1" name="Line 636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2" name="Line 637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3" name="Line 638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4" name="Line 639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5" name="Line 640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6" name="Line 641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7" name="Line 642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8" name="Line 643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9" name="Line 644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0" name="Line 645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1" name="Line 646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2" name="Line 647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3" name="Line 648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4" name="Line 649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5" name="Line 650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6" name="Line 651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7" name="Line 652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8" name="Line 653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9" name="Line 654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0" name="Line 655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1" name="Line 656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2" name="Line 657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3" name="Line 658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4" name="Line 659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5" name="Line 660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6" name="Line 661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7" name="Line 662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8" name="Line 663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9" name="Line 664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0" name="Line 665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1" name="Line 666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2" name="Line 667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3" name="Line 668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4" name="Line 669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5" name="Line 670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6" name="Line 671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7" name="Line 672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8" name="Line 673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9" name="Line 674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0" name="Line 675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1" name="Line 676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2" name="Line 677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3" name="Line 678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4" name="Line 679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5" name="Line 680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6" name="Line 681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7" name="Line 682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8" name="Line 683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9" name="Line 684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0" name="Line 685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1" name="Line 686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2" name="Line 687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3" name="Line 688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4" name="Line 689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5" name="Line 690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6" name="Line 691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7" name="Line 692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8" name="Line 693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9" name="Line 694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0" name="Line 695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1" name="Line 696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2" name="Line 697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3" name="Line 698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4" name="Line 699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5" name="Line 700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6" name="Line 701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7" name="Line 702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8" name="Line 703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9" name="Line 704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0" name="Line 705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1" name="Line 706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2" name="Line 707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3" name="Line 708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4" name="Line 709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5" name="Line 710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6" name="Line 711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7" name="Line 712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8" name="Line 713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9" name="Line 714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0" name="Line 715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1" name="Line 716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2" name="Line 717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3" name="Line 718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4" name="Line 719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5" name="Line 720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6" name="Line 721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7" name="Line 722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8" name="Line 723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9" name="Line 724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0" name="Line 725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1" name="Line 726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2" name="Line 727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3" name="Line 728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4" name="Line 729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5" name="Line 730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6" name="Line 731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7" name="Line 732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8" name="Line 733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9" name="Line 734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0" name="Line 735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1" name="Line 736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2" name="Line 737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3" name="Line 738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4" name="Line 739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5" name="Line 740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6" name="Line 741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7" name="Line 742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8" name="Line 743"/>
            <p:cNvSpPr>
              <a:spLocks noChangeShapeType="1"/>
            </p:cNvSpPr>
            <p:nvPr/>
          </p:nvSpPr>
          <p:spPr bwMode="auto">
            <a:xfrm>
              <a:off x="4513749" y="1172605"/>
              <a:ext cx="9525" cy="0"/>
            </a:xfrm>
            <a:prstGeom prst="line">
              <a:avLst/>
            </a:prstGeom>
            <a:noFill/>
            <a:ln w="6" cap="flat">
              <a:solidFill>
                <a:srgbClr val="DAD10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9" name="Freeform 744"/>
            <p:cNvSpPr>
              <a:spLocks/>
            </p:cNvSpPr>
            <p:nvPr/>
          </p:nvSpPr>
          <p:spPr bwMode="auto">
            <a:xfrm>
              <a:off x="3627924" y="1172605"/>
              <a:ext cx="2047875" cy="2047875"/>
            </a:xfrm>
            <a:custGeom>
              <a:avLst/>
              <a:gdLst>
                <a:gd name="T0" fmla="*/ 0 w 1290"/>
                <a:gd name="T1" fmla="*/ 1191 h 1290"/>
                <a:gd name="T2" fmla="*/ 10 w 1290"/>
                <a:gd name="T3" fmla="*/ 1092 h 1290"/>
                <a:gd name="T4" fmla="*/ 30 w 1290"/>
                <a:gd name="T5" fmla="*/ 1092 h 1290"/>
                <a:gd name="T6" fmla="*/ 40 w 1290"/>
                <a:gd name="T7" fmla="*/ 993 h 1290"/>
                <a:gd name="T8" fmla="*/ 51 w 1290"/>
                <a:gd name="T9" fmla="*/ 893 h 1290"/>
                <a:gd name="T10" fmla="*/ 61 w 1290"/>
                <a:gd name="T11" fmla="*/ 794 h 1290"/>
                <a:gd name="T12" fmla="*/ 91 w 1290"/>
                <a:gd name="T13" fmla="*/ 794 h 1290"/>
                <a:gd name="T14" fmla="*/ 101 w 1290"/>
                <a:gd name="T15" fmla="*/ 695 h 1290"/>
                <a:gd name="T16" fmla="*/ 121 w 1290"/>
                <a:gd name="T17" fmla="*/ 695 h 1290"/>
                <a:gd name="T18" fmla="*/ 141 w 1290"/>
                <a:gd name="T19" fmla="*/ 695 h 1290"/>
                <a:gd name="T20" fmla="*/ 161 w 1290"/>
                <a:gd name="T21" fmla="*/ 496 h 1290"/>
                <a:gd name="T22" fmla="*/ 171 w 1290"/>
                <a:gd name="T23" fmla="*/ 397 h 1290"/>
                <a:gd name="T24" fmla="*/ 192 w 1290"/>
                <a:gd name="T25" fmla="*/ 397 h 1290"/>
                <a:gd name="T26" fmla="*/ 212 w 1290"/>
                <a:gd name="T27" fmla="*/ 397 h 1290"/>
                <a:gd name="T28" fmla="*/ 232 w 1290"/>
                <a:gd name="T29" fmla="*/ 397 h 1290"/>
                <a:gd name="T30" fmla="*/ 282 w 1290"/>
                <a:gd name="T31" fmla="*/ 298 h 1290"/>
                <a:gd name="T32" fmla="*/ 303 w 1290"/>
                <a:gd name="T33" fmla="*/ 298 h 1290"/>
                <a:gd name="T34" fmla="*/ 322 w 1290"/>
                <a:gd name="T35" fmla="*/ 298 h 1290"/>
                <a:gd name="T36" fmla="*/ 373 w 1290"/>
                <a:gd name="T37" fmla="*/ 298 h 1290"/>
                <a:gd name="T38" fmla="*/ 403 w 1290"/>
                <a:gd name="T39" fmla="*/ 298 h 1290"/>
                <a:gd name="T40" fmla="*/ 504 w 1290"/>
                <a:gd name="T41" fmla="*/ 199 h 1290"/>
                <a:gd name="T42" fmla="*/ 544 w 1290"/>
                <a:gd name="T43" fmla="*/ 199 h 1290"/>
                <a:gd name="T44" fmla="*/ 574 w 1290"/>
                <a:gd name="T45" fmla="*/ 199 h 1290"/>
                <a:gd name="T46" fmla="*/ 605 w 1290"/>
                <a:gd name="T47" fmla="*/ 199 h 1290"/>
                <a:gd name="T48" fmla="*/ 625 w 1290"/>
                <a:gd name="T49" fmla="*/ 199 h 1290"/>
                <a:gd name="T50" fmla="*/ 655 w 1290"/>
                <a:gd name="T51" fmla="*/ 199 h 1290"/>
                <a:gd name="T52" fmla="*/ 756 w 1290"/>
                <a:gd name="T53" fmla="*/ 199 h 1290"/>
                <a:gd name="T54" fmla="*/ 827 w 1290"/>
                <a:gd name="T55" fmla="*/ 199 h 1290"/>
                <a:gd name="T56" fmla="*/ 867 w 1290"/>
                <a:gd name="T57" fmla="*/ 99 h 1290"/>
                <a:gd name="T58" fmla="*/ 907 w 1290"/>
                <a:gd name="T59" fmla="*/ 99 h 1290"/>
                <a:gd name="T60" fmla="*/ 948 w 1290"/>
                <a:gd name="T61" fmla="*/ 99 h 1290"/>
                <a:gd name="T62" fmla="*/ 1058 w 1290"/>
                <a:gd name="T63" fmla="*/ 0 h 1290"/>
                <a:gd name="T64" fmla="*/ 1109 w 1290"/>
                <a:gd name="T65" fmla="*/ 0 h 1290"/>
                <a:gd name="T66" fmla="*/ 1230 w 1290"/>
                <a:gd name="T67" fmla="*/ 0 h 1290"/>
                <a:gd name="T68" fmla="*/ 1270 w 1290"/>
                <a:gd name="T69" fmla="*/ 0 h 1290"/>
                <a:gd name="T70" fmla="*/ 1290 w 1290"/>
                <a:gd name="T71" fmla="*/ 0 h 12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</a:cxnLst>
              <a:rect l="0" t="0" r="r" b="b"/>
              <a:pathLst>
                <a:path w="1290" h="1290">
                  <a:moveTo>
                    <a:pt x="0" y="1290"/>
                  </a:moveTo>
                  <a:lnTo>
                    <a:pt x="0" y="1191"/>
                  </a:lnTo>
                  <a:lnTo>
                    <a:pt x="0" y="1092"/>
                  </a:lnTo>
                  <a:lnTo>
                    <a:pt x="10" y="1092"/>
                  </a:lnTo>
                  <a:lnTo>
                    <a:pt x="20" y="1092"/>
                  </a:lnTo>
                  <a:lnTo>
                    <a:pt x="30" y="1092"/>
                  </a:lnTo>
                  <a:lnTo>
                    <a:pt x="40" y="1092"/>
                  </a:lnTo>
                  <a:lnTo>
                    <a:pt x="40" y="993"/>
                  </a:lnTo>
                  <a:lnTo>
                    <a:pt x="51" y="993"/>
                  </a:lnTo>
                  <a:lnTo>
                    <a:pt x="51" y="893"/>
                  </a:lnTo>
                  <a:lnTo>
                    <a:pt x="51" y="794"/>
                  </a:lnTo>
                  <a:lnTo>
                    <a:pt x="61" y="794"/>
                  </a:lnTo>
                  <a:lnTo>
                    <a:pt x="81" y="794"/>
                  </a:lnTo>
                  <a:lnTo>
                    <a:pt x="91" y="794"/>
                  </a:lnTo>
                  <a:lnTo>
                    <a:pt x="101" y="794"/>
                  </a:lnTo>
                  <a:lnTo>
                    <a:pt x="101" y="695"/>
                  </a:lnTo>
                  <a:lnTo>
                    <a:pt x="111" y="695"/>
                  </a:lnTo>
                  <a:lnTo>
                    <a:pt x="121" y="695"/>
                  </a:lnTo>
                  <a:lnTo>
                    <a:pt x="131" y="695"/>
                  </a:lnTo>
                  <a:lnTo>
                    <a:pt x="141" y="695"/>
                  </a:lnTo>
                  <a:lnTo>
                    <a:pt x="161" y="595"/>
                  </a:lnTo>
                  <a:lnTo>
                    <a:pt x="161" y="496"/>
                  </a:lnTo>
                  <a:lnTo>
                    <a:pt x="161" y="397"/>
                  </a:lnTo>
                  <a:lnTo>
                    <a:pt x="171" y="397"/>
                  </a:lnTo>
                  <a:lnTo>
                    <a:pt x="181" y="397"/>
                  </a:lnTo>
                  <a:lnTo>
                    <a:pt x="192" y="397"/>
                  </a:lnTo>
                  <a:lnTo>
                    <a:pt x="202" y="397"/>
                  </a:lnTo>
                  <a:lnTo>
                    <a:pt x="212" y="397"/>
                  </a:lnTo>
                  <a:lnTo>
                    <a:pt x="222" y="397"/>
                  </a:lnTo>
                  <a:lnTo>
                    <a:pt x="232" y="397"/>
                  </a:lnTo>
                  <a:lnTo>
                    <a:pt x="242" y="397"/>
                  </a:lnTo>
                  <a:lnTo>
                    <a:pt x="282" y="298"/>
                  </a:lnTo>
                  <a:lnTo>
                    <a:pt x="292" y="298"/>
                  </a:lnTo>
                  <a:lnTo>
                    <a:pt x="303" y="298"/>
                  </a:lnTo>
                  <a:lnTo>
                    <a:pt x="313" y="298"/>
                  </a:lnTo>
                  <a:lnTo>
                    <a:pt x="322" y="298"/>
                  </a:lnTo>
                  <a:lnTo>
                    <a:pt x="333" y="298"/>
                  </a:lnTo>
                  <a:lnTo>
                    <a:pt x="373" y="298"/>
                  </a:lnTo>
                  <a:lnTo>
                    <a:pt x="383" y="298"/>
                  </a:lnTo>
                  <a:lnTo>
                    <a:pt x="403" y="298"/>
                  </a:lnTo>
                  <a:lnTo>
                    <a:pt x="413" y="298"/>
                  </a:lnTo>
                  <a:lnTo>
                    <a:pt x="504" y="199"/>
                  </a:lnTo>
                  <a:lnTo>
                    <a:pt x="514" y="199"/>
                  </a:lnTo>
                  <a:lnTo>
                    <a:pt x="544" y="199"/>
                  </a:lnTo>
                  <a:lnTo>
                    <a:pt x="564" y="199"/>
                  </a:lnTo>
                  <a:lnTo>
                    <a:pt x="574" y="199"/>
                  </a:lnTo>
                  <a:lnTo>
                    <a:pt x="595" y="199"/>
                  </a:lnTo>
                  <a:lnTo>
                    <a:pt x="605" y="199"/>
                  </a:lnTo>
                  <a:lnTo>
                    <a:pt x="615" y="199"/>
                  </a:lnTo>
                  <a:lnTo>
                    <a:pt x="625" y="199"/>
                  </a:lnTo>
                  <a:lnTo>
                    <a:pt x="645" y="199"/>
                  </a:lnTo>
                  <a:lnTo>
                    <a:pt x="655" y="199"/>
                  </a:lnTo>
                  <a:lnTo>
                    <a:pt x="686" y="199"/>
                  </a:lnTo>
                  <a:lnTo>
                    <a:pt x="756" y="199"/>
                  </a:lnTo>
                  <a:lnTo>
                    <a:pt x="786" y="199"/>
                  </a:lnTo>
                  <a:lnTo>
                    <a:pt x="827" y="199"/>
                  </a:lnTo>
                  <a:lnTo>
                    <a:pt x="847" y="99"/>
                  </a:lnTo>
                  <a:lnTo>
                    <a:pt x="867" y="99"/>
                  </a:lnTo>
                  <a:lnTo>
                    <a:pt x="877" y="99"/>
                  </a:lnTo>
                  <a:lnTo>
                    <a:pt x="907" y="99"/>
                  </a:lnTo>
                  <a:lnTo>
                    <a:pt x="917" y="99"/>
                  </a:lnTo>
                  <a:lnTo>
                    <a:pt x="948" y="99"/>
                  </a:lnTo>
                  <a:lnTo>
                    <a:pt x="1028" y="0"/>
                  </a:lnTo>
                  <a:lnTo>
                    <a:pt x="1058" y="0"/>
                  </a:lnTo>
                  <a:lnTo>
                    <a:pt x="1099" y="0"/>
                  </a:lnTo>
                  <a:lnTo>
                    <a:pt x="1109" y="0"/>
                  </a:lnTo>
                  <a:lnTo>
                    <a:pt x="1159" y="0"/>
                  </a:lnTo>
                  <a:lnTo>
                    <a:pt x="1230" y="0"/>
                  </a:lnTo>
                  <a:lnTo>
                    <a:pt x="1240" y="0"/>
                  </a:lnTo>
                  <a:lnTo>
                    <a:pt x="1270" y="0"/>
                  </a:lnTo>
                  <a:lnTo>
                    <a:pt x="1280" y="0"/>
                  </a:lnTo>
                  <a:lnTo>
                    <a:pt x="1290" y="0"/>
                  </a:lnTo>
                  <a:lnTo>
                    <a:pt x="1290" y="0"/>
                  </a:lnTo>
                </a:path>
              </a:pathLst>
            </a:cu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0" name="Rectangle 745"/>
            <p:cNvSpPr>
              <a:spLocks noChangeArrowheads="1"/>
            </p:cNvSpPr>
            <p:nvPr/>
          </p:nvSpPr>
          <p:spPr bwMode="auto">
            <a:xfrm>
              <a:off x="3623162" y="1167842"/>
              <a:ext cx="2047875" cy="2047875"/>
            </a:xfrm>
            <a:prstGeom prst="rect">
              <a:avLst/>
            </a:pr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1" name="Line 746"/>
            <p:cNvSpPr>
              <a:spLocks noChangeShapeType="1"/>
            </p:cNvSpPr>
            <p:nvPr/>
          </p:nvSpPr>
          <p:spPr bwMode="auto">
            <a:xfrm>
              <a:off x="3623162" y="3215717"/>
              <a:ext cx="0" cy="57150"/>
            </a:xfrm>
            <a:prstGeom prst="line">
              <a:avLst/>
            </a:pr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2" name="Line 748"/>
            <p:cNvSpPr>
              <a:spLocks noChangeShapeType="1"/>
            </p:cNvSpPr>
            <p:nvPr/>
          </p:nvSpPr>
          <p:spPr bwMode="auto">
            <a:xfrm>
              <a:off x="3727937" y="3215717"/>
              <a:ext cx="0" cy="28575"/>
            </a:xfrm>
            <a:prstGeom prst="line">
              <a:avLst/>
            </a:pr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3" name="Line 749"/>
            <p:cNvSpPr>
              <a:spLocks noChangeShapeType="1"/>
            </p:cNvSpPr>
            <p:nvPr/>
          </p:nvSpPr>
          <p:spPr bwMode="auto">
            <a:xfrm>
              <a:off x="3832712" y="3215717"/>
              <a:ext cx="0" cy="57150"/>
            </a:xfrm>
            <a:prstGeom prst="line">
              <a:avLst/>
            </a:pr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4" name="Line 750"/>
            <p:cNvSpPr>
              <a:spLocks noChangeShapeType="1"/>
            </p:cNvSpPr>
            <p:nvPr/>
          </p:nvSpPr>
          <p:spPr bwMode="auto">
            <a:xfrm>
              <a:off x="3927962" y="3215717"/>
              <a:ext cx="0" cy="28575"/>
            </a:xfrm>
            <a:prstGeom prst="line">
              <a:avLst/>
            </a:pr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5" name="Line 751"/>
            <p:cNvSpPr>
              <a:spLocks noChangeShapeType="1"/>
            </p:cNvSpPr>
            <p:nvPr/>
          </p:nvSpPr>
          <p:spPr bwMode="auto">
            <a:xfrm>
              <a:off x="4032737" y="3215717"/>
              <a:ext cx="0" cy="57150"/>
            </a:xfrm>
            <a:prstGeom prst="line">
              <a:avLst/>
            </a:pr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6" name="Line 753"/>
            <p:cNvSpPr>
              <a:spLocks noChangeShapeType="1"/>
            </p:cNvSpPr>
            <p:nvPr/>
          </p:nvSpPr>
          <p:spPr bwMode="auto">
            <a:xfrm>
              <a:off x="4137512" y="3215717"/>
              <a:ext cx="0" cy="28575"/>
            </a:xfrm>
            <a:prstGeom prst="line">
              <a:avLst/>
            </a:pr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7" name="Line 754"/>
            <p:cNvSpPr>
              <a:spLocks noChangeShapeType="1"/>
            </p:cNvSpPr>
            <p:nvPr/>
          </p:nvSpPr>
          <p:spPr bwMode="auto">
            <a:xfrm>
              <a:off x="4242287" y="3215717"/>
              <a:ext cx="0" cy="57150"/>
            </a:xfrm>
            <a:prstGeom prst="line">
              <a:avLst/>
            </a:pr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8" name="Line 755"/>
            <p:cNvSpPr>
              <a:spLocks noChangeShapeType="1"/>
            </p:cNvSpPr>
            <p:nvPr/>
          </p:nvSpPr>
          <p:spPr bwMode="auto">
            <a:xfrm>
              <a:off x="4337537" y="3215717"/>
              <a:ext cx="0" cy="28575"/>
            </a:xfrm>
            <a:prstGeom prst="line">
              <a:avLst/>
            </a:pr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9" name="Line 756"/>
            <p:cNvSpPr>
              <a:spLocks noChangeShapeType="1"/>
            </p:cNvSpPr>
            <p:nvPr/>
          </p:nvSpPr>
          <p:spPr bwMode="auto">
            <a:xfrm>
              <a:off x="4442312" y="3215717"/>
              <a:ext cx="0" cy="57150"/>
            </a:xfrm>
            <a:prstGeom prst="line">
              <a:avLst/>
            </a:pr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0" name="Line 758"/>
            <p:cNvSpPr>
              <a:spLocks noChangeShapeType="1"/>
            </p:cNvSpPr>
            <p:nvPr/>
          </p:nvSpPr>
          <p:spPr bwMode="auto">
            <a:xfrm>
              <a:off x="4547087" y="3215717"/>
              <a:ext cx="0" cy="28575"/>
            </a:xfrm>
            <a:prstGeom prst="line">
              <a:avLst/>
            </a:pr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1" name="Line 759"/>
            <p:cNvSpPr>
              <a:spLocks noChangeShapeType="1"/>
            </p:cNvSpPr>
            <p:nvPr/>
          </p:nvSpPr>
          <p:spPr bwMode="auto">
            <a:xfrm>
              <a:off x="4651862" y="3215717"/>
              <a:ext cx="0" cy="57150"/>
            </a:xfrm>
            <a:prstGeom prst="line">
              <a:avLst/>
            </a:pr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2" name="Line 760"/>
            <p:cNvSpPr>
              <a:spLocks noChangeShapeType="1"/>
            </p:cNvSpPr>
            <p:nvPr/>
          </p:nvSpPr>
          <p:spPr bwMode="auto">
            <a:xfrm>
              <a:off x="4747112" y="3215717"/>
              <a:ext cx="0" cy="28575"/>
            </a:xfrm>
            <a:prstGeom prst="line">
              <a:avLst/>
            </a:pr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3" name="Line 761"/>
            <p:cNvSpPr>
              <a:spLocks noChangeShapeType="1"/>
            </p:cNvSpPr>
            <p:nvPr/>
          </p:nvSpPr>
          <p:spPr bwMode="auto">
            <a:xfrm>
              <a:off x="4851887" y="3215717"/>
              <a:ext cx="0" cy="57150"/>
            </a:xfrm>
            <a:prstGeom prst="line">
              <a:avLst/>
            </a:pr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4" name="Line 763"/>
            <p:cNvSpPr>
              <a:spLocks noChangeShapeType="1"/>
            </p:cNvSpPr>
            <p:nvPr/>
          </p:nvSpPr>
          <p:spPr bwMode="auto">
            <a:xfrm>
              <a:off x="4956662" y="3215717"/>
              <a:ext cx="0" cy="28575"/>
            </a:xfrm>
            <a:prstGeom prst="line">
              <a:avLst/>
            </a:pr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5" name="Line 764"/>
            <p:cNvSpPr>
              <a:spLocks noChangeShapeType="1"/>
            </p:cNvSpPr>
            <p:nvPr/>
          </p:nvSpPr>
          <p:spPr bwMode="auto">
            <a:xfrm>
              <a:off x="5061437" y="3215717"/>
              <a:ext cx="0" cy="57150"/>
            </a:xfrm>
            <a:prstGeom prst="line">
              <a:avLst/>
            </a:pr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6" name="Line 765"/>
            <p:cNvSpPr>
              <a:spLocks noChangeShapeType="1"/>
            </p:cNvSpPr>
            <p:nvPr/>
          </p:nvSpPr>
          <p:spPr bwMode="auto">
            <a:xfrm>
              <a:off x="5156687" y="3215717"/>
              <a:ext cx="0" cy="28575"/>
            </a:xfrm>
            <a:prstGeom prst="line">
              <a:avLst/>
            </a:pr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7" name="Line 766"/>
            <p:cNvSpPr>
              <a:spLocks noChangeShapeType="1"/>
            </p:cNvSpPr>
            <p:nvPr/>
          </p:nvSpPr>
          <p:spPr bwMode="auto">
            <a:xfrm>
              <a:off x="5261462" y="3215717"/>
              <a:ext cx="0" cy="57150"/>
            </a:xfrm>
            <a:prstGeom prst="line">
              <a:avLst/>
            </a:pr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8" name="Line 768"/>
            <p:cNvSpPr>
              <a:spLocks noChangeShapeType="1"/>
            </p:cNvSpPr>
            <p:nvPr/>
          </p:nvSpPr>
          <p:spPr bwMode="auto">
            <a:xfrm>
              <a:off x="5366237" y="3215717"/>
              <a:ext cx="0" cy="28575"/>
            </a:xfrm>
            <a:prstGeom prst="line">
              <a:avLst/>
            </a:pr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9" name="Line 769"/>
            <p:cNvSpPr>
              <a:spLocks noChangeShapeType="1"/>
            </p:cNvSpPr>
            <p:nvPr/>
          </p:nvSpPr>
          <p:spPr bwMode="auto">
            <a:xfrm>
              <a:off x="5461487" y="3215717"/>
              <a:ext cx="0" cy="57150"/>
            </a:xfrm>
            <a:prstGeom prst="line">
              <a:avLst/>
            </a:pr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0" name="Line 770"/>
            <p:cNvSpPr>
              <a:spLocks noChangeShapeType="1"/>
            </p:cNvSpPr>
            <p:nvPr/>
          </p:nvSpPr>
          <p:spPr bwMode="auto">
            <a:xfrm>
              <a:off x="5566262" y="3215717"/>
              <a:ext cx="0" cy="28575"/>
            </a:xfrm>
            <a:prstGeom prst="line">
              <a:avLst/>
            </a:pr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1" name="Line 771"/>
            <p:cNvSpPr>
              <a:spLocks noChangeShapeType="1"/>
            </p:cNvSpPr>
            <p:nvPr/>
          </p:nvSpPr>
          <p:spPr bwMode="auto">
            <a:xfrm>
              <a:off x="5671037" y="3215717"/>
              <a:ext cx="0" cy="57150"/>
            </a:xfrm>
            <a:prstGeom prst="line">
              <a:avLst/>
            </a:pr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2" name="テキスト ボックス 381"/>
            <p:cNvSpPr txBox="1"/>
            <p:nvPr/>
          </p:nvSpPr>
          <p:spPr>
            <a:xfrm>
              <a:off x="4201257" y="2396568"/>
              <a:ext cx="901209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0.69 g/day</a:t>
              </a:r>
              <a:endParaRPr kumimoji="1" lang="ja-JP" altLang="en-US" sz="1200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383" name="テキスト ボックス 382"/>
            <p:cNvSpPr txBox="1"/>
            <p:nvPr/>
          </p:nvSpPr>
          <p:spPr>
            <a:xfrm>
              <a:off x="4471880" y="1954868"/>
              <a:ext cx="901209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0.40 g/day</a:t>
              </a:r>
              <a:endParaRPr kumimoji="1" lang="ja-JP" altLang="en-US" sz="1200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cxnSp>
          <p:nvCxnSpPr>
            <p:cNvPr id="384" name="直線矢印コネクタ 383"/>
            <p:cNvCxnSpPr/>
            <p:nvPr/>
          </p:nvCxnSpPr>
          <p:spPr>
            <a:xfrm flipH="1" flipV="1">
              <a:off x="3927962" y="1871826"/>
              <a:ext cx="273295" cy="524742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5" name="直線矢印コネクタ 384"/>
            <p:cNvCxnSpPr/>
            <p:nvPr/>
          </p:nvCxnSpPr>
          <p:spPr>
            <a:xfrm flipH="1" flipV="1">
              <a:off x="4137512" y="1696480"/>
              <a:ext cx="334368" cy="258388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96" name="テキスト ボックス 795"/>
          <p:cNvSpPr txBox="1"/>
          <p:nvPr/>
        </p:nvSpPr>
        <p:spPr>
          <a:xfrm>
            <a:off x="2140736" y="1999873"/>
            <a:ext cx="1063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True positive</a:t>
            </a:r>
            <a:endParaRPr kumimoji="1" lang="ja-JP" altLang="en-US" sz="1200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797" name="テキスト ボックス 796"/>
          <p:cNvSpPr txBox="1"/>
          <p:nvPr/>
        </p:nvSpPr>
        <p:spPr>
          <a:xfrm>
            <a:off x="4067944" y="3440033"/>
            <a:ext cx="11224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False positive</a:t>
            </a:r>
            <a:endParaRPr kumimoji="1" lang="ja-JP" altLang="en-US" sz="1200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386" name="テキスト ボックス 385"/>
          <p:cNvSpPr txBox="1"/>
          <p:nvPr/>
        </p:nvSpPr>
        <p:spPr>
          <a:xfrm>
            <a:off x="613916" y="4437112"/>
            <a:ext cx="72704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/>
              <a:t>Supplemental Figure E. </a:t>
            </a:r>
            <a:r>
              <a:rPr kumimoji="1" lang="en-US" altLang="ja-JP" dirty="0" smtClean="0"/>
              <a:t>ROC analysis for renal outcome by UPE at one year</a:t>
            </a:r>
            <a:endParaRPr kumimoji="1" lang="ja-JP" altLang="en-US" dirty="0"/>
          </a:p>
        </p:txBody>
      </p:sp>
      <p:sp>
        <p:nvSpPr>
          <p:cNvPr id="387" name="テキスト ボックス 386"/>
          <p:cNvSpPr txBox="1"/>
          <p:nvPr/>
        </p:nvSpPr>
        <p:spPr>
          <a:xfrm>
            <a:off x="5796136" y="2791961"/>
            <a:ext cx="1773242" cy="27699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UPE at one year, g/day</a:t>
            </a:r>
            <a:endParaRPr kumimoji="1" lang="ja-JP" altLang="en-US" sz="1200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335091627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2500409116"/>
              </p:ext>
            </p:extLst>
          </p:nvPr>
        </p:nvGraphicFramePr>
        <p:xfrm>
          <a:off x="2012950" y="1268760"/>
          <a:ext cx="5118100" cy="2245360"/>
        </p:xfrm>
        <a:graphic>
          <a:graphicData uri="http://schemas.openxmlformats.org/drawingml/2006/table">
            <a:tbl>
              <a:tblPr/>
              <a:tblGrid>
                <a:gridCol w="1778968"/>
                <a:gridCol w="684950"/>
                <a:gridCol w="684950"/>
                <a:gridCol w="684950"/>
                <a:gridCol w="1284282"/>
              </a:tblGrid>
              <a:tr h="507365">
                <a:tc gridSpan="5"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Supplemental Table D.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UPE predicting the outcome in multivariable Cox-Hazard model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25527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 UP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B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S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p valu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HR (95% CI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527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UPE at baseline,     g/day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0.30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0.32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&gt;0.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1.36 (0.73 to 2.54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5527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UPE at six months, g/day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0.22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0.51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&gt;0.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1.25 (0.46 to 3.42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527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UPE at one year,    g/day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0.86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0.28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.00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2.38 (1.37 to 4.15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9550">
                <a:tc gridSpan="5"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This model was adjusted baseline eGFR.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507365">
                <a:tc gridSpan="5"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Abbreviations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: B; coefficient, SE; standard error, HR; hazard ratio, CI; confidence interval.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</a:tbl>
          </a:graphicData>
        </a:graphic>
      </p:graphicFrame>
    </p:spTree>
    <p:extLst>
      <p:ext uri="{BB962C8B-B14F-4D97-AF65-F5344CB8AC3E}">
        <p14:creationId xmlns="" xmlns:p14="http://schemas.microsoft.com/office/powerpoint/2010/main" val="8895256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47</TotalTime>
  <Words>1230</Words>
  <Application>Microsoft Office PowerPoint</Application>
  <PresentationFormat>画面に合わせる (4:3)</PresentationFormat>
  <Paragraphs>260</Paragraphs>
  <Slides>1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1</vt:i4>
      </vt:variant>
    </vt:vector>
  </HeadingPairs>
  <TitlesOfParts>
    <vt:vector size="12" baseType="lpstr">
      <vt:lpstr>Office ​​テーマ</vt:lpstr>
      <vt:lpstr>スライド 1</vt:lpstr>
      <vt:lpstr>スライド 2</vt:lpstr>
      <vt:lpstr>スライド 3</vt:lpstr>
      <vt:lpstr>スライド 4</vt:lpstr>
      <vt:lpstr>スライド 5</vt:lpstr>
      <vt:lpstr>スライド 6</vt:lpstr>
      <vt:lpstr>スライド 7</vt:lpstr>
      <vt:lpstr>スライド 8</vt:lpstr>
      <vt:lpstr>スライド 9</vt:lpstr>
      <vt:lpstr>スライド 10</vt:lpstr>
      <vt:lpstr>スライド 1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eita</dc:creator>
  <cp:lastModifiedBy>TETSUYA KAWAMURA</cp:lastModifiedBy>
  <cp:revision>53</cp:revision>
  <dcterms:created xsi:type="dcterms:W3CDTF">2012-10-10T00:33:16Z</dcterms:created>
  <dcterms:modified xsi:type="dcterms:W3CDTF">2012-11-07T12:40:32Z</dcterms:modified>
</cp:coreProperties>
</file>